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57" r:id="rId2"/>
    <p:sldId id="256" r:id="rId3"/>
  </p:sldIdLst>
  <p:sldSz cx="10058400" cy="7772400"/>
  <p:notesSz cx="10058400" cy="7772400"/>
  <p:embeddedFontLst>
    <p:embeddedFont>
      <p:font typeface="AlbanyAMT,Regular"/>
      <p:regular r:id="rId4"/>
    </p:embeddedFont>
  </p:embeddedFontLst>
  <p:defaultTextStyle/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2" d="100"/>
          <a:sy n="112" d="100"/>
        </p:scale>
        <p:origin x="12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font" Target="fonts/font1.fntdata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Freeform 101"/>
          <p:cNvSpPr/>
          <p:nvPr/>
        </p:nvSpPr>
        <p:spPr>
          <a:xfrm>
            <a:off x="468303" y="1098230"/>
            <a:ext cx="4705737" cy="3528297"/>
          </a:xfrm>
          <a:custGeom>
            <a:avLst/>
            <a:gdLst/>
            <a:ahLst/>
            <a:cxnLst/>
            <a:rect l="0" t="0" r="0" b="0"/>
            <a:pathLst>
              <a:path w="6089777" h="4566031">
                <a:moveTo>
                  <a:pt x="3044825" y="0"/>
                </a:moveTo>
                <a:lnTo>
                  <a:pt x="6089777" y="0"/>
                </a:lnTo>
                <a:lnTo>
                  <a:pt x="6089777" y="4566031"/>
                </a:lnTo>
                <a:lnTo>
                  <a:pt x="0" y="4566031"/>
                </a:lnTo>
                <a:lnTo>
                  <a:pt x="0" y="0"/>
                </a:lnTo>
                <a:lnTo>
                  <a:pt x="3044825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2" name="Freeform 102"/>
          <p:cNvSpPr/>
          <p:nvPr/>
        </p:nvSpPr>
        <p:spPr>
          <a:xfrm>
            <a:off x="468303" y="1098230"/>
            <a:ext cx="4705737" cy="3528297"/>
          </a:xfrm>
          <a:custGeom>
            <a:avLst/>
            <a:gdLst/>
            <a:ahLst/>
            <a:cxnLst/>
            <a:rect l="0" t="0" r="0" b="0"/>
            <a:pathLst>
              <a:path w="6089777" h="4566031">
                <a:moveTo>
                  <a:pt x="3044825" y="0"/>
                </a:moveTo>
                <a:lnTo>
                  <a:pt x="6089777" y="0"/>
                </a:lnTo>
                <a:lnTo>
                  <a:pt x="6089777" y="4566031"/>
                </a:lnTo>
                <a:lnTo>
                  <a:pt x="0" y="4566031"/>
                </a:lnTo>
                <a:lnTo>
                  <a:pt x="0" y="0"/>
                </a:lnTo>
                <a:lnTo>
                  <a:pt x="3044825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3" name="Freeform 103"/>
          <p:cNvSpPr/>
          <p:nvPr/>
        </p:nvSpPr>
        <p:spPr>
          <a:xfrm>
            <a:off x="974196" y="1211283"/>
            <a:ext cx="4103376" cy="2954101"/>
          </a:xfrm>
          <a:custGeom>
            <a:avLst/>
            <a:gdLst/>
            <a:ahLst/>
            <a:cxnLst/>
            <a:rect l="0" t="0" r="0" b="0"/>
            <a:pathLst>
              <a:path w="5310251" h="3822954">
                <a:moveTo>
                  <a:pt x="2655062" y="0"/>
                </a:moveTo>
                <a:lnTo>
                  <a:pt x="5310251" y="0"/>
                </a:lnTo>
                <a:lnTo>
                  <a:pt x="5310251" y="3822954"/>
                </a:lnTo>
                <a:lnTo>
                  <a:pt x="0" y="3822954"/>
                </a:lnTo>
                <a:lnTo>
                  <a:pt x="0" y="0"/>
                </a:lnTo>
                <a:lnTo>
                  <a:pt x="2655062" y="0"/>
                </a:lnTo>
              </a:path>
            </a:pathLst>
          </a:custGeom>
          <a:solidFill>
            <a:srgbClr val="FFFFFF">
              <a:alpha val="100000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4" name="Freeform 104"/>
          <p:cNvSpPr/>
          <p:nvPr/>
        </p:nvSpPr>
        <p:spPr>
          <a:xfrm>
            <a:off x="1291765" y="4091585"/>
            <a:ext cx="242004" cy="45536"/>
          </a:xfrm>
          <a:custGeom>
            <a:avLst/>
            <a:gdLst/>
            <a:ahLst/>
            <a:cxnLst/>
            <a:rect l="0" t="0" r="0" b="0"/>
            <a:pathLst>
              <a:path w="313181" h="58929">
                <a:moveTo>
                  <a:pt x="156590" y="0"/>
                </a:moveTo>
                <a:lnTo>
                  <a:pt x="313181" y="0"/>
                </a:lnTo>
                <a:lnTo>
                  <a:pt x="313181" y="58929"/>
                </a:lnTo>
                <a:lnTo>
                  <a:pt x="0" y="58929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6F7EB3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5" name="Freeform 105"/>
          <p:cNvSpPr/>
          <p:nvPr/>
        </p:nvSpPr>
        <p:spPr>
          <a:xfrm>
            <a:off x="1291765" y="4091585"/>
            <a:ext cx="242004" cy="45536"/>
          </a:xfrm>
          <a:custGeom>
            <a:avLst/>
            <a:gdLst/>
            <a:ahLst/>
            <a:cxnLst/>
            <a:rect l="0" t="0" r="0" b="0"/>
            <a:pathLst>
              <a:path w="313181" h="58929">
                <a:moveTo>
                  <a:pt x="156590" y="0"/>
                </a:moveTo>
                <a:lnTo>
                  <a:pt x="313181" y="0"/>
                </a:lnTo>
                <a:lnTo>
                  <a:pt x="313181" y="58929"/>
                </a:lnTo>
                <a:lnTo>
                  <a:pt x="0" y="58929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6" name="Freeform 106"/>
          <p:cNvSpPr/>
          <p:nvPr/>
        </p:nvSpPr>
        <p:spPr>
          <a:xfrm>
            <a:off x="1533769" y="3590403"/>
            <a:ext cx="241907" cy="546718"/>
          </a:xfrm>
          <a:custGeom>
            <a:avLst/>
            <a:gdLst/>
            <a:ahLst/>
            <a:cxnLst/>
            <a:rect l="0" t="0" r="0" b="0"/>
            <a:pathLst>
              <a:path w="313056" h="707517">
                <a:moveTo>
                  <a:pt x="156592" y="0"/>
                </a:moveTo>
                <a:lnTo>
                  <a:pt x="313056" y="0"/>
                </a:lnTo>
                <a:lnTo>
                  <a:pt x="313056" y="707517"/>
                </a:lnTo>
                <a:lnTo>
                  <a:pt x="0" y="707517"/>
                </a:lnTo>
                <a:lnTo>
                  <a:pt x="0" y="0"/>
                </a:lnTo>
                <a:lnTo>
                  <a:pt x="156592" y="0"/>
                </a:lnTo>
              </a:path>
            </a:pathLst>
          </a:custGeom>
          <a:solidFill>
            <a:srgbClr val="6F7EB3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7" name="Freeform 107"/>
          <p:cNvSpPr/>
          <p:nvPr/>
        </p:nvSpPr>
        <p:spPr>
          <a:xfrm>
            <a:off x="1533769" y="3590403"/>
            <a:ext cx="241907" cy="546718"/>
          </a:xfrm>
          <a:custGeom>
            <a:avLst/>
            <a:gdLst/>
            <a:ahLst/>
            <a:cxnLst/>
            <a:rect l="0" t="0" r="0" b="0"/>
            <a:pathLst>
              <a:path w="313056" h="707517">
                <a:moveTo>
                  <a:pt x="156592" y="0"/>
                </a:moveTo>
                <a:lnTo>
                  <a:pt x="313056" y="0"/>
                </a:lnTo>
                <a:lnTo>
                  <a:pt x="313056" y="707517"/>
                </a:lnTo>
                <a:lnTo>
                  <a:pt x="0" y="707517"/>
                </a:lnTo>
                <a:lnTo>
                  <a:pt x="0" y="0"/>
                </a:lnTo>
                <a:lnTo>
                  <a:pt x="156592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8" name="Freeform 108"/>
          <p:cNvSpPr/>
          <p:nvPr/>
        </p:nvSpPr>
        <p:spPr>
          <a:xfrm>
            <a:off x="1775676" y="2815911"/>
            <a:ext cx="242004" cy="1321210"/>
          </a:xfrm>
          <a:custGeom>
            <a:avLst/>
            <a:gdLst/>
            <a:ahLst/>
            <a:cxnLst/>
            <a:rect l="0" t="0" r="0" b="0"/>
            <a:pathLst>
              <a:path w="313182" h="1709801">
                <a:moveTo>
                  <a:pt x="156591" y="0"/>
                </a:moveTo>
                <a:lnTo>
                  <a:pt x="313182" y="0"/>
                </a:lnTo>
                <a:lnTo>
                  <a:pt x="313182" y="1709801"/>
                </a:lnTo>
                <a:lnTo>
                  <a:pt x="0" y="1709801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solidFill>
            <a:srgbClr val="6F7EB3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9" name="Freeform 109"/>
          <p:cNvSpPr/>
          <p:nvPr/>
        </p:nvSpPr>
        <p:spPr>
          <a:xfrm>
            <a:off x="1775676" y="2815911"/>
            <a:ext cx="242004" cy="1321210"/>
          </a:xfrm>
          <a:custGeom>
            <a:avLst/>
            <a:gdLst/>
            <a:ahLst/>
            <a:cxnLst/>
            <a:rect l="0" t="0" r="0" b="0"/>
            <a:pathLst>
              <a:path w="313182" h="1709801">
                <a:moveTo>
                  <a:pt x="156591" y="0"/>
                </a:moveTo>
                <a:lnTo>
                  <a:pt x="313182" y="0"/>
                </a:lnTo>
                <a:lnTo>
                  <a:pt x="313182" y="1709801"/>
                </a:lnTo>
                <a:lnTo>
                  <a:pt x="0" y="1709801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0" name="Freeform 110"/>
          <p:cNvSpPr/>
          <p:nvPr/>
        </p:nvSpPr>
        <p:spPr>
          <a:xfrm>
            <a:off x="2017680" y="1266828"/>
            <a:ext cx="242004" cy="2870293"/>
          </a:xfrm>
          <a:custGeom>
            <a:avLst/>
            <a:gdLst/>
            <a:ahLst/>
            <a:cxnLst/>
            <a:rect l="0" t="0" r="0" b="0"/>
            <a:pathLst>
              <a:path w="313181" h="3714497">
                <a:moveTo>
                  <a:pt x="156591" y="0"/>
                </a:moveTo>
                <a:lnTo>
                  <a:pt x="313181" y="0"/>
                </a:lnTo>
                <a:lnTo>
                  <a:pt x="313181" y="3714497"/>
                </a:lnTo>
                <a:lnTo>
                  <a:pt x="0" y="3714497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solidFill>
            <a:srgbClr val="6F7EB3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1" name="Freeform 111"/>
          <p:cNvSpPr/>
          <p:nvPr/>
        </p:nvSpPr>
        <p:spPr>
          <a:xfrm>
            <a:off x="2017680" y="1266828"/>
            <a:ext cx="242004" cy="2870293"/>
          </a:xfrm>
          <a:custGeom>
            <a:avLst/>
            <a:gdLst/>
            <a:ahLst/>
            <a:cxnLst/>
            <a:rect l="0" t="0" r="0" b="0"/>
            <a:pathLst>
              <a:path w="313181" h="3714497">
                <a:moveTo>
                  <a:pt x="156591" y="0"/>
                </a:moveTo>
                <a:lnTo>
                  <a:pt x="313181" y="0"/>
                </a:lnTo>
                <a:lnTo>
                  <a:pt x="313181" y="3714497"/>
                </a:lnTo>
                <a:lnTo>
                  <a:pt x="0" y="3714497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2" name="Freeform 112"/>
          <p:cNvSpPr/>
          <p:nvPr/>
        </p:nvSpPr>
        <p:spPr>
          <a:xfrm>
            <a:off x="2259683" y="1768010"/>
            <a:ext cx="241907" cy="2369111"/>
          </a:xfrm>
          <a:custGeom>
            <a:avLst/>
            <a:gdLst/>
            <a:ahLst/>
            <a:cxnLst/>
            <a:rect l="0" t="0" r="0" b="0"/>
            <a:pathLst>
              <a:path w="313056" h="3065908">
                <a:moveTo>
                  <a:pt x="156465" y="0"/>
                </a:moveTo>
                <a:lnTo>
                  <a:pt x="313056" y="0"/>
                </a:lnTo>
                <a:lnTo>
                  <a:pt x="313056" y="3065908"/>
                </a:lnTo>
                <a:lnTo>
                  <a:pt x="0" y="3065908"/>
                </a:lnTo>
                <a:lnTo>
                  <a:pt x="0" y="0"/>
                </a:lnTo>
                <a:lnTo>
                  <a:pt x="156465" y="0"/>
                </a:lnTo>
              </a:path>
            </a:pathLst>
          </a:custGeom>
          <a:solidFill>
            <a:srgbClr val="6F7EB3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3" name="Freeform 113"/>
          <p:cNvSpPr/>
          <p:nvPr/>
        </p:nvSpPr>
        <p:spPr>
          <a:xfrm>
            <a:off x="2259683" y="1768010"/>
            <a:ext cx="241907" cy="2369111"/>
          </a:xfrm>
          <a:custGeom>
            <a:avLst/>
            <a:gdLst/>
            <a:ahLst/>
            <a:cxnLst/>
            <a:rect l="0" t="0" r="0" b="0"/>
            <a:pathLst>
              <a:path w="313056" h="3065908">
                <a:moveTo>
                  <a:pt x="156465" y="0"/>
                </a:moveTo>
                <a:lnTo>
                  <a:pt x="313056" y="0"/>
                </a:lnTo>
                <a:lnTo>
                  <a:pt x="313056" y="3065908"/>
                </a:lnTo>
                <a:lnTo>
                  <a:pt x="0" y="3065908"/>
                </a:lnTo>
                <a:lnTo>
                  <a:pt x="0" y="0"/>
                </a:lnTo>
                <a:lnTo>
                  <a:pt x="156465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4" name="Freeform 114"/>
          <p:cNvSpPr/>
          <p:nvPr/>
        </p:nvSpPr>
        <p:spPr>
          <a:xfrm>
            <a:off x="2501590" y="2269193"/>
            <a:ext cx="242004" cy="1867928"/>
          </a:xfrm>
          <a:custGeom>
            <a:avLst/>
            <a:gdLst/>
            <a:ahLst/>
            <a:cxnLst/>
            <a:rect l="0" t="0" r="0" b="0"/>
            <a:pathLst>
              <a:path w="313182" h="2417318">
                <a:moveTo>
                  <a:pt x="156591" y="0"/>
                </a:moveTo>
                <a:lnTo>
                  <a:pt x="313182" y="0"/>
                </a:lnTo>
                <a:lnTo>
                  <a:pt x="313182" y="2417318"/>
                </a:lnTo>
                <a:lnTo>
                  <a:pt x="0" y="2417318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solidFill>
            <a:srgbClr val="6F7EB3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5" name="Freeform 115"/>
          <p:cNvSpPr/>
          <p:nvPr/>
        </p:nvSpPr>
        <p:spPr>
          <a:xfrm>
            <a:off x="2501590" y="2269193"/>
            <a:ext cx="242004" cy="1867928"/>
          </a:xfrm>
          <a:custGeom>
            <a:avLst/>
            <a:gdLst/>
            <a:ahLst/>
            <a:cxnLst/>
            <a:rect l="0" t="0" r="0" b="0"/>
            <a:pathLst>
              <a:path w="313182" h="2417318">
                <a:moveTo>
                  <a:pt x="156591" y="0"/>
                </a:moveTo>
                <a:lnTo>
                  <a:pt x="313182" y="0"/>
                </a:lnTo>
                <a:lnTo>
                  <a:pt x="313182" y="2417318"/>
                </a:lnTo>
                <a:lnTo>
                  <a:pt x="0" y="2417318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6" name="Freeform 116"/>
          <p:cNvSpPr/>
          <p:nvPr/>
        </p:nvSpPr>
        <p:spPr>
          <a:xfrm>
            <a:off x="2743595" y="3863810"/>
            <a:ext cx="241906" cy="273311"/>
          </a:xfrm>
          <a:custGeom>
            <a:avLst/>
            <a:gdLst/>
            <a:ahLst/>
            <a:cxnLst/>
            <a:rect l="0" t="0" r="0" b="0"/>
            <a:pathLst>
              <a:path w="313055" h="353696">
                <a:moveTo>
                  <a:pt x="156590" y="0"/>
                </a:moveTo>
                <a:lnTo>
                  <a:pt x="313055" y="0"/>
                </a:lnTo>
                <a:lnTo>
                  <a:pt x="313055" y="353696"/>
                </a:lnTo>
                <a:lnTo>
                  <a:pt x="0" y="353696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6F7EB3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7" name="Freeform 117"/>
          <p:cNvSpPr/>
          <p:nvPr/>
        </p:nvSpPr>
        <p:spPr>
          <a:xfrm>
            <a:off x="2743595" y="3863810"/>
            <a:ext cx="241906" cy="273311"/>
          </a:xfrm>
          <a:custGeom>
            <a:avLst/>
            <a:gdLst/>
            <a:ahLst/>
            <a:cxnLst/>
            <a:rect l="0" t="0" r="0" b="0"/>
            <a:pathLst>
              <a:path w="313055" h="353696">
                <a:moveTo>
                  <a:pt x="156590" y="0"/>
                </a:moveTo>
                <a:lnTo>
                  <a:pt x="313055" y="0"/>
                </a:lnTo>
                <a:lnTo>
                  <a:pt x="313055" y="353696"/>
                </a:lnTo>
                <a:lnTo>
                  <a:pt x="0" y="353696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8" name="Freeform 118"/>
          <p:cNvSpPr/>
          <p:nvPr/>
        </p:nvSpPr>
        <p:spPr>
          <a:xfrm>
            <a:off x="2985501" y="3863810"/>
            <a:ext cx="242004" cy="273311"/>
          </a:xfrm>
          <a:custGeom>
            <a:avLst/>
            <a:gdLst/>
            <a:ahLst/>
            <a:cxnLst/>
            <a:rect l="0" t="0" r="0" b="0"/>
            <a:pathLst>
              <a:path w="313182" h="353696">
                <a:moveTo>
                  <a:pt x="156590" y="0"/>
                </a:moveTo>
                <a:lnTo>
                  <a:pt x="313182" y="0"/>
                </a:lnTo>
                <a:lnTo>
                  <a:pt x="313182" y="353696"/>
                </a:lnTo>
                <a:lnTo>
                  <a:pt x="0" y="353696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6F7EB3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9" name="Freeform 119"/>
          <p:cNvSpPr/>
          <p:nvPr/>
        </p:nvSpPr>
        <p:spPr>
          <a:xfrm>
            <a:off x="2985501" y="3863810"/>
            <a:ext cx="242004" cy="273311"/>
          </a:xfrm>
          <a:custGeom>
            <a:avLst/>
            <a:gdLst/>
            <a:ahLst/>
            <a:cxnLst/>
            <a:rect l="0" t="0" r="0" b="0"/>
            <a:pathLst>
              <a:path w="313182" h="353696">
                <a:moveTo>
                  <a:pt x="156590" y="0"/>
                </a:moveTo>
                <a:lnTo>
                  <a:pt x="313182" y="0"/>
                </a:lnTo>
                <a:lnTo>
                  <a:pt x="313182" y="353696"/>
                </a:lnTo>
                <a:lnTo>
                  <a:pt x="0" y="353696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0" name="Freeform 120"/>
          <p:cNvSpPr/>
          <p:nvPr/>
        </p:nvSpPr>
        <p:spPr>
          <a:xfrm>
            <a:off x="3227505" y="4046050"/>
            <a:ext cx="242004" cy="91071"/>
          </a:xfrm>
          <a:custGeom>
            <a:avLst/>
            <a:gdLst/>
            <a:ahLst/>
            <a:cxnLst/>
            <a:rect l="0" t="0" r="0" b="0"/>
            <a:pathLst>
              <a:path w="313182" h="117856">
                <a:moveTo>
                  <a:pt x="156590" y="0"/>
                </a:moveTo>
                <a:lnTo>
                  <a:pt x="313182" y="0"/>
                </a:lnTo>
                <a:lnTo>
                  <a:pt x="313182" y="117856"/>
                </a:lnTo>
                <a:lnTo>
                  <a:pt x="0" y="117856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6F7EB3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1" name="Freeform 121"/>
          <p:cNvSpPr/>
          <p:nvPr/>
        </p:nvSpPr>
        <p:spPr>
          <a:xfrm>
            <a:off x="3227505" y="4046050"/>
            <a:ext cx="242004" cy="91071"/>
          </a:xfrm>
          <a:custGeom>
            <a:avLst/>
            <a:gdLst/>
            <a:ahLst/>
            <a:cxnLst/>
            <a:rect l="0" t="0" r="0" b="0"/>
            <a:pathLst>
              <a:path w="313182" h="117856">
                <a:moveTo>
                  <a:pt x="156590" y="0"/>
                </a:moveTo>
                <a:lnTo>
                  <a:pt x="313182" y="0"/>
                </a:lnTo>
                <a:lnTo>
                  <a:pt x="313182" y="117856"/>
                </a:lnTo>
                <a:lnTo>
                  <a:pt x="0" y="117856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2" name="Freeform 122"/>
          <p:cNvSpPr/>
          <p:nvPr/>
        </p:nvSpPr>
        <p:spPr>
          <a:xfrm>
            <a:off x="3469510" y="4137121"/>
            <a:ext cx="241906" cy="0"/>
          </a:xfrm>
          <a:custGeom>
            <a:avLst/>
            <a:gdLst/>
            <a:ahLst/>
            <a:cxnLst/>
            <a:rect l="0" t="0" r="0" b="0"/>
            <a:pathLst>
              <a:path w="313055">
                <a:moveTo>
                  <a:pt x="0" y="0"/>
                </a:moveTo>
                <a:lnTo>
                  <a:pt x="313055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3" name="Freeform 123"/>
          <p:cNvSpPr/>
          <p:nvPr/>
        </p:nvSpPr>
        <p:spPr>
          <a:xfrm>
            <a:off x="3711416" y="4137121"/>
            <a:ext cx="242004" cy="0"/>
          </a:xfrm>
          <a:custGeom>
            <a:avLst/>
            <a:gdLst/>
            <a:ahLst/>
            <a:cxnLst/>
            <a:rect l="0" t="0" r="0" b="0"/>
            <a:pathLst>
              <a:path w="313182">
                <a:moveTo>
                  <a:pt x="0" y="0"/>
                </a:moveTo>
                <a:lnTo>
                  <a:pt x="313182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4" name="Freeform 124"/>
          <p:cNvSpPr/>
          <p:nvPr/>
        </p:nvSpPr>
        <p:spPr>
          <a:xfrm>
            <a:off x="3953420" y="4137121"/>
            <a:ext cx="241905" cy="0"/>
          </a:xfrm>
          <a:custGeom>
            <a:avLst/>
            <a:gdLst/>
            <a:ahLst/>
            <a:cxnLst/>
            <a:rect l="0" t="0" r="0" b="0"/>
            <a:pathLst>
              <a:path w="313054">
                <a:moveTo>
                  <a:pt x="0" y="0"/>
                </a:moveTo>
                <a:lnTo>
                  <a:pt x="313054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5" name="Freeform 125"/>
          <p:cNvSpPr/>
          <p:nvPr/>
        </p:nvSpPr>
        <p:spPr>
          <a:xfrm>
            <a:off x="4195326" y="4137121"/>
            <a:ext cx="242005" cy="0"/>
          </a:xfrm>
          <a:custGeom>
            <a:avLst/>
            <a:gdLst/>
            <a:ahLst/>
            <a:cxnLst/>
            <a:rect l="0" t="0" r="0" b="0"/>
            <a:pathLst>
              <a:path w="313183">
                <a:moveTo>
                  <a:pt x="0" y="0"/>
                </a:moveTo>
                <a:lnTo>
                  <a:pt x="313183" y="0"/>
                </a:lnTo>
              </a:path>
            </a:pathLst>
          </a:custGeom>
          <a:noFill/>
          <a:ln w="12191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6" name="Freeform 126"/>
          <p:cNvSpPr/>
          <p:nvPr/>
        </p:nvSpPr>
        <p:spPr>
          <a:xfrm>
            <a:off x="1291765" y="4137121"/>
            <a:ext cx="242004" cy="0"/>
          </a:xfrm>
          <a:custGeom>
            <a:avLst/>
            <a:gdLst/>
            <a:ahLst/>
            <a:cxnLst/>
            <a:rect l="0" t="0" r="0" b="0"/>
            <a:pathLst>
              <a:path w="313181">
                <a:moveTo>
                  <a:pt x="0" y="0"/>
                </a:moveTo>
                <a:lnTo>
                  <a:pt x="313181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7" name="Freeform 127"/>
          <p:cNvSpPr/>
          <p:nvPr/>
        </p:nvSpPr>
        <p:spPr>
          <a:xfrm>
            <a:off x="1533769" y="4137121"/>
            <a:ext cx="241907" cy="0"/>
          </a:xfrm>
          <a:custGeom>
            <a:avLst/>
            <a:gdLst/>
            <a:ahLst/>
            <a:cxnLst/>
            <a:rect l="0" t="0" r="0" b="0"/>
            <a:pathLst>
              <a:path w="313056">
                <a:moveTo>
                  <a:pt x="0" y="0"/>
                </a:moveTo>
                <a:lnTo>
                  <a:pt x="313056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8" name="Freeform 128"/>
          <p:cNvSpPr/>
          <p:nvPr/>
        </p:nvSpPr>
        <p:spPr>
          <a:xfrm>
            <a:off x="1775676" y="4028582"/>
            <a:ext cx="242004" cy="108539"/>
          </a:xfrm>
          <a:custGeom>
            <a:avLst/>
            <a:gdLst/>
            <a:ahLst/>
            <a:cxnLst/>
            <a:rect l="0" t="0" r="0" b="0"/>
            <a:pathLst>
              <a:path w="313182" h="140462">
                <a:moveTo>
                  <a:pt x="156591" y="0"/>
                </a:moveTo>
                <a:lnTo>
                  <a:pt x="313182" y="0"/>
                </a:lnTo>
                <a:lnTo>
                  <a:pt x="313182" y="140462"/>
                </a:lnTo>
                <a:lnTo>
                  <a:pt x="0" y="140462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solidFill>
            <a:srgbClr val="D05B5B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9" name="Freeform 129"/>
          <p:cNvSpPr/>
          <p:nvPr/>
        </p:nvSpPr>
        <p:spPr>
          <a:xfrm>
            <a:off x="1775676" y="4028582"/>
            <a:ext cx="242004" cy="108539"/>
          </a:xfrm>
          <a:custGeom>
            <a:avLst/>
            <a:gdLst/>
            <a:ahLst/>
            <a:cxnLst/>
            <a:rect l="0" t="0" r="0" b="0"/>
            <a:pathLst>
              <a:path w="313182" h="140462">
                <a:moveTo>
                  <a:pt x="156591" y="0"/>
                </a:moveTo>
                <a:lnTo>
                  <a:pt x="313182" y="0"/>
                </a:lnTo>
                <a:lnTo>
                  <a:pt x="313182" y="140462"/>
                </a:lnTo>
                <a:lnTo>
                  <a:pt x="0" y="140462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0" name="Freeform 130"/>
          <p:cNvSpPr/>
          <p:nvPr/>
        </p:nvSpPr>
        <p:spPr>
          <a:xfrm>
            <a:off x="2017680" y="3485985"/>
            <a:ext cx="242004" cy="651136"/>
          </a:xfrm>
          <a:custGeom>
            <a:avLst/>
            <a:gdLst/>
            <a:ahLst/>
            <a:cxnLst/>
            <a:rect l="0" t="0" r="0" b="0"/>
            <a:pathLst>
              <a:path w="313181" h="842646">
                <a:moveTo>
                  <a:pt x="156591" y="0"/>
                </a:moveTo>
                <a:lnTo>
                  <a:pt x="313181" y="0"/>
                </a:lnTo>
                <a:lnTo>
                  <a:pt x="313181" y="842646"/>
                </a:lnTo>
                <a:lnTo>
                  <a:pt x="0" y="842646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solidFill>
            <a:srgbClr val="D05B5B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1" name="Freeform 131"/>
          <p:cNvSpPr/>
          <p:nvPr/>
        </p:nvSpPr>
        <p:spPr>
          <a:xfrm>
            <a:off x="2017680" y="3485985"/>
            <a:ext cx="242004" cy="651136"/>
          </a:xfrm>
          <a:custGeom>
            <a:avLst/>
            <a:gdLst/>
            <a:ahLst/>
            <a:cxnLst/>
            <a:rect l="0" t="0" r="0" b="0"/>
            <a:pathLst>
              <a:path w="313181" h="842646">
                <a:moveTo>
                  <a:pt x="156591" y="0"/>
                </a:moveTo>
                <a:lnTo>
                  <a:pt x="313181" y="0"/>
                </a:lnTo>
                <a:lnTo>
                  <a:pt x="313181" y="842646"/>
                </a:lnTo>
                <a:lnTo>
                  <a:pt x="0" y="842646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2" name="Freeform 132"/>
          <p:cNvSpPr/>
          <p:nvPr/>
        </p:nvSpPr>
        <p:spPr>
          <a:xfrm>
            <a:off x="2259683" y="1749561"/>
            <a:ext cx="241907" cy="2387560"/>
          </a:xfrm>
          <a:custGeom>
            <a:avLst/>
            <a:gdLst/>
            <a:ahLst/>
            <a:cxnLst/>
            <a:rect l="0" t="0" r="0" b="0"/>
            <a:pathLst>
              <a:path w="313056" h="3089784">
                <a:moveTo>
                  <a:pt x="156465" y="0"/>
                </a:moveTo>
                <a:lnTo>
                  <a:pt x="313056" y="0"/>
                </a:lnTo>
                <a:lnTo>
                  <a:pt x="313056" y="3089784"/>
                </a:lnTo>
                <a:lnTo>
                  <a:pt x="0" y="3089784"/>
                </a:lnTo>
                <a:lnTo>
                  <a:pt x="0" y="0"/>
                </a:lnTo>
                <a:lnTo>
                  <a:pt x="156465" y="0"/>
                </a:lnTo>
              </a:path>
            </a:pathLst>
          </a:custGeom>
          <a:solidFill>
            <a:srgbClr val="D05B5B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3" name="Freeform 133"/>
          <p:cNvSpPr/>
          <p:nvPr/>
        </p:nvSpPr>
        <p:spPr>
          <a:xfrm>
            <a:off x="2259683" y="1749561"/>
            <a:ext cx="241907" cy="2387560"/>
          </a:xfrm>
          <a:custGeom>
            <a:avLst/>
            <a:gdLst/>
            <a:ahLst/>
            <a:cxnLst/>
            <a:rect l="0" t="0" r="0" b="0"/>
            <a:pathLst>
              <a:path w="313056" h="3089784">
                <a:moveTo>
                  <a:pt x="156465" y="0"/>
                </a:moveTo>
                <a:lnTo>
                  <a:pt x="313056" y="0"/>
                </a:lnTo>
                <a:lnTo>
                  <a:pt x="313056" y="3089784"/>
                </a:lnTo>
                <a:lnTo>
                  <a:pt x="0" y="3089784"/>
                </a:lnTo>
                <a:lnTo>
                  <a:pt x="0" y="0"/>
                </a:lnTo>
                <a:lnTo>
                  <a:pt x="156465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4" name="Freeform 134"/>
          <p:cNvSpPr/>
          <p:nvPr/>
        </p:nvSpPr>
        <p:spPr>
          <a:xfrm>
            <a:off x="2501590" y="2075177"/>
            <a:ext cx="242004" cy="2061944"/>
          </a:xfrm>
          <a:custGeom>
            <a:avLst/>
            <a:gdLst/>
            <a:ahLst/>
            <a:cxnLst/>
            <a:rect l="0" t="0" r="0" b="0"/>
            <a:pathLst>
              <a:path w="313182" h="2668398">
                <a:moveTo>
                  <a:pt x="156591" y="0"/>
                </a:moveTo>
                <a:lnTo>
                  <a:pt x="313182" y="0"/>
                </a:lnTo>
                <a:lnTo>
                  <a:pt x="313182" y="2668398"/>
                </a:lnTo>
                <a:lnTo>
                  <a:pt x="0" y="2668398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solidFill>
            <a:srgbClr val="D05B5B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5" name="Freeform 135"/>
          <p:cNvSpPr/>
          <p:nvPr/>
        </p:nvSpPr>
        <p:spPr>
          <a:xfrm>
            <a:off x="2501590" y="2075177"/>
            <a:ext cx="242004" cy="2061944"/>
          </a:xfrm>
          <a:custGeom>
            <a:avLst/>
            <a:gdLst/>
            <a:ahLst/>
            <a:cxnLst/>
            <a:rect l="0" t="0" r="0" b="0"/>
            <a:pathLst>
              <a:path w="313182" h="2668398">
                <a:moveTo>
                  <a:pt x="156591" y="0"/>
                </a:moveTo>
                <a:lnTo>
                  <a:pt x="313182" y="0"/>
                </a:lnTo>
                <a:lnTo>
                  <a:pt x="313182" y="2668398"/>
                </a:lnTo>
                <a:lnTo>
                  <a:pt x="0" y="2668398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6" name="Freeform 136"/>
          <p:cNvSpPr/>
          <p:nvPr/>
        </p:nvSpPr>
        <p:spPr>
          <a:xfrm>
            <a:off x="2743595" y="1424043"/>
            <a:ext cx="241906" cy="2713078"/>
          </a:xfrm>
          <a:custGeom>
            <a:avLst/>
            <a:gdLst/>
            <a:ahLst/>
            <a:cxnLst/>
            <a:rect l="0" t="0" r="0" b="0"/>
            <a:pathLst>
              <a:path w="313055" h="3511042">
                <a:moveTo>
                  <a:pt x="156590" y="0"/>
                </a:moveTo>
                <a:lnTo>
                  <a:pt x="313055" y="0"/>
                </a:lnTo>
                <a:lnTo>
                  <a:pt x="313055" y="3511042"/>
                </a:lnTo>
                <a:lnTo>
                  <a:pt x="0" y="3511042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D05B5B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7" name="Freeform 137"/>
          <p:cNvSpPr/>
          <p:nvPr/>
        </p:nvSpPr>
        <p:spPr>
          <a:xfrm>
            <a:off x="2743595" y="1424043"/>
            <a:ext cx="241906" cy="2713078"/>
          </a:xfrm>
          <a:custGeom>
            <a:avLst/>
            <a:gdLst/>
            <a:ahLst/>
            <a:cxnLst/>
            <a:rect l="0" t="0" r="0" b="0"/>
            <a:pathLst>
              <a:path w="313055" h="3511042">
                <a:moveTo>
                  <a:pt x="156590" y="0"/>
                </a:moveTo>
                <a:lnTo>
                  <a:pt x="313055" y="0"/>
                </a:lnTo>
                <a:lnTo>
                  <a:pt x="313055" y="3511042"/>
                </a:lnTo>
                <a:lnTo>
                  <a:pt x="0" y="3511042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8" name="Freeform 138"/>
          <p:cNvSpPr/>
          <p:nvPr/>
        </p:nvSpPr>
        <p:spPr>
          <a:xfrm>
            <a:off x="2985501" y="3268909"/>
            <a:ext cx="242004" cy="868212"/>
          </a:xfrm>
          <a:custGeom>
            <a:avLst/>
            <a:gdLst/>
            <a:ahLst/>
            <a:cxnLst/>
            <a:rect l="0" t="0" r="0" b="0"/>
            <a:pathLst>
              <a:path w="313182" h="1123569">
                <a:moveTo>
                  <a:pt x="156590" y="0"/>
                </a:moveTo>
                <a:lnTo>
                  <a:pt x="313182" y="0"/>
                </a:lnTo>
                <a:lnTo>
                  <a:pt x="313182" y="1123569"/>
                </a:lnTo>
                <a:lnTo>
                  <a:pt x="0" y="1123569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D05B5B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9" name="Freeform 139"/>
          <p:cNvSpPr/>
          <p:nvPr/>
        </p:nvSpPr>
        <p:spPr>
          <a:xfrm>
            <a:off x="2985501" y="3268909"/>
            <a:ext cx="242004" cy="868212"/>
          </a:xfrm>
          <a:custGeom>
            <a:avLst/>
            <a:gdLst/>
            <a:ahLst/>
            <a:cxnLst/>
            <a:rect l="0" t="0" r="0" b="0"/>
            <a:pathLst>
              <a:path w="313182" h="1123569">
                <a:moveTo>
                  <a:pt x="156590" y="0"/>
                </a:moveTo>
                <a:lnTo>
                  <a:pt x="313182" y="0"/>
                </a:lnTo>
                <a:lnTo>
                  <a:pt x="313182" y="1123569"/>
                </a:lnTo>
                <a:lnTo>
                  <a:pt x="0" y="1123569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0" name="Freeform 140"/>
          <p:cNvSpPr/>
          <p:nvPr/>
        </p:nvSpPr>
        <p:spPr>
          <a:xfrm>
            <a:off x="3227505" y="3485985"/>
            <a:ext cx="242004" cy="651136"/>
          </a:xfrm>
          <a:custGeom>
            <a:avLst/>
            <a:gdLst/>
            <a:ahLst/>
            <a:cxnLst/>
            <a:rect l="0" t="0" r="0" b="0"/>
            <a:pathLst>
              <a:path w="313182" h="842646">
                <a:moveTo>
                  <a:pt x="156590" y="0"/>
                </a:moveTo>
                <a:lnTo>
                  <a:pt x="313182" y="0"/>
                </a:lnTo>
                <a:lnTo>
                  <a:pt x="313182" y="842646"/>
                </a:lnTo>
                <a:lnTo>
                  <a:pt x="0" y="842646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D05B5B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1" name="Freeform 141"/>
          <p:cNvSpPr/>
          <p:nvPr/>
        </p:nvSpPr>
        <p:spPr>
          <a:xfrm>
            <a:off x="3227505" y="3485985"/>
            <a:ext cx="242004" cy="651136"/>
          </a:xfrm>
          <a:custGeom>
            <a:avLst/>
            <a:gdLst/>
            <a:ahLst/>
            <a:cxnLst/>
            <a:rect l="0" t="0" r="0" b="0"/>
            <a:pathLst>
              <a:path w="313182" h="842646">
                <a:moveTo>
                  <a:pt x="156590" y="0"/>
                </a:moveTo>
                <a:lnTo>
                  <a:pt x="313182" y="0"/>
                </a:lnTo>
                <a:lnTo>
                  <a:pt x="313182" y="842646"/>
                </a:lnTo>
                <a:lnTo>
                  <a:pt x="0" y="842646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2" name="Freeform 142"/>
          <p:cNvSpPr/>
          <p:nvPr/>
        </p:nvSpPr>
        <p:spPr>
          <a:xfrm>
            <a:off x="3469510" y="4028582"/>
            <a:ext cx="241906" cy="108539"/>
          </a:xfrm>
          <a:custGeom>
            <a:avLst/>
            <a:gdLst/>
            <a:ahLst/>
            <a:cxnLst/>
            <a:rect l="0" t="0" r="0" b="0"/>
            <a:pathLst>
              <a:path w="313055" h="140462">
                <a:moveTo>
                  <a:pt x="156464" y="0"/>
                </a:moveTo>
                <a:lnTo>
                  <a:pt x="313055" y="0"/>
                </a:lnTo>
                <a:lnTo>
                  <a:pt x="313055" y="140462"/>
                </a:lnTo>
                <a:lnTo>
                  <a:pt x="0" y="140462"/>
                </a:lnTo>
                <a:lnTo>
                  <a:pt x="0" y="0"/>
                </a:lnTo>
                <a:lnTo>
                  <a:pt x="156464" y="0"/>
                </a:lnTo>
              </a:path>
            </a:pathLst>
          </a:custGeom>
          <a:solidFill>
            <a:srgbClr val="D05B5B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3" name="Freeform 143"/>
          <p:cNvSpPr/>
          <p:nvPr/>
        </p:nvSpPr>
        <p:spPr>
          <a:xfrm>
            <a:off x="3469510" y="4028582"/>
            <a:ext cx="241906" cy="108539"/>
          </a:xfrm>
          <a:custGeom>
            <a:avLst/>
            <a:gdLst/>
            <a:ahLst/>
            <a:cxnLst/>
            <a:rect l="0" t="0" r="0" b="0"/>
            <a:pathLst>
              <a:path w="313055" h="140462">
                <a:moveTo>
                  <a:pt x="156464" y="0"/>
                </a:moveTo>
                <a:lnTo>
                  <a:pt x="313055" y="0"/>
                </a:lnTo>
                <a:lnTo>
                  <a:pt x="313055" y="140462"/>
                </a:lnTo>
                <a:lnTo>
                  <a:pt x="0" y="140462"/>
                </a:lnTo>
                <a:lnTo>
                  <a:pt x="0" y="0"/>
                </a:lnTo>
                <a:lnTo>
                  <a:pt x="156464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4" name="Freeform 144"/>
          <p:cNvSpPr/>
          <p:nvPr/>
        </p:nvSpPr>
        <p:spPr>
          <a:xfrm>
            <a:off x="3711416" y="4028582"/>
            <a:ext cx="242004" cy="108539"/>
          </a:xfrm>
          <a:custGeom>
            <a:avLst/>
            <a:gdLst/>
            <a:ahLst/>
            <a:cxnLst/>
            <a:rect l="0" t="0" r="0" b="0"/>
            <a:pathLst>
              <a:path w="313182" h="140462">
                <a:moveTo>
                  <a:pt x="156590" y="0"/>
                </a:moveTo>
                <a:lnTo>
                  <a:pt x="313182" y="0"/>
                </a:lnTo>
                <a:lnTo>
                  <a:pt x="313182" y="140462"/>
                </a:lnTo>
                <a:lnTo>
                  <a:pt x="0" y="140462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D05B5B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5" name="Freeform 145"/>
          <p:cNvSpPr/>
          <p:nvPr/>
        </p:nvSpPr>
        <p:spPr>
          <a:xfrm>
            <a:off x="3711416" y="4028582"/>
            <a:ext cx="242004" cy="108539"/>
          </a:xfrm>
          <a:custGeom>
            <a:avLst/>
            <a:gdLst/>
            <a:ahLst/>
            <a:cxnLst/>
            <a:rect l="0" t="0" r="0" b="0"/>
            <a:pathLst>
              <a:path w="313182" h="140462">
                <a:moveTo>
                  <a:pt x="156590" y="0"/>
                </a:moveTo>
                <a:lnTo>
                  <a:pt x="313182" y="0"/>
                </a:lnTo>
                <a:lnTo>
                  <a:pt x="313182" y="140462"/>
                </a:lnTo>
                <a:lnTo>
                  <a:pt x="0" y="140462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6" name="Freeform 146"/>
          <p:cNvSpPr/>
          <p:nvPr/>
        </p:nvSpPr>
        <p:spPr>
          <a:xfrm>
            <a:off x="3953420" y="4137121"/>
            <a:ext cx="241905" cy="0"/>
          </a:xfrm>
          <a:custGeom>
            <a:avLst/>
            <a:gdLst/>
            <a:ahLst/>
            <a:cxnLst/>
            <a:rect l="0" t="0" r="0" b="0"/>
            <a:pathLst>
              <a:path w="313054">
                <a:moveTo>
                  <a:pt x="0" y="0"/>
                </a:moveTo>
                <a:lnTo>
                  <a:pt x="313054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7" name="Freeform 147"/>
          <p:cNvSpPr/>
          <p:nvPr/>
        </p:nvSpPr>
        <p:spPr>
          <a:xfrm>
            <a:off x="4195326" y="4137121"/>
            <a:ext cx="242005" cy="0"/>
          </a:xfrm>
          <a:custGeom>
            <a:avLst/>
            <a:gdLst/>
            <a:ahLst/>
            <a:cxnLst/>
            <a:rect l="0" t="0" r="0" b="0"/>
            <a:pathLst>
              <a:path w="313183">
                <a:moveTo>
                  <a:pt x="0" y="0"/>
                </a:moveTo>
                <a:lnTo>
                  <a:pt x="313183" y="0"/>
                </a:lnTo>
              </a:path>
            </a:pathLst>
          </a:custGeom>
          <a:noFill/>
          <a:ln w="12191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8" name="Freeform 148"/>
          <p:cNvSpPr/>
          <p:nvPr/>
        </p:nvSpPr>
        <p:spPr>
          <a:xfrm>
            <a:off x="1291765" y="4137121"/>
            <a:ext cx="242004" cy="0"/>
          </a:xfrm>
          <a:custGeom>
            <a:avLst/>
            <a:gdLst/>
            <a:ahLst/>
            <a:cxnLst/>
            <a:rect l="0" t="0" r="0" b="0"/>
            <a:pathLst>
              <a:path w="313181">
                <a:moveTo>
                  <a:pt x="0" y="0"/>
                </a:moveTo>
                <a:lnTo>
                  <a:pt x="313181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9" name="Freeform 149"/>
          <p:cNvSpPr/>
          <p:nvPr/>
        </p:nvSpPr>
        <p:spPr>
          <a:xfrm>
            <a:off x="1533769" y="4137121"/>
            <a:ext cx="241907" cy="0"/>
          </a:xfrm>
          <a:custGeom>
            <a:avLst/>
            <a:gdLst/>
            <a:ahLst/>
            <a:cxnLst/>
            <a:rect l="0" t="0" r="0" b="0"/>
            <a:pathLst>
              <a:path w="313056">
                <a:moveTo>
                  <a:pt x="0" y="0"/>
                </a:moveTo>
                <a:lnTo>
                  <a:pt x="313056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0" name="Freeform 150"/>
          <p:cNvSpPr/>
          <p:nvPr/>
        </p:nvSpPr>
        <p:spPr>
          <a:xfrm>
            <a:off x="1775676" y="4137121"/>
            <a:ext cx="242004" cy="0"/>
          </a:xfrm>
          <a:custGeom>
            <a:avLst/>
            <a:gdLst/>
            <a:ahLst/>
            <a:cxnLst/>
            <a:rect l="0" t="0" r="0" b="0"/>
            <a:pathLst>
              <a:path w="313182">
                <a:moveTo>
                  <a:pt x="0" y="0"/>
                </a:moveTo>
                <a:lnTo>
                  <a:pt x="313182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1" name="Freeform 151"/>
          <p:cNvSpPr/>
          <p:nvPr/>
        </p:nvSpPr>
        <p:spPr>
          <a:xfrm>
            <a:off x="2017680" y="3981379"/>
            <a:ext cx="242004" cy="155742"/>
          </a:xfrm>
          <a:custGeom>
            <a:avLst/>
            <a:gdLst/>
            <a:ahLst/>
            <a:cxnLst/>
            <a:rect l="0" t="0" r="0" b="0"/>
            <a:pathLst>
              <a:path w="313181" h="201549">
                <a:moveTo>
                  <a:pt x="156591" y="0"/>
                </a:moveTo>
                <a:lnTo>
                  <a:pt x="313181" y="0"/>
                </a:lnTo>
                <a:lnTo>
                  <a:pt x="313181" y="201549"/>
                </a:lnTo>
                <a:lnTo>
                  <a:pt x="0" y="201549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solidFill>
            <a:srgbClr val="66A5A0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2" name="Freeform 152"/>
          <p:cNvSpPr/>
          <p:nvPr/>
        </p:nvSpPr>
        <p:spPr>
          <a:xfrm>
            <a:off x="2017680" y="3981379"/>
            <a:ext cx="242004" cy="155742"/>
          </a:xfrm>
          <a:custGeom>
            <a:avLst/>
            <a:gdLst/>
            <a:ahLst/>
            <a:cxnLst/>
            <a:rect l="0" t="0" r="0" b="0"/>
            <a:pathLst>
              <a:path w="313181" h="201549">
                <a:moveTo>
                  <a:pt x="156591" y="0"/>
                </a:moveTo>
                <a:lnTo>
                  <a:pt x="313181" y="0"/>
                </a:lnTo>
                <a:lnTo>
                  <a:pt x="313181" y="201549"/>
                </a:lnTo>
                <a:lnTo>
                  <a:pt x="0" y="201549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3" name="Freeform 153"/>
          <p:cNvSpPr/>
          <p:nvPr/>
        </p:nvSpPr>
        <p:spPr>
          <a:xfrm>
            <a:off x="2259683" y="3747716"/>
            <a:ext cx="241907" cy="389405"/>
          </a:xfrm>
          <a:custGeom>
            <a:avLst/>
            <a:gdLst/>
            <a:ahLst/>
            <a:cxnLst/>
            <a:rect l="0" t="0" r="0" b="0"/>
            <a:pathLst>
              <a:path w="313056" h="503936">
                <a:moveTo>
                  <a:pt x="156465" y="0"/>
                </a:moveTo>
                <a:lnTo>
                  <a:pt x="313056" y="0"/>
                </a:lnTo>
                <a:lnTo>
                  <a:pt x="313056" y="503936"/>
                </a:lnTo>
                <a:lnTo>
                  <a:pt x="0" y="503936"/>
                </a:lnTo>
                <a:lnTo>
                  <a:pt x="0" y="0"/>
                </a:lnTo>
                <a:lnTo>
                  <a:pt x="156465" y="0"/>
                </a:lnTo>
              </a:path>
            </a:pathLst>
          </a:custGeom>
          <a:solidFill>
            <a:srgbClr val="66A5A0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4" name="Freeform 154"/>
          <p:cNvSpPr/>
          <p:nvPr/>
        </p:nvSpPr>
        <p:spPr>
          <a:xfrm>
            <a:off x="2259683" y="3747716"/>
            <a:ext cx="241907" cy="389405"/>
          </a:xfrm>
          <a:custGeom>
            <a:avLst/>
            <a:gdLst/>
            <a:ahLst/>
            <a:cxnLst/>
            <a:rect l="0" t="0" r="0" b="0"/>
            <a:pathLst>
              <a:path w="313056" h="503936">
                <a:moveTo>
                  <a:pt x="156465" y="0"/>
                </a:moveTo>
                <a:lnTo>
                  <a:pt x="313056" y="0"/>
                </a:lnTo>
                <a:lnTo>
                  <a:pt x="313056" y="503936"/>
                </a:lnTo>
                <a:lnTo>
                  <a:pt x="0" y="503936"/>
                </a:lnTo>
                <a:lnTo>
                  <a:pt x="0" y="0"/>
                </a:lnTo>
                <a:lnTo>
                  <a:pt x="156465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5" name="Freeform 155"/>
          <p:cNvSpPr/>
          <p:nvPr/>
        </p:nvSpPr>
        <p:spPr>
          <a:xfrm>
            <a:off x="2501590" y="3124549"/>
            <a:ext cx="242004" cy="1012572"/>
          </a:xfrm>
          <a:custGeom>
            <a:avLst/>
            <a:gdLst/>
            <a:ahLst/>
            <a:cxnLst/>
            <a:rect l="0" t="0" r="0" b="0"/>
            <a:pathLst>
              <a:path w="313182" h="1310387">
                <a:moveTo>
                  <a:pt x="156591" y="0"/>
                </a:moveTo>
                <a:lnTo>
                  <a:pt x="313182" y="0"/>
                </a:lnTo>
                <a:lnTo>
                  <a:pt x="313182" y="1310387"/>
                </a:lnTo>
                <a:lnTo>
                  <a:pt x="0" y="1310387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solidFill>
            <a:srgbClr val="66A5A0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6" name="Freeform 156"/>
          <p:cNvSpPr/>
          <p:nvPr/>
        </p:nvSpPr>
        <p:spPr>
          <a:xfrm>
            <a:off x="2501590" y="3124549"/>
            <a:ext cx="242004" cy="1012572"/>
          </a:xfrm>
          <a:custGeom>
            <a:avLst/>
            <a:gdLst/>
            <a:ahLst/>
            <a:cxnLst/>
            <a:rect l="0" t="0" r="0" b="0"/>
            <a:pathLst>
              <a:path w="313182" h="1310387">
                <a:moveTo>
                  <a:pt x="156591" y="0"/>
                </a:moveTo>
                <a:lnTo>
                  <a:pt x="313182" y="0"/>
                </a:lnTo>
                <a:lnTo>
                  <a:pt x="313182" y="1310387"/>
                </a:lnTo>
                <a:lnTo>
                  <a:pt x="0" y="1310387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7" name="Freeform 157"/>
          <p:cNvSpPr/>
          <p:nvPr/>
        </p:nvSpPr>
        <p:spPr>
          <a:xfrm>
            <a:off x="2743595" y="1878217"/>
            <a:ext cx="241906" cy="2258904"/>
          </a:xfrm>
          <a:custGeom>
            <a:avLst/>
            <a:gdLst/>
            <a:ahLst/>
            <a:cxnLst/>
            <a:rect l="0" t="0" r="0" b="0"/>
            <a:pathLst>
              <a:path w="313055" h="2923287">
                <a:moveTo>
                  <a:pt x="156590" y="0"/>
                </a:moveTo>
                <a:lnTo>
                  <a:pt x="313055" y="0"/>
                </a:lnTo>
                <a:lnTo>
                  <a:pt x="313055" y="2923287"/>
                </a:lnTo>
                <a:lnTo>
                  <a:pt x="0" y="2923287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66A5A0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8" name="Freeform 158"/>
          <p:cNvSpPr/>
          <p:nvPr/>
        </p:nvSpPr>
        <p:spPr>
          <a:xfrm>
            <a:off x="2743595" y="1878217"/>
            <a:ext cx="241906" cy="2258904"/>
          </a:xfrm>
          <a:custGeom>
            <a:avLst/>
            <a:gdLst/>
            <a:ahLst/>
            <a:cxnLst/>
            <a:rect l="0" t="0" r="0" b="0"/>
            <a:pathLst>
              <a:path w="313055" h="2923287">
                <a:moveTo>
                  <a:pt x="156590" y="0"/>
                </a:moveTo>
                <a:lnTo>
                  <a:pt x="313055" y="0"/>
                </a:lnTo>
                <a:lnTo>
                  <a:pt x="313055" y="2923287"/>
                </a:lnTo>
                <a:lnTo>
                  <a:pt x="0" y="2923287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9" name="Freeform 159"/>
          <p:cNvSpPr/>
          <p:nvPr/>
        </p:nvSpPr>
        <p:spPr>
          <a:xfrm>
            <a:off x="2985501" y="1722475"/>
            <a:ext cx="242004" cy="2414646"/>
          </a:xfrm>
          <a:custGeom>
            <a:avLst/>
            <a:gdLst/>
            <a:ahLst/>
            <a:cxnLst/>
            <a:rect l="0" t="0" r="0" b="0"/>
            <a:pathLst>
              <a:path w="313182" h="3124836">
                <a:moveTo>
                  <a:pt x="156590" y="0"/>
                </a:moveTo>
                <a:lnTo>
                  <a:pt x="313182" y="0"/>
                </a:lnTo>
                <a:lnTo>
                  <a:pt x="313182" y="3124836"/>
                </a:lnTo>
                <a:lnTo>
                  <a:pt x="0" y="3124836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66A5A0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0" name="Freeform 160"/>
          <p:cNvSpPr/>
          <p:nvPr/>
        </p:nvSpPr>
        <p:spPr>
          <a:xfrm>
            <a:off x="2985501" y="1722475"/>
            <a:ext cx="242004" cy="2414646"/>
          </a:xfrm>
          <a:custGeom>
            <a:avLst/>
            <a:gdLst/>
            <a:ahLst/>
            <a:cxnLst/>
            <a:rect l="0" t="0" r="0" b="0"/>
            <a:pathLst>
              <a:path w="313182" h="3124836">
                <a:moveTo>
                  <a:pt x="156590" y="0"/>
                </a:moveTo>
                <a:lnTo>
                  <a:pt x="313182" y="0"/>
                </a:lnTo>
                <a:lnTo>
                  <a:pt x="313182" y="3124836"/>
                </a:lnTo>
                <a:lnTo>
                  <a:pt x="0" y="3124836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1" name="Freeform 161"/>
          <p:cNvSpPr/>
          <p:nvPr/>
        </p:nvSpPr>
        <p:spPr>
          <a:xfrm>
            <a:off x="3227505" y="2812966"/>
            <a:ext cx="242004" cy="1324155"/>
          </a:xfrm>
          <a:custGeom>
            <a:avLst/>
            <a:gdLst/>
            <a:ahLst/>
            <a:cxnLst/>
            <a:rect l="0" t="0" r="0" b="0"/>
            <a:pathLst>
              <a:path w="313182" h="1713612">
                <a:moveTo>
                  <a:pt x="156590" y="0"/>
                </a:moveTo>
                <a:lnTo>
                  <a:pt x="313182" y="0"/>
                </a:lnTo>
                <a:lnTo>
                  <a:pt x="313182" y="1713612"/>
                </a:lnTo>
                <a:lnTo>
                  <a:pt x="0" y="1713612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66A5A0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2" name="Freeform 162"/>
          <p:cNvSpPr/>
          <p:nvPr/>
        </p:nvSpPr>
        <p:spPr>
          <a:xfrm>
            <a:off x="3227505" y="2812966"/>
            <a:ext cx="242004" cy="1324155"/>
          </a:xfrm>
          <a:custGeom>
            <a:avLst/>
            <a:gdLst/>
            <a:ahLst/>
            <a:cxnLst/>
            <a:rect l="0" t="0" r="0" b="0"/>
            <a:pathLst>
              <a:path w="313182" h="1713612">
                <a:moveTo>
                  <a:pt x="156590" y="0"/>
                </a:moveTo>
                <a:lnTo>
                  <a:pt x="313182" y="0"/>
                </a:lnTo>
                <a:lnTo>
                  <a:pt x="313182" y="1713612"/>
                </a:lnTo>
                <a:lnTo>
                  <a:pt x="0" y="1713612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3" name="Freeform 163"/>
          <p:cNvSpPr/>
          <p:nvPr/>
        </p:nvSpPr>
        <p:spPr>
          <a:xfrm>
            <a:off x="3469510" y="3046629"/>
            <a:ext cx="241906" cy="1090492"/>
          </a:xfrm>
          <a:custGeom>
            <a:avLst/>
            <a:gdLst/>
            <a:ahLst/>
            <a:cxnLst/>
            <a:rect l="0" t="0" r="0" b="0"/>
            <a:pathLst>
              <a:path w="313055" h="1411225">
                <a:moveTo>
                  <a:pt x="156464" y="0"/>
                </a:moveTo>
                <a:lnTo>
                  <a:pt x="313055" y="0"/>
                </a:lnTo>
                <a:lnTo>
                  <a:pt x="313055" y="1411225"/>
                </a:lnTo>
                <a:lnTo>
                  <a:pt x="0" y="1411225"/>
                </a:lnTo>
                <a:lnTo>
                  <a:pt x="0" y="0"/>
                </a:lnTo>
                <a:lnTo>
                  <a:pt x="156464" y="0"/>
                </a:lnTo>
              </a:path>
            </a:pathLst>
          </a:custGeom>
          <a:solidFill>
            <a:srgbClr val="66A5A0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4" name="Freeform 164"/>
          <p:cNvSpPr/>
          <p:nvPr/>
        </p:nvSpPr>
        <p:spPr>
          <a:xfrm>
            <a:off x="3469510" y="3046629"/>
            <a:ext cx="241906" cy="1090492"/>
          </a:xfrm>
          <a:custGeom>
            <a:avLst/>
            <a:gdLst/>
            <a:ahLst/>
            <a:cxnLst/>
            <a:rect l="0" t="0" r="0" b="0"/>
            <a:pathLst>
              <a:path w="313055" h="1411225">
                <a:moveTo>
                  <a:pt x="156464" y="0"/>
                </a:moveTo>
                <a:lnTo>
                  <a:pt x="313055" y="0"/>
                </a:lnTo>
                <a:lnTo>
                  <a:pt x="313055" y="1411225"/>
                </a:lnTo>
                <a:lnTo>
                  <a:pt x="0" y="1411225"/>
                </a:lnTo>
                <a:lnTo>
                  <a:pt x="0" y="0"/>
                </a:lnTo>
                <a:lnTo>
                  <a:pt x="156464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5" name="Freeform 165"/>
          <p:cNvSpPr/>
          <p:nvPr/>
        </p:nvSpPr>
        <p:spPr>
          <a:xfrm>
            <a:off x="3711416" y="3591875"/>
            <a:ext cx="242004" cy="545246"/>
          </a:xfrm>
          <a:custGeom>
            <a:avLst/>
            <a:gdLst/>
            <a:ahLst/>
            <a:cxnLst/>
            <a:rect l="0" t="0" r="0" b="0"/>
            <a:pathLst>
              <a:path w="313182" h="705612">
                <a:moveTo>
                  <a:pt x="156590" y="0"/>
                </a:moveTo>
                <a:lnTo>
                  <a:pt x="313182" y="0"/>
                </a:lnTo>
                <a:lnTo>
                  <a:pt x="313182" y="705612"/>
                </a:lnTo>
                <a:lnTo>
                  <a:pt x="0" y="705612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66A5A0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6" name="Freeform 166"/>
          <p:cNvSpPr/>
          <p:nvPr/>
        </p:nvSpPr>
        <p:spPr>
          <a:xfrm>
            <a:off x="3711416" y="3591875"/>
            <a:ext cx="242004" cy="545246"/>
          </a:xfrm>
          <a:custGeom>
            <a:avLst/>
            <a:gdLst/>
            <a:ahLst/>
            <a:cxnLst/>
            <a:rect l="0" t="0" r="0" b="0"/>
            <a:pathLst>
              <a:path w="313182" h="705612">
                <a:moveTo>
                  <a:pt x="156590" y="0"/>
                </a:moveTo>
                <a:lnTo>
                  <a:pt x="313182" y="0"/>
                </a:lnTo>
                <a:lnTo>
                  <a:pt x="313182" y="705612"/>
                </a:lnTo>
                <a:lnTo>
                  <a:pt x="0" y="705612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7" name="Freeform 167"/>
          <p:cNvSpPr/>
          <p:nvPr/>
        </p:nvSpPr>
        <p:spPr>
          <a:xfrm>
            <a:off x="3953420" y="3825538"/>
            <a:ext cx="241905" cy="311583"/>
          </a:xfrm>
          <a:custGeom>
            <a:avLst/>
            <a:gdLst/>
            <a:ahLst/>
            <a:cxnLst/>
            <a:rect l="0" t="0" r="0" b="0"/>
            <a:pathLst>
              <a:path w="313054" h="403225">
                <a:moveTo>
                  <a:pt x="156590" y="0"/>
                </a:moveTo>
                <a:lnTo>
                  <a:pt x="313054" y="0"/>
                </a:lnTo>
                <a:lnTo>
                  <a:pt x="313054" y="403225"/>
                </a:lnTo>
                <a:lnTo>
                  <a:pt x="0" y="403225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solidFill>
            <a:srgbClr val="66A5A0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8" name="Freeform 168"/>
          <p:cNvSpPr/>
          <p:nvPr/>
        </p:nvSpPr>
        <p:spPr>
          <a:xfrm>
            <a:off x="3953420" y="3825538"/>
            <a:ext cx="241905" cy="311583"/>
          </a:xfrm>
          <a:custGeom>
            <a:avLst/>
            <a:gdLst/>
            <a:ahLst/>
            <a:cxnLst/>
            <a:rect l="0" t="0" r="0" b="0"/>
            <a:pathLst>
              <a:path w="313054" h="403225">
                <a:moveTo>
                  <a:pt x="156590" y="0"/>
                </a:moveTo>
                <a:lnTo>
                  <a:pt x="313054" y="0"/>
                </a:lnTo>
                <a:lnTo>
                  <a:pt x="313054" y="403225"/>
                </a:lnTo>
                <a:lnTo>
                  <a:pt x="0" y="403225"/>
                </a:lnTo>
                <a:lnTo>
                  <a:pt x="0" y="0"/>
                </a:lnTo>
                <a:lnTo>
                  <a:pt x="156590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9" name="Freeform 169"/>
          <p:cNvSpPr/>
          <p:nvPr/>
        </p:nvSpPr>
        <p:spPr>
          <a:xfrm>
            <a:off x="4195326" y="3981379"/>
            <a:ext cx="242005" cy="155742"/>
          </a:xfrm>
          <a:custGeom>
            <a:avLst/>
            <a:gdLst/>
            <a:ahLst/>
            <a:cxnLst/>
            <a:rect l="0" t="0" r="0" b="0"/>
            <a:pathLst>
              <a:path w="313183" h="201549">
                <a:moveTo>
                  <a:pt x="156591" y="0"/>
                </a:moveTo>
                <a:lnTo>
                  <a:pt x="313183" y="0"/>
                </a:lnTo>
                <a:lnTo>
                  <a:pt x="313183" y="201549"/>
                </a:lnTo>
                <a:lnTo>
                  <a:pt x="0" y="201549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solidFill>
            <a:srgbClr val="66A5A0">
              <a:alpha val="49799"/>
            </a:srgbClr>
          </a:solidFill>
          <a:ln w="12191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0" name="Freeform 170"/>
          <p:cNvSpPr/>
          <p:nvPr/>
        </p:nvSpPr>
        <p:spPr>
          <a:xfrm>
            <a:off x="4195326" y="3981379"/>
            <a:ext cx="242005" cy="155742"/>
          </a:xfrm>
          <a:custGeom>
            <a:avLst/>
            <a:gdLst/>
            <a:ahLst/>
            <a:cxnLst/>
            <a:rect l="0" t="0" r="0" b="0"/>
            <a:pathLst>
              <a:path w="313183" h="201549">
                <a:moveTo>
                  <a:pt x="156591" y="0"/>
                </a:moveTo>
                <a:lnTo>
                  <a:pt x="313183" y="0"/>
                </a:lnTo>
                <a:lnTo>
                  <a:pt x="313183" y="201549"/>
                </a:lnTo>
                <a:lnTo>
                  <a:pt x="0" y="201549"/>
                </a:lnTo>
                <a:lnTo>
                  <a:pt x="0" y="0"/>
                </a:lnTo>
                <a:lnTo>
                  <a:pt x="156591" y="0"/>
                </a:lnTo>
              </a:path>
            </a:pathLst>
          </a:custGeom>
          <a:noFill/>
          <a:ln w="12191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1" name="Freeform 171"/>
          <p:cNvSpPr/>
          <p:nvPr/>
        </p:nvSpPr>
        <p:spPr>
          <a:xfrm>
            <a:off x="1013549" y="1454465"/>
            <a:ext cx="2670486" cy="2681184"/>
          </a:xfrm>
          <a:custGeom>
            <a:avLst/>
            <a:gdLst/>
            <a:ahLst/>
            <a:cxnLst/>
            <a:rect l="0" t="0" r="0" b="0"/>
            <a:pathLst>
              <a:path w="3455923" h="3469768">
                <a:moveTo>
                  <a:pt x="0" y="3469768"/>
                </a:moveTo>
                <a:lnTo>
                  <a:pt x="20828" y="3469006"/>
                </a:lnTo>
                <a:lnTo>
                  <a:pt x="41656" y="3467989"/>
                </a:lnTo>
                <a:lnTo>
                  <a:pt x="62483" y="3466846"/>
                </a:lnTo>
                <a:lnTo>
                  <a:pt x="83311" y="3465195"/>
                </a:lnTo>
                <a:lnTo>
                  <a:pt x="104013" y="3463290"/>
                </a:lnTo>
                <a:lnTo>
                  <a:pt x="124840" y="3461005"/>
                </a:lnTo>
                <a:lnTo>
                  <a:pt x="145668" y="3458337"/>
                </a:lnTo>
                <a:lnTo>
                  <a:pt x="166496" y="3455289"/>
                </a:lnTo>
                <a:lnTo>
                  <a:pt x="187324" y="3451861"/>
                </a:lnTo>
                <a:lnTo>
                  <a:pt x="208152" y="3448050"/>
                </a:lnTo>
                <a:lnTo>
                  <a:pt x="228980" y="3443987"/>
                </a:lnTo>
                <a:lnTo>
                  <a:pt x="270637" y="3435350"/>
                </a:lnTo>
                <a:lnTo>
                  <a:pt x="333121" y="3422143"/>
                </a:lnTo>
                <a:lnTo>
                  <a:pt x="395477" y="3409315"/>
                </a:lnTo>
                <a:lnTo>
                  <a:pt x="416305" y="3404617"/>
                </a:lnTo>
                <a:lnTo>
                  <a:pt x="437134" y="3399537"/>
                </a:lnTo>
                <a:lnTo>
                  <a:pt x="457962" y="3393440"/>
                </a:lnTo>
                <a:lnTo>
                  <a:pt x="478790" y="3386075"/>
                </a:lnTo>
                <a:lnTo>
                  <a:pt x="499618" y="3376931"/>
                </a:lnTo>
                <a:lnTo>
                  <a:pt x="520446" y="3365755"/>
                </a:lnTo>
                <a:lnTo>
                  <a:pt x="541274" y="3351657"/>
                </a:lnTo>
                <a:lnTo>
                  <a:pt x="562101" y="3334386"/>
                </a:lnTo>
                <a:lnTo>
                  <a:pt x="582929" y="3313431"/>
                </a:lnTo>
                <a:lnTo>
                  <a:pt x="603757" y="3288285"/>
                </a:lnTo>
                <a:lnTo>
                  <a:pt x="624585" y="3258694"/>
                </a:lnTo>
                <a:lnTo>
                  <a:pt x="645413" y="3224150"/>
                </a:lnTo>
                <a:lnTo>
                  <a:pt x="666241" y="3184525"/>
                </a:lnTo>
                <a:lnTo>
                  <a:pt x="687070" y="3139949"/>
                </a:lnTo>
                <a:lnTo>
                  <a:pt x="707771" y="3090164"/>
                </a:lnTo>
                <a:lnTo>
                  <a:pt x="728599" y="3035555"/>
                </a:lnTo>
                <a:lnTo>
                  <a:pt x="749426" y="2976245"/>
                </a:lnTo>
                <a:lnTo>
                  <a:pt x="770254" y="2912619"/>
                </a:lnTo>
                <a:lnTo>
                  <a:pt x="791082" y="2845308"/>
                </a:lnTo>
                <a:lnTo>
                  <a:pt x="811910" y="2774696"/>
                </a:lnTo>
                <a:lnTo>
                  <a:pt x="853566" y="2626360"/>
                </a:lnTo>
                <a:lnTo>
                  <a:pt x="1061720" y="1870964"/>
                </a:lnTo>
                <a:lnTo>
                  <a:pt x="1103376" y="1723263"/>
                </a:lnTo>
                <a:lnTo>
                  <a:pt x="1124204" y="1646936"/>
                </a:lnTo>
                <a:lnTo>
                  <a:pt x="1145032" y="1567943"/>
                </a:lnTo>
                <a:lnTo>
                  <a:pt x="1165860" y="1485393"/>
                </a:lnTo>
                <a:lnTo>
                  <a:pt x="1186688" y="1398779"/>
                </a:lnTo>
                <a:lnTo>
                  <a:pt x="1207515" y="1307338"/>
                </a:lnTo>
                <a:lnTo>
                  <a:pt x="1228343" y="1211326"/>
                </a:lnTo>
                <a:lnTo>
                  <a:pt x="1249171" y="1110615"/>
                </a:lnTo>
                <a:lnTo>
                  <a:pt x="1290827" y="898525"/>
                </a:lnTo>
                <a:lnTo>
                  <a:pt x="1353185" y="573786"/>
                </a:lnTo>
                <a:lnTo>
                  <a:pt x="1374013" y="471297"/>
                </a:lnTo>
                <a:lnTo>
                  <a:pt x="1394840" y="375159"/>
                </a:lnTo>
                <a:lnTo>
                  <a:pt x="1415668" y="287401"/>
                </a:lnTo>
                <a:lnTo>
                  <a:pt x="1436496" y="209805"/>
                </a:lnTo>
                <a:lnTo>
                  <a:pt x="1457324" y="143510"/>
                </a:lnTo>
                <a:lnTo>
                  <a:pt x="1478152" y="89535"/>
                </a:lnTo>
                <a:lnTo>
                  <a:pt x="1498980" y="48514"/>
                </a:lnTo>
                <a:lnTo>
                  <a:pt x="1519808" y="20321"/>
                </a:lnTo>
                <a:lnTo>
                  <a:pt x="1540636" y="4319"/>
                </a:lnTo>
                <a:lnTo>
                  <a:pt x="1561464" y="0"/>
                </a:lnTo>
                <a:lnTo>
                  <a:pt x="1582292" y="5843"/>
                </a:lnTo>
                <a:lnTo>
                  <a:pt x="1602993" y="20701"/>
                </a:lnTo>
                <a:lnTo>
                  <a:pt x="1623821" y="43054"/>
                </a:lnTo>
                <a:lnTo>
                  <a:pt x="1644649" y="71501"/>
                </a:lnTo>
                <a:lnTo>
                  <a:pt x="1665477" y="104648"/>
                </a:lnTo>
                <a:lnTo>
                  <a:pt x="1686305" y="141224"/>
                </a:lnTo>
                <a:lnTo>
                  <a:pt x="1707133" y="180340"/>
                </a:lnTo>
                <a:lnTo>
                  <a:pt x="1748789" y="263018"/>
                </a:lnTo>
                <a:lnTo>
                  <a:pt x="1790445" y="349759"/>
                </a:lnTo>
                <a:lnTo>
                  <a:pt x="1811273" y="394462"/>
                </a:lnTo>
                <a:lnTo>
                  <a:pt x="1832102" y="440690"/>
                </a:lnTo>
                <a:lnTo>
                  <a:pt x="1852930" y="488570"/>
                </a:lnTo>
                <a:lnTo>
                  <a:pt x="1873758" y="538988"/>
                </a:lnTo>
                <a:lnTo>
                  <a:pt x="1894458" y="592201"/>
                </a:lnTo>
                <a:lnTo>
                  <a:pt x="1915286" y="649097"/>
                </a:lnTo>
                <a:lnTo>
                  <a:pt x="1936114" y="710311"/>
                </a:lnTo>
                <a:lnTo>
                  <a:pt x="1956942" y="776351"/>
                </a:lnTo>
                <a:lnTo>
                  <a:pt x="1977770" y="847598"/>
                </a:lnTo>
                <a:lnTo>
                  <a:pt x="1998598" y="924560"/>
                </a:lnTo>
                <a:lnTo>
                  <a:pt x="2019427" y="1007364"/>
                </a:lnTo>
                <a:lnTo>
                  <a:pt x="2040255" y="1096137"/>
                </a:lnTo>
                <a:lnTo>
                  <a:pt x="2061083" y="1190625"/>
                </a:lnTo>
                <a:lnTo>
                  <a:pt x="2081911" y="1290447"/>
                </a:lnTo>
                <a:lnTo>
                  <a:pt x="2102739" y="1395349"/>
                </a:lnTo>
                <a:lnTo>
                  <a:pt x="2123567" y="1504443"/>
                </a:lnTo>
                <a:lnTo>
                  <a:pt x="2165223" y="1732026"/>
                </a:lnTo>
                <a:lnTo>
                  <a:pt x="2248408" y="2194687"/>
                </a:lnTo>
                <a:lnTo>
                  <a:pt x="2269236" y="2305050"/>
                </a:lnTo>
                <a:lnTo>
                  <a:pt x="2290064" y="2410969"/>
                </a:lnTo>
                <a:lnTo>
                  <a:pt x="2310892" y="2511298"/>
                </a:lnTo>
                <a:lnTo>
                  <a:pt x="2331720" y="2605151"/>
                </a:lnTo>
                <a:lnTo>
                  <a:pt x="2352548" y="2691638"/>
                </a:lnTo>
                <a:lnTo>
                  <a:pt x="2373376" y="2770125"/>
                </a:lnTo>
                <a:lnTo>
                  <a:pt x="2394204" y="2840229"/>
                </a:lnTo>
                <a:lnTo>
                  <a:pt x="2415032" y="2901696"/>
                </a:lnTo>
                <a:lnTo>
                  <a:pt x="2435860" y="2954401"/>
                </a:lnTo>
                <a:lnTo>
                  <a:pt x="2456688" y="2998725"/>
                </a:lnTo>
                <a:lnTo>
                  <a:pt x="2477515" y="3035046"/>
                </a:lnTo>
                <a:lnTo>
                  <a:pt x="2498217" y="3064002"/>
                </a:lnTo>
                <a:lnTo>
                  <a:pt x="2519045" y="3086481"/>
                </a:lnTo>
                <a:lnTo>
                  <a:pt x="2539873" y="3103373"/>
                </a:lnTo>
                <a:lnTo>
                  <a:pt x="2560701" y="3115692"/>
                </a:lnTo>
                <a:lnTo>
                  <a:pt x="2581528" y="3124708"/>
                </a:lnTo>
                <a:lnTo>
                  <a:pt x="2602357" y="3131312"/>
                </a:lnTo>
                <a:lnTo>
                  <a:pt x="2623184" y="3136774"/>
                </a:lnTo>
                <a:lnTo>
                  <a:pt x="2644013" y="3141726"/>
                </a:lnTo>
                <a:lnTo>
                  <a:pt x="2664841" y="3147187"/>
                </a:lnTo>
                <a:lnTo>
                  <a:pt x="2685668" y="3153664"/>
                </a:lnTo>
                <a:lnTo>
                  <a:pt x="2706497" y="3161538"/>
                </a:lnTo>
                <a:lnTo>
                  <a:pt x="2727324" y="3170937"/>
                </a:lnTo>
                <a:lnTo>
                  <a:pt x="2748153" y="3182112"/>
                </a:lnTo>
                <a:lnTo>
                  <a:pt x="2768980" y="3194812"/>
                </a:lnTo>
                <a:lnTo>
                  <a:pt x="2789809" y="3208910"/>
                </a:lnTo>
                <a:lnTo>
                  <a:pt x="2810509" y="3223895"/>
                </a:lnTo>
                <a:lnTo>
                  <a:pt x="2914649" y="3301493"/>
                </a:lnTo>
                <a:lnTo>
                  <a:pt x="2935478" y="3315462"/>
                </a:lnTo>
                <a:lnTo>
                  <a:pt x="2956305" y="3328670"/>
                </a:lnTo>
                <a:lnTo>
                  <a:pt x="2977134" y="3340862"/>
                </a:lnTo>
                <a:lnTo>
                  <a:pt x="2997961" y="3352165"/>
                </a:lnTo>
                <a:lnTo>
                  <a:pt x="3018790" y="3362706"/>
                </a:lnTo>
                <a:lnTo>
                  <a:pt x="3039617" y="3372612"/>
                </a:lnTo>
                <a:lnTo>
                  <a:pt x="3060446" y="3381756"/>
                </a:lnTo>
                <a:lnTo>
                  <a:pt x="3081273" y="3390519"/>
                </a:lnTo>
                <a:lnTo>
                  <a:pt x="3101974" y="3398775"/>
                </a:lnTo>
                <a:lnTo>
                  <a:pt x="3122803" y="3406649"/>
                </a:lnTo>
                <a:lnTo>
                  <a:pt x="3143630" y="3414014"/>
                </a:lnTo>
                <a:lnTo>
                  <a:pt x="3164459" y="3421126"/>
                </a:lnTo>
                <a:lnTo>
                  <a:pt x="3185286" y="3427731"/>
                </a:lnTo>
                <a:lnTo>
                  <a:pt x="3206115" y="3433954"/>
                </a:lnTo>
                <a:lnTo>
                  <a:pt x="3226942" y="3439669"/>
                </a:lnTo>
                <a:lnTo>
                  <a:pt x="3247771" y="3444875"/>
                </a:lnTo>
                <a:lnTo>
                  <a:pt x="3268598" y="3449575"/>
                </a:lnTo>
                <a:lnTo>
                  <a:pt x="3289427" y="3453638"/>
                </a:lnTo>
                <a:lnTo>
                  <a:pt x="3310254" y="3457194"/>
                </a:lnTo>
                <a:lnTo>
                  <a:pt x="3331083" y="3460243"/>
                </a:lnTo>
                <a:lnTo>
                  <a:pt x="3351910" y="3462782"/>
                </a:lnTo>
                <a:lnTo>
                  <a:pt x="3372739" y="3464942"/>
                </a:lnTo>
                <a:lnTo>
                  <a:pt x="3393566" y="3466593"/>
                </a:lnTo>
                <a:lnTo>
                  <a:pt x="3414267" y="3467862"/>
                </a:lnTo>
                <a:lnTo>
                  <a:pt x="3435096" y="3468879"/>
                </a:lnTo>
                <a:lnTo>
                  <a:pt x="3455923" y="3469768"/>
                </a:lnTo>
              </a:path>
            </a:pathLst>
          </a:custGeom>
          <a:noFill/>
          <a:ln w="18288" cap="flat" cmpd="sng">
            <a:solidFill>
              <a:srgbClr val="445694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2" name="Freeform 172"/>
          <p:cNvSpPr/>
          <p:nvPr/>
        </p:nvSpPr>
        <p:spPr>
          <a:xfrm>
            <a:off x="1610807" y="1645635"/>
            <a:ext cx="2512586" cy="2488541"/>
          </a:xfrm>
          <a:custGeom>
            <a:avLst/>
            <a:gdLst/>
            <a:ahLst/>
            <a:cxnLst/>
            <a:rect l="0" t="0" r="0" b="0"/>
            <a:pathLst>
              <a:path w="3251582" h="3220465">
                <a:moveTo>
                  <a:pt x="0" y="3219577"/>
                </a:moveTo>
                <a:lnTo>
                  <a:pt x="17653" y="3218307"/>
                </a:lnTo>
                <a:lnTo>
                  <a:pt x="35306" y="3216783"/>
                </a:lnTo>
                <a:lnTo>
                  <a:pt x="52959" y="3214751"/>
                </a:lnTo>
                <a:lnTo>
                  <a:pt x="70613" y="3212465"/>
                </a:lnTo>
                <a:lnTo>
                  <a:pt x="88392" y="3209543"/>
                </a:lnTo>
                <a:lnTo>
                  <a:pt x="106045" y="3206115"/>
                </a:lnTo>
                <a:lnTo>
                  <a:pt x="123699" y="3202051"/>
                </a:lnTo>
                <a:lnTo>
                  <a:pt x="141352" y="3197224"/>
                </a:lnTo>
                <a:lnTo>
                  <a:pt x="159005" y="3191509"/>
                </a:lnTo>
                <a:lnTo>
                  <a:pt x="176658" y="3184905"/>
                </a:lnTo>
                <a:lnTo>
                  <a:pt x="194437" y="3177285"/>
                </a:lnTo>
                <a:lnTo>
                  <a:pt x="212090" y="3168396"/>
                </a:lnTo>
                <a:lnTo>
                  <a:pt x="229743" y="3158235"/>
                </a:lnTo>
                <a:lnTo>
                  <a:pt x="247396" y="3146678"/>
                </a:lnTo>
                <a:lnTo>
                  <a:pt x="265049" y="3133597"/>
                </a:lnTo>
                <a:lnTo>
                  <a:pt x="282702" y="3118865"/>
                </a:lnTo>
                <a:lnTo>
                  <a:pt x="300356" y="3102228"/>
                </a:lnTo>
                <a:lnTo>
                  <a:pt x="318136" y="3083814"/>
                </a:lnTo>
                <a:lnTo>
                  <a:pt x="335789" y="3063240"/>
                </a:lnTo>
                <a:lnTo>
                  <a:pt x="353442" y="3040507"/>
                </a:lnTo>
                <a:lnTo>
                  <a:pt x="371094" y="3015615"/>
                </a:lnTo>
                <a:lnTo>
                  <a:pt x="388747" y="2988309"/>
                </a:lnTo>
                <a:lnTo>
                  <a:pt x="406400" y="2958465"/>
                </a:lnTo>
                <a:lnTo>
                  <a:pt x="424053" y="2925953"/>
                </a:lnTo>
                <a:lnTo>
                  <a:pt x="441834" y="2890901"/>
                </a:lnTo>
                <a:lnTo>
                  <a:pt x="459487" y="2852928"/>
                </a:lnTo>
                <a:lnTo>
                  <a:pt x="477140" y="2812160"/>
                </a:lnTo>
                <a:lnTo>
                  <a:pt x="494793" y="2768472"/>
                </a:lnTo>
                <a:lnTo>
                  <a:pt x="512446" y="2721864"/>
                </a:lnTo>
                <a:lnTo>
                  <a:pt x="530099" y="2672079"/>
                </a:lnTo>
                <a:lnTo>
                  <a:pt x="547878" y="2619374"/>
                </a:lnTo>
                <a:lnTo>
                  <a:pt x="565531" y="2563622"/>
                </a:lnTo>
                <a:lnTo>
                  <a:pt x="583184" y="2504693"/>
                </a:lnTo>
                <a:lnTo>
                  <a:pt x="600837" y="2442845"/>
                </a:lnTo>
                <a:lnTo>
                  <a:pt x="618490" y="2378075"/>
                </a:lnTo>
                <a:lnTo>
                  <a:pt x="636143" y="2310511"/>
                </a:lnTo>
                <a:lnTo>
                  <a:pt x="653796" y="2240152"/>
                </a:lnTo>
                <a:lnTo>
                  <a:pt x="671577" y="2167254"/>
                </a:lnTo>
                <a:lnTo>
                  <a:pt x="706883" y="2014600"/>
                </a:lnTo>
                <a:lnTo>
                  <a:pt x="742189" y="1854708"/>
                </a:lnTo>
                <a:lnTo>
                  <a:pt x="883540" y="1204595"/>
                </a:lnTo>
                <a:lnTo>
                  <a:pt x="901319" y="1129918"/>
                </a:lnTo>
                <a:lnTo>
                  <a:pt x="918972" y="1058163"/>
                </a:lnTo>
                <a:lnTo>
                  <a:pt x="936625" y="989964"/>
                </a:lnTo>
                <a:lnTo>
                  <a:pt x="954278" y="925449"/>
                </a:lnTo>
                <a:lnTo>
                  <a:pt x="971931" y="864870"/>
                </a:lnTo>
                <a:lnTo>
                  <a:pt x="989584" y="808609"/>
                </a:lnTo>
                <a:lnTo>
                  <a:pt x="1007237" y="756538"/>
                </a:lnTo>
                <a:lnTo>
                  <a:pt x="1025018" y="708787"/>
                </a:lnTo>
                <a:lnTo>
                  <a:pt x="1042671" y="665225"/>
                </a:lnTo>
                <a:lnTo>
                  <a:pt x="1060324" y="625601"/>
                </a:lnTo>
                <a:lnTo>
                  <a:pt x="1077977" y="589787"/>
                </a:lnTo>
                <a:lnTo>
                  <a:pt x="1095630" y="557275"/>
                </a:lnTo>
                <a:lnTo>
                  <a:pt x="1113283" y="527685"/>
                </a:lnTo>
                <a:lnTo>
                  <a:pt x="1130936" y="500507"/>
                </a:lnTo>
                <a:lnTo>
                  <a:pt x="1148715" y="475361"/>
                </a:lnTo>
                <a:lnTo>
                  <a:pt x="1166368" y="451738"/>
                </a:lnTo>
                <a:lnTo>
                  <a:pt x="1201674" y="406780"/>
                </a:lnTo>
                <a:lnTo>
                  <a:pt x="1236981" y="362076"/>
                </a:lnTo>
                <a:lnTo>
                  <a:pt x="1254761" y="338962"/>
                </a:lnTo>
                <a:lnTo>
                  <a:pt x="1272414" y="315087"/>
                </a:lnTo>
                <a:lnTo>
                  <a:pt x="1290067" y="290195"/>
                </a:lnTo>
                <a:lnTo>
                  <a:pt x="1307719" y="264287"/>
                </a:lnTo>
                <a:lnTo>
                  <a:pt x="1343025" y="210185"/>
                </a:lnTo>
                <a:lnTo>
                  <a:pt x="1396112" y="127126"/>
                </a:lnTo>
                <a:lnTo>
                  <a:pt x="1413765" y="100711"/>
                </a:lnTo>
                <a:lnTo>
                  <a:pt x="1431418" y="75946"/>
                </a:lnTo>
                <a:lnTo>
                  <a:pt x="1449071" y="53339"/>
                </a:lnTo>
                <a:lnTo>
                  <a:pt x="1466724" y="33782"/>
                </a:lnTo>
                <a:lnTo>
                  <a:pt x="1484377" y="17907"/>
                </a:lnTo>
                <a:lnTo>
                  <a:pt x="1502156" y="6476"/>
                </a:lnTo>
                <a:lnTo>
                  <a:pt x="1519809" y="253"/>
                </a:lnTo>
                <a:lnTo>
                  <a:pt x="1537462" y="0"/>
                </a:lnTo>
                <a:lnTo>
                  <a:pt x="1555115" y="6223"/>
                </a:lnTo>
                <a:lnTo>
                  <a:pt x="1572768" y="19558"/>
                </a:lnTo>
                <a:lnTo>
                  <a:pt x="1590421" y="40512"/>
                </a:lnTo>
                <a:lnTo>
                  <a:pt x="1608202" y="69468"/>
                </a:lnTo>
                <a:lnTo>
                  <a:pt x="1625855" y="106679"/>
                </a:lnTo>
                <a:lnTo>
                  <a:pt x="1643508" y="152146"/>
                </a:lnTo>
                <a:lnTo>
                  <a:pt x="1661161" y="205866"/>
                </a:lnTo>
                <a:lnTo>
                  <a:pt x="1678814" y="267588"/>
                </a:lnTo>
                <a:lnTo>
                  <a:pt x="1696467" y="337058"/>
                </a:lnTo>
                <a:lnTo>
                  <a:pt x="1714119" y="413385"/>
                </a:lnTo>
                <a:lnTo>
                  <a:pt x="1731899" y="496188"/>
                </a:lnTo>
                <a:lnTo>
                  <a:pt x="1749552" y="584580"/>
                </a:lnTo>
                <a:lnTo>
                  <a:pt x="1767206" y="677545"/>
                </a:lnTo>
                <a:lnTo>
                  <a:pt x="1802512" y="873251"/>
                </a:lnTo>
                <a:lnTo>
                  <a:pt x="1890903" y="1369695"/>
                </a:lnTo>
                <a:lnTo>
                  <a:pt x="1908557" y="1462659"/>
                </a:lnTo>
                <a:lnTo>
                  <a:pt x="1926209" y="1551812"/>
                </a:lnTo>
                <a:lnTo>
                  <a:pt x="1943863" y="1636775"/>
                </a:lnTo>
                <a:lnTo>
                  <a:pt x="1961643" y="1717039"/>
                </a:lnTo>
                <a:lnTo>
                  <a:pt x="1979295" y="1792604"/>
                </a:lnTo>
                <a:lnTo>
                  <a:pt x="1996949" y="1863343"/>
                </a:lnTo>
                <a:lnTo>
                  <a:pt x="2014601" y="1929511"/>
                </a:lnTo>
                <a:lnTo>
                  <a:pt x="2032255" y="1991360"/>
                </a:lnTo>
                <a:lnTo>
                  <a:pt x="2049907" y="2049017"/>
                </a:lnTo>
                <a:lnTo>
                  <a:pt x="2067561" y="2102992"/>
                </a:lnTo>
                <a:lnTo>
                  <a:pt x="2085340" y="2153665"/>
                </a:lnTo>
                <a:lnTo>
                  <a:pt x="2102994" y="2201545"/>
                </a:lnTo>
                <a:lnTo>
                  <a:pt x="2120646" y="2247137"/>
                </a:lnTo>
                <a:lnTo>
                  <a:pt x="2138300" y="2290699"/>
                </a:lnTo>
                <a:lnTo>
                  <a:pt x="2173606" y="2373757"/>
                </a:lnTo>
                <a:lnTo>
                  <a:pt x="2209038" y="2453004"/>
                </a:lnTo>
                <a:lnTo>
                  <a:pt x="2261997" y="2567559"/>
                </a:lnTo>
                <a:lnTo>
                  <a:pt x="2297303" y="2640838"/>
                </a:lnTo>
                <a:lnTo>
                  <a:pt x="2315083" y="2676143"/>
                </a:lnTo>
                <a:lnTo>
                  <a:pt x="2332737" y="2710307"/>
                </a:lnTo>
                <a:lnTo>
                  <a:pt x="2350389" y="2743199"/>
                </a:lnTo>
                <a:lnTo>
                  <a:pt x="2368043" y="2774568"/>
                </a:lnTo>
                <a:lnTo>
                  <a:pt x="2385695" y="2804159"/>
                </a:lnTo>
                <a:lnTo>
                  <a:pt x="2403349" y="2831972"/>
                </a:lnTo>
                <a:lnTo>
                  <a:pt x="2421001" y="2857753"/>
                </a:lnTo>
                <a:lnTo>
                  <a:pt x="2438782" y="2881503"/>
                </a:lnTo>
                <a:lnTo>
                  <a:pt x="2456434" y="2903092"/>
                </a:lnTo>
                <a:lnTo>
                  <a:pt x="2474088" y="2922651"/>
                </a:lnTo>
                <a:lnTo>
                  <a:pt x="2491740" y="2940177"/>
                </a:lnTo>
                <a:lnTo>
                  <a:pt x="2509394" y="2955797"/>
                </a:lnTo>
                <a:lnTo>
                  <a:pt x="2527046" y="2969640"/>
                </a:lnTo>
                <a:lnTo>
                  <a:pt x="2544700" y="2981833"/>
                </a:lnTo>
                <a:lnTo>
                  <a:pt x="2562480" y="2992501"/>
                </a:lnTo>
                <a:lnTo>
                  <a:pt x="2580132" y="3002026"/>
                </a:lnTo>
                <a:lnTo>
                  <a:pt x="2597786" y="3010534"/>
                </a:lnTo>
                <a:lnTo>
                  <a:pt x="2615438" y="3018154"/>
                </a:lnTo>
                <a:lnTo>
                  <a:pt x="2633092" y="3025266"/>
                </a:lnTo>
                <a:lnTo>
                  <a:pt x="2650745" y="3031871"/>
                </a:lnTo>
                <a:lnTo>
                  <a:pt x="2739137" y="3064002"/>
                </a:lnTo>
                <a:lnTo>
                  <a:pt x="2756789" y="3070859"/>
                </a:lnTo>
                <a:lnTo>
                  <a:pt x="2774443" y="3077972"/>
                </a:lnTo>
                <a:lnTo>
                  <a:pt x="2792222" y="3085465"/>
                </a:lnTo>
                <a:lnTo>
                  <a:pt x="2827528" y="3101085"/>
                </a:lnTo>
                <a:lnTo>
                  <a:pt x="2951226" y="3156584"/>
                </a:lnTo>
                <a:lnTo>
                  <a:pt x="2968880" y="3163697"/>
                </a:lnTo>
                <a:lnTo>
                  <a:pt x="2986532" y="3170428"/>
                </a:lnTo>
                <a:lnTo>
                  <a:pt x="3004186" y="3176778"/>
                </a:lnTo>
                <a:lnTo>
                  <a:pt x="3021965" y="3182620"/>
                </a:lnTo>
                <a:lnTo>
                  <a:pt x="3039619" y="3188080"/>
                </a:lnTo>
                <a:lnTo>
                  <a:pt x="3057271" y="3192907"/>
                </a:lnTo>
                <a:lnTo>
                  <a:pt x="3074925" y="3197478"/>
                </a:lnTo>
                <a:lnTo>
                  <a:pt x="3092577" y="3201415"/>
                </a:lnTo>
                <a:lnTo>
                  <a:pt x="3110231" y="3204972"/>
                </a:lnTo>
                <a:lnTo>
                  <a:pt x="3127883" y="3208147"/>
                </a:lnTo>
                <a:lnTo>
                  <a:pt x="3145663" y="3210814"/>
                </a:lnTo>
                <a:lnTo>
                  <a:pt x="3163317" y="3213099"/>
                </a:lnTo>
                <a:lnTo>
                  <a:pt x="3180970" y="3215132"/>
                </a:lnTo>
                <a:lnTo>
                  <a:pt x="3198622" y="3216909"/>
                </a:lnTo>
                <a:lnTo>
                  <a:pt x="3216276" y="3218307"/>
                </a:lnTo>
                <a:lnTo>
                  <a:pt x="3233928" y="3219449"/>
                </a:lnTo>
                <a:lnTo>
                  <a:pt x="3251582" y="3220465"/>
                </a:lnTo>
              </a:path>
            </a:pathLst>
          </a:custGeom>
          <a:noFill/>
          <a:ln w="18288" cap="flat" cmpd="sng">
            <a:solidFill>
              <a:srgbClr val="A23A2E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3" name="Freeform 173"/>
          <p:cNvSpPr/>
          <p:nvPr/>
        </p:nvSpPr>
        <p:spPr>
          <a:xfrm>
            <a:off x="1688433" y="2165954"/>
            <a:ext cx="3211709" cy="1968321"/>
          </a:xfrm>
          <a:custGeom>
            <a:avLst/>
            <a:gdLst/>
            <a:ahLst/>
            <a:cxnLst/>
            <a:rect l="0" t="0" r="0" b="0"/>
            <a:pathLst>
              <a:path w="4156329" h="2547239">
                <a:moveTo>
                  <a:pt x="0" y="2547239"/>
                </a:moveTo>
                <a:lnTo>
                  <a:pt x="23114" y="2546224"/>
                </a:lnTo>
                <a:lnTo>
                  <a:pt x="46228" y="2544954"/>
                </a:lnTo>
                <a:lnTo>
                  <a:pt x="69341" y="2543302"/>
                </a:lnTo>
                <a:lnTo>
                  <a:pt x="92456" y="2541270"/>
                </a:lnTo>
                <a:lnTo>
                  <a:pt x="115442" y="2538985"/>
                </a:lnTo>
                <a:lnTo>
                  <a:pt x="138557" y="2536190"/>
                </a:lnTo>
                <a:lnTo>
                  <a:pt x="161670" y="2532762"/>
                </a:lnTo>
                <a:lnTo>
                  <a:pt x="184785" y="2528825"/>
                </a:lnTo>
                <a:lnTo>
                  <a:pt x="207898" y="2524252"/>
                </a:lnTo>
                <a:lnTo>
                  <a:pt x="231013" y="2519045"/>
                </a:lnTo>
                <a:lnTo>
                  <a:pt x="254000" y="2512950"/>
                </a:lnTo>
                <a:lnTo>
                  <a:pt x="277113" y="2506092"/>
                </a:lnTo>
                <a:lnTo>
                  <a:pt x="300228" y="2498344"/>
                </a:lnTo>
                <a:lnTo>
                  <a:pt x="323341" y="2489581"/>
                </a:lnTo>
                <a:lnTo>
                  <a:pt x="346456" y="2479930"/>
                </a:lnTo>
                <a:lnTo>
                  <a:pt x="369442" y="2469135"/>
                </a:lnTo>
                <a:lnTo>
                  <a:pt x="392557" y="2457324"/>
                </a:lnTo>
                <a:lnTo>
                  <a:pt x="415670" y="2444369"/>
                </a:lnTo>
                <a:lnTo>
                  <a:pt x="438785" y="2430145"/>
                </a:lnTo>
                <a:lnTo>
                  <a:pt x="461898" y="2414779"/>
                </a:lnTo>
                <a:lnTo>
                  <a:pt x="485013" y="2398142"/>
                </a:lnTo>
                <a:lnTo>
                  <a:pt x="508000" y="2380235"/>
                </a:lnTo>
                <a:lnTo>
                  <a:pt x="531113" y="2360804"/>
                </a:lnTo>
                <a:lnTo>
                  <a:pt x="554228" y="2339975"/>
                </a:lnTo>
                <a:lnTo>
                  <a:pt x="577341" y="2317750"/>
                </a:lnTo>
                <a:lnTo>
                  <a:pt x="600456" y="2293875"/>
                </a:lnTo>
                <a:lnTo>
                  <a:pt x="623442" y="2268348"/>
                </a:lnTo>
                <a:lnTo>
                  <a:pt x="646557" y="2241043"/>
                </a:lnTo>
                <a:lnTo>
                  <a:pt x="669670" y="2211960"/>
                </a:lnTo>
                <a:lnTo>
                  <a:pt x="692785" y="2180971"/>
                </a:lnTo>
                <a:lnTo>
                  <a:pt x="715898" y="2148079"/>
                </a:lnTo>
                <a:lnTo>
                  <a:pt x="738885" y="2113026"/>
                </a:lnTo>
                <a:lnTo>
                  <a:pt x="762000" y="2075943"/>
                </a:lnTo>
                <a:lnTo>
                  <a:pt x="785113" y="2036700"/>
                </a:lnTo>
                <a:lnTo>
                  <a:pt x="808228" y="1995298"/>
                </a:lnTo>
                <a:lnTo>
                  <a:pt x="831341" y="1951737"/>
                </a:lnTo>
                <a:lnTo>
                  <a:pt x="854456" y="1905889"/>
                </a:lnTo>
                <a:lnTo>
                  <a:pt x="877442" y="1857756"/>
                </a:lnTo>
                <a:lnTo>
                  <a:pt x="900557" y="1807464"/>
                </a:lnTo>
                <a:lnTo>
                  <a:pt x="923670" y="1755013"/>
                </a:lnTo>
                <a:lnTo>
                  <a:pt x="946785" y="1700404"/>
                </a:lnTo>
                <a:lnTo>
                  <a:pt x="969898" y="1643634"/>
                </a:lnTo>
                <a:lnTo>
                  <a:pt x="992885" y="1584960"/>
                </a:lnTo>
                <a:lnTo>
                  <a:pt x="1016000" y="1524255"/>
                </a:lnTo>
                <a:lnTo>
                  <a:pt x="1062228" y="1397255"/>
                </a:lnTo>
                <a:lnTo>
                  <a:pt x="1108329" y="1263777"/>
                </a:lnTo>
                <a:lnTo>
                  <a:pt x="1177670" y="1054482"/>
                </a:lnTo>
                <a:lnTo>
                  <a:pt x="1316228" y="631572"/>
                </a:lnTo>
                <a:lnTo>
                  <a:pt x="1339341" y="565023"/>
                </a:lnTo>
                <a:lnTo>
                  <a:pt x="1362329" y="500888"/>
                </a:lnTo>
                <a:lnTo>
                  <a:pt x="1385442" y="439421"/>
                </a:lnTo>
                <a:lnTo>
                  <a:pt x="1408557" y="381127"/>
                </a:lnTo>
                <a:lnTo>
                  <a:pt x="1431670" y="326263"/>
                </a:lnTo>
                <a:lnTo>
                  <a:pt x="1454785" y="275336"/>
                </a:lnTo>
                <a:lnTo>
                  <a:pt x="1477772" y="228473"/>
                </a:lnTo>
                <a:lnTo>
                  <a:pt x="1500885" y="185801"/>
                </a:lnTo>
                <a:lnTo>
                  <a:pt x="1524000" y="147701"/>
                </a:lnTo>
                <a:lnTo>
                  <a:pt x="1547113" y="113920"/>
                </a:lnTo>
                <a:lnTo>
                  <a:pt x="1570228" y="84836"/>
                </a:lnTo>
                <a:lnTo>
                  <a:pt x="1593341" y="60198"/>
                </a:lnTo>
                <a:lnTo>
                  <a:pt x="1616329" y="39879"/>
                </a:lnTo>
                <a:lnTo>
                  <a:pt x="1639442" y="23876"/>
                </a:lnTo>
                <a:lnTo>
                  <a:pt x="1662557" y="12065"/>
                </a:lnTo>
                <a:lnTo>
                  <a:pt x="1685670" y="4319"/>
                </a:lnTo>
                <a:lnTo>
                  <a:pt x="1708785" y="382"/>
                </a:lnTo>
                <a:lnTo>
                  <a:pt x="1731772" y="0"/>
                </a:lnTo>
                <a:lnTo>
                  <a:pt x="1754886" y="3302"/>
                </a:lnTo>
                <a:lnTo>
                  <a:pt x="1777999" y="9780"/>
                </a:lnTo>
                <a:lnTo>
                  <a:pt x="1801113" y="19559"/>
                </a:lnTo>
                <a:lnTo>
                  <a:pt x="1824228" y="32385"/>
                </a:lnTo>
                <a:lnTo>
                  <a:pt x="1847214" y="48007"/>
                </a:lnTo>
                <a:lnTo>
                  <a:pt x="1870329" y="66548"/>
                </a:lnTo>
                <a:lnTo>
                  <a:pt x="1893443" y="87631"/>
                </a:lnTo>
                <a:lnTo>
                  <a:pt x="1916556" y="111125"/>
                </a:lnTo>
                <a:lnTo>
                  <a:pt x="1939670" y="137034"/>
                </a:lnTo>
                <a:lnTo>
                  <a:pt x="1962785" y="164973"/>
                </a:lnTo>
                <a:lnTo>
                  <a:pt x="1985772" y="195072"/>
                </a:lnTo>
                <a:lnTo>
                  <a:pt x="2008886" y="226949"/>
                </a:lnTo>
                <a:lnTo>
                  <a:pt x="2031999" y="260605"/>
                </a:lnTo>
                <a:lnTo>
                  <a:pt x="2055113" y="295910"/>
                </a:lnTo>
                <a:lnTo>
                  <a:pt x="2078228" y="332613"/>
                </a:lnTo>
                <a:lnTo>
                  <a:pt x="2101214" y="370840"/>
                </a:lnTo>
                <a:lnTo>
                  <a:pt x="2124329" y="410337"/>
                </a:lnTo>
                <a:lnTo>
                  <a:pt x="2147443" y="451105"/>
                </a:lnTo>
                <a:lnTo>
                  <a:pt x="2170556" y="493269"/>
                </a:lnTo>
                <a:lnTo>
                  <a:pt x="2193670" y="536702"/>
                </a:lnTo>
                <a:lnTo>
                  <a:pt x="2216785" y="581534"/>
                </a:lnTo>
                <a:lnTo>
                  <a:pt x="2239772" y="627761"/>
                </a:lnTo>
                <a:lnTo>
                  <a:pt x="2262886" y="675386"/>
                </a:lnTo>
                <a:lnTo>
                  <a:pt x="2285999" y="724535"/>
                </a:lnTo>
                <a:lnTo>
                  <a:pt x="2332228" y="827279"/>
                </a:lnTo>
                <a:lnTo>
                  <a:pt x="2378329" y="935483"/>
                </a:lnTo>
                <a:lnTo>
                  <a:pt x="2424556" y="1048132"/>
                </a:lnTo>
                <a:lnTo>
                  <a:pt x="2609214" y="1501522"/>
                </a:lnTo>
                <a:lnTo>
                  <a:pt x="2632329" y="1553464"/>
                </a:lnTo>
                <a:lnTo>
                  <a:pt x="2655443" y="1603502"/>
                </a:lnTo>
                <a:lnTo>
                  <a:pt x="2678556" y="1651509"/>
                </a:lnTo>
                <a:lnTo>
                  <a:pt x="2701670" y="1697356"/>
                </a:lnTo>
                <a:lnTo>
                  <a:pt x="2724657" y="1740789"/>
                </a:lnTo>
                <a:lnTo>
                  <a:pt x="2747772" y="1782064"/>
                </a:lnTo>
                <a:lnTo>
                  <a:pt x="2770886" y="1820926"/>
                </a:lnTo>
                <a:lnTo>
                  <a:pt x="2793999" y="1857375"/>
                </a:lnTo>
                <a:lnTo>
                  <a:pt x="2817113" y="1891665"/>
                </a:lnTo>
                <a:lnTo>
                  <a:pt x="2840100" y="1923669"/>
                </a:lnTo>
                <a:lnTo>
                  <a:pt x="2863214" y="1953514"/>
                </a:lnTo>
                <a:lnTo>
                  <a:pt x="2886329" y="1981200"/>
                </a:lnTo>
                <a:lnTo>
                  <a:pt x="2909443" y="2006981"/>
                </a:lnTo>
                <a:lnTo>
                  <a:pt x="2932556" y="2030985"/>
                </a:lnTo>
                <a:lnTo>
                  <a:pt x="2955670" y="2053082"/>
                </a:lnTo>
                <a:lnTo>
                  <a:pt x="2978657" y="2073656"/>
                </a:lnTo>
                <a:lnTo>
                  <a:pt x="3001772" y="2092833"/>
                </a:lnTo>
                <a:lnTo>
                  <a:pt x="3024886" y="2110487"/>
                </a:lnTo>
                <a:lnTo>
                  <a:pt x="3047999" y="2126996"/>
                </a:lnTo>
                <a:lnTo>
                  <a:pt x="3071113" y="2142490"/>
                </a:lnTo>
                <a:lnTo>
                  <a:pt x="3094100" y="2157095"/>
                </a:lnTo>
                <a:lnTo>
                  <a:pt x="3117214" y="2170938"/>
                </a:lnTo>
                <a:lnTo>
                  <a:pt x="3140329" y="2184019"/>
                </a:lnTo>
                <a:lnTo>
                  <a:pt x="3163443" y="2196593"/>
                </a:lnTo>
                <a:lnTo>
                  <a:pt x="3209543" y="2220723"/>
                </a:lnTo>
                <a:lnTo>
                  <a:pt x="3255772" y="2243710"/>
                </a:lnTo>
                <a:lnTo>
                  <a:pt x="3348100" y="2288160"/>
                </a:lnTo>
                <a:lnTo>
                  <a:pt x="3555999" y="2385187"/>
                </a:lnTo>
                <a:lnTo>
                  <a:pt x="3648329" y="2426844"/>
                </a:lnTo>
                <a:lnTo>
                  <a:pt x="3694556" y="2446782"/>
                </a:lnTo>
                <a:lnTo>
                  <a:pt x="3717543" y="2456307"/>
                </a:lnTo>
                <a:lnTo>
                  <a:pt x="3740657" y="2465451"/>
                </a:lnTo>
                <a:lnTo>
                  <a:pt x="3763772" y="2474214"/>
                </a:lnTo>
                <a:lnTo>
                  <a:pt x="3786886" y="2482596"/>
                </a:lnTo>
                <a:lnTo>
                  <a:pt x="3809999" y="2490470"/>
                </a:lnTo>
                <a:lnTo>
                  <a:pt x="3832987" y="2497837"/>
                </a:lnTo>
                <a:lnTo>
                  <a:pt x="3856100" y="2504694"/>
                </a:lnTo>
                <a:lnTo>
                  <a:pt x="3879214" y="2510918"/>
                </a:lnTo>
                <a:lnTo>
                  <a:pt x="3902329" y="2516632"/>
                </a:lnTo>
                <a:lnTo>
                  <a:pt x="3925443" y="2521712"/>
                </a:lnTo>
                <a:lnTo>
                  <a:pt x="3948556" y="2526285"/>
                </a:lnTo>
                <a:lnTo>
                  <a:pt x="3971543" y="2530221"/>
                </a:lnTo>
                <a:lnTo>
                  <a:pt x="3994657" y="2533777"/>
                </a:lnTo>
                <a:lnTo>
                  <a:pt x="4017772" y="2536825"/>
                </a:lnTo>
                <a:lnTo>
                  <a:pt x="4040886" y="2539365"/>
                </a:lnTo>
                <a:lnTo>
                  <a:pt x="4063999" y="2541651"/>
                </a:lnTo>
                <a:lnTo>
                  <a:pt x="4086987" y="2543430"/>
                </a:lnTo>
                <a:lnTo>
                  <a:pt x="4110100" y="2544954"/>
                </a:lnTo>
                <a:lnTo>
                  <a:pt x="4133214" y="2546224"/>
                </a:lnTo>
                <a:lnTo>
                  <a:pt x="4156329" y="2547239"/>
                </a:lnTo>
              </a:path>
            </a:pathLst>
          </a:custGeom>
          <a:noFill/>
          <a:ln w="18288" cap="flat" cmpd="sng">
            <a:solidFill>
              <a:srgbClr val="01665E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4" name="Freeform 174"/>
          <p:cNvSpPr/>
          <p:nvPr/>
        </p:nvSpPr>
        <p:spPr>
          <a:xfrm>
            <a:off x="971841" y="4165384"/>
            <a:ext cx="4112796" cy="0"/>
          </a:xfrm>
          <a:custGeom>
            <a:avLst/>
            <a:gdLst/>
            <a:ahLst/>
            <a:cxnLst/>
            <a:rect l="0" t="0" r="0" b="0"/>
            <a:pathLst>
              <a:path w="5322442">
                <a:moveTo>
                  <a:pt x="0" y="0"/>
                </a:moveTo>
                <a:lnTo>
                  <a:pt x="5322442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5" name="Freeform 175"/>
          <p:cNvSpPr/>
          <p:nvPr/>
        </p:nvSpPr>
        <p:spPr>
          <a:xfrm>
            <a:off x="5079927" y="1211283"/>
            <a:ext cx="0" cy="2954101"/>
          </a:xfrm>
          <a:custGeom>
            <a:avLst/>
            <a:gdLst/>
            <a:ahLst/>
            <a:cxnLst/>
            <a:rect l="0" t="0" r="0" b="0"/>
            <a:pathLst>
              <a:path h="3822954">
                <a:moveTo>
                  <a:pt x="0" y="3822954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6" name="Freeform 176"/>
          <p:cNvSpPr/>
          <p:nvPr/>
        </p:nvSpPr>
        <p:spPr>
          <a:xfrm>
            <a:off x="971841" y="1215993"/>
            <a:ext cx="4108086" cy="0"/>
          </a:xfrm>
          <a:custGeom>
            <a:avLst/>
            <a:gdLst/>
            <a:ahLst/>
            <a:cxnLst/>
            <a:rect l="0" t="0" r="0" b="0"/>
            <a:pathLst>
              <a:path w="5316347">
                <a:moveTo>
                  <a:pt x="0" y="0"/>
                </a:moveTo>
                <a:lnTo>
                  <a:pt x="5316347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7" name="Freeform 177"/>
          <p:cNvSpPr/>
          <p:nvPr/>
        </p:nvSpPr>
        <p:spPr>
          <a:xfrm>
            <a:off x="976551" y="1211283"/>
            <a:ext cx="0" cy="2954101"/>
          </a:xfrm>
          <a:custGeom>
            <a:avLst/>
            <a:gdLst/>
            <a:ahLst/>
            <a:cxnLst/>
            <a:rect l="0" t="0" r="0" b="0"/>
            <a:pathLst>
              <a:path h="3822954">
                <a:moveTo>
                  <a:pt x="0" y="3822954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8" name="Freeform 178"/>
          <p:cNvSpPr/>
          <p:nvPr/>
        </p:nvSpPr>
        <p:spPr>
          <a:xfrm>
            <a:off x="971841" y="4165384"/>
            <a:ext cx="4112796" cy="0"/>
          </a:xfrm>
          <a:custGeom>
            <a:avLst/>
            <a:gdLst/>
            <a:ahLst/>
            <a:cxnLst/>
            <a:rect l="0" t="0" r="0" b="0"/>
            <a:pathLst>
              <a:path w="5322442">
                <a:moveTo>
                  <a:pt x="0" y="0"/>
                </a:moveTo>
                <a:lnTo>
                  <a:pt x="5322442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9" name="Freeform 179"/>
          <p:cNvSpPr/>
          <p:nvPr/>
        </p:nvSpPr>
        <p:spPr>
          <a:xfrm>
            <a:off x="1009525" y="4165384"/>
            <a:ext cx="0" cy="45240"/>
          </a:xfrm>
          <a:custGeom>
            <a:avLst/>
            <a:gdLst/>
            <a:ahLst/>
            <a:cxnLst/>
            <a:rect l="0" t="0" r="0" b="0"/>
            <a:pathLst>
              <a:path h="58546">
                <a:moveTo>
                  <a:pt x="0" y="0"/>
                </a:moveTo>
                <a:lnTo>
                  <a:pt x="0" y="58546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0" name="Freeform 180"/>
          <p:cNvSpPr/>
          <p:nvPr/>
        </p:nvSpPr>
        <p:spPr>
          <a:xfrm>
            <a:off x="1816010" y="4165384"/>
            <a:ext cx="0" cy="45240"/>
          </a:xfrm>
          <a:custGeom>
            <a:avLst/>
            <a:gdLst/>
            <a:ahLst/>
            <a:cxnLst/>
            <a:rect l="0" t="0" r="0" b="0"/>
            <a:pathLst>
              <a:path h="58546">
                <a:moveTo>
                  <a:pt x="0" y="0"/>
                </a:moveTo>
                <a:lnTo>
                  <a:pt x="0" y="58546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1" name="Freeform 181"/>
          <p:cNvSpPr/>
          <p:nvPr/>
        </p:nvSpPr>
        <p:spPr>
          <a:xfrm>
            <a:off x="2622592" y="4165384"/>
            <a:ext cx="0" cy="45240"/>
          </a:xfrm>
          <a:custGeom>
            <a:avLst/>
            <a:gdLst/>
            <a:ahLst/>
            <a:cxnLst/>
            <a:rect l="0" t="0" r="0" b="0"/>
            <a:pathLst>
              <a:path h="58546">
                <a:moveTo>
                  <a:pt x="0" y="0"/>
                </a:moveTo>
                <a:lnTo>
                  <a:pt x="0" y="58546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2" name="Freeform 182"/>
          <p:cNvSpPr/>
          <p:nvPr/>
        </p:nvSpPr>
        <p:spPr>
          <a:xfrm>
            <a:off x="3429174" y="4165384"/>
            <a:ext cx="0" cy="45240"/>
          </a:xfrm>
          <a:custGeom>
            <a:avLst/>
            <a:gdLst/>
            <a:ahLst/>
            <a:cxnLst/>
            <a:rect l="0" t="0" r="0" b="0"/>
            <a:pathLst>
              <a:path h="58546">
                <a:moveTo>
                  <a:pt x="0" y="0"/>
                </a:moveTo>
                <a:lnTo>
                  <a:pt x="0" y="58546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3" name="Freeform 183"/>
          <p:cNvSpPr/>
          <p:nvPr/>
        </p:nvSpPr>
        <p:spPr>
          <a:xfrm>
            <a:off x="4235660" y="4165384"/>
            <a:ext cx="0" cy="45240"/>
          </a:xfrm>
          <a:custGeom>
            <a:avLst/>
            <a:gdLst/>
            <a:ahLst/>
            <a:cxnLst/>
            <a:rect l="0" t="0" r="0" b="0"/>
            <a:pathLst>
              <a:path h="58546">
                <a:moveTo>
                  <a:pt x="0" y="0"/>
                </a:moveTo>
                <a:lnTo>
                  <a:pt x="0" y="58546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4" name="Freeform 184"/>
          <p:cNvSpPr/>
          <p:nvPr/>
        </p:nvSpPr>
        <p:spPr>
          <a:xfrm>
            <a:off x="5042242" y="4165384"/>
            <a:ext cx="0" cy="45240"/>
          </a:xfrm>
          <a:custGeom>
            <a:avLst/>
            <a:gdLst/>
            <a:ahLst/>
            <a:cxnLst/>
            <a:rect l="0" t="0" r="0" b="0"/>
            <a:pathLst>
              <a:path h="58546">
                <a:moveTo>
                  <a:pt x="0" y="0"/>
                </a:moveTo>
                <a:lnTo>
                  <a:pt x="0" y="58546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5" name="Freeform 185"/>
          <p:cNvSpPr/>
          <p:nvPr/>
        </p:nvSpPr>
        <p:spPr>
          <a:xfrm>
            <a:off x="976551" y="1211283"/>
            <a:ext cx="0" cy="2954101"/>
          </a:xfrm>
          <a:custGeom>
            <a:avLst/>
            <a:gdLst/>
            <a:ahLst/>
            <a:cxnLst/>
            <a:rect l="0" t="0" r="0" b="0"/>
            <a:pathLst>
              <a:path h="3822954">
                <a:moveTo>
                  <a:pt x="0" y="3822954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6" name="Freeform 186"/>
          <p:cNvSpPr/>
          <p:nvPr/>
        </p:nvSpPr>
        <p:spPr>
          <a:xfrm>
            <a:off x="926600" y="4137121"/>
            <a:ext cx="45241" cy="0"/>
          </a:xfrm>
          <a:custGeom>
            <a:avLst/>
            <a:gdLst/>
            <a:ahLst/>
            <a:cxnLst/>
            <a:rect l="0" t="0" r="0" b="0"/>
            <a:pathLst>
              <a:path w="58547">
                <a:moveTo>
                  <a:pt x="5854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7" name="Freeform 187"/>
          <p:cNvSpPr/>
          <p:nvPr/>
        </p:nvSpPr>
        <p:spPr>
          <a:xfrm>
            <a:off x="926600" y="3654192"/>
            <a:ext cx="45241" cy="0"/>
          </a:xfrm>
          <a:custGeom>
            <a:avLst/>
            <a:gdLst/>
            <a:ahLst/>
            <a:cxnLst/>
            <a:rect l="0" t="0" r="0" b="0"/>
            <a:pathLst>
              <a:path w="58547">
                <a:moveTo>
                  <a:pt x="5854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8" name="Freeform 188"/>
          <p:cNvSpPr/>
          <p:nvPr/>
        </p:nvSpPr>
        <p:spPr>
          <a:xfrm>
            <a:off x="926600" y="3171262"/>
            <a:ext cx="45241" cy="0"/>
          </a:xfrm>
          <a:custGeom>
            <a:avLst/>
            <a:gdLst/>
            <a:ahLst/>
            <a:cxnLst/>
            <a:rect l="0" t="0" r="0" b="0"/>
            <a:pathLst>
              <a:path w="58547">
                <a:moveTo>
                  <a:pt x="5854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9" name="Freeform 189"/>
          <p:cNvSpPr/>
          <p:nvPr/>
        </p:nvSpPr>
        <p:spPr>
          <a:xfrm>
            <a:off x="926600" y="2688334"/>
            <a:ext cx="45241" cy="0"/>
          </a:xfrm>
          <a:custGeom>
            <a:avLst/>
            <a:gdLst/>
            <a:ahLst/>
            <a:cxnLst/>
            <a:rect l="0" t="0" r="0" b="0"/>
            <a:pathLst>
              <a:path w="58547">
                <a:moveTo>
                  <a:pt x="5854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0" name="Freeform 190"/>
          <p:cNvSpPr/>
          <p:nvPr/>
        </p:nvSpPr>
        <p:spPr>
          <a:xfrm>
            <a:off x="926600" y="2205405"/>
            <a:ext cx="45241" cy="0"/>
          </a:xfrm>
          <a:custGeom>
            <a:avLst/>
            <a:gdLst/>
            <a:ahLst/>
            <a:cxnLst/>
            <a:rect l="0" t="0" r="0" b="0"/>
            <a:pathLst>
              <a:path w="58547">
                <a:moveTo>
                  <a:pt x="5854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1" name="Freeform 191"/>
          <p:cNvSpPr/>
          <p:nvPr/>
        </p:nvSpPr>
        <p:spPr>
          <a:xfrm>
            <a:off x="926600" y="1722475"/>
            <a:ext cx="45241" cy="0"/>
          </a:xfrm>
          <a:custGeom>
            <a:avLst/>
            <a:gdLst/>
            <a:ahLst/>
            <a:cxnLst/>
            <a:rect l="0" t="0" r="0" b="0"/>
            <a:pathLst>
              <a:path w="58547">
                <a:moveTo>
                  <a:pt x="5854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2" name="Freeform 192"/>
          <p:cNvSpPr/>
          <p:nvPr/>
        </p:nvSpPr>
        <p:spPr>
          <a:xfrm>
            <a:off x="926600" y="1239547"/>
            <a:ext cx="45241" cy="0"/>
          </a:xfrm>
          <a:custGeom>
            <a:avLst/>
            <a:gdLst/>
            <a:ahLst/>
            <a:cxnLst/>
            <a:rect l="0" t="0" r="0" b="0"/>
            <a:pathLst>
              <a:path w="58547">
                <a:moveTo>
                  <a:pt x="58547" y="0"/>
                </a:moveTo>
                <a:lnTo>
                  <a:pt x="0" y="0"/>
                </a:lnTo>
              </a:path>
            </a:pathLst>
          </a:custGeom>
          <a:noFill/>
          <a:ln w="12191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5" name="Rectangle 195"/>
          <p:cNvSpPr/>
          <p:nvPr/>
        </p:nvSpPr>
        <p:spPr>
          <a:xfrm>
            <a:off x="939358" y="4223486"/>
            <a:ext cx="4196020" cy="11400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defTabSz="706557">
              <a:tabLst>
                <a:tab pos="833737" algn="l"/>
                <a:tab pos="1658053" algn="l"/>
                <a:tab pos="2463528" algn="l"/>
                <a:tab pos="3245451" algn="l"/>
                <a:tab pos="4050925" algn="l"/>
              </a:tabLst>
            </a:pPr>
            <a:r>
              <a:rPr lang="en-US" sz="741" dirty="0">
                <a:solidFill>
                  <a:srgbClr val="000000"/>
                </a:solidFill>
                <a:latin typeface="AlbanyAMT,Regular"/>
              </a:rPr>
              <a:t>-10	-5	0	5	10	15</a:t>
            </a:r>
          </a:p>
        </p:txBody>
      </p:sp>
      <p:sp>
        <p:nvSpPr>
          <p:cNvPr id="197" name="Rectangle 197"/>
          <p:cNvSpPr/>
          <p:nvPr/>
        </p:nvSpPr>
        <p:spPr>
          <a:xfrm>
            <a:off x="1775676" y="4412404"/>
            <a:ext cx="2572820" cy="13080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defTabSz="706557"/>
            <a:r>
              <a:rPr lang="en-US" sz="850" dirty="0">
                <a:solidFill>
                  <a:srgbClr val="000000"/>
                </a:solidFill>
                <a:latin typeface="AlbanyAMT,Regular"/>
              </a:rPr>
              <a:t>Pre-pregnancy BMI-associated predictive component</a:t>
            </a:r>
          </a:p>
        </p:txBody>
      </p:sp>
      <p:sp>
        <p:nvSpPr>
          <p:cNvPr id="198" name="Rectangle 198"/>
          <p:cNvSpPr/>
          <p:nvPr/>
        </p:nvSpPr>
        <p:spPr>
          <a:xfrm>
            <a:off x="845147" y="4068038"/>
            <a:ext cx="52900" cy="11400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defTabSz="706557"/>
            <a:r>
              <a:rPr lang="en-US" sz="741" dirty="0">
                <a:solidFill>
                  <a:srgbClr val="000000"/>
                </a:solidFill>
                <a:latin typeface="AlbanyAMT,Regular"/>
              </a:rPr>
              <a:t>0</a:t>
            </a:r>
          </a:p>
        </p:txBody>
      </p:sp>
      <p:sp>
        <p:nvSpPr>
          <p:cNvPr id="199" name="Rectangle 199"/>
          <p:cNvSpPr/>
          <p:nvPr/>
        </p:nvSpPr>
        <p:spPr>
          <a:xfrm>
            <a:off x="845147" y="3582852"/>
            <a:ext cx="52900" cy="11400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defTabSz="706557"/>
            <a:r>
              <a:rPr lang="en-US" sz="741" dirty="0">
                <a:solidFill>
                  <a:srgbClr val="000000"/>
                </a:solidFill>
                <a:latin typeface="AlbanyAMT,Regular"/>
              </a:rPr>
              <a:t>5</a:t>
            </a:r>
          </a:p>
        </p:txBody>
      </p:sp>
      <p:sp>
        <p:nvSpPr>
          <p:cNvPr id="200" name="Rectangle 200"/>
          <p:cNvSpPr/>
          <p:nvPr/>
        </p:nvSpPr>
        <p:spPr>
          <a:xfrm>
            <a:off x="793331" y="3102375"/>
            <a:ext cx="105798" cy="11400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defTabSz="706557"/>
            <a:r>
              <a:rPr lang="en-US" sz="741" dirty="0">
                <a:solidFill>
                  <a:srgbClr val="000000"/>
                </a:solidFill>
                <a:latin typeface="AlbanyAMT,Regular"/>
              </a:rPr>
              <a:t>10</a:t>
            </a:r>
          </a:p>
        </p:txBody>
      </p:sp>
      <p:sp>
        <p:nvSpPr>
          <p:cNvPr id="201" name="Rectangle 201"/>
          <p:cNvSpPr/>
          <p:nvPr/>
        </p:nvSpPr>
        <p:spPr>
          <a:xfrm>
            <a:off x="793331" y="2617189"/>
            <a:ext cx="105798" cy="11400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defTabSz="706557"/>
            <a:r>
              <a:rPr lang="en-US" sz="741" dirty="0">
                <a:solidFill>
                  <a:srgbClr val="000000"/>
                </a:solidFill>
                <a:latin typeface="AlbanyAMT,Regular"/>
              </a:rPr>
              <a:t>15</a:t>
            </a:r>
          </a:p>
        </p:txBody>
      </p:sp>
      <p:sp>
        <p:nvSpPr>
          <p:cNvPr id="202" name="Rectangle 202"/>
          <p:cNvSpPr/>
          <p:nvPr/>
        </p:nvSpPr>
        <p:spPr>
          <a:xfrm>
            <a:off x="793331" y="2136714"/>
            <a:ext cx="105798" cy="11400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defTabSz="706557"/>
            <a:r>
              <a:rPr lang="en-US" sz="741" dirty="0">
                <a:solidFill>
                  <a:srgbClr val="000000"/>
                </a:solidFill>
                <a:latin typeface="AlbanyAMT,Regular"/>
              </a:rPr>
              <a:t>20</a:t>
            </a:r>
          </a:p>
        </p:txBody>
      </p:sp>
      <p:sp>
        <p:nvSpPr>
          <p:cNvPr id="203" name="Rectangle 203"/>
          <p:cNvSpPr/>
          <p:nvPr/>
        </p:nvSpPr>
        <p:spPr>
          <a:xfrm>
            <a:off x="793331" y="1651528"/>
            <a:ext cx="105798" cy="11400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defTabSz="706557"/>
            <a:r>
              <a:rPr lang="en-US" sz="741" dirty="0">
                <a:solidFill>
                  <a:srgbClr val="000000"/>
                </a:solidFill>
                <a:latin typeface="AlbanyAMT,Regular"/>
              </a:rPr>
              <a:t>25</a:t>
            </a:r>
          </a:p>
        </p:txBody>
      </p:sp>
      <p:sp>
        <p:nvSpPr>
          <p:cNvPr id="204" name="Rectangle 204"/>
          <p:cNvSpPr/>
          <p:nvPr/>
        </p:nvSpPr>
        <p:spPr>
          <a:xfrm>
            <a:off x="793331" y="1166342"/>
            <a:ext cx="105798" cy="11400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defTabSz="706557"/>
            <a:r>
              <a:rPr lang="en-US" sz="741" dirty="0">
                <a:solidFill>
                  <a:srgbClr val="000000"/>
                </a:solidFill>
                <a:latin typeface="AlbanyAMT,Regular"/>
              </a:rPr>
              <a:t>30</a:t>
            </a:r>
          </a:p>
        </p:txBody>
      </p:sp>
      <p:sp>
        <p:nvSpPr>
          <p:cNvPr id="205" name="Rectangle 205"/>
          <p:cNvSpPr/>
          <p:nvPr/>
        </p:nvSpPr>
        <p:spPr>
          <a:xfrm rot="-5400000">
            <a:off x="423577" y="2623328"/>
            <a:ext cx="376706" cy="13080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defTabSz="706557"/>
            <a:r>
              <a:rPr lang="en-US" sz="850" dirty="0">
                <a:solidFill>
                  <a:srgbClr val="000000"/>
                </a:solidFill>
                <a:latin typeface="AlbanyAMT,Regular"/>
              </a:rPr>
              <a:t>Percent</a:t>
            </a:r>
          </a:p>
        </p:txBody>
      </p:sp>
      <p:sp>
        <p:nvSpPr>
          <p:cNvPr id="194" name="Freeform 177"/>
          <p:cNvSpPr/>
          <p:nvPr/>
        </p:nvSpPr>
        <p:spPr>
          <a:xfrm>
            <a:off x="3468920" y="5141071"/>
            <a:ext cx="66045" cy="65948"/>
          </a:xfrm>
          <a:custGeom>
            <a:avLst/>
            <a:gdLst/>
            <a:ahLst/>
            <a:cxnLst/>
            <a:rect l="0" t="0" r="0" b="0"/>
            <a:pathLst>
              <a:path w="85470" h="85344">
                <a:moveTo>
                  <a:pt x="42672" y="0"/>
                </a:moveTo>
                <a:lnTo>
                  <a:pt x="85470" y="0"/>
                </a:lnTo>
                <a:lnTo>
                  <a:pt x="85470" y="85344"/>
                </a:lnTo>
                <a:lnTo>
                  <a:pt x="0" y="85344"/>
                </a:lnTo>
                <a:lnTo>
                  <a:pt x="0" y="0"/>
                </a:lnTo>
                <a:lnTo>
                  <a:pt x="42672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6" name="Freeform 178"/>
          <p:cNvSpPr/>
          <p:nvPr/>
        </p:nvSpPr>
        <p:spPr>
          <a:xfrm>
            <a:off x="3466462" y="5141071"/>
            <a:ext cx="66045" cy="65948"/>
          </a:xfrm>
          <a:custGeom>
            <a:avLst/>
            <a:gdLst/>
            <a:ahLst/>
            <a:cxnLst/>
            <a:rect l="0" t="0" r="0" b="0"/>
            <a:pathLst>
              <a:path w="85470" h="85344">
                <a:moveTo>
                  <a:pt x="42672" y="0"/>
                </a:moveTo>
                <a:lnTo>
                  <a:pt x="85470" y="0"/>
                </a:lnTo>
                <a:lnTo>
                  <a:pt x="85470" y="85344"/>
                </a:lnTo>
                <a:lnTo>
                  <a:pt x="0" y="85344"/>
                </a:lnTo>
                <a:lnTo>
                  <a:pt x="0" y="0"/>
                </a:lnTo>
                <a:lnTo>
                  <a:pt x="42672" y="0"/>
                </a:lnTo>
              </a:path>
            </a:pathLst>
          </a:custGeom>
          <a:noFill/>
          <a:ln w="6095" cap="sq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6" name="Freeform 179"/>
          <p:cNvSpPr/>
          <p:nvPr/>
        </p:nvSpPr>
        <p:spPr>
          <a:xfrm>
            <a:off x="2490154" y="5141071"/>
            <a:ext cx="65948" cy="65948"/>
          </a:xfrm>
          <a:custGeom>
            <a:avLst/>
            <a:gdLst/>
            <a:ahLst/>
            <a:cxnLst/>
            <a:rect l="0" t="0" r="0" b="0"/>
            <a:pathLst>
              <a:path w="85344" h="85344">
                <a:moveTo>
                  <a:pt x="42672" y="0"/>
                </a:moveTo>
                <a:lnTo>
                  <a:pt x="85344" y="0"/>
                </a:lnTo>
                <a:lnTo>
                  <a:pt x="85344" y="85344"/>
                </a:lnTo>
                <a:lnTo>
                  <a:pt x="0" y="85344"/>
                </a:lnTo>
                <a:lnTo>
                  <a:pt x="0" y="0"/>
                </a:lnTo>
                <a:lnTo>
                  <a:pt x="42672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7" name="Freeform 180"/>
          <p:cNvSpPr/>
          <p:nvPr/>
        </p:nvSpPr>
        <p:spPr>
          <a:xfrm>
            <a:off x="2490154" y="5141071"/>
            <a:ext cx="65948" cy="65948"/>
          </a:xfrm>
          <a:custGeom>
            <a:avLst/>
            <a:gdLst/>
            <a:ahLst/>
            <a:cxnLst/>
            <a:rect l="0" t="0" r="0" b="0"/>
            <a:pathLst>
              <a:path w="85344" h="85344">
                <a:moveTo>
                  <a:pt x="42672" y="0"/>
                </a:moveTo>
                <a:lnTo>
                  <a:pt x="85344" y="0"/>
                </a:lnTo>
                <a:lnTo>
                  <a:pt x="85344" y="85344"/>
                </a:lnTo>
                <a:lnTo>
                  <a:pt x="0" y="85344"/>
                </a:lnTo>
                <a:lnTo>
                  <a:pt x="0" y="0"/>
                </a:lnTo>
                <a:lnTo>
                  <a:pt x="42672" y="0"/>
                </a:lnTo>
              </a:path>
            </a:pathLst>
          </a:custGeom>
          <a:noFill/>
          <a:ln w="6095" cap="sq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8" name="Freeform 181"/>
          <p:cNvSpPr/>
          <p:nvPr/>
        </p:nvSpPr>
        <p:spPr>
          <a:xfrm>
            <a:off x="1684651" y="5141071"/>
            <a:ext cx="65948" cy="65948"/>
          </a:xfrm>
          <a:custGeom>
            <a:avLst/>
            <a:gdLst/>
            <a:ahLst/>
            <a:cxnLst/>
            <a:rect l="0" t="0" r="0" b="0"/>
            <a:pathLst>
              <a:path w="85344" h="85344">
                <a:moveTo>
                  <a:pt x="42672" y="0"/>
                </a:moveTo>
                <a:lnTo>
                  <a:pt x="85344" y="0"/>
                </a:lnTo>
                <a:lnTo>
                  <a:pt x="85344" y="85344"/>
                </a:lnTo>
                <a:lnTo>
                  <a:pt x="0" y="85344"/>
                </a:lnTo>
                <a:lnTo>
                  <a:pt x="0" y="0"/>
                </a:lnTo>
                <a:lnTo>
                  <a:pt x="42672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9" name="Freeform 182"/>
          <p:cNvSpPr/>
          <p:nvPr/>
        </p:nvSpPr>
        <p:spPr>
          <a:xfrm>
            <a:off x="1684651" y="5141071"/>
            <a:ext cx="65948" cy="65948"/>
          </a:xfrm>
          <a:custGeom>
            <a:avLst/>
            <a:gdLst/>
            <a:ahLst/>
            <a:cxnLst/>
            <a:rect l="0" t="0" r="0" b="0"/>
            <a:pathLst>
              <a:path w="85344" h="85344">
                <a:moveTo>
                  <a:pt x="42672" y="0"/>
                </a:moveTo>
                <a:lnTo>
                  <a:pt x="85344" y="0"/>
                </a:lnTo>
                <a:lnTo>
                  <a:pt x="85344" y="85344"/>
                </a:lnTo>
                <a:lnTo>
                  <a:pt x="0" y="85344"/>
                </a:lnTo>
                <a:lnTo>
                  <a:pt x="0" y="0"/>
                </a:lnTo>
                <a:lnTo>
                  <a:pt x="42672" y="0"/>
                </a:lnTo>
              </a:path>
            </a:pathLst>
          </a:custGeom>
          <a:noFill/>
          <a:ln w="6095" cap="sq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0" name="Rectangle 194"/>
          <p:cNvSpPr/>
          <p:nvPr/>
        </p:nvSpPr>
        <p:spPr>
          <a:xfrm>
            <a:off x="1841450" y="5108583"/>
            <a:ext cx="2677702" cy="11400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defTabSz="706557">
              <a:tabLst>
                <a:tab pos="805474" algn="l"/>
                <a:tab pos="1474348" algn="l"/>
              </a:tabLst>
            </a:pPr>
            <a:r>
              <a:rPr lang="en-US" sz="741" spc="-50" dirty="0">
                <a:solidFill>
                  <a:srgbClr val="000000"/>
                </a:solidFill>
                <a:latin typeface="AlbanyAMT,Regular"/>
              </a:rPr>
              <a:t>Below 25 kg/m</a:t>
            </a:r>
            <a:r>
              <a:rPr lang="en-US" sz="741" spc="-50" baseline="30000" dirty="0">
                <a:solidFill>
                  <a:srgbClr val="000000"/>
                </a:solidFill>
                <a:latin typeface="AlbanyAMT,Regular"/>
              </a:rPr>
              <a:t>2</a:t>
            </a:r>
            <a:r>
              <a:rPr lang="en-US" sz="741" dirty="0">
                <a:solidFill>
                  <a:srgbClr val="000000"/>
                </a:solidFill>
                <a:latin typeface="AlbanyAMT,Regular"/>
              </a:rPr>
              <a:t>	25 to 30</a:t>
            </a:r>
            <a:r>
              <a:rPr lang="en-US" sz="741" spc="-50" dirty="0">
                <a:solidFill>
                  <a:srgbClr val="000000"/>
                </a:solidFill>
                <a:latin typeface="AlbanyAMT,Regular"/>
              </a:rPr>
              <a:t> kg/m</a:t>
            </a:r>
            <a:r>
              <a:rPr lang="en-US" sz="741" spc="-50" baseline="30000" dirty="0">
                <a:solidFill>
                  <a:srgbClr val="000000"/>
                </a:solidFill>
                <a:latin typeface="AlbanyAMT,Regular"/>
              </a:rPr>
              <a:t>2</a:t>
            </a:r>
            <a:r>
              <a:rPr lang="en-US" sz="741" dirty="0">
                <a:solidFill>
                  <a:srgbClr val="000000"/>
                </a:solidFill>
                <a:latin typeface="AlbanyAMT,Regular"/>
              </a:rPr>
              <a:t>              30</a:t>
            </a:r>
            <a:r>
              <a:rPr lang="en-US" sz="741" spc="-50" dirty="0">
                <a:solidFill>
                  <a:srgbClr val="000000"/>
                </a:solidFill>
                <a:latin typeface="AlbanyAMT,Regular"/>
              </a:rPr>
              <a:t> kg/m</a:t>
            </a:r>
            <a:r>
              <a:rPr lang="en-US" sz="741" spc="-50" baseline="30000" dirty="0">
                <a:solidFill>
                  <a:srgbClr val="000000"/>
                </a:solidFill>
                <a:latin typeface="AlbanyAMT,Regular"/>
              </a:rPr>
              <a:t>2 </a:t>
            </a:r>
            <a:r>
              <a:rPr lang="en-US" sz="741" spc="-50" dirty="0">
                <a:solidFill>
                  <a:srgbClr val="000000"/>
                </a:solidFill>
                <a:latin typeface="AlbanyAMT,Regular"/>
              </a:rPr>
              <a:t>and above</a:t>
            </a:r>
            <a:r>
              <a:rPr lang="en-US" sz="741" spc="-50" baseline="30000" dirty="0">
                <a:solidFill>
                  <a:srgbClr val="000000"/>
                </a:solidFill>
                <a:latin typeface="AlbanyAMT,Regular"/>
              </a:rPr>
              <a:t>               </a:t>
            </a:r>
            <a:r>
              <a:rPr lang="en-US" sz="741" dirty="0">
                <a:solidFill>
                  <a:srgbClr val="000000"/>
                </a:solidFill>
                <a:latin typeface="AlbanyAMT,Regular"/>
              </a:rPr>
              <a:t>         </a:t>
            </a:r>
          </a:p>
        </p:txBody>
      </p:sp>
      <p:sp>
        <p:nvSpPr>
          <p:cNvPr id="211" name="Rectangle 195"/>
          <p:cNvSpPr/>
          <p:nvPr/>
        </p:nvSpPr>
        <p:spPr>
          <a:xfrm>
            <a:off x="2259684" y="4901476"/>
            <a:ext cx="1491181" cy="13080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defTabSz="706557"/>
            <a:r>
              <a:rPr lang="en-US" sz="850" dirty="0">
                <a:solidFill>
                  <a:srgbClr val="000000"/>
                </a:solidFill>
                <a:latin typeface="AlbanyAMT,Regular"/>
              </a:rPr>
              <a:t>Materna</a:t>
            </a:r>
            <a:r>
              <a:rPr lang="en-US" sz="850" spc="-37" dirty="0">
                <a:solidFill>
                  <a:srgbClr val="000000"/>
                </a:solidFill>
                <a:latin typeface="AlbanyAMT,Regular"/>
              </a:rPr>
              <a:t>l</a:t>
            </a:r>
            <a:r>
              <a:rPr lang="en-US" sz="850" dirty="0">
                <a:solidFill>
                  <a:srgbClr val="000000"/>
                </a:solidFill>
                <a:latin typeface="AlbanyAMT,Regular"/>
              </a:rPr>
              <a:t> pre-pregnancy BMI</a:t>
            </a:r>
          </a:p>
        </p:txBody>
      </p:sp>
      <p:sp>
        <p:nvSpPr>
          <p:cNvPr id="193" name="TextBox 192"/>
          <p:cNvSpPr txBox="1"/>
          <p:nvPr/>
        </p:nvSpPr>
        <p:spPr>
          <a:xfrm>
            <a:off x="618650" y="182821"/>
            <a:ext cx="21291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/>
              <a:t>Supplemental Figure 4. </a:t>
            </a:r>
            <a:r>
              <a:rPr lang="en-US" sz="1000" b="1" dirty="0" smtClean="0"/>
              <a:t>Panel A.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4419014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Freeform 101"/>
          <p:cNvSpPr/>
          <p:nvPr/>
        </p:nvSpPr>
        <p:spPr>
          <a:xfrm>
            <a:off x="712381" y="518727"/>
            <a:ext cx="7498080" cy="5669280"/>
          </a:xfrm>
          <a:custGeom>
            <a:avLst/>
            <a:gdLst/>
            <a:ahLst/>
            <a:cxnLst/>
            <a:rect l="0" t="0" r="0" b="0"/>
            <a:pathLst>
              <a:path w="7498080" h="5669280">
                <a:moveTo>
                  <a:pt x="0" y="5669280"/>
                </a:moveTo>
                <a:lnTo>
                  <a:pt x="7498080" y="5669280"/>
                </a:lnTo>
                <a:lnTo>
                  <a:pt x="7498080" y="0"/>
                </a:lnTo>
                <a:lnTo>
                  <a:pt x="0" y="0"/>
                </a:lnTo>
                <a:lnTo>
                  <a:pt x="0" y="5669280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6095" cap="rnd" cmpd="sng">
            <a:solidFill>
              <a:srgbClr val="FFFFFF">
                <a:alpha val="100000"/>
              </a:srgbClr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2" name="Freeform 102"/>
          <p:cNvSpPr/>
          <p:nvPr/>
        </p:nvSpPr>
        <p:spPr>
          <a:xfrm>
            <a:off x="712381" y="518727"/>
            <a:ext cx="3651377" cy="2737231"/>
          </a:xfrm>
          <a:custGeom>
            <a:avLst/>
            <a:gdLst/>
            <a:ahLst/>
            <a:cxnLst/>
            <a:rect l="0" t="0" r="0" b="0"/>
            <a:pathLst>
              <a:path w="3651377" h="2737231">
                <a:moveTo>
                  <a:pt x="1825625" y="0"/>
                </a:moveTo>
                <a:lnTo>
                  <a:pt x="3651377" y="0"/>
                </a:lnTo>
                <a:lnTo>
                  <a:pt x="3651377" y="2737231"/>
                </a:lnTo>
                <a:lnTo>
                  <a:pt x="0" y="2737231"/>
                </a:lnTo>
                <a:lnTo>
                  <a:pt x="0" y="0"/>
                </a:lnTo>
                <a:lnTo>
                  <a:pt x="1825625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3" name="Freeform 103"/>
          <p:cNvSpPr/>
          <p:nvPr/>
        </p:nvSpPr>
        <p:spPr>
          <a:xfrm>
            <a:off x="712381" y="518727"/>
            <a:ext cx="3651377" cy="2737231"/>
          </a:xfrm>
          <a:custGeom>
            <a:avLst/>
            <a:gdLst/>
            <a:ahLst/>
            <a:cxnLst/>
            <a:rect l="0" t="0" r="0" b="0"/>
            <a:pathLst>
              <a:path w="3651377" h="2737231">
                <a:moveTo>
                  <a:pt x="1825625" y="0"/>
                </a:moveTo>
                <a:lnTo>
                  <a:pt x="3651377" y="0"/>
                </a:lnTo>
                <a:lnTo>
                  <a:pt x="3651377" y="2737231"/>
                </a:lnTo>
                <a:lnTo>
                  <a:pt x="0" y="2737231"/>
                </a:lnTo>
                <a:lnTo>
                  <a:pt x="0" y="0"/>
                </a:lnTo>
                <a:lnTo>
                  <a:pt x="1825625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4" name="Freeform 104"/>
          <p:cNvSpPr/>
          <p:nvPr/>
        </p:nvSpPr>
        <p:spPr>
          <a:xfrm>
            <a:off x="712381" y="518727"/>
            <a:ext cx="3596513" cy="48895"/>
          </a:xfrm>
          <a:custGeom>
            <a:avLst/>
            <a:gdLst/>
            <a:ahLst/>
            <a:cxnLst/>
            <a:rect l="0" t="0" r="0" b="0"/>
            <a:pathLst>
              <a:path w="3596513" h="48895">
                <a:moveTo>
                  <a:pt x="1798192" y="0"/>
                </a:moveTo>
                <a:lnTo>
                  <a:pt x="3596513" y="0"/>
                </a:lnTo>
                <a:lnTo>
                  <a:pt x="3596513" y="48895"/>
                </a:lnTo>
                <a:lnTo>
                  <a:pt x="0" y="48895"/>
                </a:lnTo>
                <a:lnTo>
                  <a:pt x="0" y="0"/>
                </a:lnTo>
                <a:lnTo>
                  <a:pt x="1798192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5" name="Freeform 105"/>
          <p:cNvSpPr/>
          <p:nvPr/>
        </p:nvSpPr>
        <p:spPr>
          <a:xfrm>
            <a:off x="712381" y="573719"/>
            <a:ext cx="48640" cy="2682239"/>
          </a:xfrm>
          <a:custGeom>
            <a:avLst/>
            <a:gdLst/>
            <a:ahLst/>
            <a:cxnLst/>
            <a:rect l="0" t="0" r="0" b="0"/>
            <a:pathLst>
              <a:path w="48640" h="2682239">
                <a:moveTo>
                  <a:pt x="24256" y="0"/>
                </a:moveTo>
                <a:lnTo>
                  <a:pt x="48640" y="0"/>
                </a:lnTo>
                <a:lnTo>
                  <a:pt x="48640" y="2682239"/>
                </a:lnTo>
                <a:lnTo>
                  <a:pt x="0" y="2682239"/>
                </a:lnTo>
                <a:lnTo>
                  <a:pt x="0" y="0"/>
                </a:lnTo>
                <a:lnTo>
                  <a:pt x="24256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6" name="Freeform 106"/>
          <p:cNvSpPr/>
          <p:nvPr/>
        </p:nvSpPr>
        <p:spPr>
          <a:xfrm>
            <a:off x="767245" y="3207191"/>
            <a:ext cx="3596513" cy="48767"/>
          </a:xfrm>
          <a:custGeom>
            <a:avLst/>
            <a:gdLst/>
            <a:ahLst/>
            <a:cxnLst/>
            <a:rect l="0" t="0" r="0" b="0"/>
            <a:pathLst>
              <a:path w="3596513" h="48767">
                <a:moveTo>
                  <a:pt x="1798193" y="0"/>
                </a:moveTo>
                <a:lnTo>
                  <a:pt x="3596513" y="0"/>
                </a:lnTo>
                <a:lnTo>
                  <a:pt x="3596513" y="48767"/>
                </a:lnTo>
                <a:lnTo>
                  <a:pt x="0" y="48767"/>
                </a:lnTo>
                <a:lnTo>
                  <a:pt x="0" y="0"/>
                </a:lnTo>
                <a:lnTo>
                  <a:pt x="1798193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7" name="Freeform 107"/>
          <p:cNvSpPr/>
          <p:nvPr/>
        </p:nvSpPr>
        <p:spPr>
          <a:xfrm>
            <a:off x="4315116" y="518727"/>
            <a:ext cx="48642" cy="2682241"/>
          </a:xfrm>
          <a:custGeom>
            <a:avLst/>
            <a:gdLst/>
            <a:ahLst/>
            <a:cxnLst/>
            <a:rect l="0" t="0" r="0" b="0"/>
            <a:pathLst>
              <a:path w="48642" h="2682241">
                <a:moveTo>
                  <a:pt x="24257" y="0"/>
                </a:moveTo>
                <a:lnTo>
                  <a:pt x="48642" y="0"/>
                </a:lnTo>
                <a:lnTo>
                  <a:pt x="48642" y="2682241"/>
                </a:lnTo>
                <a:lnTo>
                  <a:pt x="0" y="2682241"/>
                </a:lnTo>
                <a:lnTo>
                  <a:pt x="0" y="0"/>
                </a:lnTo>
                <a:lnTo>
                  <a:pt x="24257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8" name="Freeform 108"/>
          <p:cNvSpPr/>
          <p:nvPr/>
        </p:nvSpPr>
        <p:spPr>
          <a:xfrm>
            <a:off x="1205394" y="576639"/>
            <a:ext cx="3091434" cy="2226056"/>
          </a:xfrm>
          <a:custGeom>
            <a:avLst/>
            <a:gdLst/>
            <a:ahLst/>
            <a:cxnLst/>
            <a:rect l="0" t="0" r="0" b="0"/>
            <a:pathLst>
              <a:path w="3091434" h="2226056">
                <a:moveTo>
                  <a:pt x="1545717" y="0"/>
                </a:moveTo>
                <a:lnTo>
                  <a:pt x="3091434" y="0"/>
                </a:lnTo>
                <a:lnTo>
                  <a:pt x="3091434" y="2226056"/>
                </a:lnTo>
                <a:lnTo>
                  <a:pt x="0" y="2226056"/>
                </a:lnTo>
                <a:lnTo>
                  <a:pt x="0" y="0"/>
                </a:lnTo>
                <a:lnTo>
                  <a:pt x="1545717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9" name="Freeform 109"/>
          <p:cNvSpPr/>
          <p:nvPr/>
        </p:nvSpPr>
        <p:spPr>
          <a:xfrm>
            <a:off x="1476539" y="2758118"/>
            <a:ext cx="240666" cy="17145"/>
          </a:xfrm>
          <a:custGeom>
            <a:avLst/>
            <a:gdLst/>
            <a:ahLst/>
            <a:cxnLst/>
            <a:rect l="0" t="0" r="0" b="0"/>
            <a:pathLst>
              <a:path w="240666" h="17145">
                <a:moveTo>
                  <a:pt x="120269" y="0"/>
                </a:moveTo>
                <a:lnTo>
                  <a:pt x="240666" y="0"/>
                </a:lnTo>
                <a:lnTo>
                  <a:pt x="240666" y="17145"/>
                </a:lnTo>
                <a:lnTo>
                  <a:pt x="0" y="17145"/>
                </a:lnTo>
                <a:lnTo>
                  <a:pt x="0" y="0"/>
                </a:lnTo>
                <a:lnTo>
                  <a:pt x="120269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0" name="Freeform 110"/>
          <p:cNvSpPr/>
          <p:nvPr/>
        </p:nvSpPr>
        <p:spPr>
          <a:xfrm>
            <a:off x="1476539" y="2758118"/>
            <a:ext cx="240666" cy="17145"/>
          </a:xfrm>
          <a:custGeom>
            <a:avLst/>
            <a:gdLst/>
            <a:ahLst/>
            <a:cxnLst/>
            <a:rect l="0" t="0" r="0" b="0"/>
            <a:pathLst>
              <a:path w="240666" h="17145">
                <a:moveTo>
                  <a:pt x="120269" y="0"/>
                </a:moveTo>
                <a:lnTo>
                  <a:pt x="240666" y="0"/>
                </a:lnTo>
                <a:lnTo>
                  <a:pt x="240666" y="17145"/>
                </a:lnTo>
                <a:lnTo>
                  <a:pt x="0" y="17145"/>
                </a:lnTo>
                <a:lnTo>
                  <a:pt x="0" y="0"/>
                </a:lnTo>
                <a:lnTo>
                  <a:pt x="120269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1" name="Freeform 111"/>
          <p:cNvSpPr/>
          <p:nvPr/>
        </p:nvSpPr>
        <p:spPr>
          <a:xfrm>
            <a:off x="1717205" y="2671886"/>
            <a:ext cx="240792" cy="103377"/>
          </a:xfrm>
          <a:custGeom>
            <a:avLst/>
            <a:gdLst/>
            <a:ahLst/>
            <a:cxnLst/>
            <a:rect l="0" t="0" r="0" b="0"/>
            <a:pathLst>
              <a:path w="240792" h="103377">
                <a:moveTo>
                  <a:pt x="120395" y="0"/>
                </a:moveTo>
                <a:lnTo>
                  <a:pt x="240792" y="0"/>
                </a:lnTo>
                <a:lnTo>
                  <a:pt x="240792" y="103377"/>
                </a:lnTo>
                <a:lnTo>
                  <a:pt x="0" y="103377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2" name="Freeform 112"/>
          <p:cNvSpPr/>
          <p:nvPr/>
        </p:nvSpPr>
        <p:spPr>
          <a:xfrm>
            <a:off x="1717205" y="2671886"/>
            <a:ext cx="240792" cy="103377"/>
          </a:xfrm>
          <a:custGeom>
            <a:avLst/>
            <a:gdLst/>
            <a:ahLst/>
            <a:cxnLst/>
            <a:rect l="0" t="0" r="0" b="0"/>
            <a:pathLst>
              <a:path w="240792" h="103377">
                <a:moveTo>
                  <a:pt x="120395" y="0"/>
                </a:moveTo>
                <a:lnTo>
                  <a:pt x="240792" y="0"/>
                </a:lnTo>
                <a:lnTo>
                  <a:pt x="240792" y="103377"/>
                </a:lnTo>
                <a:lnTo>
                  <a:pt x="0" y="103377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3" name="Freeform 113"/>
          <p:cNvSpPr/>
          <p:nvPr/>
        </p:nvSpPr>
        <p:spPr>
          <a:xfrm>
            <a:off x="1957997" y="2516818"/>
            <a:ext cx="240664" cy="258445"/>
          </a:xfrm>
          <a:custGeom>
            <a:avLst/>
            <a:gdLst/>
            <a:ahLst/>
            <a:cxnLst/>
            <a:rect l="0" t="0" r="0" b="0"/>
            <a:pathLst>
              <a:path w="240664" h="258445">
                <a:moveTo>
                  <a:pt x="120269" y="0"/>
                </a:moveTo>
                <a:lnTo>
                  <a:pt x="240664" y="0"/>
                </a:lnTo>
                <a:lnTo>
                  <a:pt x="240664" y="258445"/>
                </a:lnTo>
                <a:lnTo>
                  <a:pt x="0" y="258445"/>
                </a:lnTo>
                <a:lnTo>
                  <a:pt x="0" y="0"/>
                </a:lnTo>
                <a:lnTo>
                  <a:pt x="120269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4" name="Freeform 114"/>
          <p:cNvSpPr/>
          <p:nvPr/>
        </p:nvSpPr>
        <p:spPr>
          <a:xfrm>
            <a:off x="1957997" y="2516818"/>
            <a:ext cx="240664" cy="258445"/>
          </a:xfrm>
          <a:custGeom>
            <a:avLst/>
            <a:gdLst/>
            <a:ahLst/>
            <a:cxnLst/>
            <a:rect l="0" t="0" r="0" b="0"/>
            <a:pathLst>
              <a:path w="240664" h="258445">
                <a:moveTo>
                  <a:pt x="120269" y="0"/>
                </a:moveTo>
                <a:lnTo>
                  <a:pt x="240664" y="0"/>
                </a:lnTo>
                <a:lnTo>
                  <a:pt x="240664" y="258445"/>
                </a:lnTo>
                <a:lnTo>
                  <a:pt x="0" y="258445"/>
                </a:lnTo>
                <a:lnTo>
                  <a:pt x="0" y="0"/>
                </a:lnTo>
                <a:lnTo>
                  <a:pt x="120269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5" name="Freeform 115"/>
          <p:cNvSpPr/>
          <p:nvPr/>
        </p:nvSpPr>
        <p:spPr>
          <a:xfrm>
            <a:off x="2198661" y="1431223"/>
            <a:ext cx="240665" cy="1344040"/>
          </a:xfrm>
          <a:custGeom>
            <a:avLst/>
            <a:gdLst/>
            <a:ahLst/>
            <a:cxnLst/>
            <a:rect l="0" t="0" r="0" b="0"/>
            <a:pathLst>
              <a:path w="240665" h="1344040">
                <a:moveTo>
                  <a:pt x="120397" y="0"/>
                </a:moveTo>
                <a:lnTo>
                  <a:pt x="240665" y="0"/>
                </a:lnTo>
                <a:lnTo>
                  <a:pt x="240665" y="1344040"/>
                </a:lnTo>
                <a:lnTo>
                  <a:pt x="0" y="1344040"/>
                </a:lnTo>
                <a:lnTo>
                  <a:pt x="0" y="0"/>
                </a:lnTo>
                <a:lnTo>
                  <a:pt x="120397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6" name="Freeform 116"/>
          <p:cNvSpPr/>
          <p:nvPr/>
        </p:nvSpPr>
        <p:spPr>
          <a:xfrm>
            <a:off x="2198661" y="1431223"/>
            <a:ext cx="240665" cy="1344040"/>
          </a:xfrm>
          <a:custGeom>
            <a:avLst/>
            <a:gdLst/>
            <a:ahLst/>
            <a:cxnLst/>
            <a:rect l="0" t="0" r="0" b="0"/>
            <a:pathLst>
              <a:path w="240665" h="1344040">
                <a:moveTo>
                  <a:pt x="120397" y="0"/>
                </a:moveTo>
                <a:lnTo>
                  <a:pt x="240665" y="0"/>
                </a:lnTo>
                <a:lnTo>
                  <a:pt x="240665" y="1344040"/>
                </a:lnTo>
                <a:lnTo>
                  <a:pt x="0" y="1344040"/>
                </a:lnTo>
                <a:lnTo>
                  <a:pt x="0" y="0"/>
                </a:lnTo>
                <a:lnTo>
                  <a:pt x="120397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7" name="Freeform 117"/>
          <p:cNvSpPr/>
          <p:nvPr/>
        </p:nvSpPr>
        <p:spPr>
          <a:xfrm>
            <a:off x="2439326" y="604071"/>
            <a:ext cx="240793" cy="2171192"/>
          </a:xfrm>
          <a:custGeom>
            <a:avLst/>
            <a:gdLst/>
            <a:ahLst/>
            <a:cxnLst/>
            <a:rect l="0" t="0" r="0" b="0"/>
            <a:pathLst>
              <a:path w="240793" h="2171192">
                <a:moveTo>
                  <a:pt x="120397" y="0"/>
                </a:moveTo>
                <a:lnTo>
                  <a:pt x="240793" y="0"/>
                </a:lnTo>
                <a:lnTo>
                  <a:pt x="240793" y="2171192"/>
                </a:lnTo>
                <a:lnTo>
                  <a:pt x="0" y="2171192"/>
                </a:lnTo>
                <a:lnTo>
                  <a:pt x="0" y="0"/>
                </a:lnTo>
                <a:lnTo>
                  <a:pt x="120397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8" name="Freeform 118"/>
          <p:cNvSpPr/>
          <p:nvPr/>
        </p:nvSpPr>
        <p:spPr>
          <a:xfrm>
            <a:off x="2439326" y="604071"/>
            <a:ext cx="240793" cy="2171192"/>
          </a:xfrm>
          <a:custGeom>
            <a:avLst/>
            <a:gdLst/>
            <a:ahLst/>
            <a:cxnLst/>
            <a:rect l="0" t="0" r="0" b="0"/>
            <a:pathLst>
              <a:path w="240793" h="2171192">
                <a:moveTo>
                  <a:pt x="120397" y="0"/>
                </a:moveTo>
                <a:lnTo>
                  <a:pt x="240793" y="0"/>
                </a:lnTo>
                <a:lnTo>
                  <a:pt x="240793" y="2171192"/>
                </a:lnTo>
                <a:lnTo>
                  <a:pt x="0" y="2171192"/>
                </a:lnTo>
                <a:lnTo>
                  <a:pt x="0" y="0"/>
                </a:lnTo>
                <a:lnTo>
                  <a:pt x="120397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9" name="Freeform 119"/>
          <p:cNvSpPr/>
          <p:nvPr/>
        </p:nvSpPr>
        <p:spPr>
          <a:xfrm>
            <a:off x="2680119" y="2051618"/>
            <a:ext cx="240664" cy="723645"/>
          </a:xfrm>
          <a:custGeom>
            <a:avLst/>
            <a:gdLst/>
            <a:ahLst/>
            <a:cxnLst/>
            <a:rect l="0" t="0" r="0" b="0"/>
            <a:pathLst>
              <a:path w="240664" h="723645">
                <a:moveTo>
                  <a:pt x="120395" y="0"/>
                </a:moveTo>
                <a:lnTo>
                  <a:pt x="240664" y="0"/>
                </a:lnTo>
                <a:lnTo>
                  <a:pt x="240664" y="723645"/>
                </a:lnTo>
                <a:lnTo>
                  <a:pt x="0" y="723645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0" name="Freeform 120"/>
          <p:cNvSpPr/>
          <p:nvPr/>
        </p:nvSpPr>
        <p:spPr>
          <a:xfrm>
            <a:off x="2680119" y="2051618"/>
            <a:ext cx="240664" cy="723645"/>
          </a:xfrm>
          <a:custGeom>
            <a:avLst/>
            <a:gdLst/>
            <a:ahLst/>
            <a:cxnLst/>
            <a:rect l="0" t="0" r="0" b="0"/>
            <a:pathLst>
              <a:path w="240664" h="723645">
                <a:moveTo>
                  <a:pt x="120395" y="0"/>
                </a:moveTo>
                <a:lnTo>
                  <a:pt x="240664" y="0"/>
                </a:lnTo>
                <a:lnTo>
                  <a:pt x="240664" y="723645"/>
                </a:lnTo>
                <a:lnTo>
                  <a:pt x="0" y="723645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1" name="Freeform 121"/>
          <p:cNvSpPr/>
          <p:nvPr/>
        </p:nvSpPr>
        <p:spPr>
          <a:xfrm>
            <a:off x="2920783" y="2189412"/>
            <a:ext cx="240793" cy="585851"/>
          </a:xfrm>
          <a:custGeom>
            <a:avLst/>
            <a:gdLst/>
            <a:ahLst/>
            <a:cxnLst/>
            <a:rect l="0" t="0" r="0" b="0"/>
            <a:pathLst>
              <a:path w="240793" h="585851">
                <a:moveTo>
                  <a:pt x="120396" y="0"/>
                </a:moveTo>
                <a:lnTo>
                  <a:pt x="240793" y="0"/>
                </a:lnTo>
                <a:lnTo>
                  <a:pt x="240793" y="585851"/>
                </a:lnTo>
                <a:lnTo>
                  <a:pt x="0" y="585851"/>
                </a:lnTo>
                <a:lnTo>
                  <a:pt x="0" y="0"/>
                </a:lnTo>
                <a:lnTo>
                  <a:pt x="120396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2" name="Freeform 122"/>
          <p:cNvSpPr/>
          <p:nvPr/>
        </p:nvSpPr>
        <p:spPr>
          <a:xfrm>
            <a:off x="2920783" y="2189412"/>
            <a:ext cx="240793" cy="585851"/>
          </a:xfrm>
          <a:custGeom>
            <a:avLst/>
            <a:gdLst/>
            <a:ahLst/>
            <a:cxnLst/>
            <a:rect l="0" t="0" r="0" b="0"/>
            <a:pathLst>
              <a:path w="240793" h="585851">
                <a:moveTo>
                  <a:pt x="120396" y="0"/>
                </a:moveTo>
                <a:lnTo>
                  <a:pt x="240793" y="0"/>
                </a:lnTo>
                <a:lnTo>
                  <a:pt x="240793" y="585851"/>
                </a:lnTo>
                <a:lnTo>
                  <a:pt x="0" y="585851"/>
                </a:lnTo>
                <a:lnTo>
                  <a:pt x="0" y="0"/>
                </a:lnTo>
                <a:lnTo>
                  <a:pt x="120396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3" name="Freeform 123"/>
          <p:cNvSpPr/>
          <p:nvPr/>
        </p:nvSpPr>
        <p:spPr>
          <a:xfrm>
            <a:off x="3161576" y="2241101"/>
            <a:ext cx="240665" cy="534162"/>
          </a:xfrm>
          <a:custGeom>
            <a:avLst/>
            <a:gdLst/>
            <a:ahLst/>
            <a:cxnLst/>
            <a:rect l="0" t="0" r="0" b="0"/>
            <a:pathLst>
              <a:path w="240665" h="534162">
                <a:moveTo>
                  <a:pt x="120396" y="0"/>
                </a:moveTo>
                <a:lnTo>
                  <a:pt x="240665" y="0"/>
                </a:lnTo>
                <a:lnTo>
                  <a:pt x="240665" y="534162"/>
                </a:lnTo>
                <a:lnTo>
                  <a:pt x="0" y="534162"/>
                </a:lnTo>
                <a:lnTo>
                  <a:pt x="0" y="0"/>
                </a:lnTo>
                <a:lnTo>
                  <a:pt x="120396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4" name="Freeform 124"/>
          <p:cNvSpPr/>
          <p:nvPr/>
        </p:nvSpPr>
        <p:spPr>
          <a:xfrm>
            <a:off x="3161576" y="2241101"/>
            <a:ext cx="240665" cy="534162"/>
          </a:xfrm>
          <a:custGeom>
            <a:avLst/>
            <a:gdLst/>
            <a:ahLst/>
            <a:cxnLst/>
            <a:rect l="0" t="0" r="0" b="0"/>
            <a:pathLst>
              <a:path w="240665" h="534162">
                <a:moveTo>
                  <a:pt x="120396" y="0"/>
                </a:moveTo>
                <a:lnTo>
                  <a:pt x="240665" y="0"/>
                </a:lnTo>
                <a:lnTo>
                  <a:pt x="240665" y="534162"/>
                </a:lnTo>
                <a:lnTo>
                  <a:pt x="0" y="534162"/>
                </a:lnTo>
                <a:lnTo>
                  <a:pt x="0" y="0"/>
                </a:lnTo>
                <a:lnTo>
                  <a:pt x="120396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5" name="Freeform 125"/>
          <p:cNvSpPr/>
          <p:nvPr/>
        </p:nvSpPr>
        <p:spPr>
          <a:xfrm>
            <a:off x="3402241" y="2551236"/>
            <a:ext cx="240791" cy="224027"/>
          </a:xfrm>
          <a:custGeom>
            <a:avLst/>
            <a:gdLst/>
            <a:ahLst/>
            <a:cxnLst/>
            <a:rect l="0" t="0" r="0" b="0"/>
            <a:pathLst>
              <a:path w="240791" h="224027">
                <a:moveTo>
                  <a:pt x="120395" y="0"/>
                </a:moveTo>
                <a:lnTo>
                  <a:pt x="240791" y="0"/>
                </a:lnTo>
                <a:lnTo>
                  <a:pt x="240791" y="224027"/>
                </a:lnTo>
                <a:lnTo>
                  <a:pt x="0" y="224027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6" name="Freeform 126"/>
          <p:cNvSpPr/>
          <p:nvPr/>
        </p:nvSpPr>
        <p:spPr>
          <a:xfrm>
            <a:off x="3402241" y="2551236"/>
            <a:ext cx="240791" cy="224027"/>
          </a:xfrm>
          <a:custGeom>
            <a:avLst/>
            <a:gdLst/>
            <a:ahLst/>
            <a:cxnLst/>
            <a:rect l="0" t="0" r="0" b="0"/>
            <a:pathLst>
              <a:path w="240791" h="224027">
                <a:moveTo>
                  <a:pt x="120395" y="0"/>
                </a:moveTo>
                <a:lnTo>
                  <a:pt x="240791" y="0"/>
                </a:lnTo>
                <a:lnTo>
                  <a:pt x="240791" y="224027"/>
                </a:lnTo>
                <a:lnTo>
                  <a:pt x="0" y="224027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7" name="Freeform 127"/>
          <p:cNvSpPr/>
          <p:nvPr/>
        </p:nvSpPr>
        <p:spPr>
          <a:xfrm>
            <a:off x="3643032" y="2758118"/>
            <a:ext cx="240666" cy="17145"/>
          </a:xfrm>
          <a:custGeom>
            <a:avLst/>
            <a:gdLst/>
            <a:ahLst/>
            <a:cxnLst/>
            <a:rect l="0" t="0" r="0" b="0"/>
            <a:pathLst>
              <a:path w="240666" h="17145">
                <a:moveTo>
                  <a:pt x="120269" y="0"/>
                </a:moveTo>
                <a:lnTo>
                  <a:pt x="240666" y="0"/>
                </a:lnTo>
                <a:lnTo>
                  <a:pt x="240666" y="17145"/>
                </a:lnTo>
                <a:lnTo>
                  <a:pt x="0" y="17145"/>
                </a:lnTo>
                <a:lnTo>
                  <a:pt x="0" y="0"/>
                </a:lnTo>
                <a:lnTo>
                  <a:pt x="120269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8" name="Freeform 128"/>
          <p:cNvSpPr/>
          <p:nvPr/>
        </p:nvSpPr>
        <p:spPr>
          <a:xfrm>
            <a:off x="3643032" y="2758118"/>
            <a:ext cx="240666" cy="17145"/>
          </a:xfrm>
          <a:custGeom>
            <a:avLst/>
            <a:gdLst/>
            <a:ahLst/>
            <a:cxnLst/>
            <a:rect l="0" t="0" r="0" b="0"/>
            <a:pathLst>
              <a:path w="240666" h="17145">
                <a:moveTo>
                  <a:pt x="120269" y="0"/>
                </a:moveTo>
                <a:lnTo>
                  <a:pt x="240666" y="0"/>
                </a:lnTo>
                <a:lnTo>
                  <a:pt x="240666" y="17145"/>
                </a:lnTo>
                <a:lnTo>
                  <a:pt x="0" y="17145"/>
                </a:lnTo>
                <a:lnTo>
                  <a:pt x="0" y="0"/>
                </a:lnTo>
                <a:lnTo>
                  <a:pt x="120269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9" name="Freeform 129"/>
          <p:cNvSpPr/>
          <p:nvPr/>
        </p:nvSpPr>
        <p:spPr>
          <a:xfrm>
            <a:off x="1476539" y="2775263"/>
            <a:ext cx="240666" cy="0"/>
          </a:xfrm>
          <a:custGeom>
            <a:avLst/>
            <a:gdLst/>
            <a:ahLst/>
            <a:cxnLst/>
            <a:rect l="0" t="0" r="0" b="0"/>
            <a:pathLst>
              <a:path w="240666">
                <a:moveTo>
                  <a:pt x="0" y="0"/>
                </a:moveTo>
                <a:lnTo>
                  <a:pt x="240666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0" name="Freeform 130"/>
          <p:cNvSpPr/>
          <p:nvPr/>
        </p:nvSpPr>
        <p:spPr>
          <a:xfrm>
            <a:off x="1717205" y="2775263"/>
            <a:ext cx="240792" cy="0"/>
          </a:xfrm>
          <a:custGeom>
            <a:avLst/>
            <a:gdLst/>
            <a:ahLst/>
            <a:cxnLst/>
            <a:rect l="0" t="0" r="0" b="0"/>
            <a:pathLst>
              <a:path w="240792">
                <a:moveTo>
                  <a:pt x="0" y="0"/>
                </a:moveTo>
                <a:lnTo>
                  <a:pt x="240792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1" name="Freeform 131"/>
          <p:cNvSpPr/>
          <p:nvPr/>
        </p:nvSpPr>
        <p:spPr>
          <a:xfrm>
            <a:off x="1957997" y="2719383"/>
            <a:ext cx="240664" cy="55880"/>
          </a:xfrm>
          <a:custGeom>
            <a:avLst/>
            <a:gdLst/>
            <a:ahLst/>
            <a:cxnLst/>
            <a:rect l="0" t="0" r="0" b="0"/>
            <a:pathLst>
              <a:path w="240664" h="55880">
                <a:moveTo>
                  <a:pt x="120269" y="0"/>
                </a:moveTo>
                <a:lnTo>
                  <a:pt x="240664" y="0"/>
                </a:lnTo>
                <a:lnTo>
                  <a:pt x="240664" y="55880"/>
                </a:lnTo>
                <a:lnTo>
                  <a:pt x="0" y="55880"/>
                </a:lnTo>
                <a:lnTo>
                  <a:pt x="0" y="0"/>
                </a:lnTo>
                <a:lnTo>
                  <a:pt x="120269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2" name="Freeform 132"/>
          <p:cNvSpPr/>
          <p:nvPr/>
        </p:nvSpPr>
        <p:spPr>
          <a:xfrm>
            <a:off x="1957997" y="2719383"/>
            <a:ext cx="240664" cy="55880"/>
          </a:xfrm>
          <a:custGeom>
            <a:avLst/>
            <a:gdLst/>
            <a:ahLst/>
            <a:cxnLst/>
            <a:rect l="0" t="0" r="0" b="0"/>
            <a:pathLst>
              <a:path w="240664" h="55880">
                <a:moveTo>
                  <a:pt x="120269" y="0"/>
                </a:moveTo>
                <a:lnTo>
                  <a:pt x="240664" y="0"/>
                </a:lnTo>
                <a:lnTo>
                  <a:pt x="240664" y="55880"/>
                </a:lnTo>
                <a:lnTo>
                  <a:pt x="0" y="55880"/>
                </a:lnTo>
                <a:lnTo>
                  <a:pt x="0" y="0"/>
                </a:lnTo>
                <a:lnTo>
                  <a:pt x="120269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3" name="Freeform 133"/>
          <p:cNvSpPr/>
          <p:nvPr/>
        </p:nvSpPr>
        <p:spPr>
          <a:xfrm>
            <a:off x="2198661" y="1937063"/>
            <a:ext cx="240665" cy="838200"/>
          </a:xfrm>
          <a:custGeom>
            <a:avLst/>
            <a:gdLst/>
            <a:ahLst/>
            <a:cxnLst/>
            <a:rect l="0" t="0" r="0" b="0"/>
            <a:pathLst>
              <a:path w="240665" h="838200">
                <a:moveTo>
                  <a:pt x="120397" y="0"/>
                </a:moveTo>
                <a:lnTo>
                  <a:pt x="240665" y="0"/>
                </a:lnTo>
                <a:lnTo>
                  <a:pt x="240665" y="838200"/>
                </a:lnTo>
                <a:lnTo>
                  <a:pt x="0" y="838200"/>
                </a:lnTo>
                <a:lnTo>
                  <a:pt x="0" y="0"/>
                </a:lnTo>
                <a:lnTo>
                  <a:pt x="120397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4" name="Freeform 134"/>
          <p:cNvSpPr/>
          <p:nvPr/>
        </p:nvSpPr>
        <p:spPr>
          <a:xfrm>
            <a:off x="2198661" y="1937063"/>
            <a:ext cx="240665" cy="838200"/>
          </a:xfrm>
          <a:custGeom>
            <a:avLst/>
            <a:gdLst/>
            <a:ahLst/>
            <a:cxnLst/>
            <a:rect l="0" t="0" r="0" b="0"/>
            <a:pathLst>
              <a:path w="240665" h="838200">
                <a:moveTo>
                  <a:pt x="120397" y="0"/>
                </a:moveTo>
                <a:lnTo>
                  <a:pt x="240665" y="0"/>
                </a:lnTo>
                <a:lnTo>
                  <a:pt x="240665" y="838200"/>
                </a:lnTo>
                <a:lnTo>
                  <a:pt x="0" y="838200"/>
                </a:lnTo>
                <a:lnTo>
                  <a:pt x="0" y="0"/>
                </a:lnTo>
                <a:lnTo>
                  <a:pt x="120397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5" name="Freeform 135"/>
          <p:cNvSpPr/>
          <p:nvPr/>
        </p:nvSpPr>
        <p:spPr>
          <a:xfrm>
            <a:off x="2439326" y="1098863"/>
            <a:ext cx="240793" cy="1676400"/>
          </a:xfrm>
          <a:custGeom>
            <a:avLst/>
            <a:gdLst/>
            <a:ahLst/>
            <a:cxnLst/>
            <a:rect l="0" t="0" r="0" b="0"/>
            <a:pathLst>
              <a:path w="240793" h="1676400">
                <a:moveTo>
                  <a:pt x="120397" y="0"/>
                </a:moveTo>
                <a:lnTo>
                  <a:pt x="240793" y="0"/>
                </a:lnTo>
                <a:lnTo>
                  <a:pt x="240793" y="1676400"/>
                </a:lnTo>
                <a:lnTo>
                  <a:pt x="0" y="1676400"/>
                </a:lnTo>
                <a:lnTo>
                  <a:pt x="0" y="0"/>
                </a:lnTo>
                <a:lnTo>
                  <a:pt x="120397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6" name="Freeform 136"/>
          <p:cNvSpPr/>
          <p:nvPr/>
        </p:nvSpPr>
        <p:spPr>
          <a:xfrm>
            <a:off x="2439326" y="1098863"/>
            <a:ext cx="240793" cy="1676400"/>
          </a:xfrm>
          <a:custGeom>
            <a:avLst/>
            <a:gdLst/>
            <a:ahLst/>
            <a:cxnLst/>
            <a:rect l="0" t="0" r="0" b="0"/>
            <a:pathLst>
              <a:path w="240793" h="1676400">
                <a:moveTo>
                  <a:pt x="120397" y="0"/>
                </a:moveTo>
                <a:lnTo>
                  <a:pt x="240793" y="0"/>
                </a:lnTo>
                <a:lnTo>
                  <a:pt x="240793" y="1676400"/>
                </a:lnTo>
                <a:lnTo>
                  <a:pt x="0" y="1676400"/>
                </a:lnTo>
                <a:lnTo>
                  <a:pt x="0" y="0"/>
                </a:lnTo>
                <a:lnTo>
                  <a:pt x="120397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7" name="Freeform 137"/>
          <p:cNvSpPr/>
          <p:nvPr/>
        </p:nvSpPr>
        <p:spPr>
          <a:xfrm>
            <a:off x="2680119" y="1992943"/>
            <a:ext cx="240664" cy="782320"/>
          </a:xfrm>
          <a:custGeom>
            <a:avLst/>
            <a:gdLst/>
            <a:ahLst/>
            <a:cxnLst/>
            <a:rect l="0" t="0" r="0" b="0"/>
            <a:pathLst>
              <a:path w="240664" h="782320">
                <a:moveTo>
                  <a:pt x="120395" y="0"/>
                </a:moveTo>
                <a:lnTo>
                  <a:pt x="240664" y="0"/>
                </a:lnTo>
                <a:lnTo>
                  <a:pt x="240664" y="782320"/>
                </a:lnTo>
                <a:lnTo>
                  <a:pt x="0" y="782320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8" name="Freeform 138"/>
          <p:cNvSpPr/>
          <p:nvPr/>
        </p:nvSpPr>
        <p:spPr>
          <a:xfrm>
            <a:off x="2680119" y="1992943"/>
            <a:ext cx="240664" cy="782320"/>
          </a:xfrm>
          <a:custGeom>
            <a:avLst/>
            <a:gdLst/>
            <a:ahLst/>
            <a:cxnLst/>
            <a:rect l="0" t="0" r="0" b="0"/>
            <a:pathLst>
              <a:path w="240664" h="782320">
                <a:moveTo>
                  <a:pt x="120395" y="0"/>
                </a:moveTo>
                <a:lnTo>
                  <a:pt x="240664" y="0"/>
                </a:lnTo>
                <a:lnTo>
                  <a:pt x="240664" y="782320"/>
                </a:lnTo>
                <a:lnTo>
                  <a:pt x="0" y="782320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9" name="Freeform 139"/>
          <p:cNvSpPr/>
          <p:nvPr/>
        </p:nvSpPr>
        <p:spPr>
          <a:xfrm>
            <a:off x="2920783" y="1937063"/>
            <a:ext cx="240793" cy="838200"/>
          </a:xfrm>
          <a:custGeom>
            <a:avLst/>
            <a:gdLst/>
            <a:ahLst/>
            <a:cxnLst/>
            <a:rect l="0" t="0" r="0" b="0"/>
            <a:pathLst>
              <a:path w="240793" h="838200">
                <a:moveTo>
                  <a:pt x="120396" y="0"/>
                </a:moveTo>
                <a:lnTo>
                  <a:pt x="240793" y="0"/>
                </a:lnTo>
                <a:lnTo>
                  <a:pt x="240793" y="838200"/>
                </a:lnTo>
                <a:lnTo>
                  <a:pt x="0" y="838200"/>
                </a:lnTo>
                <a:lnTo>
                  <a:pt x="0" y="0"/>
                </a:lnTo>
                <a:lnTo>
                  <a:pt x="120396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0" name="Freeform 140"/>
          <p:cNvSpPr/>
          <p:nvPr/>
        </p:nvSpPr>
        <p:spPr>
          <a:xfrm>
            <a:off x="2920783" y="1937063"/>
            <a:ext cx="240793" cy="838200"/>
          </a:xfrm>
          <a:custGeom>
            <a:avLst/>
            <a:gdLst/>
            <a:ahLst/>
            <a:cxnLst/>
            <a:rect l="0" t="0" r="0" b="0"/>
            <a:pathLst>
              <a:path w="240793" h="838200">
                <a:moveTo>
                  <a:pt x="120396" y="0"/>
                </a:moveTo>
                <a:lnTo>
                  <a:pt x="240793" y="0"/>
                </a:lnTo>
                <a:lnTo>
                  <a:pt x="240793" y="838200"/>
                </a:lnTo>
                <a:lnTo>
                  <a:pt x="0" y="838200"/>
                </a:lnTo>
                <a:lnTo>
                  <a:pt x="0" y="0"/>
                </a:lnTo>
                <a:lnTo>
                  <a:pt x="120396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1" name="Freeform 141"/>
          <p:cNvSpPr/>
          <p:nvPr/>
        </p:nvSpPr>
        <p:spPr>
          <a:xfrm>
            <a:off x="3161576" y="1601783"/>
            <a:ext cx="240665" cy="1173480"/>
          </a:xfrm>
          <a:custGeom>
            <a:avLst/>
            <a:gdLst/>
            <a:ahLst/>
            <a:cxnLst/>
            <a:rect l="0" t="0" r="0" b="0"/>
            <a:pathLst>
              <a:path w="240665" h="1173480">
                <a:moveTo>
                  <a:pt x="120396" y="0"/>
                </a:moveTo>
                <a:lnTo>
                  <a:pt x="240665" y="0"/>
                </a:lnTo>
                <a:lnTo>
                  <a:pt x="240665" y="1173480"/>
                </a:lnTo>
                <a:lnTo>
                  <a:pt x="0" y="1173480"/>
                </a:lnTo>
                <a:lnTo>
                  <a:pt x="0" y="0"/>
                </a:lnTo>
                <a:lnTo>
                  <a:pt x="120396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2" name="Freeform 142"/>
          <p:cNvSpPr/>
          <p:nvPr/>
        </p:nvSpPr>
        <p:spPr>
          <a:xfrm>
            <a:off x="3161576" y="1601783"/>
            <a:ext cx="240665" cy="1173480"/>
          </a:xfrm>
          <a:custGeom>
            <a:avLst/>
            <a:gdLst/>
            <a:ahLst/>
            <a:cxnLst/>
            <a:rect l="0" t="0" r="0" b="0"/>
            <a:pathLst>
              <a:path w="240665" h="1173480">
                <a:moveTo>
                  <a:pt x="120396" y="0"/>
                </a:moveTo>
                <a:lnTo>
                  <a:pt x="240665" y="0"/>
                </a:lnTo>
                <a:lnTo>
                  <a:pt x="240665" y="1173480"/>
                </a:lnTo>
                <a:lnTo>
                  <a:pt x="0" y="1173480"/>
                </a:lnTo>
                <a:lnTo>
                  <a:pt x="0" y="0"/>
                </a:lnTo>
                <a:lnTo>
                  <a:pt x="120396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3" name="Freeform 143"/>
          <p:cNvSpPr/>
          <p:nvPr/>
        </p:nvSpPr>
        <p:spPr>
          <a:xfrm>
            <a:off x="3402241" y="2216463"/>
            <a:ext cx="240791" cy="558800"/>
          </a:xfrm>
          <a:custGeom>
            <a:avLst/>
            <a:gdLst/>
            <a:ahLst/>
            <a:cxnLst/>
            <a:rect l="0" t="0" r="0" b="0"/>
            <a:pathLst>
              <a:path w="240791" h="558800">
                <a:moveTo>
                  <a:pt x="120395" y="0"/>
                </a:moveTo>
                <a:lnTo>
                  <a:pt x="240791" y="0"/>
                </a:lnTo>
                <a:lnTo>
                  <a:pt x="240791" y="558800"/>
                </a:lnTo>
                <a:lnTo>
                  <a:pt x="0" y="558800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4" name="Freeform 144"/>
          <p:cNvSpPr/>
          <p:nvPr/>
        </p:nvSpPr>
        <p:spPr>
          <a:xfrm>
            <a:off x="3402241" y="2216463"/>
            <a:ext cx="240791" cy="558800"/>
          </a:xfrm>
          <a:custGeom>
            <a:avLst/>
            <a:gdLst/>
            <a:ahLst/>
            <a:cxnLst/>
            <a:rect l="0" t="0" r="0" b="0"/>
            <a:pathLst>
              <a:path w="240791" h="558800">
                <a:moveTo>
                  <a:pt x="120395" y="0"/>
                </a:moveTo>
                <a:lnTo>
                  <a:pt x="240791" y="0"/>
                </a:lnTo>
                <a:lnTo>
                  <a:pt x="240791" y="558800"/>
                </a:lnTo>
                <a:lnTo>
                  <a:pt x="0" y="558800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5" name="Freeform 145"/>
          <p:cNvSpPr/>
          <p:nvPr/>
        </p:nvSpPr>
        <p:spPr>
          <a:xfrm>
            <a:off x="3643032" y="2719383"/>
            <a:ext cx="240666" cy="55880"/>
          </a:xfrm>
          <a:custGeom>
            <a:avLst/>
            <a:gdLst/>
            <a:ahLst/>
            <a:cxnLst/>
            <a:rect l="0" t="0" r="0" b="0"/>
            <a:pathLst>
              <a:path w="240666" h="55880">
                <a:moveTo>
                  <a:pt x="120269" y="0"/>
                </a:moveTo>
                <a:lnTo>
                  <a:pt x="240666" y="0"/>
                </a:lnTo>
                <a:lnTo>
                  <a:pt x="240666" y="55880"/>
                </a:lnTo>
                <a:lnTo>
                  <a:pt x="0" y="55880"/>
                </a:lnTo>
                <a:lnTo>
                  <a:pt x="0" y="0"/>
                </a:lnTo>
                <a:lnTo>
                  <a:pt x="120269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6" name="Freeform 146"/>
          <p:cNvSpPr/>
          <p:nvPr/>
        </p:nvSpPr>
        <p:spPr>
          <a:xfrm>
            <a:off x="3643032" y="2719383"/>
            <a:ext cx="240666" cy="55880"/>
          </a:xfrm>
          <a:custGeom>
            <a:avLst/>
            <a:gdLst/>
            <a:ahLst/>
            <a:cxnLst/>
            <a:rect l="0" t="0" r="0" b="0"/>
            <a:pathLst>
              <a:path w="240666" h="55880">
                <a:moveTo>
                  <a:pt x="120269" y="0"/>
                </a:moveTo>
                <a:lnTo>
                  <a:pt x="240666" y="0"/>
                </a:lnTo>
                <a:lnTo>
                  <a:pt x="240666" y="55880"/>
                </a:lnTo>
                <a:lnTo>
                  <a:pt x="0" y="55880"/>
                </a:lnTo>
                <a:lnTo>
                  <a:pt x="0" y="0"/>
                </a:lnTo>
                <a:lnTo>
                  <a:pt x="120269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7" name="Freeform 147"/>
          <p:cNvSpPr/>
          <p:nvPr/>
        </p:nvSpPr>
        <p:spPr>
          <a:xfrm>
            <a:off x="1476539" y="2775263"/>
            <a:ext cx="240666" cy="0"/>
          </a:xfrm>
          <a:custGeom>
            <a:avLst/>
            <a:gdLst/>
            <a:ahLst/>
            <a:cxnLst/>
            <a:rect l="0" t="0" r="0" b="0"/>
            <a:pathLst>
              <a:path w="240666">
                <a:moveTo>
                  <a:pt x="0" y="0"/>
                </a:moveTo>
                <a:lnTo>
                  <a:pt x="24066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8" name="Freeform 148"/>
          <p:cNvSpPr/>
          <p:nvPr/>
        </p:nvSpPr>
        <p:spPr>
          <a:xfrm>
            <a:off x="1717205" y="2775263"/>
            <a:ext cx="240792" cy="0"/>
          </a:xfrm>
          <a:custGeom>
            <a:avLst/>
            <a:gdLst/>
            <a:ahLst/>
            <a:cxnLst/>
            <a:rect l="0" t="0" r="0" b="0"/>
            <a:pathLst>
              <a:path w="240792">
                <a:moveTo>
                  <a:pt x="0" y="0"/>
                </a:moveTo>
                <a:lnTo>
                  <a:pt x="240792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9" name="Freeform 149"/>
          <p:cNvSpPr/>
          <p:nvPr/>
        </p:nvSpPr>
        <p:spPr>
          <a:xfrm>
            <a:off x="1957997" y="2613719"/>
            <a:ext cx="240664" cy="161544"/>
          </a:xfrm>
          <a:custGeom>
            <a:avLst/>
            <a:gdLst/>
            <a:ahLst/>
            <a:cxnLst/>
            <a:rect l="0" t="0" r="0" b="0"/>
            <a:pathLst>
              <a:path w="240664" h="161544">
                <a:moveTo>
                  <a:pt x="120269" y="0"/>
                </a:moveTo>
                <a:lnTo>
                  <a:pt x="240664" y="0"/>
                </a:lnTo>
                <a:lnTo>
                  <a:pt x="240664" y="161544"/>
                </a:lnTo>
                <a:lnTo>
                  <a:pt x="0" y="161544"/>
                </a:lnTo>
                <a:lnTo>
                  <a:pt x="0" y="0"/>
                </a:lnTo>
                <a:lnTo>
                  <a:pt x="120269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0" name="Freeform 150"/>
          <p:cNvSpPr/>
          <p:nvPr/>
        </p:nvSpPr>
        <p:spPr>
          <a:xfrm>
            <a:off x="1957997" y="2613719"/>
            <a:ext cx="240664" cy="161544"/>
          </a:xfrm>
          <a:custGeom>
            <a:avLst/>
            <a:gdLst/>
            <a:ahLst/>
            <a:cxnLst/>
            <a:rect l="0" t="0" r="0" b="0"/>
            <a:pathLst>
              <a:path w="240664" h="161544">
                <a:moveTo>
                  <a:pt x="120269" y="0"/>
                </a:moveTo>
                <a:lnTo>
                  <a:pt x="240664" y="0"/>
                </a:lnTo>
                <a:lnTo>
                  <a:pt x="240664" y="161544"/>
                </a:lnTo>
                <a:lnTo>
                  <a:pt x="0" y="161544"/>
                </a:lnTo>
                <a:lnTo>
                  <a:pt x="0" y="0"/>
                </a:lnTo>
                <a:lnTo>
                  <a:pt x="120269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1" name="Freeform 151"/>
          <p:cNvSpPr/>
          <p:nvPr/>
        </p:nvSpPr>
        <p:spPr>
          <a:xfrm>
            <a:off x="2198661" y="2290505"/>
            <a:ext cx="240665" cy="484758"/>
          </a:xfrm>
          <a:custGeom>
            <a:avLst/>
            <a:gdLst/>
            <a:ahLst/>
            <a:cxnLst/>
            <a:rect l="0" t="0" r="0" b="0"/>
            <a:pathLst>
              <a:path w="240665" h="484758">
                <a:moveTo>
                  <a:pt x="120397" y="0"/>
                </a:moveTo>
                <a:lnTo>
                  <a:pt x="240665" y="0"/>
                </a:lnTo>
                <a:lnTo>
                  <a:pt x="240665" y="484758"/>
                </a:lnTo>
                <a:lnTo>
                  <a:pt x="0" y="484758"/>
                </a:lnTo>
                <a:lnTo>
                  <a:pt x="0" y="0"/>
                </a:lnTo>
                <a:lnTo>
                  <a:pt x="120397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2" name="Freeform 152"/>
          <p:cNvSpPr/>
          <p:nvPr/>
        </p:nvSpPr>
        <p:spPr>
          <a:xfrm>
            <a:off x="2198661" y="2290505"/>
            <a:ext cx="240665" cy="484758"/>
          </a:xfrm>
          <a:custGeom>
            <a:avLst/>
            <a:gdLst/>
            <a:ahLst/>
            <a:cxnLst/>
            <a:rect l="0" t="0" r="0" b="0"/>
            <a:pathLst>
              <a:path w="240665" h="484758">
                <a:moveTo>
                  <a:pt x="120397" y="0"/>
                </a:moveTo>
                <a:lnTo>
                  <a:pt x="240665" y="0"/>
                </a:lnTo>
                <a:lnTo>
                  <a:pt x="240665" y="484758"/>
                </a:lnTo>
                <a:lnTo>
                  <a:pt x="0" y="484758"/>
                </a:lnTo>
                <a:lnTo>
                  <a:pt x="0" y="0"/>
                </a:lnTo>
                <a:lnTo>
                  <a:pt x="120397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3" name="Freeform 153"/>
          <p:cNvSpPr/>
          <p:nvPr/>
        </p:nvSpPr>
        <p:spPr>
          <a:xfrm>
            <a:off x="2439326" y="997645"/>
            <a:ext cx="240793" cy="1777618"/>
          </a:xfrm>
          <a:custGeom>
            <a:avLst/>
            <a:gdLst/>
            <a:ahLst/>
            <a:cxnLst/>
            <a:rect l="0" t="0" r="0" b="0"/>
            <a:pathLst>
              <a:path w="240793" h="1777618">
                <a:moveTo>
                  <a:pt x="120397" y="0"/>
                </a:moveTo>
                <a:lnTo>
                  <a:pt x="240793" y="0"/>
                </a:lnTo>
                <a:lnTo>
                  <a:pt x="240793" y="1777618"/>
                </a:lnTo>
                <a:lnTo>
                  <a:pt x="0" y="1777618"/>
                </a:lnTo>
                <a:lnTo>
                  <a:pt x="0" y="0"/>
                </a:lnTo>
                <a:lnTo>
                  <a:pt x="120397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4" name="Freeform 154"/>
          <p:cNvSpPr/>
          <p:nvPr/>
        </p:nvSpPr>
        <p:spPr>
          <a:xfrm>
            <a:off x="2439326" y="997645"/>
            <a:ext cx="240793" cy="1777618"/>
          </a:xfrm>
          <a:custGeom>
            <a:avLst/>
            <a:gdLst/>
            <a:ahLst/>
            <a:cxnLst/>
            <a:rect l="0" t="0" r="0" b="0"/>
            <a:pathLst>
              <a:path w="240793" h="1777618">
                <a:moveTo>
                  <a:pt x="120397" y="0"/>
                </a:moveTo>
                <a:lnTo>
                  <a:pt x="240793" y="0"/>
                </a:lnTo>
                <a:lnTo>
                  <a:pt x="240793" y="1777618"/>
                </a:lnTo>
                <a:lnTo>
                  <a:pt x="0" y="1777618"/>
                </a:lnTo>
                <a:lnTo>
                  <a:pt x="0" y="0"/>
                </a:lnTo>
                <a:lnTo>
                  <a:pt x="120397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5" name="Freeform 155"/>
          <p:cNvSpPr/>
          <p:nvPr/>
        </p:nvSpPr>
        <p:spPr>
          <a:xfrm>
            <a:off x="2680119" y="2452049"/>
            <a:ext cx="240664" cy="323214"/>
          </a:xfrm>
          <a:custGeom>
            <a:avLst/>
            <a:gdLst/>
            <a:ahLst/>
            <a:cxnLst/>
            <a:rect l="0" t="0" r="0" b="0"/>
            <a:pathLst>
              <a:path w="240664" h="323214">
                <a:moveTo>
                  <a:pt x="120395" y="0"/>
                </a:moveTo>
                <a:lnTo>
                  <a:pt x="240664" y="0"/>
                </a:lnTo>
                <a:lnTo>
                  <a:pt x="240664" y="323214"/>
                </a:lnTo>
                <a:lnTo>
                  <a:pt x="0" y="323214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6" name="Freeform 156"/>
          <p:cNvSpPr/>
          <p:nvPr/>
        </p:nvSpPr>
        <p:spPr>
          <a:xfrm>
            <a:off x="2680119" y="2452049"/>
            <a:ext cx="240664" cy="323214"/>
          </a:xfrm>
          <a:custGeom>
            <a:avLst/>
            <a:gdLst/>
            <a:ahLst/>
            <a:cxnLst/>
            <a:rect l="0" t="0" r="0" b="0"/>
            <a:pathLst>
              <a:path w="240664" h="323214">
                <a:moveTo>
                  <a:pt x="120395" y="0"/>
                </a:moveTo>
                <a:lnTo>
                  <a:pt x="240664" y="0"/>
                </a:lnTo>
                <a:lnTo>
                  <a:pt x="240664" y="323214"/>
                </a:lnTo>
                <a:lnTo>
                  <a:pt x="0" y="323214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7" name="Freeform 157"/>
          <p:cNvSpPr/>
          <p:nvPr/>
        </p:nvSpPr>
        <p:spPr>
          <a:xfrm>
            <a:off x="2920783" y="1967289"/>
            <a:ext cx="240793" cy="807974"/>
          </a:xfrm>
          <a:custGeom>
            <a:avLst/>
            <a:gdLst/>
            <a:ahLst/>
            <a:cxnLst/>
            <a:rect l="0" t="0" r="0" b="0"/>
            <a:pathLst>
              <a:path w="240793" h="807974">
                <a:moveTo>
                  <a:pt x="120396" y="0"/>
                </a:moveTo>
                <a:lnTo>
                  <a:pt x="240793" y="0"/>
                </a:lnTo>
                <a:lnTo>
                  <a:pt x="240793" y="807974"/>
                </a:lnTo>
                <a:lnTo>
                  <a:pt x="0" y="807974"/>
                </a:lnTo>
                <a:lnTo>
                  <a:pt x="0" y="0"/>
                </a:lnTo>
                <a:lnTo>
                  <a:pt x="120396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8" name="Freeform 158"/>
          <p:cNvSpPr/>
          <p:nvPr/>
        </p:nvSpPr>
        <p:spPr>
          <a:xfrm>
            <a:off x="2920783" y="1967289"/>
            <a:ext cx="240793" cy="807974"/>
          </a:xfrm>
          <a:custGeom>
            <a:avLst/>
            <a:gdLst/>
            <a:ahLst/>
            <a:cxnLst/>
            <a:rect l="0" t="0" r="0" b="0"/>
            <a:pathLst>
              <a:path w="240793" h="807974">
                <a:moveTo>
                  <a:pt x="120396" y="0"/>
                </a:moveTo>
                <a:lnTo>
                  <a:pt x="240793" y="0"/>
                </a:lnTo>
                <a:lnTo>
                  <a:pt x="240793" y="807974"/>
                </a:lnTo>
                <a:lnTo>
                  <a:pt x="0" y="807974"/>
                </a:lnTo>
                <a:lnTo>
                  <a:pt x="0" y="0"/>
                </a:lnTo>
                <a:lnTo>
                  <a:pt x="12039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9" name="Freeform 159"/>
          <p:cNvSpPr/>
          <p:nvPr/>
        </p:nvSpPr>
        <p:spPr>
          <a:xfrm>
            <a:off x="3161576" y="1805618"/>
            <a:ext cx="240665" cy="969645"/>
          </a:xfrm>
          <a:custGeom>
            <a:avLst/>
            <a:gdLst/>
            <a:ahLst/>
            <a:cxnLst/>
            <a:rect l="0" t="0" r="0" b="0"/>
            <a:pathLst>
              <a:path w="240665" h="969645">
                <a:moveTo>
                  <a:pt x="120396" y="0"/>
                </a:moveTo>
                <a:lnTo>
                  <a:pt x="240665" y="0"/>
                </a:lnTo>
                <a:lnTo>
                  <a:pt x="240665" y="969645"/>
                </a:lnTo>
                <a:lnTo>
                  <a:pt x="0" y="969645"/>
                </a:lnTo>
                <a:lnTo>
                  <a:pt x="0" y="0"/>
                </a:lnTo>
                <a:lnTo>
                  <a:pt x="120396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0" name="Freeform 160"/>
          <p:cNvSpPr/>
          <p:nvPr/>
        </p:nvSpPr>
        <p:spPr>
          <a:xfrm>
            <a:off x="3161576" y="1805618"/>
            <a:ext cx="240665" cy="969645"/>
          </a:xfrm>
          <a:custGeom>
            <a:avLst/>
            <a:gdLst/>
            <a:ahLst/>
            <a:cxnLst/>
            <a:rect l="0" t="0" r="0" b="0"/>
            <a:pathLst>
              <a:path w="240665" h="969645">
                <a:moveTo>
                  <a:pt x="120396" y="0"/>
                </a:moveTo>
                <a:lnTo>
                  <a:pt x="240665" y="0"/>
                </a:lnTo>
                <a:lnTo>
                  <a:pt x="240665" y="969645"/>
                </a:lnTo>
                <a:lnTo>
                  <a:pt x="0" y="969645"/>
                </a:lnTo>
                <a:lnTo>
                  <a:pt x="0" y="0"/>
                </a:lnTo>
                <a:lnTo>
                  <a:pt x="12039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1" name="Freeform 161"/>
          <p:cNvSpPr/>
          <p:nvPr/>
        </p:nvSpPr>
        <p:spPr>
          <a:xfrm>
            <a:off x="3402241" y="1320859"/>
            <a:ext cx="240791" cy="1454404"/>
          </a:xfrm>
          <a:custGeom>
            <a:avLst/>
            <a:gdLst/>
            <a:ahLst/>
            <a:cxnLst/>
            <a:rect l="0" t="0" r="0" b="0"/>
            <a:pathLst>
              <a:path w="240791" h="1454404">
                <a:moveTo>
                  <a:pt x="120395" y="0"/>
                </a:moveTo>
                <a:lnTo>
                  <a:pt x="240791" y="0"/>
                </a:lnTo>
                <a:lnTo>
                  <a:pt x="240791" y="1454404"/>
                </a:lnTo>
                <a:lnTo>
                  <a:pt x="0" y="1454404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2" name="Freeform 162"/>
          <p:cNvSpPr/>
          <p:nvPr/>
        </p:nvSpPr>
        <p:spPr>
          <a:xfrm>
            <a:off x="3402241" y="1320859"/>
            <a:ext cx="240791" cy="1454404"/>
          </a:xfrm>
          <a:custGeom>
            <a:avLst/>
            <a:gdLst/>
            <a:ahLst/>
            <a:cxnLst/>
            <a:rect l="0" t="0" r="0" b="0"/>
            <a:pathLst>
              <a:path w="240791" h="1454404">
                <a:moveTo>
                  <a:pt x="120395" y="0"/>
                </a:moveTo>
                <a:lnTo>
                  <a:pt x="240791" y="0"/>
                </a:lnTo>
                <a:lnTo>
                  <a:pt x="240791" y="1454404"/>
                </a:lnTo>
                <a:lnTo>
                  <a:pt x="0" y="1454404"/>
                </a:lnTo>
                <a:lnTo>
                  <a:pt x="0" y="0"/>
                </a:lnTo>
                <a:lnTo>
                  <a:pt x="120395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3" name="Freeform 163"/>
          <p:cNvSpPr/>
          <p:nvPr/>
        </p:nvSpPr>
        <p:spPr>
          <a:xfrm>
            <a:off x="3643032" y="2775263"/>
            <a:ext cx="240666" cy="0"/>
          </a:xfrm>
          <a:custGeom>
            <a:avLst/>
            <a:gdLst/>
            <a:ahLst/>
            <a:cxnLst/>
            <a:rect l="0" t="0" r="0" b="0"/>
            <a:pathLst>
              <a:path w="240666">
                <a:moveTo>
                  <a:pt x="0" y="0"/>
                </a:moveTo>
                <a:lnTo>
                  <a:pt x="24066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4" name="Freeform 164"/>
          <p:cNvSpPr/>
          <p:nvPr/>
        </p:nvSpPr>
        <p:spPr>
          <a:xfrm>
            <a:off x="1275499" y="665032"/>
            <a:ext cx="2746883" cy="2109724"/>
          </a:xfrm>
          <a:custGeom>
            <a:avLst/>
            <a:gdLst/>
            <a:ahLst/>
            <a:cxnLst/>
            <a:rect l="0" t="0" r="0" b="0"/>
            <a:pathLst>
              <a:path w="2746883" h="2109724">
                <a:moveTo>
                  <a:pt x="0" y="2109724"/>
                </a:moveTo>
                <a:lnTo>
                  <a:pt x="17018" y="2109469"/>
                </a:lnTo>
                <a:lnTo>
                  <a:pt x="33908" y="2109088"/>
                </a:lnTo>
                <a:lnTo>
                  <a:pt x="50926" y="2108580"/>
                </a:lnTo>
                <a:lnTo>
                  <a:pt x="67818" y="2107945"/>
                </a:lnTo>
                <a:lnTo>
                  <a:pt x="84836" y="2107311"/>
                </a:lnTo>
                <a:lnTo>
                  <a:pt x="101726" y="2106294"/>
                </a:lnTo>
                <a:lnTo>
                  <a:pt x="118744" y="2105279"/>
                </a:lnTo>
                <a:lnTo>
                  <a:pt x="135636" y="2104009"/>
                </a:lnTo>
                <a:lnTo>
                  <a:pt x="152654" y="2102485"/>
                </a:lnTo>
                <a:lnTo>
                  <a:pt x="169544" y="2100961"/>
                </a:lnTo>
                <a:lnTo>
                  <a:pt x="186562" y="2099182"/>
                </a:lnTo>
                <a:lnTo>
                  <a:pt x="203454" y="2097405"/>
                </a:lnTo>
                <a:lnTo>
                  <a:pt x="220472" y="2095373"/>
                </a:lnTo>
                <a:lnTo>
                  <a:pt x="237362" y="2093341"/>
                </a:lnTo>
                <a:lnTo>
                  <a:pt x="254381" y="2091309"/>
                </a:lnTo>
                <a:lnTo>
                  <a:pt x="271271" y="2089023"/>
                </a:lnTo>
                <a:lnTo>
                  <a:pt x="288290" y="2086736"/>
                </a:lnTo>
                <a:lnTo>
                  <a:pt x="305181" y="2084324"/>
                </a:lnTo>
                <a:lnTo>
                  <a:pt x="322198" y="2081784"/>
                </a:lnTo>
                <a:lnTo>
                  <a:pt x="339090" y="2078990"/>
                </a:lnTo>
                <a:lnTo>
                  <a:pt x="356107" y="2076068"/>
                </a:lnTo>
                <a:lnTo>
                  <a:pt x="373126" y="2072767"/>
                </a:lnTo>
                <a:lnTo>
                  <a:pt x="390017" y="2069211"/>
                </a:lnTo>
                <a:lnTo>
                  <a:pt x="407034" y="2065274"/>
                </a:lnTo>
                <a:lnTo>
                  <a:pt x="423926" y="2061210"/>
                </a:lnTo>
                <a:lnTo>
                  <a:pt x="440943" y="2056765"/>
                </a:lnTo>
                <a:lnTo>
                  <a:pt x="457834" y="2052192"/>
                </a:lnTo>
                <a:lnTo>
                  <a:pt x="491743" y="2042541"/>
                </a:lnTo>
                <a:lnTo>
                  <a:pt x="525653" y="2032507"/>
                </a:lnTo>
                <a:lnTo>
                  <a:pt x="559562" y="2021967"/>
                </a:lnTo>
                <a:lnTo>
                  <a:pt x="576579" y="2016379"/>
                </a:lnTo>
                <a:lnTo>
                  <a:pt x="593470" y="2010536"/>
                </a:lnTo>
                <a:lnTo>
                  <a:pt x="610489" y="2004186"/>
                </a:lnTo>
                <a:lnTo>
                  <a:pt x="627379" y="1996948"/>
                </a:lnTo>
                <a:lnTo>
                  <a:pt x="644398" y="1988819"/>
                </a:lnTo>
                <a:lnTo>
                  <a:pt x="661289" y="1979167"/>
                </a:lnTo>
                <a:lnTo>
                  <a:pt x="678307" y="1967865"/>
                </a:lnTo>
                <a:lnTo>
                  <a:pt x="695198" y="1954403"/>
                </a:lnTo>
                <a:lnTo>
                  <a:pt x="712215" y="1938274"/>
                </a:lnTo>
                <a:lnTo>
                  <a:pt x="729107" y="1919224"/>
                </a:lnTo>
                <a:lnTo>
                  <a:pt x="746124" y="1896872"/>
                </a:lnTo>
                <a:lnTo>
                  <a:pt x="763015" y="1870710"/>
                </a:lnTo>
                <a:lnTo>
                  <a:pt x="780034" y="1840484"/>
                </a:lnTo>
                <a:lnTo>
                  <a:pt x="796924" y="1805940"/>
                </a:lnTo>
                <a:lnTo>
                  <a:pt x="813943" y="1766824"/>
                </a:lnTo>
                <a:lnTo>
                  <a:pt x="830834" y="1722881"/>
                </a:lnTo>
                <a:lnTo>
                  <a:pt x="847851" y="1673860"/>
                </a:lnTo>
                <a:lnTo>
                  <a:pt x="864743" y="1619504"/>
                </a:lnTo>
                <a:lnTo>
                  <a:pt x="881760" y="1559686"/>
                </a:lnTo>
                <a:lnTo>
                  <a:pt x="898651" y="1493900"/>
                </a:lnTo>
                <a:lnTo>
                  <a:pt x="915670" y="1422018"/>
                </a:lnTo>
                <a:lnTo>
                  <a:pt x="932560" y="1343786"/>
                </a:lnTo>
                <a:lnTo>
                  <a:pt x="949579" y="1259331"/>
                </a:lnTo>
                <a:lnTo>
                  <a:pt x="966470" y="1168654"/>
                </a:lnTo>
                <a:lnTo>
                  <a:pt x="983487" y="1072261"/>
                </a:lnTo>
                <a:lnTo>
                  <a:pt x="1000506" y="970787"/>
                </a:lnTo>
                <a:lnTo>
                  <a:pt x="1034415" y="757300"/>
                </a:lnTo>
                <a:lnTo>
                  <a:pt x="1068324" y="540765"/>
                </a:lnTo>
                <a:lnTo>
                  <a:pt x="1085214" y="436626"/>
                </a:lnTo>
                <a:lnTo>
                  <a:pt x="1102233" y="338454"/>
                </a:lnTo>
                <a:lnTo>
                  <a:pt x="1119124" y="248665"/>
                </a:lnTo>
                <a:lnTo>
                  <a:pt x="1136142" y="169799"/>
                </a:lnTo>
                <a:lnTo>
                  <a:pt x="1153033" y="103759"/>
                </a:lnTo>
                <a:lnTo>
                  <a:pt x="1170051" y="52577"/>
                </a:lnTo>
                <a:lnTo>
                  <a:pt x="1186942" y="17652"/>
                </a:lnTo>
                <a:lnTo>
                  <a:pt x="1203959" y="0"/>
                </a:lnTo>
                <a:lnTo>
                  <a:pt x="1220851" y="0"/>
                </a:lnTo>
                <a:lnTo>
                  <a:pt x="1237868" y="17272"/>
                </a:lnTo>
                <a:lnTo>
                  <a:pt x="1254759" y="51307"/>
                </a:lnTo>
                <a:lnTo>
                  <a:pt x="1271777" y="100838"/>
                </a:lnTo>
                <a:lnTo>
                  <a:pt x="1288668" y="164211"/>
                </a:lnTo>
                <a:lnTo>
                  <a:pt x="1305686" y="239267"/>
                </a:lnTo>
                <a:lnTo>
                  <a:pt x="1322577" y="324103"/>
                </a:lnTo>
                <a:lnTo>
                  <a:pt x="1339596" y="416052"/>
                </a:lnTo>
                <a:lnTo>
                  <a:pt x="1373505" y="612139"/>
                </a:lnTo>
                <a:lnTo>
                  <a:pt x="1407414" y="809751"/>
                </a:lnTo>
                <a:lnTo>
                  <a:pt x="1424305" y="904367"/>
                </a:lnTo>
                <a:lnTo>
                  <a:pt x="1441323" y="994029"/>
                </a:lnTo>
                <a:lnTo>
                  <a:pt x="1458214" y="1077722"/>
                </a:lnTo>
                <a:lnTo>
                  <a:pt x="1475232" y="1154430"/>
                </a:lnTo>
                <a:lnTo>
                  <a:pt x="1492123" y="1223644"/>
                </a:lnTo>
                <a:lnTo>
                  <a:pt x="1509140" y="1285112"/>
                </a:lnTo>
                <a:lnTo>
                  <a:pt x="1526032" y="1338706"/>
                </a:lnTo>
                <a:lnTo>
                  <a:pt x="1543049" y="1384554"/>
                </a:lnTo>
                <a:lnTo>
                  <a:pt x="1559940" y="1422907"/>
                </a:lnTo>
                <a:lnTo>
                  <a:pt x="1576958" y="1454404"/>
                </a:lnTo>
                <a:lnTo>
                  <a:pt x="1593977" y="1479295"/>
                </a:lnTo>
                <a:lnTo>
                  <a:pt x="1610867" y="1498473"/>
                </a:lnTo>
                <a:lnTo>
                  <a:pt x="1627886" y="1512316"/>
                </a:lnTo>
                <a:lnTo>
                  <a:pt x="1644777" y="1521460"/>
                </a:lnTo>
                <a:lnTo>
                  <a:pt x="1661795" y="1526667"/>
                </a:lnTo>
                <a:lnTo>
                  <a:pt x="1678686" y="1528572"/>
                </a:lnTo>
                <a:lnTo>
                  <a:pt x="1695704" y="1527810"/>
                </a:lnTo>
                <a:lnTo>
                  <a:pt x="1712595" y="1525016"/>
                </a:lnTo>
                <a:lnTo>
                  <a:pt x="1729612" y="1520824"/>
                </a:lnTo>
                <a:lnTo>
                  <a:pt x="1763521" y="1511173"/>
                </a:lnTo>
                <a:lnTo>
                  <a:pt x="1780412" y="1506600"/>
                </a:lnTo>
                <a:lnTo>
                  <a:pt x="1797430" y="1502917"/>
                </a:lnTo>
                <a:lnTo>
                  <a:pt x="1814321" y="1500505"/>
                </a:lnTo>
                <a:lnTo>
                  <a:pt x="1831339" y="1499488"/>
                </a:lnTo>
                <a:lnTo>
                  <a:pt x="1848230" y="1499997"/>
                </a:lnTo>
                <a:lnTo>
                  <a:pt x="1865249" y="1502155"/>
                </a:lnTo>
                <a:lnTo>
                  <a:pt x="1882139" y="1505838"/>
                </a:lnTo>
                <a:lnTo>
                  <a:pt x="1899158" y="1511045"/>
                </a:lnTo>
                <a:lnTo>
                  <a:pt x="1916049" y="1517776"/>
                </a:lnTo>
                <a:lnTo>
                  <a:pt x="1933067" y="1526031"/>
                </a:lnTo>
                <a:lnTo>
                  <a:pt x="1949958" y="1535937"/>
                </a:lnTo>
                <a:lnTo>
                  <a:pt x="1966976" y="1547494"/>
                </a:lnTo>
                <a:lnTo>
                  <a:pt x="1983867" y="1560575"/>
                </a:lnTo>
                <a:lnTo>
                  <a:pt x="2000884" y="1575435"/>
                </a:lnTo>
                <a:lnTo>
                  <a:pt x="2017776" y="1591944"/>
                </a:lnTo>
                <a:lnTo>
                  <a:pt x="2034793" y="1610105"/>
                </a:lnTo>
                <a:lnTo>
                  <a:pt x="2051684" y="1629663"/>
                </a:lnTo>
                <a:lnTo>
                  <a:pt x="2068702" y="1650492"/>
                </a:lnTo>
                <a:lnTo>
                  <a:pt x="2102611" y="1694561"/>
                </a:lnTo>
                <a:lnTo>
                  <a:pt x="2204339" y="1828926"/>
                </a:lnTo>
                <a:lnTo>
                  <a:pt x="2238248" y="1870963"/>
                </a:lnTo>
                <a:lnTo>
                  <a:pt x="2272157" y="1911095"/>
                </a:lnTo>
                <a:lnTo>
                  <a:pt x="2289174" y="1930273"/>
                </a:lnTo>
                <a:lnTo>
                  <a:pt x="2306065" y="1948687"/>
                </a:lnTo>
                <a:lnTo>
                  <a:pt x="2323083" y="1966341"/>
                </a:lnTo>
                <a:lnTo>
                  <a:pt x="2339974" y="1982978"/>
                </a:lnTo>
                <a:lnTo>
                  <a:pt x="2356992" y="1998344"/>
                </a:lnTo>
                <a:lnTo>
                  <a:pt x="2373883" y="2012695"/>
                </a:lnTo>
                <a:lnTo>
                  <a:pt x="2390902" y="2025649"/>
                </a:lnTo>
                <a:lnTo>
                  <a:pt x="2407792" y="2037206"/>
                </a:lnTo>
                <a:lnTo>
                  <a:pt x="2424811" y="2047620"/>
                </a:lnTo>
                <a:lnTo>
                  <a:pt x="2441702" y="2056765"/>
                </a:lnTo>
                <a:lnTo>
                  <a:pt x="2458720" y="2064892"/>
                </a:lnTo>
                <a:lnTo>
                  <a:pt x="2475611" y="2071878"/>
                </a:lnTo>
                <a:lnTo>
                  <a:pt x="2492629" y="2077974"/>
                </a:lnTo>
                <a:lnTo>
                  <a:pt x="2509520" y="2083180"/>
                </a:lnTo>
                <a:lnTo>
                  <a:pt x="2526537" y="2087753"/>
                </a:lnTo>
                <a:lnTo>
                  <a:pt x="2543429" y="2091690"/>
                </a:lnTo>
                <a:lnTo>
                  <a:pt x="2560446" y="2095118"/>
                </a:lnTo>
                <a:lnTo>
                  <a:pt x="2577337" y="2098040"/>
                </a:lnTo>
                <a:lnTo>
                  <a:pt x="2594355" y="2100453"/>
                </a:lnTo>
                <a:lnTo>
                  <a:pt x="2611246" y="2102611"/>
                </a:lnTo>
                <a:lnTo>
                  <a:pt x="2628264" y="2104262"/>
                </a:lnTo>
                <a:lnTo>
                  <a:pt x="2645155" y="2105660"/>
                </a:lnTo>
                <a:lnTo>
                  <a:pt x="2662174" y="2106803"/>
                </a:lnTo>
                <a:lnTo>
                  <a:pt x="2679064" y="2107692"/>
                </a:lnTo>
                <a:lnTo>
                  <a:pt x="2696083" y="2108454"/>
                </a:lnTo>
                <a:lnTo>
                  <a:pt x="2712973" y="2108961"/>
                </a:lnTo>
                <a:lnTo>
                  <a:pt x="2729991" y="2109342"/>
                </a:lnTo>
                <a:lnTo>
                  <a:pt x="2746883" y="2109597"/>
                </a:lnTo>
              </a:path>
            </a:pathLst>
          </a:custGeom>
          <a:noFill/>
          <a:ln w="18288" cap="flat" cmpd="sng">
            <a:solidFill>
              <a:srgbClr val="445694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5" name="Freeform 165"/>
          <p:cNvSpPr/>
          <p:nvPr/>
        </p:nvSpPr>
        <p:spPr>
          <a:xfrm>
            <a:off x="1625892" y="1630231"/>
            <a:ext cx="2632710" cy="1143127"/>
          </a:xfrm>
          <a:custGeom>
            <a:avLst/>
            <a:gdLst/>
            <a:ahLst/>
            <a:cxnLst/>
            <a:rect l="0" t="0" r="0" b="0"/>
            <a:pathLst>
              <a:path w="2632710" h="1143127">
                <a:moveTo>
                  <a:pt x="0" y="1141604"/>
                </a:moveTo>
                <a:lnTo>
                  <a:pt x="11811" y="1140968"/>
                </a:lnTo>
                <a:lnTo>
                  <a:pt x="23749" y="1140333"/>
                </a:lnTo>
                <a:lnTo>
                  <a:pt x="35560" y="1139571"/>
                </a:lnTo>
                <a:lnTo>
                  <a:pt x="47497" y="1138682"/>
                </a:lnTo>
                <a:lnTo>
                  <a:pt x="59308" y="1137667"/>
                </a:lnTo>
                <a:lnTo>
                  <a:pt x="71119" y="1136524"/>
                </a:lnTo>
                <a:lnTo>
                  <a:pt x="83058" y="1135126"/>
                </a:lnTo>
                <a:lnTo>
                  <a:pt x="94869" y="1133602"/>
                </a:lnTo>
                <a:lnTo>
                  <a:pt x="106680" y="1131951"/>
                </a:lnTo>
                <a:lnTo>
                  <a:pt x="118617" y="1129919"/>
                </a:lnTo>
                <a:lnTo>
                  <a:pt x="130428" y="1127761"/>
                </a:lnTo>
                <a:lnTo>
                  <a:pt x="142366" y="1125348"/>
                </a:lnTo>
                <a:lnTo>
                  <a:pt x="154177" y="1122681"/>
                </a:lnTo>
                <a:lnTo>
                  <a:pt x="165989" y="1119506"/>
                </a:lnTo>
                <a:lnTo>
                  <a:pt x="177927" y="1116204"/>
                </a:lnTo>
                <a:lnTo>
                  <a:pt x="189738" y="1112393"/>
                </a:lnTo>
                <a:lnTo>
                  <a:pt x="201549" y="1108075"/>
                </a:lnTo>
                <a:lnTo>
                  <a:pt x="213486" y="1103504"/>
                </a:lnTo>
                <a:lnTo>
                  <a:pt x="225297" y="1098296"/>
                </a:lnTo>
                <a:lnTo>
                  <a:pt x="237236" y="1092581"/>
                </a:lnTo>
                <a:lnTo>
                  <a:pt x="249047" y="1086358"/>
                </a:lnTo>
                <a:lnTo>
                  <a:pt x="260858" y="1079627"/>
                </a:lnTo>
                <a:lnTo>
                  <a:pt x="272796" y="1072135"/>
                </a:lnTo>
                <a:lnTo>
                  <a:pt x="284606" y="1064006"/>
                </a:lnTo>
                <a:lnTo>
                  <a:pt x="296417" y="1055117"/>
                </a:lnTo>
                <a:lnTo>
                  <a:pt x="308355" y="1045464"/>
                </a:lnTo>
                <a:lnTo>
                  <a:pt x="320166" y="1035050"/>
                </a:lnTo>
                <a:lnTo>
                  <a:pt x="332105" y="1023875"/>
                </a:lnTo>
                <a:lnTo>
                  <a:pt x="343916" y="1011810"/>
                </a:lnTo>
                <a:lnTo>
                  <a:pt x="355727" y="998856"/>
                </a:lnTo>
                <a:lnTo>
                  <a:pt x="367664" y="984886"/>
                </a:lnTo>
                <a:lnTo>
                  <a:pt x="379475" y="970154"/>
                </a:lnTo>
                <a:lnTo>
                  <a:pt x="391414" y="954279"/>
                </a:lnTo>
                <a:lnTo>
                  <a:pt x="403225" y="937514"/>
                </a:lnTo>
                <a:lnTo>
                  <a:pt x="415036" y="919735"/>
                </a:lnTo>
                <a:lnTo>
                  <a:pt x="426974" y="900938"/>
                </a:lnTo>
                <a:lnTo>
                  <a:pt x="438785" y="881126"/>
                </a:lnTo>
                <a:lnTo>
                  <a:pt x="450596" y="860299"/>
                </a:lnTo>
                <a:lnTo>
                  <a:pt x="462533" y="838581"/>
                </a:lnTo>
                <a:lnTo>
                  <a:pt x="474344" y="815721"/>
                </a:lnTo>
                <a:lnTo>
                  <a:pt x="486283" y="792100"/>
                </a:lnTo>
                <a:lnTo>
                  <a:pt x="498094" y="767462"/>
                </a:lnTo>
                <a:lnTo>
                  <a:pt x="509905" y="741935"/>
                </a:lnTo>
                <a:lnTo>
                  <a:pt x="533653" y="688594"/>
                </a:lnTo>
                <a:lnTo>
                  <a:pt x="557402" y="632461"/>
                </a:lnTo>
                <a:lnTo>
                  <a:pt x="592963" y="544323"/>
                </a:lnTo>
                <a:lnTo>
                  <a:pt x="687831" y="307213"/>
                </a:lnTo>
                <a:lnTo>
                  <a:pt x="711580" y="252476"/>
                </a:lnTo>
                <a:lnTo>
                  <a:pt x="723391" y="226568"/>
                </a:lnTo>
                <a:lnTo>
                  <a:pt x="735330" y="201550"/>
                </a:lnTo>
                <a:lnTo>
                  <a:pt x="747140" y="177800"/>
                </a:lnTo>
                <a:lnTo>
                  <a:pt x="758952" y="155194"/>
                </a:lnTo>
                <a:lnTo>
                  <a:pt x="770890" y="133986"/>
                </a:lnTo>
                <a:lnTo>
                  <a:pt x="782700" y="114174"/>
                </a:lnTo>
                <a:lnTo>
                  <a:pt x="794512" y="95886"/>
                </a:lnTo>
                <a:lnTo>
                  <a:pt x="806449" y="79121"/>
                </a:lnTo>
                <a:lnTo>
                  <a:pt x="818261" y="63881"/>
                </a:lnTo>
                <a:lnTo>
                  <a:pt x="830199" y="50293"/>
                </a:lnTo>
                <a:lnTo>
                  <a:pt x="842009" y="38355"/>
                </a:lnTo>
                <a:lnTo>
                  <a:pt x="853821" y="28068"/>
                </a:lnTo>
                <a:lnTo>
                  <a:pt x="865759" y="19431"/>
                </a:lnTo>
                <a:lnTo>
                  <a:pt x="877569" y="12446"/>
                </a:lnTo>
                <a:lnTo>
                  <a:pt x="889381" y="6986"/>
                </a:lnTo>
                <a:lnTo>
                  <a:pt x="901318" y="3175"/>
                </a:lnTo>
                <a:lnTo>
                  <a:pt x="913130" y="889"/>
                </a:lnTo>
                <a:lnTo>
                  <a:pt x="925068" y="0"/>
                </a:lnTo>
                <a:lnTo>
                  <a:pt x="936878" y="508"/>
                </a:lnTo>
                <a:lnTo>
                  <a:pt x="948690" y="2287"/>
                </a:lnTo>
                <a:lnTo>
                  <a:pt x="960628" y="5335"/>
                </a:lnTo>
                <a:lnTo>
                  <a:pt x="972439" y="9399"/>
                </a:lnTo>
                <a:lnTo>
                  <a:pt x="984249" y="14606"/>
                </a:lnTo>
                <a:lnTo>
                  <a:pt x="996187" y="20701"/>
                </a:lnTo>
                <a:lnTo>
                  <a:pt x="1007999" y="27560"/>
                </a:lnTo>
                <a:lnTo>
                  <a:pt x="1019937" y="35180"/>
                </a:lnTo>
                <a:lnTo>
                  <a:pt x="1031747" y="43435"/>
                </a:lnTo>
                <a:lnTo>
                  <a:pt x="1043559" y="52070"/>
                </a:lnTo>
                <a:lnTo>
                  <a:pt x="1055496" y="61214"/>
                </a:lnTo>
                <a:lnTo>
                  <a:pt x="1079246" y="80264"/>
                </a:lnTo>
                <a:lnTo>
                  <a:pt x="1138428" y="128143"/>
                </a:lnTo>
                <a:lnTo>
                  <a:pt x="1150365" y="137161"/>
                </a:lnTo>
                <a:lnTo>
                  <a:pt x="1162177" y="145924"/>
                </a:lnTo>
                <a:lnTo>
                  <a:pt x="1174115" y="154306"/>
                </a:lnTo>
                <a:lnTo>
                  <a:pt x="1185925" y="162180"/>
                </a:lnTo>
                <a:lnTo>
                  <a:pt x="1197737" y="169673"/>
                </a:lnTo>
                <a:lnTo>
                  <a:pt x="1209674" y="176531"/>
                </a:lnTo>
                <a:lnTo>
                  <a:pt x="1221486" y="183007"/>
                </a:lnTo>
                <a:lnTo>
                  <a:pt x="1233296" y="188976"/>
                </a:lnTo>
                <a:lnTo>
                  <a:pt x="1245234" y="194437"/>
                </a:lnTo>
                <a:lnTo>
                  <a:pt x="1257046" y="199263"/>
                </a:lnTo>
                <a:lnTo>
                  <a:pt x="1268984" y="203708"/>
                </a:lnTo>
                <a:lnTo>
                  <a:pt x="1280794" y="207518"/>
                </a:lnTo>
                <a:lnTo>
                  <a:pt x="1292606" y="210820"/>
                </a:lnTo>
                <a:lnTo>
                  <a:pt x="1304543" y="213614"/>
                </a:lnTo>
                <a:lnTo>
                  <a:pt x="1316355" y="215900"/>
                </a:lnTo>
                <a:lnTo>
                  <a:pt x="1328165" y="217806"/>
                </a:lnTo>
                <a:lnTo>
                  <a:pt x="1340103" y="219330"/>
                </a:lnTo>
                <a:lnTo>
                  <a:pt x="1351915" y="220345"/>
                </a:lnTo>
                <a:lnTo>
                  <a:pt x="1363853" y="220981"/>
                </a:lnTo>
                <a:lnTo>
                  <a:pt x="1375664" y="221362"/>
                </a:lnTo>
                <a:lnTo>
                  <a:pt x="1387474" y="221488"/>
                </a:lnTo>
                <a:lnTo>
                  <a:pt x="1399412" y="221235"/>
                </a:lnTo>
                <a:lnTo>
                  <a:pt x="1411224" y="220854"/>
                </a:lnTo>
                <a:lnTo>
                  <a:pt x="1423162" y="220345"/>
                </a:lnTo>
                <a:lnTo>
                  <a:pt x="1434972" y="219583"/>
                </a:lnTo>
                <a:lnTo>
                  <a:pt x="1470533" y="217298"/>
                </a:lnTo>
                <a:lnTo>
                  <a:pt x="1482343" y="216662"/>
                </a:lnTo>
                <a:lnTo>
                  <a:pt x="1494281" y="216155"/>
                </a:lnTo>
                <a:lnTo>
                  <a:pt x="1506093" y="215900"/>
                </a:lnTo>
                <a:lnTo>
                  <a:pt x="1518031" y="215774"/>
                </a:lnTo>
                <a:lnTo>
                  <a:pt x="1529841" y="216027"/>
                </a:lnTo>
                <a:lnTo>
                  <a:pt x="1541653" y="216536"/>
                </a:lnTo>
                <a:lnTo>
                  <a:pt x="1553590" y="217551"/>
                </a:lnTo>
                <a:lnTo>
                  <a:pt x="1565402" y="218949"/>
                </a:lnTo>
                <a:lnTo>
                  <a:pt x="1577212" y="220854"/>
                </a:lnTo>
                <a:lnTo>
                  <a:pt x="1589150" y="223393"/>
                </a:lnTo>
                <a:lnTo>
                  <a:pt x="1600962" y="226442"/>
                </a:lnTo>
                <a:lnTo>
                  <a:pt x="1612899" y="230251"/>
                </a:lnTo>
                <a:lnTo>
                  <a:pt x="1624711" y="234569"/>
                </a:lnTo>
                <a:lnTo>
                  <a:pt x="1636521" y="239776"/>
                </a:lnTo>
                <a:lnTo>
                  <a:pt x="1648459" y="245618"/>
                </a:lnTo>
                <a:lnTo>
                  <a:pt x="1660271" y="252350"/>
                </a:lnTo>
                <a:lnTo>
                  <a:pt x="1672081" y="259843"/>
                </a:lnTo>
                <a:lnTo>
                  <a:pt x="1684019" y="268098"/>
                </a:lnTo>
                <a:lnTo>
                  <a:pt x="1695831" y="277242"/>
                </a:lnTo>
                <a:lnTo>
                  <a:pt x="1707768" y="287148"/>
                </a:lnTo>
                <a:lnTo>
                  <a:pt x="1719580" y="298069"/>
                </a:lnTo>
                <a:lnTo>
                  <a:pt x="1731390" y="309754"/>
                </a:lnTo>
                <a:lnTo>
                  <a:pt x="1743328" y="322200"/>
                </a:lnTo>
                <a:lnTo>
                  <a:pt x="1755140" y="335535"/>
                </a:lnTo>
                <a:lnTo>
                  <a:pt x="1767078" y="349758"/>
                </a:lnTo>
                <a:lnTo>
                  <a:pt x="1778889" y="364618"/>
                </a:lnTo>
                <a:lnTo>
                  <a:pt x="1790699" y="380366"/>
                </a:lnTo>
                <a:lnTo>
                  <a:pt x="1802637" y="396749"/>
                </a:lnTo>
                <a:lnTo>
                  <a:pt x="1814449" y="413893"/>
                </a:lnTo>
                <a:lnTo>
                  <a:pt x="1826259" y="431546"/>
                </a:lnTo>
                <a:lnTo>
                  <a:pt x="1850009" y="468757"/>
                </a:lnTo>
                <a:lnTo>
                  <a:pt x="1873758" y="507874"/>
                </a:lnTo>
                <a:lnTo>
                  <a:pt x="1909318" y="569214"/>
                </a:lnTo>
                <a:lnTo>
                  <a:pt x="2039746" y="795529"/>
                </a:lnTo>
                <a:lnTo>
                  <a:pt x="2063496" y="832993"/>
                </a:lnTo>
                <a:lnTo>
                  <a:pt x="2087244" y="868426"/>
                </a:lnTo>
                <a:lnTo>
                  <a:pt x="2099056" y="885444"/>
                </a:lnTo>
                <a:lnTo>
                  <a:pt x="2110993" y="901700"/>
                </a:lnTo>
                <a:lnTo>
                  <a:pt x="2122805" y="917449"/>
                </a:lnTo>
                <a:lnTo>
                  <a:pt x="2134615" y="932562"/>
                </a:lnTo>
                <a:lnTo>
                  <a:pt x="2146553" y="947039"/>
                </a:lnTo>
                <a:lnTo>
                  <a:pt x="2158365" y="960882"/>
                </a:lnTo>
                <a:lnTo>
                  <a:pt x="2170175" y="974091"/>
                </a:lnTo>
                <a:lnTo>
                  <a:pt x="2182114" y="986537"/>
                </a:lnTo>
                <a:lnTo>
                  <a:pt x="2193924" y="998475"/>
                </a:lnTo>
                <a:lnTo>
                  <a:pt x="2205862" y="1009777"/>
                </a:lnTo>
                <a:lnTo>
                  <a:pt x="2217674" y="1020445"/>
                </a:lnTo>
                <a:lnTo>
                  <a:pt x="2229484" y="1030479"/>
                </a:lnTo>
                <a:lnTo>
                  <a:pt x="2241422" y="1039876"/>
                </a:lnTo>
                <a:lnTo>
                  <a:pt x="2253234" y="1048767"/>
                </a:lnTo>
                <a:lnTo>
                  <a:pt x="2265044" y="1057021"/>
                </a:lnTo>
                <a:lnTo>
                  <a:pt x="2276983" y="1064768"/>
                </a:lnTo>
                <a:lnTo>
                  <a:pt x="2288793" y="1071881"/>
                </a:lnTo>
                <a:lnTo>
                  <a:pt x="2300731" y="1078612"/>
                </a:lnTo>
                <a:lnTo>
                  <a:pt x="2312543" y="1084835"/>
                </a:lnTo>
                <a:lnTo>
                  <a:pt x="2324353" y="1090550"/>
                </a:lnTo>
                <a:lnTo>
                  <a:pt x="2336291" y="1095756"/>
                </a:lnTo>
                <a:lnTo>
                  <a:pt x="2348103" y="1100710"/>
                </a:lnTo>
                <a:lnTo>
                  <a:pt x="2360041" y="1105155"/>
                </a:lnTo>
                <a:lnTo>
                  <a:pt x="2371852" y="1109218"/>
                </a:lnTo>
                <a:lnTo>
                  <a:pt x="2383662" y="1112901"/>
                </a:lnTo>
                <a:lnTo>
                  <a:pt x="2395600" y="1116331"/>
                </a:lnTo>
                <a:lnTo>
                  <a:pt x="2407411" y="1119506"/>
                </a:lnTo>
                <a:lnTo>
                  <a:pt x="2419223" y="1122300"/>
                </a:lnTo>
                <a:lnTo>
                  <a:pt x="2431160" y="1124839"/>
                </a:lnTo>
                <a:lnTo>
                  <a:pt x="2442972" y="1127125"/>
                </a:lnTo>
                <a:lnTo>
                  <a:pt x="2454910" y="1129157"/>
                </a:lnTo>
                <a:lnTo>
                  <a:pt x="2466721" y="1131062"/>
                </a:lnTo>
                <a:lnTo>
                  <a:pt x="2478531" y="1132713"/>
                </a:lnTo>
                <a:lnTo>
                  <a:pt x="2490469" y="1134237"/>
                </a:lnTo>
                <a:lnTo>
                  <a:pt x="2502280" y="1135635"/>
                </a:lnTo>
                <a:lnTo>
                  <a:pt x="2514092" y="1136777"/>
                </a:lnTo>
                <a:lnTo>
                  <a:pt x="2526029" y="1137793"/>
                </a:lnTo>
                <a:lnTo>
                  <a:pt x="2537841" y="1138810"/>
                </a:lnTo>
                <a:lnTo>
                  <a:pt x="2549779" y="1139571"/>
                </a:lnTo>
                <a:lnTo>
                  <a:pt x="2561590" y="1140333"/>
                </a:lnTo>
                <a:lnTo>
                  <a:pt x="2573400" y="1140968"/>
                </a:lnTo>
                <a:lnTo>
                  <a:pt x="2585339" y="1141476"/>
                </a:lnTo>
                <a:lnTo>
                  <a:pt x="2597149" y="1141985"/>
                </a:lnTo>
                <a:lnTo>
                  <a:pt x="2608960" y="1142493"/>
                </a:lnTo>
                <a:lnTo>
                  <a:pt x="2620898" y="1142874"/>
                </a:lnTo>
                <a:lnTo>
                  <a:pt x="2632710" y="1143127"/>
                </a:lnTo>
              </a:path>
            </a:pathLst>
          </a:custGeom>
          <a:noFill/>
          <a:ln w="18288" cap="flat" cmpd="sng">
            <a:solidFill>
              <a:srgbClr val="A23A2E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6" name="Freeform 166"/>
          <p:cNvSpPr/>
          <p:nvPr/>
        </p:nvSpPr>
        <p:spPr>
          <a:xfrm>
            <a:off x="1296581" y="1833177"/>
            <a:ext cx="2969767" cy="939547"/>
          </a:xfrm>
          <a:custGeom>
            <a:avLst/>
            <a:gdLst/>
            <a:ahLst/>
            <a:cxnLst/>
            <a:rect l="0" t="0" r="0" b="0"/>
            <a:pathLst>
              <a:path w="2969767" h="939547">
                <a:moveTo>
                  <a:pt x="0" y="939547"/>
                </a:moveTo>
                <a:lnTo>
                  <a:pt x="11811" y="939166"/>
                </a:lnTo>
                <a:lnTo>
                  <a:pt x="23622" y="938911"/>
                </a:lnTo>
                <a:lnTo>
                  <a:pt x="35305" y="938530"/>
                </a:lnTo>
                <a:lnTo>
                  <a:pt x="47116" y="938149"/>
                </a:lnTo>
                <a:lnTo>
                  <a:pt x="58927" y="937768"/>
                </a:lnTo>
                <a:lnTo>
                  <a:pt x="70738" y="937260"/>
                </a:lnTo>
                <a:lnTo>
                  <a:pt x="82550" y="936753"/>
                </a:lnTo>
                <a:lnTo>
                  <a:pt x="94233" y="936245"/>
                </a:lnTo>
                <a:lnTo>
                  <a:pt x="106044" y="935610"/>
                </a:lnTo>
                <a:lnTo>
                  <a:pt x="117855" y="934974"/>
                </a:lnTo>
                <a:lnTo>
                  <a:pt x="129666" y="934340"/>
                </a:lnTo>
                <a:lnTo>
                  <a:pt x="141477" y="933578"/>
                </a:lnTo>
                <a:lnTo>
                  <a:pt x="153162" y="932816"/>
                </a:lnTo>
                <a:lnTo>
                  <a:pt x="164973" y="931927"/>
                </a:lnTo>
                <a:lnTo>
                  <a:pt x="176783" y="930910"/>
                </a:lnTo>
                <a:lnTo>
                  <a:pt x="188594" y="929895"/>
                </a:lnTo>
                <a:lnTo>
                  <a:pt x="200405" y="928879"/>
                </a:lnTo>
                <a:lnTo>
                  <a:pt x="212090" y="927735"/>
                </a:lnTo>
                <a:lnTo>
                  <a:pt x="223901" y="926466"/>
                </a:lnTo>
                <a:lnTo>
                  <a:pt x="235711" y="925068"/>
                </a:lnTo>
                <a:lnTo>
                  <a:pt x="247522" y="923672"/>
                </a:lnTo>
                <a:lnTo>
                  <a:pt x="259333" y="922147"/>
                </a:lnTo>
                <a:lnTo>
                  <a:pt x="271017" y="920497"/>
                </a:lnTo>
                <a:lnTo>
                  <a:pt x="282828" y="918718"/>
                </a:lnTo>
                <a:lnTo>
                  <a:pt x="294639" y="916814"/>
                </a:lnTo>
                <a:lnTo>
                  <a:pt x="306450" y="914781"/>
                </a:lnTo>
                <a:lnTo>
                  <a:pt x="318261" y="912622"/>
                </a:lnTo>
                <a:lnTo>
                  <a:pt x="329946" y="910464"/>
                </a:lnTo>
                <a:lnTo>
                  <a:pt x="341757" y="908050"/>
                </a:lnTo>
                <a:lnTo>
                  <a:pt x="353567" y="905384"/>
                </a:lnTo>
                <a:lnTo>
                  <a:pt x="365378" y="902716"/>
                </a:lnTo>
                <a:lnTo>
                  <a:pt x="377189" y="899796"/>
                </a:lnTo>
                <a:lnTo>
                  <a:pt x="388874" y="896747"/>
                </a:lnTo>
                <a:lnTo>
                  <a:pt x="400685" y="893572"/>
                </a:lnTo>
                <a:lnTo>
                  <a:pt x="412496" y="890143"/>
                </a:lnTo>
                <a:lnTo>
                  <a:pt x="424307" y="886460"/>
                </a:lnTo>
                <a:lnTo>
                  <a:pt x="435991" y="882650"/>
                </a:lnTo>
                <a:lnTo>
                  <a:pt x="447802" y="878586"/>
                </a:lnTo>
                <a:lnTo>
                  <a:pt x="459613" y="874396"/>
                </a:lnTo>
                <a:lnTo>
                  <a:pt x="471424" y="869823"/>
                </a:lnTo>
                <a:lnTo>
                  <a:pt x="483235" y="865124"/>
                </a:lnTo>
                <a:lnTo>
                  <a:pt x="494919" y="860045"/>
                </a:lnTo>
                <a:lnTo>
                  <a:pt x="506730" y="854837"/>
                </a:lnTo>
                <a:lnTo>
                  <a:pt x="518541" y="849249"/>
                </a:lnTo>
                <a:lnTo>
                  <a:pt x="530352" y="843535"/>
                </a:lnTo>
                <a:lnTo>
                  <a:pt x="542163" y="837311"/>
                </a:lnTo>
                <a:lnTo>
                  <a:pt x="553847" y="830961"/>
                </a:lnTo>
                <a:lnTo>
                  <a:pt x="565658" y="824230"/>
                </a:lnTo>
                <a:lnTo>
                  <a:pt x="577469" y="817118"/>
                </a:lnTo>
                <a:lnTo>
                  <a:pt x="589280" y="809753"/>
                </a:lnTo>
                <a:lnTo>
                  <a:pt x="601091" y="802005"/>
                </a:lnTo>
                <a:lnTo>
                  <a:pt x="612775" y="794004"/>
                </a:lnTo>
                <a:lnTo>
                  <a:pt x="624586" y="785496"/>
                </a:lnTo>
                <a:lnTo>
                  <a:pt x="636397" y="776733"/>
                </a:lnTo>
                <a:lnTo>
                  <a:pt x="648208" y="767461"/>
                </a:lnTo>
                <a:lnTo>
                  <a:pt x="660019" y="757936"/>
                </a:lnTo>
                <a:lnTo>
                  <a:pt x="671702" y="748030"/>
                </a:lnTo>
                <a:lnTo>
                  <a:pt x="683513" y="737616"/>
                </a:lnTo>
                <a:lnTo>
                  <a:pt x="695325" y="726822"/>
                </a:lnTo>
                <a:lnTo>
                  <a:pt x="707136" y="715646"/>
                </a:lnTo>
                <a:lnTo>
                  <a:pt x="718947" y="704089"/>
                </a:lnTo>
                <a:lnTo>
                  <a:pt x="730630" y="692150"/>
                </a:lnTo>
                <a:lnTo>
                  <a:pt x="742441" y="679704"/>
                </a:lnTo>
                <a:lnTo>
                  <a:pt x="754252" y="667004"/>
                </a:lnTo>
                <a:lnTo>
                  <a:pt x="777875" y="640208"/>
                </a:lnTo>
                <a:lnTo>
                  <a:pt x="801369" y="611886"/>
                </a:lnTo>
                <a:lnTo>
                  <a:pt x="824991" y="582168"/>
                </a:lnTo>
                <a:lnTo>
                  <a:pt x="848486" y="551054"/>
                </a:lnTo>
                <a:lnTo>
                  <a:pt x="872108" y="518668"/>
                </a:lnTo>
                <a:lnTo>
                  <a:pt x="907414" y="468249"/>
                </a:lnTo>
                <a:lnTo>
                  <a:pt x="978153" y="363602"/>
                </a:lnTo>
                <a:lnTo>
                  <a:pt x="1037082" y="276987"/>
                </a:lnTo>
                <a:lnTo>
                  <a:pt x="1060704" y="243714"/>
                </a:lnTo>
                <a:lnTo>
                  <a:pt x="1084198" y="211710"/>
                </a:lnTo>
                <a:lnTo>
                  <a:pt x="1107820" y="181103"/>
                </a:lnTo>
                <a:lnTo>
                  <a:pt x="1119632" y="166497"/>
                </a:lnTo>
                <a:lnTo>
                  <a:pt x="1131316" y="152528"/>
                </a:lnTo>
                <a:lnTo>
                  <a:pt x="1143126" y="138939"/>
                </a:lnTo>
                <a:lnTo>
                  <a:pt x="1154938" y="125858"/>
                </a:lnTo>
                <a:lnTo>
                  <a:pt x="1166748" y="113411"/>
                </a:lnTo>
                <a:lnTo>
                  <a:pt x="1178432" y="101600"/>
                </a:lnTo>
                <a:lnTo>
                  <a:pt x="1190244" y="90424"/>
                </a:lnTo>
                <a:lnTo>
                  <a:pt x="1202054" y="79884"/>
                </a:lnTo>
                <a:lnTo>
                  <a:pt x="1213866" y="69978"/>
                </a:lnTo>
                <a:lnTo>
                  <a:pt x="1225676" y="60706"/>
                </a:lnTo>
                <a:lnTo>
                  <a:pt x="1237360" y="52197"/>
                </a:lnTo>
                <a:lnTo>
                  <a:pt x="1249172" y="44323"/>
                </a:lnTo>
                <a:lnTo>
                  <a:pt x="1260982" y="37085"/>
                </a:lnTo>
                <a:lnTo>
                  <a:pt x="1272794" y="30608"/>
                </a:lnTo>
                <a:lnTo>
                  <a:pt x="1284604" y="24766"/>
                </a:lnTo>
                <a:lnTo>
                  <a:pt x="1296289" y="19559"/>
                </a:lnTo>
                <a:lnTo>
                  <a:pt x="1308100" y="14986"/>
                </a:lnTo>
                <a:lnTo>
                  <a:pt x="1319910" y="11177"/>
                </a:lnTo>
                <a:lnTo>
                  <a:pt x="1331722" y="7874"/>
                </a:lnTo>
                <a:lnTo>
                  <a:pt x="1343532" y="5208"/>
                </a:lnTo>
                <a:lnTo>
                  <a:pt x="1355217" y="3175"/>
                </a:lnTo>
                <a:lnTo>
                  <a:pt x="1367027" y="1652"/>
                </a:lnTo>
                <a:lnTo>
                  <a:pt x="1378839" y="635"/>
                </a:lnTo>
                <a:lnTo>
                  <a:pt x="1390650" y="128"/>
                </a:lnTo>
                <a:lnTo>
                  <a:pt x="1402460" y="0"/>
                </a:lnTo>
                <a:lnTo>
                  <a:pt x="1414145" y="254"/>
                </a:lnTo>
                <a:lnTo>
                  <a:pt x="1425955" y="1016"/>
                </a:lnTo>
                <a:lnTo>
                  <a:pt x="1437767" y="2033"/>
                </a:lnTo>
                <a:lnTo>
                  <a:pt x="1449577" y="3429"/>
                </a:lnTo>
                <a:lnTo>
                  <a:pt x="1461389" y="5080"/>
                </a:lnTo>
                <a:lnTo>
                  <a:pt x="1473073" y="6859"/>
                </a:lnTo>
                <a:lnTo>
                  <a:pt x="1484883" y="8891"/>
                </a:lnTo>
                <a:lnTo>
                  <a:pt x="1496695" y="11049"/>
                </a:lnTo>
                <a:lnTo>
                  <a:pt x="1508505" y="13335"/>
                </a:lnTo>
                <a:lnTo>
                  <a:pt x="1579117" y="27179"/>
                </a:lnTo>
                <a:lnTo>
                  <a:pt x="1590929" y="29210"/>
                </a:lnTo>
                <a:lnTo>
                  <a:pt x="1602739" y="31116"/>
                </a:lnTo>
                <a:lnTo>
                  <a:pt x="1614551" y="32893"/>
                </a:lnTo>
                <a:lnTo>
                  <a:pt x="1626361" y="34417"/>
                </a:lnTo>
                <a:lnTo>
                  <a:pt x="1638045" y="35815"/>
                </a:lnTo>
                <a:lnTo>
                  <a:pt x="1649857" y="36830"/>
                </a:lnTo>
                <a:lnTo>
                  <a:pt x="1661667" y="37847"/>
                </a:lnTo>
                <a:lnTo>
                  <a:pt x="1673479" y="38481"/>
                </a:lnTo>
                <a:lnTo>
                  <a:pt x="1685289" y="38862"/>
                </a:lnTo>
                <a:lnTo>
                  <a:pt x="1696973" y="39116"/>
                </a:lnTo>
                <a:lnTo>
                  <a:pt x="1708785" y="39116"/>
                </a:lnTo>
                <a:lnTo>
                  <a:pt x="1720595" y="38862"/>
                </a:lnTo>
                <a:lnTo>
                  <a:pt x="1732407" y="38354"/>
                </a:lnTo>
                <a:lnTo>
                  <a:pt x="1744217" y="37720"/>
                </a:lnTo>
                <a:lnTo>
                  <a:pt x="1755901" y="36958"/>
                </a:lnTo>
                <a:lnTo>
                  <a:pt x="1767713" y="35941"/>
                </a:lnTo>
                <a:lnTo>
                  <a:pt x="1779523" y="34798"/>
                </a:lnTo>
                <a:lnTo>
                  <a:pt x="1791335" y="33655"/>
                </a:lnTo>
                <a:lnTo>
                  <a:pt x="1803145" y="32259"/>
                </a:lnTo>
                <a:lnTo>
                  <a:pt x="1850263" y="26797"/>
                </a:lnTo>
                <a:lnTo>
                  <a:pt x="1862073" y="25528"/>
                </a:lnTo>
                <a:lnTo>
                  <a:pt x="1873757" y="24385"/>
                </a:lnTo>
                <a:lnTo>
                  <a:pt x="1885569" y="23496"/>
                </a:lnTo>
                <a:lnTo>
                  <a:pt x="1897379" y="22734"/>
                </a:lnTo>
                <a:lnTo>
                  <a:pt x="1909191" y="22098"/>
                </a:lnTo>
                <a:lnTo>
                  <a:pt x="1921001" y="21845"/>
                </a:lnTo>
                <a:lnTo>
                  <a:pt x="1932685" y="21972"/>
                </a:lnTo>
                <a:lnTo>
                  <a:pt x="1944497" y="22353"/>
                </a:lnTo>
                <a:lnTo>
                  <a:pt x="1956307" y="23241"/>
                </a:lnTo>
                <a:lnTo>
                  <a:pt x="1968119" y="24511"/>
                </a:lnTo>
                <a:lnTo>
                  <a:pt x="1979802" y="26162"/>
                </a:lnTo>
                <a:lnTo>
                  <a:pt x="1991614" y="28448"/>
                </a:lnTo>
                <a:lnTo>
                  <a:pt x="2003425" y="31116"/>
                </a:lnTo>
                <a:lnTo>
                  <a:pt x="2015235" y="34417"/>
                </a:lnTo>
                <a:lnTo>
                  <a:pt x="2027047" y="38354"/>
                </a:lnTo>
                <a:lnTo>
                  <a:pt x="2038730" y="42927"/>
                </a:lnTo>
                <a:lnTo>
                  <a:pt x="2050542" y="48006"/>
                </a:lnTo>
                <a:lnTo>
                  <a:pt x="2062352" y="53848"/>
                </a:lnTo>
                <a:lnTo>
                  <a:pt x="2074164" y="60325"/>
                </a:lnTo>
                <a:lnTo>
                  <a:pt x="2085975" y="67437"/>
                </a:lnTo>
                <a:lnTo>
                  <a:pt x="2097658" y="75311"/>
                </a:lnTo>
                <a:lnTo>
                  <a:pt x="2109470" y="83821"/>
                </a:lnTo>
                <a:lnTo>
                  <a:pt x="2121280" y="93091"/>
                </a:lnTo>
                <a:lnTo>
                  <a:pt x="2133092" y="102997"/>
                </a:lnTo>
                <a:lnTo>
                  <a:pt x="2144902" y="113539"/>
                </a:lnTo>
                <a:lnTo>
                  <a:pt x="2156586" y="124841"/>
                </a:lnTo>
                <a:lnTo>
                  <a:pt x="2168398" y="136779"/>
                </a:lnTo>
                <a:lnTo>
                  <a:pt x="2180208" y="149353"/>
                </a:lnTo>
                <a:lnTo>
                  <a:pt x="2192020" y="162687"/>
                </a:lnTo>
                <a:lnTo>
                  <a:pt x="2203830" y="176530"/>
                </a:lnTo>
                <a:lnTo>
                  <a:pt x="2215514" y="190881"/>
                </a:lnTo>
                <a:lnTo>
                  <a:pt x="2227326" y="205867"/>
                </a:lnTo>
                <a:lnTo>
                  <a:pt x="2239136" y="221361"/>
                </a:lnTo>
                <a:lnTo>
                  <a:pt x="2262758" y="253873"/>
                </a:lnTo>
                <a:lnTo>
                  <a:pt x="2286254" y="287910"/>
                </a:lnTo>
                <a:lnTo>
                  <a:pt x="2309876" y="323342"/>
                </a:lnTo>
                <a:lnTo>
                  <a:pt x="2356992" y="396748"/>
                </a:lnTo>
                <a:lnTo>
                  <a:pt x="2451226" y="544322"/>
                </a:lnTo>
                <a:lnTo>
                  <a:pt x="2474848" y="579374"/>
                </a:lnTo>
                <a:lnTo>
                  <a:pt x="2498344" y="613156"/>
                </a:lnTo>
                <a:lnTo>
                  <a:pt x="2521966" y="645415"/>
                </a:lnTo>
                <a:lnTo>
                  <a:pt x="2545588" y="676148"/>
                </a:lnTo>
                <a:lnTo>
                  <a:pt x="2557272" y="690754"/>
                </a:lnTo>
                <a:lnTo>
                  <a:pt x="2569082" y="704978"/>
                </a:lnTo>
                <a:lnTo>
                  <a:pt x="2580894" y="718566"/>
                </a:lnTo>
                <a:lnTo>
                  <a:pt x="2592704" y="731774"/>
                </a:lnTo>
                <a:lnTo>
                  <a:pt x="2604516" y="744474"/>
                </a:lnTo>
                <a:lnTo>
                  <a:pt x="2616200" y="756793"/>
                </a:lnTo>
                <a:lnTo>
                  <a:pt x="2628010" y="768478"/>
                </a:lnTo>
                <a:lnTo>
                  <a:pt x="2639822" y="779654"/>
                </a:lnTo>
                <a:lnTo>
                  <a:pt x="2651632" y="790322"/>
                </a:lnTo>
                <a:lnTo>
                  <a:pt x="2663444" y="800609"/>
                </a:lnTo>
                <a:lnTo>
                  <a:pt x="2675128" y="810260"/>
                </a:lnTo>
                <a:lnTo>
                  <a:pt x="2686939" y="819531"/>
                </a:lnTo>
                <a:lnTo>
                  <a:pt x="2698750" y="828167"/>
                </a:lnTo>
                <a:lnTo>
                  <a:pt x="2710560" y="836549"/>
                </a:lnTo>
                <a:lnTo>
                  <a:pt x="2722245" y="844297"/>
                </a:lnTo>
                <a:lnTo>
                  <a:pt x="2734055" y="851662"/>
                </a:lnTo>
                <a:lnTo>
                  <a:pt x="2745866" y="858647"/>
                </a:lnTo>
                <a:lnTo>
                  <a:pt x="2757678" y="865124"/>
                </a:lnTo>
                <a:lnTo>
                  <a:pt x="2769489" y="871347"/>
                </a:lnTo>
                <a:lnTo>
                  <a:pt x="2781172" y="877062"/>
                </a:lnTo>
                <a:lnTo>
                  <a:pt x="2792984" y="882397"/>
                </a:lnTo>
                <a:lnTo>
                  <a:pt x="2804795" y="887349"/>
                </a:lnTo>
                <a:lnTo>
                  <a:pt x="2816605" y="892048"/>
                </a:lnTo>
                <a:lnTo>
                  <a:pt x="2828416" y="896366"/>
                </a:lnTo>
                <a:lnTo>
                  <a:pt x="2840101" y="900430"/>
                </a:lnTo>
                <a:lnTo>
                  <a:pt x="2851911" y="904114"/>
                </a:lnTo>
                <a:lnTo>
                  <a:pt x="2863722" y="907542"/>
                </a:lnTo>
                <a:lnTo>
                  <a:pt x="2875534" y="910717"/>
                </a:lnTo>
                <a:lnTo>
                  <a:pt x="2887345" y="913639"/>
                </a:lnTo>
                <a:lnTo>
                  <a:pt x="2899028" y="916305"/>
                </a:lnTo>
                <a:lnTo>
                  <a:pt x="2910840" y="918846"/>
                </a:lnTo>
                <a:lnTo>
                  <a:pt x="2922651" y="921131"/>
                </a:lnTo>
                <a:lnTo>
                  <a:pt x="2934461" y="923164"/>
                </a:lnTo>
                <a:lnTo>
                  <a:pt x="2946272" y="925068"/>
                </a:lnTo>
                <a:lnTo>
                  <a:pt x="2957957" y="926847"/>
                </a:lnTo>
                <a:lnTo>
                  <a:pt x="2969767" y="928371"/>
                </a:lnTo>
              </a:path>
            </a:pathLst>
          </a:custGeom>
          <a:noFill/>
          <a:ln w="18288" cap="flat" cmpd="sng">
            <a:solidFill>
              <a:srgbClr val="01665E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7" name="Freeform 167"/>
          <p:cNvSpPr/>
          <p:nvPr/>
        </p:nvSpPr>
        <p:spPr>
          <a:xfrm>
            <a:off x="1205394" y="2805743"/>
            <a:ext cx="3091434" cy="0"/>
          </a:xfrm>
          <a:custGeom>
            <a:avLst/>
            <a:gdLst/>
            <a:ahLst/>
            <a:cxnLst/>
            <a:rect l="0" t="0" r="0" b="0"/>
            <a:pathLst>
              <a:path w="3091434">
                <a:moveTo>
                  <a:pt x="0" y="0"/>
                </a:moveTo>
                <a:lnTo>
                  <a:pt x="3091434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8" name="Freeform 168"/>
          <p:cNvSpPr/>
          <p:nvPr/>
        </p:nvSpPr>
        <p:spPr>
          <a:xfrm>
            <a:off x="4296828" y="573719"/>
            <a:ext cx="0" cy="2232024"/>
          </a:xfrm>
          <a:custGeom>
            <a:avLst/>
            <a:gdLst/>
            <a:ahLst/>
            <a:cxnLst/>
            <a:rect l="0" t="0" r="0" b="0"/>
            <a:pathLst>
              <a:path h="2232024">
                <a:moveTo>
                  <a:pt x="0" y="2232024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9" name="Freeform 169"/>
          <p:cNvSpPr/>
          <p:nvPr/>
        </p:nvSpPr>
        <p:spPr>
          <a:xfrm>
            <a:off x="1205394" y="573719"/>
            <a:ext cx="3091434" cy="0"/>
          </a:xfrm>
          <a:custGeom>
            <a:avLst/>
            <a:gdLst/>
            <a:ahLst/>
            <a:cxnLst/>
            <a:rect l="0" t="0" r="0" b="0"/>
            <a:pathLst>
              <a:path w="3091434">
                <a:moveTo>
                  <a:pt x="0" y="0"/>
                </a:moveTo>
                <a:lnTo>
                  <a:pt x="3091434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0" name="Freeform 170"/>
          <p:cNvSpPr/>
          <p:nvPr/>
        </p:nvSpPr>
        <p:spPr>
          <a:xfrm>
            <a:off x="1205394" y="573719"/>
            <a:ext cx="0" cy="2232024"/>
          </a:xfrm>
          <a:custGeom>
            <a:avLst/>
            <a:gdLst/>
            <a:ahLst/>
            <a:cxnLst/>
            <a:rect l="0" t="0" r="0" b="0"/>
            <a:pathLst>
              <a:path h="2232024">
                <a:moveTo>
                  <a:pt x="0" y="2232024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1" name="Freeform 171"/>
          <p:cNvSpPr/>
          <p:nvPr/>
        </p:nvSpPr>
        <p:spPr>
          <a:xfrm>
            <a:off x="1205394" y="2805743"/>
            <a:ext cx="3091434" cy="0"/>
          </a:xfrm>
          <a:custGeom>
            <a:avLst/>
            <a:gdLst/>
            <a:ahLst/>
            <a:cxnLst/>
            <a:rect l="0" t="0" r="0" b="0"/>
            <a:pathLst>
              <a:path w="3091434">
                <a:moveTo>
                  <a:pt x="0" y="0"/>
                </a:moveTo>
                <a:lnTo>
                  <a:pt x="3091434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2" name="Freeform 172"/>
          <p:cNvSpPr/>
          <p:nvPr/>
        </p:nvSpPr>
        <p:spPr>
          <a:xfrm>
            <a:off x="1235747" y="280574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3" name="Freeform 173"/>
          <p:cNvSpPr/>
          <p:nvPr/>
        </p:nvSpPr>
        <p:spPr>
          <a:xfrm>
            <a:off x="1837600" y="280574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4" name="Freeform 174"/>
          <p:cNvSpPr/>
          <p:nvPr/>
        </p:nvSpPr>
        <p:spPr>
          <a:xfrm>
            <a:off x="2439326" y="280574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5" name="Freeform 175"/>
          <p:cNvSpPr/>
          <p:nvPr/>
        </p:nvSpPr>
        <p:spPr>
          <a:xfrm>
            <a:off x="3041179" y="280574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6" name="Freeform 176"/>
          <p:cNvSpPr/>
          <p:nvPr/>
        </p:nvSpPr>
        <p:spPr>
          <a:xfrm>
            <a:off x="3643032" y="280574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7" name="Freeform 177"/>
          <p:cNvSpPr/>
          <p:nvPr/>
        </p:nvSpPr>
        <p:spPr>
          <a:xfrm>
            <a:off x="4244759" y="280574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8" name="Freeform 178"/>
          <p:cNvSpPr/>
          <p:nvPr/>
        </p:nvSpPr>
        <p:spPr>
          <a:xfrm>
            <a:off x="1205394" y="573719"/>
            <a:ext cx="0" cy="2232024"/>
          </a:xfrm>
          <a:custGeom>
            <a:avLst/>
            <a:gdLst/>
            <a:ahLst/>
            <a:cxnLst/>
            <a:rect l="0" t="0" r="0" b="0"/>
            <a:pathLst>
              <a:path h="2232024">
                <a:moveTo>
                  <a:pt x="0" y="2232024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79" name="Freeform 179"/>
          <p:cNvSpPr/>
          <p:nvPr/>
        </p:nvSpPr>
        <p:spPr>
          <a:xfrm>
            <a:off x="1159039" y="2775263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0" name="Freeform 180"/>
          <p:cNvSpPr/>
          <p:nvPr/>
        </p:nvSpPr>
        <p:spPr>
          <a:xfrm>
            <a:off x="1159039" y="2177348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1" name="Freeform 181"/>
          <p:cNvSpPr/>
          <p:nvPr/>
        </p:nvSpPr>
        <p:spPr>
          <a:xfrm>
            <a:off x="1159039" y="1579431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2" name="Freeform 182"/>
          <p:cNvSpPr/>
          <p:nvPr/>
        </p:nvSpPr>
        <p:spPr>
          <a:xfrm>
            <a:off x="1159039" y="981388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3" name="Freeform 183"/>
          <p:cNvSpPr/>
          <p:nvPr/>
        </p:nvSpPr>
        <p:spPr>
          <a:xfrm>
            <a:off x="4552860" y="518727"/>
            <a:ext cx="3651377" cy="2737231"/>
          </a:xfrm>
          <a:custGeom>
            <a:avLst/>
            <a:gdLst/>
            <a:ahLst/>
            <a:cxnLst/>
            <a:rect l="0" t="0" r="0" b="0"/>
            <a:pathLst>
              <a:path w="3651377" h="2737231">
                <a:moveTo>
                  <a:pt x="1825625" y="0"/>
                </a:moveTo>
                <a:lnTo>
                  <a:pt x="3651377" y="0"/>
                </a:lnTo>
                <a:lnTo>
                  <a:pt x="3651377" y="2737231"/>
                </a:lnTo>
                <a:lnTo>
                  <a:pt x="0" y="2737231"/>
                </a:lnTo>
                <a:lnTo>
                  <a:pt x="0" y="0"/>
                </a:lnTo>
                <a:lnTo>
                  <a:pt x="1825625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4" name="Freeform 184"/>
          <p:cNvSpPr/>
          <p:nvPr/>
        </p:nvSpPr>
        <p:spPr>
          <a:xfrm>
            <a:off x="4552860" y="518727"/>
            <a:ext cx="3651377" cy="2737231"/>
          </a:xfrm>
          <a:custGeom>
            <a:avLst/>
            <a:gdLst/>
            <a:ahLst/>
            <a:cxnLst/>
            <a:rect l="0" t="0" r="0" b="0"/>
            <a:pathLst>
              <a:path w="3651377" h="2737231">
                <a:moveTo>
                  <a:pt x="1825625" y="0"/>
                </a:moveTo>
                <a:lnTo>
                  <a:pt x="3651377" y="0"/>
                </a:lnTo>
                <a:lnTo>
                  <a:pt x="3651377" y="2737231"/>
                </a:lnTo>
                <a:lnTo>
                  <a:pt x="0" y="2737231"/>
                </a:lnTo>
                <a:lnTo>
                  <a:pt x="0" y="0"/>
                </a:lnTo>
                <a:lnTo>
                  <a:pt x="1825625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5" name="Freeform 185"/>
          <p:cNvSpPr/>
          <p:nvPr/>
        </p:nvSpPr>
        <p:spPr>
          <a:xfrm>
            <a:off x="4552860" y="518727"/>
            <a:ext cx="3596513" cy="48895"/>
          </a:xfrm>
          <a:custGeom>
            <a:avLst/>
            <a:gdLst/>
            <a:ahLst/>
            <a:cxnLst/>
            <a:rect l="0" t="0" r="0" b="0"/>
            <a:pathLst>
              <a:path w="3596513" h="48895">
                <a:moveTo>
                  <a:pt x="1798192" y="0"/>
                </a:moveTo>
                <a:lnTo>
                  <a:pt x="3596513" y="0"/>
                </a:lnTo>
                <a:lnTo>
                  <a:pt x="3596513" y="48895"/>
                </a:lnTo>
                <a:lnTo>
                  <a:pt x="0" y="48895"/>
                </a:lnTo>
                <a:lnTo>
                  <a:pt x="0" y="0"/>
                </a:lnTo>
                <a:lnTo>
                  <a:pt x="1798192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6" name="Freeform 186"/>
          <p:cNvSpPr/>
          <p:nvPr/>
        </p:nvSpPr>
        <p:spPr>
          <a:xfrm>
            <a:off x="4552860" y="573719"/>
            <a:ext cx="48640" cy="2682239"/>
          </a:xfrm>
          <a:custGeom>
            <a:avLst/>
            <a:gdLst/>
            <a:ahLst/>
            <a:cxnLst/>
            <a:rect l="0" t="0" r="0" b="0"/>
            <a:pathLst>
              <a:path w="48640" h="2682239">
                <a:moveTo>
                  <a:pt x="24256" y="0"/>
                </a:moveTo>
                <a:lnTo>
                  <a:pt x="48640" y="0"/>
                </a:lnTo>
                <a:lnTo>
                  <a:pt x="48640" y="2682239"/>
                </a:lnTo>
                <a:lnTo>
                  <a:pt x="0" y="2682239"/>
                </a:lnTo>
                <a:lnTo>
                  <a:pt x="0" y="0"/>
                </a:lnTo>
                <a:lnTo>
                  <a:pt x="24256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7" name="Freeform 187"/>
          <p:cNvSpPr/>
          <p:nvPr/>
        </p:nvSpPr>
        <p:spPr>
          <a:xfrm>
            <a:off x="4607724" y="3207191"/>
            <a:ext cx="3596513" cy="48767"/>
          </a:xfrm>
          <a:custGeom>
            <a:avLst/>
            <a:gdLst/>
            <a:ahLst/>
            <a:cxnLst/>
            <a:rect l="0" t="0" r="0" b="0"/>
            <a:pathLst>
              <a:path w="3596513" h="48767">
                <a:moveTo>
                  <a:pt x="1798193" y="0"/>
                </a:moveTo>
                <a:lnTo>
                  <a:pt x="3596513" y="0"/>
                </a:lnTo>
                <a:lnTo>
                  <a:pt x="3596513" y="48767"/>
                </a:lnTo>
                <a:lnTo>
                  <a:pt x="0" y="48767"/>
                </a:lnTo>
                <a:lnTo>
                  <a:pt x="0" y="0"/>
                </a:lnTo>
                <a:lnTo>
                  <a:pt x="1798193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8" name="Freeform 188"/>
          <p:cNvSpPr/>
          <p:nvPr/>
        </p:nvSpPr>
        <p:spPr>
          <a:xfrm>
            <a:off x="8155596" y="518727"/>
            <a:ext cx="48642" cy="2682241"/>
          </a:xfrm>
          <a:custGeom>
            <a:avLst/>
            <a:gdLst/>
            <a:ahLst/>
            <a:cxnLst/>
            <a:rect l="0" t="0" r="0" b="0"/>
            <a:pathLst>
              <a:path w="48642" h="2682241">
                <a:moveTo>
                  <a:pt x="24257" y="0"/>
                </a:moveTo>
                <a:lnTo>
                  <a:pt x="48642" y="0"/>
                </a:lnTo>
                <a:lnTo>
                  <a:pt x="48642" y="2682241"/>
                </a:lnTo>
                <a:lnTo>
                  <a:pt x="0" y="2682241"/>
                </a:lnTo>
                <a:lnTo>
                  <a:pt x="0" y="0"/>
                </a:lnTo>
                <a:lnTo>
                  <a:pt x="24257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89" name="Freeform 189"/>
          <p:cNvSpPr/>
          <p:nvPr/>
        </p:nvSpPr>
        <p:spPr>
          <a:xfrm>
            <a:off x="5045874" y="576639"/>
            <a:ext cx="3103627" cy="2226056"/>
          </a:xfrm>
          <a:custGeom>
            <a:avLst/>
            <a:gdLst/>
            <a:ahLst/>
            <a:cxnLst/>
            <a:rect l="0" t="0" r="0" b="0"/>
            <a:pathLst>
              <a:path w="3103627" h="2226056">
                <a:moveTo>
                  <a:pt x="1551813" y="0"/>
                </a:moveTo>
                <a:lnTo>
                  <a:pt x="3103627" y="0"/>
                </a:lnTo>
                <a:lnTo>
                  <a:pt x="3103627" y="2226056"/>
                </a:lnTo>
                <a:lnTo>
                  <a:pt x="0" y="2226056"/>
                </a:lnTo>
                <a:lnTo>
                  <a:pt x="0" y="0"/>
                </a:lnTo>
                <a:lnTo>
                  <a:pt x="1551813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0" name="Freeform 190"/>
          <p:cNvSpPr/>
          <p:nvPr/>
        </p:nvSpPr>
        <p:spPr>
          <a:xfrm>
            <a:off x="5323115" y="2736529"/>
            <a:ext cx="173989" cy="38734"/>
          </a:xfrm>
          <a:custGeom>
            <a:avLst/>
            <a:gdLst/>
            <a:ahLst/>
            <a:cxnLst/>
            <a:rect l="0" t="0" r="0" b="0"/>
            <a:pathLst>
              <a:path w="173989" h="38734">
                <a:moveTo>
                  <a:pt x="86995" y="0"/>
                </a:moveTo>
                <a:lnTo>
                  <a:pt x="173989" y="0"/>
                </a:lnTo>
                <a:lnTo>
                  <a:pt x="173989" y="38734"/>
                </a:lnTo>
                <a:lnTo>
                  <a:pt x="0" y="38734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1" name="Freeform 191"/>
          <p:cNvSpPr/>
          <p:nvPr/>
        </p:nvSpPr>
        <p:spPr>
          <a:xfrm>
            <a:off x="5323115" y="2736529"/>
            <a:ext cx="173989" cy="38734"/>
          </a:xfrm>
          <a:custGeom>
            <a:avLst/>
            <a:gdLst/>
            <a:ahLst/>
            <a:cxnLst/>
            <a:rect l="0" t="0" r="0" b="0"/>
            <a:pathLst>
              <a:path w="173989" h="38734">
                <a:moveTo>
                  <a:pt x="86995" y="0"/>
                </a:moveTo>
                <a:lnTo>
                  <a:pt x="173989" y="0"/>
                </a:lnTo>
                <a:lnTo>
                  <a:pt x="173989" y="38734"/>
                </a:lnTo>
                <a:lnTo>
                  <a:pt x="0" y="38734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2" name="Freeform 192"/>
          <p:cNvSpPr/>
          <p:nvPr/>
        </p:nvSpPr>
        <p:spPr>
          <a:xfrm>
            <a:off x="5497105" y="2755960"/>
            <a:ext cx="174117" cy="19303"/>
          </a:xfrm>
          <a:custGeom>
            <a:avLst/>
            <a:gdLst/>
            <a:ahLst/>
            <a:cxnLst/>
            <a:rect l="0" t="0" r="0" b="0"/>
            <a:pathLst>
              <a:path w="174117" h="19303">
                <a:moveTo>
                  <a:pt x="87122" y="0"/>
                </a:moveTo>
                <a:lnTo>
                  <a:pt x="174117" y="0"/>
                </a:lnTo>
                <a:lnTo>
                  <a:pt x="174117" y="19303"/>
                </a:lnTo>
                <a:lnTo>
                  <a:pt x="0" y="19303"/>
                </a:lnTo>
                <a:lnTo>
                  <a:pt x="0" y="0"/>
                </a:lnTo>
                <a:lnTo>
                  <a:pt x="87122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3" name="Freeform 193"/>
          <p:cNvSpPr/>
          <p:nvPr/>
        </p:nvSpPr>
        <p:spPr>
          <a:xfrm>
            <a:off x="5497105" y="2755960"/>
            <a:ext cx="174117" cy="19303"/>
          </a:xfrm>
          <a:custGeom>
            <a:avLst/>
            <a:gdLst/>
            <a:ahLst/>
            <a:cxnLst/>
            <a:rect l="0" t="0" r="0" b="0"/>
            <a:pathLst>
              <a:path w="174117" h="19303">
                <a:moveTo>
                  <a:pt x="87122" y="0"/>
                </a:moveTo>
                <a:lnTo>
                  <a:pt x="174117" y="0"/>
                </a:lnTo>
                <a:lnTo>
                  <a:pt x="174117" y="19303"/>
                </a:lnTo>
                <a:lnTo>
                  <a:pt x="0" y="19303"/>
                </a:lnTo>
                <a:lnTo>
                  <a:pt x="0" y="0"/>
                </a:lnTo>
                <a:lnTo>
                  <a:pt x="87122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4" name="Freeform 194"/>
          <p:cNvSpPr/>
          <p:nvPr/>
        </p:nvSpPr>
        <p:spPr>
          <a:xfrm>
            <a:off x="5671222" y="2658931"/>
            <a:ext cx="173991" cy="116332"/>
          </a:xfrm>
          <a:custGeom>
            <a:avLst/>
            <a:gdLst/>
            <a:ahLst/>
            <a:cxnLst/>
            <a:rect l="0" t="0" r="0" b="0"/>
            <a:pathLst>
              <a:path w="173991" h="116332">
                <a:moveTo>
                  <a:pt x="86996" y="0"/>
                </a:moveTo>
                <a:lnTo>
                  <a:pt x="173991" y="0"/>
                </a:lnTo>
                <a:lnTo>
                  <a:pt x="173991" y="116332"/>
                </a:lnTo>
                <a:lnTo>
                  <a:pt x="0" y="116332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5" name="Freeform 195"/>
          <p:cNvSpPr/>
          <p:nvPr/>
        </p:nvSpPr>
        <p:spPr>
          <a:xfrm>
            <a:off x="5671222" y="2658931"/>
            <a:ext cx="173991" cy="116332"/>
          </a:xfrm>
          <a:custGeom>
            <a:avLst/>
            <a:gdLst/>
            <a:ahLst/>
            <a:cxnLst/>
            <a:rect l="0" t="0" r="0" b="0"/>
            <a:pathLst>
              <a:path w="173991" h="116332">
                <a:moveTo>
                  <a:pt x="86996" y="0"/>
                </a:moveTo>
                <a:lnTo>
                  <a:pt x="173991" y="0"/>
                </a:lnTo>
                <a:lnTo>
                  <a:pt x="173991" y="116332"/>
                </a:lnTo>
                <a:lnTo>
                  <a:pt x="0" y="116332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6" name="Freeform 196"/>
          <p:cNvSpPr/>
          <p:nvPr/>
        </p:nvSpPr>
        <p:spPr>
          <a:xfrm>
            <a:off x="5845212" y="2503864"/>
            <a:ext cx="173989" cy="271399"/>
          </a:xfrm>
          <a:custGeom>
            <a:avLst/>
            <a:gdLst/>
            <a:ahLst/>
            <a:cxnLst/>
            <a:rect l="0" t="0" r="0" b="0"/>
            <a:pathLst>
              <a:path w="173989" h="271399">
                <a:moveTo>
                  <a:pt x="86995" y="0"/>
                </a:moveTo>
                <a:lnTo>
                  <a:pt x="173989" y="0"/>
                </a:lnTo>
                <a:lnTo>
                  <a:pt x="173989" y="271399"/>
                </a:lnTo>
                <a:lnTo>
                  <a:pt x="0" y="271399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7" name="Freeform 197"/>
          <p:cNvSpPr/>
          <p:nvPr/>
        </p:nvSpPr>
        <p:spPr>
          <a:xfrm>
            <a:off x="5845212" y="2503864"/>
            <a:ext cx="173989" cy="271399"/>
          </a:xfrm>
          <a:custGeom>
            <a:avLst/>
            <a:gdLst/>
            <a:ahLst/>
            <a:cxnLst/>
            <a:rect l="0" t="0" r="0" b="0"/>
            <a:pathLst>
              <a:path w="173989" h="271399">
                <a:moveTo>
                  <a:pt x="86995" y="0"/>
                </a:moveTo>
                <a:lnTo>
                  <a:pt x="173989" y="0"/>
                </a:lnTo>
                <a:lnTo>
                  <a:pt x="173989" y="271399"/>
                </a:lnTo>
                <a:lnTo>
                  <a:pt x="0" y="271399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8" name="Freeform 198"/>
          <p:cNvSpPr/>
          <p:nvPr/>
        </p:nvSpPr>
        <p:spPr>
          <a:xfrm>
            <a:off x="6019202" y="1825431"/>
            <a:ext cx="174117" cy="949832"/>
          </a:xfrm>
          <a:custGeom>
            <a:avLst/>
            <a:gdLst/>
            <a:ahLst/>
            <a:cxnLst/>
            <a:rect l="0" t="0" r="0" b="0"/>
            <a:pathLst>
              <a:path w="174117" h="949832">
                <a:moveTo>
                  <a:pt x="86995" y="0"/>
                </a:moveTo>
                <a:lnTo>
                  <a:pt x="174117" y="0"/>
                </a:lnTo>
                <a:lnTo>
                  <a:pt x="174117" y="949832"/>
                </a:lnTo>
                <a:lnTo>
                  <a:pt x="0" y="949832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99" name="Freeform 199"/>
          <p:cNvSpPr/>
          <p:nvPr/>
        </p:nvSpPr>
        <p:spPr>
          <a:xfrm>
            <a:off x="6019202" y="1825431"/>
            <a:ext cx="174117" cy="949832"/>
          </a:xfrm>
          <a:custGeom>
            <a:avLst/>
            <a:gdLst/>
            <a:ahLst/>
            <a:cxnLst/>
            <a:rect l="0" t="0" r="0" b="0"/>
            <a:pathLst>
              <a:path w="174117" h="949832">
                <a:moveTo>
                  <a:pt x="86995" y="0"/>
                </a:moveTo>
                <a:lnTo>
                  <a:pt x="174117" y="0"/>
                </a:lnTo>
                <a:lnTo>
                  <a:pt x="174117" y="949832"/>
                </a:lnTo>
                <a:lnTo>
                  <a:pt x="0" y="949832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0" name="Freeform 200"/>
          <p:cNvSpPr/>
          <p:nvPr/>
        </p:nvSpPr>
        <p:spPr>
          <a:xfrm>
            <a:off x="6193319" y="604071"/>
            <a:ext cx="173990" cy="2171192"/>
          </a:xfrm>
          <a:custGeom>
            <a:avLst/>
            <a:gdLst/>
            <a:ahLst/>
            <a:cxnLst/>
            <a:rect l="0" t="0" r="0" b="0"/>
            <a:pathLst>
              <a:path w="173990" h="2171192">
                <a:moveTo>
                  <a:pt x="86996" y="0"/>
                </a:moveTo>
                <a:lnTo>
                  <a:pt x="173990" y="0"/>
                </a:lnTo>
                <a:lnTo>
                  <a:pt x="173990" y="2171192"/>
                </a:lnTo>
                <a:lnTo>
                  <a:pt x="0" y="2171192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1" name="Freeform 201"/>
          <p:cNvSpPr/>
          <p:nvPr/>
        </p:nvSpPr>
        <p:spPr>
          <a:xfrm>
            <a:off x="6193319" y="604071"/>
            <a:ext cx="173990" cy="2171192"/>
          </a:xfrm>
          <a:custGeom>
            <a:avLst/>
            <a:gdLst/>
            <a:ahLst/>
            <a:cxnLst/>
            <a:rect l="0" t="0" r="0" b="0"/>
            <a:pathLst>
              <a:path w="173990" h="2171192">
                <a:moveTo>
                  <a:pt x="86996" y="0"/>
                </a:moveTo>
                <a:lnTo>
                  <a:pt x="173990" y="0"/>
                </a:lnTo>
                <a:lnTo>
                  <a:pt x="173990" y="2171192"/>
                </a:lnTo>
                <a:lnTo>
                  <a:pt x="0" y="2171192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2" name="Freeform 202"/>
          <p:cNvSpPr/>
          <p:nvPr/>
        </p:nvSpPr>
        <p:spPr>
          <a:xfrm>
            <a:off x="6367309" y="1592767"/>
            <a:ext cx="173991" cy="1182496"/>
          </a:xfrm>
          <a:custGeom>
            <a:avLst/>
            <a:gdLst/>
            <a:ahLst/>
            <a:cxnLst/>
            <a:rect l="0" t="0" r="0" b="0"/>
            <a:pathLst>
              <a:path w="173991" h="1182496">
                <a:moveTo>
                  <a:pt x="86996" y="0"/>
                </a:moveTo>
                <a:lnTo>
                  <a:pt x="173991" y="0"/>
                </a:lnTo>
                <a:lnTo>
                  <a:pt x="173991" y="1182496"/>
                </a:lnTo>
                <a:lnTo>
                  <a:pt x="0" y="1182496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3" name="Freeform 203"/>
          <p:cNvSpPr/>
          <p:nvPr/>
        </p:nvSpPr>
        <p:spPr>
          <a:xfrm>
            <a:off x="6367309" y="1592767"/>
            <a:ext cx="173991" cy="1182496"/>
          </a:xfrm>
          <a:custGeom>
            <a:avLst/>
            <a:gdLst/>
            <a:ahLst/>
            <a:cxnLst/>
            <a:rect l="0" t="0" r="0" b="0"/>
            <a:pathLst>
              <a:path w="173991" h="1182496">
                <a:moveTo>
                  <a:pt x="86996" y="0"/>
                </a:moveTo>
                <a:lnTo>
                  <a:pt x="173991" y="0"/>
                </a:lnTo>
                <a:lnTo>
                  <a:pt x="173991" y="1182496"/>
                </a:lnTo>
                <a:lnTo>
                  <a:pt x="0" y="1182496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4" name="Freeform 204"/>
          <p:cNvSpPr/>
          <p:nvPr/>
        </p:nvSpPr>
        <p:spPr>
          <a:xfrm>
            <a:off x="6541300" y="2310062"/>
            <a:ext cx="173990" cy="465201"/>
          </a:xfrm>
          <a:custGeom>
            <a:avLst/>
            <a:gdLst/>
            <a:ahLst/>
            <a:cxnLst/>
            <a:rect l="0" t="0" r="0" b="0"/>
            <a:pathLst>
              <a:path w="173990" h="465201">
                <a:moveTo>
                  <a:pt x="86994" y="0"/>
                </a:moveTo>
                <a:lnTo>
                  <a:pt x="173990" y="0"/>
                </a:lnTo>
                <a:lnTo>
                  <a:pt x="173990" y="465201"/>
                </a:lnTo>
                <a:lnTo>
                  <a:pt x="0" y="465201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5" name="Freeform 205"/>
          <p:cNvSpPr/>
          <p:nvPr/>
        </p:nvSpPr>
        <p:spPr>
          <a:xfrm>
            <a:off x="6541300" y="2310062"/>
            <a:ext cx="173990" cy="465201"/>
          </a:xfrm>
          <a:custGeom>
            <a:avLst/>
            <a:gdLst/>
            <a:ahLst/>
            <a:cxnLst/>
            <a:rect l="0" t="0" r="0" b="0"/>
            <a:pathLst>
              <a:path w="173990" h="465201">
                <a:moveTo>
                  <a:pt x="86994" y="0"/>
                </a:moveTo>
                <a:lnTo>
                  <a:pt x="173990" y="0"/>
                </a:lnTo>
                <a:lnTo>
                  <a:pt x="173990" y="465201"/>
                </a:lnTo>
                <a:lnTo>
                  <a:pt x="0" y="465201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6" name="Freeform 206"/>
          <p:cNvSpPr/>
          <p:nvPr/>
        </p:nvSpPr>
        <p:spPr>
          <a:xfrm>
            <a:off x="6715289" y="2387532"/>
            <a:ext cx="174116" cy="387731"/>
          </a:xfrm>
          <a:custGeom>
            <a:avLst/>
            <a:gdLst/>
            <a:ahLst/>
            <a:cxnLst/>
            <a:rect l="0" t="0" r="0" b="0"/>
            <a:pathLst>
              <a:path w="174116" h="387731">
                <a:moveTo>
                  <a:pt x="86994" y="0"/>
                </a:moveTo>
                <a:lnTo>
                  <a:pt x="174116" y="0"/>
                </a:lnTo>
                <a:lnTo>
                  <a:pt x="174116" y="387731"/>
                </a:lnTo>
                <a:lnTo>
                  <a:pt x="0" y="387731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7" name="Freeform 207"/>
          <p:cNvSpPr/>
          <p:nvPr/>
        </p:nvSpPr>
        <p:spPr>
          <a:xfrm>
            <a:off x="6715289" y="2387532"/>
            <a:ext cx="174116" cy="387731"/>
          </a:xfrm>
          <a:custGeom>
            <a:avLst/>
            <a:gdLst/>
            <a:ahLst/>
            <a:cxnLst/>
            <a:rect l="0" t="0" r="0" b="0"/>
            <a:pathLst>
              <a:path w="174116" h="387731">
                <a:moveTo>
                  <a:pt x="86994" y="0"/>
                </a:moveTo>
                <a:lnTo>
                  <a:pt x="174116" y="0"/>
                </a:lnTo>
                <a:lnTo>
                  <a:pt x="174116" y="387731"/>
                </a:lnTo>
                <a:lnTo>
                  <a:pt x="0" y="387731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8" name="Freeform 208"/>
          <p:cNvSpPr/>
          <p:nvPr/>
        </p:nvSpPr>
        <p:spPr>
          <a:xfrm>
            <a:off x="6889406" y="2251897"/>
            <a:ext cx="173990" cy="523366"/>
          </a:xfrm>
          <a:custGeom>
            <a:avLst/>
            <a:gdLst/>
            <a:ahLst/>
            <a:cxnLst/>
            <a:rect l="0" t="0" r="0" b="0"/>
            <a:pathLst>
              <a:path w="173990" h="523366">
                <a:moveTo>
                  <a:pt x="86996" y="0"/>
                </a:moveTo>
                <a:lnTo>
                  <a:pt x="173990" y="0"/>
                </a:lnTo>
                <a:lnTo>
                  <a:pt x="173990" y="523366"/>
                </a:lnTo>
                <a:lnTo>
                  <a:pt x="0" y="523366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09" name="Freeform 209"/>
          <p:cNvSpPr/>
          <p:nvPr/>
        </p:nvSpPr>
        <p:spPr>
          <a:xfrm>
            <a:off x="6889406" y="2251897"/>
            <a:ext cx="173990" cy="523366"/>
          </a:xfrm>
          <a:custGeom>
            <a:avLst/>
            <a:gdLst/>
            <a:ahLst/>
            <a:cxnLst/>
            <a:rect l="0" t="0" r="0" b="0"/>
            <a:pathLst>
              <a:path w="173990" h="523366">
                <a:moveTo>
                  <a:pt x="86996" y="0"/>
                </a:moveTo>
                <a:lnTo>
                  <a:pt x="173990" y="0"/>
                </a:lnTo>
                <a:lnTo>
                  <a:pt x="173990" y="523366"/>
                </a:lnTo>
                <a:lnTo>
                  <a:pt x="0" y="523366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0" name="Freeform 210"/>
          <p:cNvSpPr/>
          <p:nvPr/>
        </p:nvSpPr>
        <p:spPr>
          <a:xfrm>
            <a:off x="7063396" y="2329367"/>
            <a:ext cx="173991" cy="445896"/>
          </a:xfrm>
          <a:custGeom>
            <a:avLst/>
            <a:gdLst/>
            <a:ahLst/>
            <a:cxnLst/>
            <a:rect l="0" t="0" r="0" b="0"/>
            <a:pathLst>
              <a:path w="173991" h="445896">
                <a:moveTo>
                  <a:pt x="86995" y="0"/>
                </a:moveTo>
                <a:lnTo>
                  <a:pt x="173991" y="0"/>
                </a:lnTo>
                <a:lnTo>
                  <a:pt x="173991" y="445896"/>
                </a:lnTo>
                <a:lnTo>
                  <a:pt x="0" y="445896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1" name="Freeform 211"/>
          <p:cNvSpPr/>
          <p:nvPr/>
        </p:nvSpPr>
        <p:spPr>
          <a:xfrm>
            <a:off x="7063396" y="2329367"/>
            <a:ext cx="173991" cy="445896"/>
          </a:xfrm>
          <a:custGeom>
            <a:avLst/>
            <a:gdLst/>
            <a:ahLst/>
            <a:cxnLst/>
            <a:rect l="0" t="0" r="0" b="0"/>
            <a:pathLst>
              <a:path w="173991" h="445896">
                <a:moveTo>
                  <a:pt x="86995" y="0"/>
                </a:moveTo>
                <a:lnTo>
                  <a:pt x="173991" y="0"/>
                </a:lnTo>
                <a:lnTo>
                  <a:pt x="173991" y="445896"/>
                </a:lnTo>
                <a:lnTo>
                  <a:pt x="0" y="445896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2" name="Freeform 212"/>
          <p:cNvSpPr/>
          <p:nvPr/>
        </p:nvSpPr>
        <p:spPr>
          <a:xfrm>
            <a:off x="7237386" y="2658931"/>
            <a:ext cx="173990" cy="116332"/>
          </a:xfrm>
          <a:custGeom>
            <a:avLst/>
            <a:gdLst/>
            <a:ahLst/>
            <a:cxnLst/>
            <a:rect l="0" t="0" r="0" b="0"/>
            <a:pathLst>
              <a:path w="173990" h="116332">
                <a:moveTo>
                  <a:pt x="86994" y="0"/>
                </a:moveTo>
                <a:lnTo>
                  <a:pt x="173990" y="0"/>
                </a:lnTo>
                <a:lnTo>
                  <a:pt x="173990" y="116332"/>
                </a:lnTo>
                <a:lnTo>
                  <a:pt x="0" y="116332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3" name="Freeform 213"/>
          <p:cNvSpPr/>
          <p:nvPr/>
        </p:nvSpPr>
        <p:spPr>
          <a:xfrm>
            <a:off x="7237386" y="2658931"/>
            <a:ext cx="173990" cy="116332"/>
          </a:xfrm>
          <a:custGeom>
            <a:avLst/>
            <a:gdLst/>
            <a:ahLst/>
            <a:cxnLst/>
            <a:rect l="0" t="0" r="0" b="0"/>
            <a:pathLst>
              <a:path w="173990" h="116332">
                <a:moveTo>
                  <a:pt x="86994" y="0"/>
                </a:moveTo>
                <a:lnTo>
                  <a:pt x="173990" y="0"/>
                </a:lnTo>
                <a:lnTo>
                  <a:pt x="173990" y="116332"/>
                </a:lnTo>
                <a:lnTo>
                  <a:pt x="0" y="116332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4" name="Freeform 214"/>
          <p:cNvSpPr/>
          <p:nvPr/>
        </p:nvSpPr>
        <p:spPr>
          <a:xfrm>
            <a:off x="7411376" y="2736529"/>
            <a:ext cx="174116" cy="38734"/>
          </a:xfrm>
          <a:custGeom>
            <a:avLst/>
            <a:gdLst/>
            <a:ahLst/>
            <a:cxnLst/>
            <a:rect l="0" t="0" r="0" b="0"/>
            <a:pathLst>
              <a:path w="174116" h="38734">
                <a:moveTo>
                  <a:pt x="87122" y="0"/>
                </a:moveTo>
                <a:lnTo>
                  <a:pt x="174116" y="0"/>
                </a:lnTo>
                <a:lnTo>
                  <a:pt x="174116" y="38734"/>
                </a:lnTo>
                <a:lnTo>
                  <a:pt x="0" y="38734"/>
                </a:lnTo>
                <a:lnTo>
                  <a:pt x="0" y="0"/>
                </a:lnTo>
                <a:lnTo>
                  <a:pt x="87122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5" name="Freeform 215"/>
          <p:cNvSpPr/>
          <p:nvPr/>
        </p:nvSpPr>
        <p:spPr>
          <a:xfrm>
            <a:off x="7411376" y="2736529"/>
            <a:ext cx="174116" cy="38734"/>
          </a:xfrm>
          <a:custGeom>
            <a:avLst/>
            <a:gdLst/>
            <a:ahLst/>
            <a:cxnLst/>
            <a:rect l="0" t="0" r="0" b="0"/>
            <a:pathLst>
              <a:path w="174116" h="38734">
                <a:moveTo>
                  <a:pt x="87122" y="0"/>
                </a:moveTo>
                <a:lnTo>
                  <a:pt x="174116" y="0"/>
                </a:lnTo>
                <a:lnTo>
                  <a:pt x="174116" y="38734"/>
                </a:lnTo>
                <a:lnTo>
                  <a:pt x="0" y="38734"/>
                </a:lnTo>
                <a:lnTo>
                  <a:pt x="0" y="0"/>
                </a:lnTo>
                <a:lnTo>
                  <a:pt x="87122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6" name="Freeform 216"/>
          <p:cNvSpPr/>
          <p:nvPr/>
        </p:nvSpPr>
        <p:spPr>
          <a:xfrm>
            <a:off x="5323115" y="2775263"/>
            <a:ext cx="173989" cy="0"/>
          </a:xfrm>
          <a:custGeom>
            <a:avLst/>
            <a:gdLst/>
            <a:ahLst/>
            <a:cxnLst/>
            <a:rect l="0" t="0" r="0" b="0"/>
            <a:pathLst>
              <a:path w="173989">
                <a:moveTo>
                  <a:pt x="0" y="0"/>
                </a:moveTo>
                <a:lnTo>
                  <a:pt x="173989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7" name="Freeform 217"/>
          <p:cNvSpPr/>
          <p:nvPr/>
        </p:nvSpPr>
        <p:spPr>
          <a:xfrm>
            <a:off x="5497105" y="2775263"/>
            <a:ext cx="174117" cy="0"/>
          </a:xfrm>
          <a:custGeom>
            <a:avLst/>
            <a:gdLst/>
            <a:ahLst/>
            <a:cxnLst/>
            <a:rect l="0" t="0" r="0" b="0"/>
            <a:pathLst>
              <a:path w="174117">
                <a:moveTo>
                  <a:pt x="0" y="0"/>
                </a:moveTo>
                <a:lnTo>
                  <a:pt x="174117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8" name="Freeform 218"/>
          <p:cNvSpPr/>
          <p:nvPr/>
        </p:nvSpPr>
        <p:spPr>
          <a:xfrm>
            <a:off x="5671222" y="2775263"/>
            <a:ext cx="173991" cy="0"/>
          </a:xfrm>
          <a:custGeom>
            <a:avLst/>
            <a:gdLst/>
            <a:ahLst/>
            <a:cxnLst/>
            <a:rect l="0" t="0" r="0" b="0"/>
            <a:pathLst>
              <a:path w="173991">
                <a:moveTo>
                  <a:pt x="0" y="0"/>
                </a:moveTo>
                <a:lnTo>
                  <a:pt x="173991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9" name="Freeform 219"/>
          <p:cNvSpPr/>
          <p:nvPr/>
        </p:nvSpPr>
        <p:spPr>
          <a:xfrm>
            <a:off x="5845212" y="2586668"/>
            <a:ext cx="173989" cy="188595"/>
          </a:xfrm>
          <a:custGeom>
            <a:avLst/>
            <a:gdLst/>
            <a:ahLst/>
            <a:cxnLst/>
            <a:rect l="0" t="0" r="0" b="0"/>
            <a:pathLst>
              <a:path w="173989" h="188595">
                <a:moveTo>
                  <a:pt x="86995" y="0"/>
                </a:moveTo>
                <a:lnTo>
                  <a:pt x="173989" y="0"/>
                </a:lnTo>
                <a:lnTo>
                  <a:pt x="173989" y="188595"/>
                </a:lnTo>
                <a:lnTo>
                  <a:pt x="0" y="188595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0" name="Freeform 220"/>
          <p:cNvSpPr/>
          <p:nvPr/>
        </p:nvSpPr>
        <p:spPr>
          <a:xfrm>
            <a:off x="5845212" y="2586668"/>
            <a:ext cx="173989" cy="188595"/>
          </a:xfrm>
          <a:custGeom>
            <a:avLst/>
            <a:gdLst/>
            <a:ahLst/>
            <a:cxnLst/>
            <a:rect l="0" t="0" r="0" b="0"/>
            <a:pathLst>
              <a:path w="173989" h="188595">
                <a:moveTo>
                  <a:pt x="86995" y="0"/>
                </a:moveTo>
                <a:lnTo>
                  <a:pt x="173989" y="0"/>
                </a:lnTo>
                <a:lnTo>
                  <a:pt x="173989" y="188595"/>
                </a:lnTo>
                <a:lnTo>
                  <a:pt x="0" y="188595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1" name="Freeform 221"/>
          <p:cNvSpPr/>
          <p:nvPr/>
        </p:nvSpPr>
        <p:spPr>
          <a:xfrm>
            <a:off x="6019202" y="2335208"/>
            <a:ext cx="174117" cy="440055"/>
          </a:xfrm>
          <a:custGeom>
            <a:avLst/>
            <a:gdLst/>
            <a:ahLst/>
            <a:cxnLst/>
            <a:rect l="0" t="0" r="0" b="0"/>
            <a:pathLst>
              <a:path w="174117" h="440055">
                <a:moveTo>
                  <a:pt x="86995" y="0"/>
                </a:moveTo>
                <a:lnTo>
                  <a:pt x="174117" y="0"/>
                </a:lnTo>
                <a:lnTo>
                  <a:pt x="174117" y="440055"/>
                </a:lnTo>
                <a:lnTo>
                  <a:pt x="0" y="440055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2" name="Freeform 222"/>
          <p:cNvSpPr/>
          <p:nvPr/>
        </p:nvSpPr>
        <p:spPr>
          <a:xfrm>
            <a:off x="6019202" y="2335208"/>
            <a:ext cx="174117" cy="440055"/>
          </a:xfrm>
          <a:custGeom>
            <a:avLst/>
            <a:gdLst/>
            <a:ahLst/>
            <a:cxnLst/>
            <a:rect l="0" t="0" r="0" b="0"/>
            <a:pathLst>
              <a:path w="174117" h="440055">
                <a:moveTo>
                  <a:pt x="86995" y="0"/>
                </a:moveTo>
                <a:lnTo>
                  <a:pt x="174117" y="0"/>
                </a:lnTo>
                <a:lnTo>
                  <a:pt x="174117" y="440055"/>
                </a:lnTo>
                <a:lnTo>
                  <a:pt x="0" y="440055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3" name="Freeform 223"/>
          <p:cNvSpPr/>
          <p:nvPr/>
        </p:nvSpPr>
        <p:spPr>
          <a:xfrm>
            <a:off x="6193319" y="1077909"/>
            <a:ext cx="173990" cy="1697354"/>
          </a:xfrm>
          <a:custGeom>
            <a:avLst/>
            <a:gdLst/>
            <a:ahLst/>
            <a:cxnLst/>
            <a:rect l="0" t="0" r="0" b="0"/>
            <a:pathLst>
              <a:path w="173990" h="1697354">
                <a:moveTo>
                  <a:pt x="86996" y="0"/>
                </a:moveTo>
                <a:lnTo>
                  <a:pt x="173990" y="0"/>
                </a:lnTo>
                <a:lnTo>
                  <a:pt x="173990" y="1697354"/>
                </a:lnTo>
                <a:lnTo>
                  <a:pt x="0" y="1697354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4" name="Freeform 224"/>
          <p:cNvSpPr/>
          <p:nvPr/>
        </p:nvSpPr>
        <p:spPr>
          <a:xfrm>
            <a:off x="6193319" y="1077909"/>
            <a:ext cx="173990" cy="1697354"/>
          </a:xfrm>
          <a:custGeom>
            <a:avLst/>
            <a:gdLst/>
            <a:ahLst/>
            <a:cxnLst/>
            <a:rect l="0" t="0" r="0" b="0"/>
            <a:pathLst>
              <a:path w="173990" h="1697354">
                <a:moveTo>
                  <a:pt x="86996" y="0"/>
                </a:moveTo>
                <a:lnTo>
                  <a:pt x="173990" y="0"/>
                </a:lnTo>
                <a:lnTo>
                  <a:pt x="173990" y="1697354"/>
                </a:lnTo>
                <a:lnTo>
                  <a:pt x="0" y="1697354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5" name="Freeform 225"/>
          <p:cNvSpPr/>
          <p:nvPr/>
        </p:nvSpPr>
        <p:spPr>
          <a:xfrm>
            <a:off x="6367309" y="2083749"/>
            <a:ext cx="173991" cy="691514"/>
          </a:xfrm>
          <a:custGeom>
            <a:avLst/>
            <a:gdLst/>
            <a:ahLst/>
            <a:cxnLst/>
            <a:rect l="0" t="0" r="0" b="0"/>
            <a:pathLst>
              <a:path w="173991" h="691514">
                <a:moveTo>
                  <a:pt x="86996" y="0"/>
                </a:moveTo>
                <a:lnTo>
                  <a:pt x="173991" y="0"/>
                </a:lnTo>
                <a:lnTo>
                  <a:pt x="173991" y="691514"/>
                </a:lnTo>
                <a:lnTo>
                  <a:pt x="0" y="691514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6" name="Freeform 226"/>
          <p:cNvSpPr/>
          <p:nvPr/>
        </p:nvSpPr>
        <p:spPr>
          <a:xfrm>
            <a:off x="6367309" y="2083749"/>
            <a:ext cx="173991" cy="691514"/>
          </a:xfrm>
          <a:custGeom>
            <a:avLst/>
            <a:gdLst/>
            <a:ahLst/>
            <a:cxnLst/>
            <a:rect l="0" t="0" r="0" b="0"/>
            <a:pathLst>
              <a:path w="173991" h="691514">
                <a:moveTo>
                  <a:pt x="86996" y="0"/>
                </a:moveTo>
                <a:lnTo>
                  <a:pt x="173991" y="0"/>
                </a:lnTo>
                <a:lnTo>
                  <a:pt x="173991" y="691514"/>
                </a:lnTo>
                <a:lnTo>
                  <a:pt x="0" y="691514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7" name="Freeform 227"/>
          <p:cNvSpPr/>
          <p:nvPr/>
        </p:nvSpPr>
        <p:spPr>
          <a:xfrm>
            <a:off x="6541300" y="2020883"/>
            <a:ext cx="173990" cy="754380"/>
          </a:xfrm>
          <a:custGeom>
            <a:avLst/>
            <a:gdLst/>
            <a:ahLst/>
            <a:cxnLst/>
            <a:rect l="0" t="0" r="0" b="0"/>
            <a:pathLst>
              <a:path w="173990" h="754380">
                <a:moveTo>
                  <a:pt x="86994" y="0"/>
                </a:moveTo>
                <a:lnTo>
                  <a:pt x="173990" y="0"/>
                </a:lnTo>
                <a:lnTo>
                  <a:pt x="173990" y="754380"/>
                </a:lnTo>
                <a:lnTo>
                  <a:pt x="0" y="754380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8" name="Freeform 228"/>
          <p:cNvSpPr/>
          <p:nvPr/>
        </p:nvSpPr>
        <p:spPr>
          <a:xfrm>
            <a:off x="6541300" y="2020883"/>
            <a:ext cx="173990" cy="754380"/>
          </a:xfrm>
          <a:custGeom>
            <a:avLst/>
            <a:gdLst/>
            <a:ahLst/>
            <a:cxnLst/>
            <a:rect l="0" t="0" r="0" b="0"/>
            <a:pathLst>
              <a:path w="173990" h="754380">
                <a:moveTo>
                  <a:pt x="86994" y="0"/>
                </a:moveTo>
                <a:lnTo>
                  <a:pt x="173990" y="0"/>
                </a:lnTo>
                <a:lnTo>
                  <a:pt x="173990" y="754380"/>
                </a:lnTo>
                <a:lnTo>
                  <a:pt x="0" y="754380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9" name="Freeform 229"/>
          <p:cNvSpPr/>
          <p:nvPr/>
        </p:nvSpPr>
        <p:spPr>
          <a:xfrm>
            <a:off x="6715289" y="2209479"/>
            <a:ext cx="174116" cy="565784"/>
          </a:xfrm>
          <a:custGeom>
            <a:avLst/>
            <a:gdLst/>
            <a:ahLst/>
            <a:cxnLst/>
            <a:rect l="0" t="0" r="0" b="0"/>
            <a:pathLst>
              <a:path w="174116" h="565784">
                <a:moveTo>
                  <a:pt x="86994" y="0"/>
                </a:moveTo>
                <a:lnTo>
                  <a:pt x="174116" y="0"/>
                </a:lnTo>
                <a:lnTo>
                  <a:pt x="174116" y="565784"/>
                </a:lnTo>
                <a:lnTo>
                  <a:pt x="0" y="565784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0" name="Freeform 230"/>
          <p:cNvSpPr/>
          <p:nvPr/>
        </p:nvSpPr>
        <p:spPr>
          <a:xfrm>
            <a:off x="6715289" y="2209479"/>
            <a:ext cx="174116" cy="565784"/>
          </a:xfrm>
          <a:custGeom>
            <a:avLst/>
            <a:gdLst/>
            <a:ahLst/>
            <a:cxnLst/>
            <a:rect l="0" t="0" r="0" b="0"/>
            <a:pathLst>
              <a:path w="174116" h="565784">
                <a:moveTo>
                  <a:pt x="86994" y="0"/>
                </a:moveTo>
                <a:lnTo>
                  <a:pt x="174116" y="0"/>
                </a:lnTo>
                <a:lnTo>
                  <a:pt x="174116" y="565784"/>
                </a:lnTo>
                <a:lnTo>
                  <a:pt x="0" y="565784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1" name="Freeform 231"/>
          <p:cNvSpPr/>
          <p:nvPr/>
        </p:nvSpPr>
        <p:spPr>
          <a:xfrm>
            <a:off x="6889406" y="2083749"/>
            <a:ext cx="173990" cy="691514"/>
          </a:xfrm>
          <a:custGeom>
            <a:avLst/>
            <a:gdLst/>
            <a:ahLst/>
            <a:cxnLst/>
            <a:rect l="0" t="0" r="0" b="0"/>
            <a:pathLst>
              <a:path w="173990" h="691514">
                <a:moveTo>
                  <a:pt x="86996" y="0"/>
                </a:moveTo>
                <a:lnTo>
                  <a:pt x="173990" y="0"/>
                </a:lnTo>
                <a:lnTo>
                  <a:pt x="173990" y="691514"/>
                </a:lnTo>
                <a:lnTo>
                  <a:pt x="0" y="691514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2" name="Freeform 232"/>
          <p:cNvSpPr/>
          <p:nvPr/>
        </p:nvSpPr>
        <p:spPr>
          <a:xfrm>
            <a:off x="6889406" y="2083749"/>
            <a:ext cx="173990" cy="691514"/>
          </a:xfrm>
          <a:custGeom>
            <a:avLst/>
            <a:gdLst/>
            <a:ahLst/>
            <a:cxnLst/>
            <a:rect l="0" t="0" r="0" b="0"/>
            <a:pathLst>
              <a:path w="173990" h="691514">
                <a:moveTo>
                  <a:pt x="86996" y="0"/>
                </a:moveTo>
                <a:lnTo>
                  <a:pt x="173990" y="0"/>
                </a:lnTo>
                <a:lnTo>
                  <a:pt x="173990" y="691514"/>
                </a:lnTo>
                <a:lnTo>
                  <a:pt x="0" y="691514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3" name="Freeform 233"/>
          <p:cNvSpPr/>
          <p:nvPr/>
        </p:nvSpPr>
        <p:spPr>
          <a:xfrm>
            <a:off x="7063396" y="1706558"/>
            <a:ext cx="173991" cy="1068705"/>
          </a:xfrm>
          <a:custGeom>
            <a:avLst/>
            <a:gdLst/>
            <a:ahLst/>
            <a:cxnLst/>
            <a:rect l="0" t="0" r="0" b="0"/>
            <a:pathLst>
              <a:path w="173991" h="1068705">
                <a:moveTo>
                  <a:pt x="86995" y="0"/>
                </a:moveTo>
                <a:lnTo>
                  <a:pt x="173991" y="0"/>
                </a:lnTo>
                <a:lnTo>
                  <a:pt x="173991" y="1068705"/>
                </a:lnTo>
                <a:lnTo>
                  <a:pt x="0" y="1068705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4" name="Freeform 234"/>
          <p:cNvSpPr/>
          <p:nvPr/>
        </p:nvSpPr>
        <p:spPr>
          <a:xfrm>
            <a:off x="7063396" y="1706558"/>
            <a:ext cx="173991" cy="1068705"/>
          </a:xfrm>
          <a:custGeom>
            <a:avLst/>
            <a:gdLst/>
            <a:ahLst/>
            <a:cxnLst/>
            <a:rect l="0" t="0" r="0" b="0"/>
            <a:pathLst>
              <a:path w="173991" h="1068705">
                <a:moveTo>
                  <a:pt x="86995" y="0"/>
                </a:moveTo>
                <a:lnTo>
                  <a:pt x="173991" y="0"/>
                </a:lnTo>
                <a:lnTo>
                  <a:pt x="173991" y="1068705"/>
                </a:lnTo>
                <a:lnTo>
                  <a:pt x="0" y="1068705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5" name="Freeform 235"/>
          <p:cNvSpPr/>
          <p:nvPr/>
        </p:nvSpPr>
        <p:spPr>
          <a:xfrm>
            <a:off x="7237386" y="2272343"/>
            <a:ext cx="173990" cy="502920"/>
          </a:xfrm>
          <a:custGeom>
            <a:avLst/>
            <a:gdLst/>
            <a:ahLst/>
            <a:cxnLst/>
            <a:rect l="0" t="0" r="0" b="0"/>
            <a:pathLst>
              <a:path w="173990" h="502920">
                <a:moveTo>
                  <a:pt x="86994" y="0"/>
                </a:moveTo>
                <a:lnTo>
                  <a:pt x="173990" y="0"/>
                </a:lnTo>
                <a:lnTo>
                  <a:pt x="173990" y="502920"/>
                </a:lnTo>
                <a:lnTo>
                  <a:pt x="0" y="502920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6" name="Freeform 236"/>
          <p:cNvSpPr/>
          <p:nvPr/>
        </p:nvSpPr>
        <p:spPr>
          <a:xfrm>
            <a:off x="7237386" y="2272343"/>
            <a:ext cx="173990" cy="502920"/>
          </a:xfrm>
          <a:custGeom>
            <a:avLst/>
            <a:gdLst/>
            <a:ahLst/>
            <a:cxnLst/>
            <a:rect l="0" t="0" r="0" b="0"/>
            <a:pathLst>
              <a:path w="173990" h="502920">
                <a:moveTo>
                  <a:pt x="86994" y="0"/>
                </a:moveTo>
                <a:lnTo>
                  <a:pt x="173990" y="0"/>
                </a:lnTo>
                <a:lnTo>
                  <a:pt x="173990" y="502920"/>
                </a:lnTo>
                <a:lnTo>
                  <a:pt x="0" y="502920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7" name="Freeform 237"/>
          <p:cNvSpPr/>
          <p:nvPr/>
        </p:nvSpPr>
        <p:spPr>
          <a:xfrm>
            <a:off x="7411376" y="2649533"/>
            <a:ext cx="174116" cy="125730"/>
          </a:xfrm>
          <a:custGeom>
            <a:avLst/>
            <a:gdLst/>
            <a:ahLst/>
            <a:cxnLst/>
            <a:rect l="0" t="0" r="0" b="0"/>
            <a:pathLst>
              <a:path w="174116" h="125730">
                <a:moveTo>
                  <a:pt x="87122" y="0"/>
                </a:moveTo>
                <a:lnTo>
                  <a:pt x="174116" y="0"/>
                </a:lnTo>
                <a:lnTo>
                  <a:pt x="174116" y="125730"/>
                </a:lnTo>
                <a:lnTo>
                  <a:pt x="0" y="125730"/>
                </a:lnTo>
                <a:lnTo>
                  <a:pt x="0" y="0"/>
                </a:lnTo>
                <a:lnTo>
                  <a:pt x="87122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8" name="Freeform 238"/>
          <p:cNvSpPr/>
          <p:nvPr/>
        </p:nvSpPr>
        <p:spPr>
          <a:xfrm>
            <a:off x="7411376" y="2649533"/>
            <a:ext cx="174116" cy="125730"/>
          </a:xfrm>
          <a:custGeom>
            <a:avLst/>
            <a:gdLst/>
            <a:ahLst/>
            <a:cxnLst/>
            <a:rect l="0" t="0" r="0" b="0"/>
            <a:pathLst>
              <a:path w="174116" h="125730">
                <a:moveTo>
                  <a:pt x="87122" y="0"/>
                </a:moveTo>
                <a:lnTo>
                  <a:pt x="174116" y="0"/>
                </a:lnTo>
                <a:lnTo>
                  <a:pt x="174116" y="125730"/>
                </a:lnTo>
                <a:lnTo>
                  <a:pt x="0" y="125730"/>
                </a:lnTo>
                <a:lnTo>
                  <a:pt x="0" y="0"/>
                </a:lnTo>
                <a:lnTo>
                  <a:pt x="87122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9" name="Freeform 239"/>
          <p:cNvSpPr/>
          <p:nvPr/>
        </p:nvSpPr>
        <p:spPr>
          <a:xfrm>
            <a:off x="5323115" y="2775263"/>
            <a:ext cx="173989" cy="0"/>
          </a:xfrm>
          <a:custGeom>
            <a:avLst/>
            <a:gdLst/>
            <a:ahLst/>
            <a:cxnLst/>
            <a:rect l="0" t="0" r="0" b="0"/>
            <a:pathLst>
              <a:path w="173989">
                <a:moveTo>
                  <a:pt x="0" y="0"/>
                </a:moveTo>
                <a:lnTo>
                  <a:pt x="173989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0" name="Freeform 240"/>
          <p:cNvSpPr/>
          <p:nvPr/>
        </p:nvSpPr>
        <p:spPr>
          <a:xfrm>
            <a:off x="5497105" y="2775263"/>
            <a:ext cx="174117" cy="0"/>
          </a:xfrm>
          <a:custGeom>
            <a:avLst/>
            <a:gdLst/>
            <a:ahLst/>
            <a:cxnLst/>
            <a:rect l="0" t="0" r="0" b="0"/>
            <a:pathLst>
              <a:path w="174117">
                <a:moveTo>
                  <a:pt x="0" y="0"/>
                </a:moveTo>
                <a:lnTo>
                  <a:pt x="174117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1" name="Freeform 241"/>
          <p:cNvSpPr/>
          <p:nvPr/>
        </p:nvSpPr>
        <p:spPr>
          <a:xfrm>
            <a:off x="5671222" y="2593526"/>
            <a:ext cx="173991" cy="181737"/>
          </a:xfrm>
          <a:custGeom>
            <a:avLst/>
            <a:gdLst/>
            <a:ahLst/>
            <a:cxnLst/>
            <a:rect l="0" t="0" r="0" b="0"/>
            <a:pathLst>
              <a:path w="173991" h="181737">
                <a:moveTo>
                  <a:pt x="86996" y="0"/>
                </a:moveTo>
                <a:lnTo>
                  <a:pt x="173991" y="0"/>
                </a:lnTo>
                <a:lnTo>
                  <a:pt x="173991" y="181737"/>
                </a:lnTo>
                <a:lnTo>
                  <a:pt x="0" y="181737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2" name="Freeform 242"/>
          <p:cNvSpPr/>
          <p:nvPr/>
        </p:nvSpPr>
        <p:spPr>
          <a:xfrm>
            <a:off x="5671222" y="2593526"/>
            <a:ext cx="173991" cy="181737"/>
          </a:xfrm>
          <a:custGeom>
            <a:avLst/>
            <a:gdLst/>
            <a:ahLst/>
            <a:cxnLst/>
            <a:rect l="0" t="0" r="0" b="0"/>
            <a:pathLst>
              <a:path w="173991" h="181737">
                <a:moveTo>
                  <a:pt x="86996" y="0"/>
                </a:moveTo>
                <a:lnTo>
                  <a:pt x="173991" y="0"/>
                </a:lnTo>
                <a:lnTo>
                  <a:pt x="173991" y="181737"/>
                </a:lnTo>
                <a:lnTo>
                  <a:pt x="0" y="181737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3" name="Freeform 243"/>
          <p:cNvSpPr/>
          <p:nvPr/>
        </p:nvSpPr>
        <p:spPr>
          <a:xfrm>
            <a:off x="5845212" y="2775263"/>
            <a:ext cx="173989" cy="0"/>
          </a:xfrm>
          <a:custGeom>
            <a:avLst/>
            <a:gdLst/>
            <a:ahLst/>
            <a:cxnLst/>
            <a:rect l="0" t="0" r="0" b="0"/>
            <a:pathLst>
              <a:path w="173989">
                <a:moveTo>
                  <a:pt x="0" y="0"/>
                </a:moveTo>
                <a:lnTo>
                  <a:pt x="173989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4" name="Freeform 244"/>
          <p:cNvSpPr/>
          <p:nvPr/>
        </p:nvSpPr>
        <p:spPr>
          <a:xfrm>
            <a:off x="6019202" y="2593526"/>
            <a:ext cx="174117" cy="181737"/>
          </a:xfrm>
          <a:custGeom>
            <a:avLst/>
            <a:gdLst/>
            <a:ahLst/>
            <a:cxnLst/>
            <a:rect l="0" t="0" r="0" b="0"/>
            <a:pathLst>
              <a:path w="174117" h="181737">
                <a:moveTo>
                  <a:pt x="86995" y="0"/>
                </a:moveTo>
                <a:lnTo>
                  <a:pt x="174117" y="0"/>
                </a:lnTo>
                <a:lnTo>
                  <a:pt x="174117" y="181737"/>
                </a:lnTo>
                <a:lnTo>
                  <a:pt x="0" y="181737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5" name="Freeform 245"/>
          <p:cNvSpPr/>
          <p:nvPr/>
        </p:nvSpPr>
        <p:spPr>
          <a:xfrm>
            <a:off x="6019202" y="2593526"/>
            <a:ext cx="174117" cy="181737"/>
          </a:xfrm>
          <a:custGeom>
            <a:avLst/>
            <a:gdLst/>
            <a:ahLst/>
            <a:cxnLst/>
            <a:rect l="0" t="0" r="0" b="0"/>
            <a:pathLst>
              <a:path w="174117" h="181737">
                <a:moveTo>
                  <a:pt x="86995" y="0"/>
                </a:moveTo>
                <a:lnTo>
                  <a:pt x="174117" y="0"/>
                </a:lnTo>
                <a:lnTo>
                  <a:pt x="174117" y="181737"/>
                </a:lnTo>
                <a:lnTo>
                  <a:pt x="0" y="181737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6" name="Freeform 246"/>
          <p:cNvSpPr/>
          <p:nvPr/>
        </p:nvSpPr>
        <p:spPr>
          <a:xfrm>
            <a:off x="6193319" y="1320859"/>
            <a:ext cx="173990" cy="1454404"/>
          </a:xfrm>
          <a:custGeom>
            <a:avLst/>
            <a:gdLst/>
            <a:ahLst/>
            <a:cxnLst/>
            <a:rect l="0" t="0" r="0" b="0"/>
            <a:pathLst>
              <a:path w="173990" h="1454404">
                <a:moveTo>
                  <a:pt x="86996" y="0"/>
                </a:moveTo>
                <a:lnTo>
                  <a:pt x="173990" y="0"/>
                </a:lnTo>
                <a:lnTo>
                  <a:pt x="173990" y="1454404"/>
                </a:lnTo>
                <a:lnTo>
                  <a:pt x="0" y="1454404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7" name="Freeform 247"/>
          <p:cNvSpPr/>
          <p:nvPr/>
        </p:nvSpPr>
        <p:spPr>
          <a:xfrm>
            <a:off x="6193319" y="1320859"/>
            <a:ext cx="173990" cy="1454404"/>
          </a:xfrm>
          <a:custGeom>
            <a:avLst/>
            <a:gdLst/>
            <a:ahLst/>
            <a:cxnLst/>
            <a:rect l="0" t="0" r="0" b="0"/>
            <a:pathLst>
              <a:path w="173990" h="1454404">
                <a:moveTo>
                  <a:pt x="86996" y="0"/>
                </a:moveTo>
                <a:lnTo>
                  <a:pt x="173990" y="0"/>
                </a:lnTo>
                <a:lnTo>
                  <a:pt x="173990" y="1454404"/>
                </a:lnTo>
                <a:lnTo>
                  <a:pt x="0" y="1454404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8" name="Freeform 248"/>
          <p:cNvSpPr/>
          <p:nvPr/>
        </p:nvSpPr>
        <p:spPr>
          <a:xfrm>
            <a:off x="6367309" y="1684461"/>
            <a:ext cx="173991" cy="1090802"/>
          </a:xfrm>
          <a:custGeom>
            <a:avLst/>
            <a:gdLst/>
            <a:ahLst/>
            <a:cxnLst/>
            <a:rect l="0" t="0" r="0" b="0"/>
            <a:pathLst>
              <a:path w="173991" h="1090802">
                <a:moveTo>
                  <a:pt x="86996" y="0"/>
                </a:moveTo>
                <a:lnTo>
                  <a:pt x="173991" y="0"/>
                </a:lnTo>
                <a:lnTo>
                  <a:pt x="173991" y="1090802"/>
                </a:lnTo>
                <a:lnTo>
                  <a:pt x="0" y="1090802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9" name="Freeform 249"/>
          <p:cNvSpPr/>
          <p:nvPr/>
        </p:nvSpPr>
        <p:spPr>
          <a:xfrm>
            <a:off x="6367309" y="1684461"/>
            <a:ext cx="173991" cy="1090802"/>
          </a:xfrm>
          <a:custGeom>
            <a:avLst/>
            <a:gdLst/>
            <a:ahLst/>
            <a:cxnLst/>
            <a:rect l="0" t="0" r="0" b="0"/>
            <a:pathLst>
              <a:path w="173991" h="1090802">
                <a:moveTo>
                  <a:pt x="86996" y="0"/>
                </a:moveTo>
                <a:lnTo>
                  <a:pt x="173991" y="0"/>
                </a:lnTo>
                <a:lnTo>
                  <a:pt x="173991" y="1090802"/>
                </a:lnTo>
                <a:lnTo>
                  <a:pt x="0" y="1090802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0" name="Freeform 250"/>
          <p:cNvSpPr/>
          <p:nvPr/>
        </p:nvSpPr>
        <p:spPr>
          <a:xfrm>
            <a:off x="6541300" y="2411662"/>
            <a:ext cx="173990" cy="363601"/>
          </a:xfrm>
          <a:custGeom>
            <a:avLst/>
            <a:gdLst/>
            <a:ahLst/>
            <a:cxnLst/>
            <a:rect l="0" t="0" r="0" b="0"/>
            <a:pathLst>
              <a:path w="173990" h="363601">
                <a:moveTo>
                  <a:pt x="86994" y="0"/>
                </a:moveTo>
                <a:lnTo>
                  <a:pt x="173990" y="0"/>
                </a:lnTo>
                <a:lnTo>
                  <a:pt x="173990" y="363601"/>
                </a:lnTo>
                <a:lnTo>
                  <a:pt x="0" y="363601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1" name="Freeform 251"/>
          <p:cNvSpPr/>
          <p:nvPr/>
        </p:nvSpPr>
        <p:spPr>
          <a:xfrm>
            <a:off x="6541300" y="2411662"/>
            <a:ext cx="173990" cy="363601"/>
          </a:xfrm>
          <a:custGeom>
            <a:avLst/>
            <a:gdLst/>
            <a:ahLst/>
            <a:cxnLst/>
            <a:rect l="0" t="0" r="0" b="0"/>
            <a:pathLst>
              <a:path w="173990" h="363601">
                <a:moveTo>
                  <a:pt x="86994" y="0"/>
                </a:moveTo>
                <a:lnTo>
                  <a:pt x="173990" y="0"/>
                </a:lnTo>
                <a:lnTo>
                  <a:pt x="173990" y="363601"/>
                </a:lnTo>
                <a:lnTo>
                  <a:pt x="0" y="363601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2" name="Freeform 252"/>
          <p:cNvSpPr/>
          <p:nvPr/>
        </p:nvSpPr>
        <p:spPr>
          <a:xfrm>
            <a:off x="6715289" y="2229925"/>
            <a:ext cx="174116" cy="545338"/>
          </a:xfrm>
          <a:custGeom>
            <a:avLst/>
            <a:gdLst/>
            <a:ahLst/>
            <a:cxnLst/>
            <a:rect l="0" t="0" r="0" b="0"/>
            <a:pathLst>
              <a:path w="174116" h="545338">
                <a:moveTo>
                  <a:pt x="86994" y="0"/>
                </a:moveTo>
                <a:lnTo>
                  <a:pt x="174116" y="0"/>
                </a:lnTo>
                <a:lnTo>
                  <a:pt x="174116" y="545338"/>
                </a:lnTo>
                <a:lnTo>
                  <a:pt x="0" y="545338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3" name="Freeform 253"/>
          <p:cNvSpPr/>
          <p:nvPr/>
        </p:nvSpPr>
        <p:spPr>
          <a:xfrm>
            <a:off x="6715289" y="2229925"/>
            <a:ext cx="174116" cy="545338"/>
          </a:xfrm>
          <a:custGeom>
            <a:avLst/>
            <a:gdLst/>
            <a:ahLst/>
            <a:cxnLst/>
            <a:rect l="0" t="0" r="0" b="0"/>
            <a:pathLst>
              <a:path w="174116" h="545338">
                <a:moveTo>
                  <a:pt x="86994" y="0"/>
                </a:moveTo>
                <a:lnTo>
                  <a:pt x="174116" y="0"/>
                </a:lnTo>
                <a:lnTo>
                  <a:pt x="174116" y="545338"/>
                </a:lnTo>
                <a:lnTo>
                  <a:pt x="0" y="545338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4" name="Freeform 254"/>
          <p:cNvSpPr/>
          <p:nvPr/>
        </p:nvSpPr>
        <p:spPr>
          <a:xfrm>
            <a:off x="6889406" y="2229925"/>
            <a:ext cx="173990" cy="545338"/>
          </a:xfrm>
          <a:custGeom>
            <a:avLst/>
            <a:gdLst/>
            <a:ahLst/>
            <a:cxnLst/>
            <a:rect l="0" t="0" r="0" b="0"/>
            <a:pathLst>
              <a:path w="173990" h="545338">
                <a:moveTo>
                  <a:pt x="86996" y="0"/>
                </a:moveTo>
                <a:lnTo>
                  <a:pt x="173990" y="0"/>
                </a:lnTo>
                <a:lnTo>
                  <a:pt x="173990" y="545338"/>
                </a:lnTo>
                <a:lnTo>
                  <a:pt x="0" y="545338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5" name="Freeform 255"/>
          <p:cNvSpPr/>
          <p:nvPr/>
        </p:nvSpPr>
        <p:spPr>
          <a:xfrm>
            <a:off x="6889406" y="2229925"/>
            <a:ext cx="173990" cy="545338"/>
          </a:xfrm>
          <a:custGeom>
            <a:avLst/>
            <a:gdLst/>
            <a:ahLst/>
            <a:cxnLst/>
            <a:rect l="0" t="0" r="0" b="0"/>
            <a:pathLst>
              <a:path w="173990" h="545338">
                <a:moveTo>
                  <a:pt x="86996" y="0"/>
                </a:moveTo>
                <a:lnTo>
                  <a:pt x="173990" y="0"/>
                </a:lnTo>
                <a:lnTo>
                  <a:pt x="173990" y="545338"/>
                </a:lnTo>
                <a:lnTo>
                  <a:pt x="0" y="545338"/>
                </a:lnTo>
                <a:lnTo>
                  <a:pt x="0" y="0"/>
                </a:lnTo>
                <a:lnTo>
                  <a:pt x="8699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6" name="Freeform 256"/>
          <p:cNvSpPr/>
          <p:nvPr/>
        </p:nvSpPr>
        <p:spPr>
          <a:xfrm>
            <a:off x="7063396" y="1320859"/>
            <a:ext cx="173991" cy="1454404"/>
          </a:xfrm>
          <a:custGeom>
            <a:avLst/>
            <a:gdLst/>
            <a:ahLst/>
            <a:cxnLst/>
            <a:rect l="0" t="0" r="0" b="0"/>
            <a:pathLst>
              <a:path w="173991" h="1454404">
                <a:moveTo>
                  <a:pt x="86995" y="0"/>
                </a:moveTo>
                <a:lnTo>
                  <a:pt x="173991" y="0"/>
                </a:lnTo>
                <a:lnTo>
                  <a:pt x="173991" y="1454404"/>
                </a:lnTo>
                <a:lnTo>
                  <a:pt x="0" y="1454404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7" name="Freeform 257"/>
          <p:cNvSpPr/>
          <p:nvPr/>
        </p:nvSpPr>
        <p:spPr>
          <a:xfrm>
            <a:off x="7063396" y="1320859"/>
            <a:ext cx="173991" cy="1454404"/>
          </a:xfrm>
          <a:custGeom>
            <a:avLst/>
            <a:gdLst/>
            <a:ahLst/>
            <a:cxnLst/>
            <a:rect l="0" t="0" r="0" b="0"/>
            <a:pathLst>
              <a:path w="173991" h="1454404">
                <a:moveTo>
                  <a:pt x="86995" y="0"/>
                </a:moveTo>
                <a:lnTo>
                  <a:pt x="173991" y="0"/>
                </a:lnTo>
                <a:lnTo>
                  <a:pt x="173991" y="1454404"/>
                </a:lnTo>
                <a:lnTo>
                  <a:pt x="0" y="1454404"/>
                </a:lnTo>
                <a:lnTo>
                  <a:pt x="0" y="0"/>
                </a:lnTo>
                <a:lnTo>
                  <a:pt x="86995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8" name="Freeform 258"/>
          <p:cNvSpPr/>
          <p:nvPr/>
        </p:nvSpPr>
        <p:spPr>
          <a:xfrm>
            <a:off x="7237386" y="1866198"/>
            <a:ext cx="173990" cy="909065"/>
          </a:xfrm>
          <a:custGeom>
            <a:avLst/>
            <a:gdLst/>
            <a:ahLst/>
            <a:cxnLst/>
            <a:rect l="0" t="0" r="0" b="0"/>
            <a:pathLst>
              <a:path w="173990" h="909065">
                <a:moveTo>
                  <a:pt x="86994" y="0"/>
                </a:moveTo>
                <a:lnTo>
                  <a:pt x="173990" y="0"/>
                </a:lnTo>
                <a:lnTo>
                  <a:pt x="173990" y="909065"/>
                </a:lnTo>
                <a:lnTo>
                  <a:pt x="0" y="909065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9" name="Freeform 259"/>
          <p:cNvSpPr/>
          <p:nvPr/>
        </p:nvSpPr>
        <p:spPr>
          <a:xfrm>
            <a:off x="7237386" y="1866198"/>
            <a:ext cx="173990" cy="909065"/>
          </a:xfrm>
          <a:custGeom>
            <a:avLst/>
            <a:gdLst/>
            <a:ahLst/>
            <a:cxnLst/>
            <a:rect l="0" t="0" r="0" b="0"/>
            <a:pathLst>
              <a:path w="173990" h="909065">
                <a:moveTo>
                  <a:pt x="86994" y="0"/>
                </a:moveTo>
                <a:lnTo>
                  <a:pt x="173990" y="0"/>
                </a:lnTo>
                <a:lnTo>
                  <a:pt x="173990" y="909065"/>
                </a:lnTo>
                <a:lnTo>
                  <a:pt x="0" y="909065"/>
                </a:lnTo>
                <a:lnTo>
                  <a:pt x="0" y="0"/>
                </a:lnTo>
                <a:lnTo>
                  <a:pt x="86994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0" name="Freeform 260"/>
          <p:cNvSpPr/>
          <p:nvPr/>
        </p:nvSpPr>
        <p:spPr>
          <a:xfrm>
            <a:off x="7411376" y="2775263"/>
            <a:ext cx="174116" cy="0"/>
          </a:xfrm>
          <a:custGeom>
            <a:avLst/>
            <a:gdLst/>
            <a:ahLst/>
            <a:cxnLst/>
            <a:rect l="0" t="0" r="0" b="0"/>
            <a:pathLst>
              <a:path w="174116">
                <a:moveTo>
                  <a:pt x="0" y="0"/>
                </a:moveTo>
                <a:lnTo>
                  <a:pt x="17411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1" name="Freeform 261"/>
          <p:cNvSpPr/>
          <p:nvPr/>
        </p:nvSpPr>
        <p:spPr>
          <a:xfrm>
            <a:off x="5132361" y="1015424"/>
            <a:ext cx="2611754" cy="1758950"/>
          </a:xfrm>
          <a:custGeom>
            <a:avLst/>
            <a:gdLst/>
            <a:ahLst/>
            <a:cxnLst/>
            <a:rect l="0" t="0" r="0" b="0"/>
            <a:pathLst>
              <a:path w="2611754" h="1758950">
                <a:moveTo>
                  <a:pt x="0" y="1758824"/>
                </a:moveTo>
                <a:lnTo>
                  <a:pt x="16129" y="1758443"/>
                </a:lnTo>
                <a:lnTo>
                  <a:pt x="32257" y="1757807"/>
                </a:lnTo>
                <a:lnTo>
                  <a:pt x="48386" y="1756919"/>
                </a:lnTo>
                <a:lnTo>
                  <a:pt x="64515" y="1755902"/>
                </a:lnTo>
                <a:lnTo>
                  <a:pt x="80644" y="1754632"/>
                </a:lnTo>
                <a:lnTo>
                  <a:pt x="96774" y="1752982"/>
                </a:lnTo>
                <a:lnTo>
                  <a:pt x="112903" y="1751076"/>
                </a:lnTo>
                <a:lnTo>
                  <a:pt x="129032" y="1748918"/>
                </a:lnTo>
                <a:lnTo>
                  <a:pt x="145161" y="1746505"/>
                </a:lnTo>
                <a:lnTo>
                  <a:pt x="161290" y="1743838"/>
                </a:lnTo>
                <a:lnTo>
                  <a:pt x="225805" y="1732534"/>
                </a:lnTo>
                <a:lnTo>
                  <a:pt x="241935" y="1730249"/>
                </a:lnTo>
                <a:lnTo>
                  <a:pt x="258063" y="1728217"/>
                </a:lnTo>
                <a:lnTo>
                  <a:pt x="274193" y="1726693"/>
                </a:lnTo>
                <a:lnTo>
                  <a:pt x="290195" y="1725676"/>
                </a:lnTo>
                <a:lnTo>
                  <a:pt x="306324" y="1725295"/>
                </a:lnTo>
                <a:lnTo>
                  <a:pt x="322452" y="1725423"/>
                </a:lnTo>
                <a:lnTo>
                  <a:pt x="338582" y="1726057"/>
                </a:lnTo>
                <a:lnTo>
                  <a:pt x="354710" y="1727074"/>
                </a:lnTo>
                <a:lnTo>
                  <a:pt x="370840" y="1728217"/>
                </a:lnTo>
                <a:lnTo>
                  <a:pt x="386968" y="1729487"/>
                </a:lnTo>
                <a:lnTo>
                  <a:pt x="403098" y="1730630"/>
                </a:lnTo>
                <a:lnTo>
                  <a:pt x="419226" y="1731264"/>
                </a:lnTo>
                <a:lnTo>
                  <a:pt x="435356" y="1731392"/>
                </a:lnTo>
                <a:lnTo>
                  <a:pt x="451485" y="1730630"/>
                </a:lnTo>
                <a:lnTo>
                  <a:pt x="467613" y="1728725"/>
                </a:lnTo>
                <a:lnTo>
                  <a:pt x="483743" y="1725423"/>
                </a:lnTo>
                <a:lnTo>
                  <a:pt x="499871" y="1720724"/>
                </a:lnTo>
                <a:lnTo>
                  <a:pt x="516001" y="1714374"/>
                </a:lnTo>
                <a:lnTo>
                  <a:pt x="532129" y="1706245"/>
                </a:lnTo>
                <a:lnTo>
                  <a:pt x="548259" y="1696339"/>
                </a:lnTo>
                <a:lnTo>
                  <a:pt x="564387" y="1684656"/>
                </a:lnTo>
                <a:lnTo>
                  <a:pt x="580390" y="1671320"/>
                </a:lnTo>
                <a:lnTo>
                  <a:pt x="596518" y="1656462"/>
                </a:lnTo>
                <a:lnTo>
                  <a:pt x="612648" y="1640206"/>
                </a:lnTo>
                <a:lnTo>
                  <a:pt x="628776" y="1622933"/>
                </a:lnTo>
                <a:lnTo>
                  <a:pt x="644906" y="1604645"/>
                </a:lnTo>
                <a:lnTo>
                  <a:pt x="677163" y="1566419"/>
                </a:lnTo>
                <a:lnTo>
                  <a:pt x="709421" y="1526413"/>
                </a:lnTo>
                <a:lnTo>
                  <a:pt x="725551" y="1505586"/>
                </a:lnTo>
                <a:lnTo>
                  <a:pt x="741679" y="1483869"/>
                </a:lnTo>
                <a:lnTo>
                  <a:pt x="757809" y="1460755"/>
                </a:lnTo>
                <a:lnTo>
                  <a:pt x="773937" y="1435608"/>
                </a:lnTo>
                <a:lnTo>
                  <a:pt x="790066" y="1407669"/>
                </a:lnTo>
                <a:lnTo>
                  <a:pt x="806196" y="1376173"/>
                </a:lnTo>
                <a:lnTo>
                  <a:pt x="822324" y="1340358"/>
                </a:lnTo>
                <a:lnTo>
                  <a:pt x="838454" y="1299211"/>
                </a:lnTo>
                <a:lnTo>
                  <a:pt x="854582" y="1251967"/>
                </a:lnTo>
                <a:lnTo>
                  <a:pt x="870585" y="1198119"/>
                </a:lnTo>
                <a:lnTo>
                  <a:pt x="886713" y="1137413"/>
                </a:lnTo>
                <a:lnTo>
                  <a:pt x="902843" y="1069594"/>
                </a:lnTo>
                <a:lnTo>
                  <a:pt x="918971" y="994792"/>
                </a:lnTo>
                <a:lnTo>
                  <a:pt x="935101" y="913765"/>
                </a:lnTo>
                <a:lnTo>
                  <a:pt x="951229" y="827278"/>
                </a:lnTo>
                <a:lnTo>
                  <a:pt x="983487" y="643256"/>
                </a:lnTo>
                <a:lnTo>
                  <a:pt x="1015746" y="456184"/>
                </a:lnTo>
                <a:lnTo>
                  <a:pt x="1031874" y="366650"/>
                </a:lnTo>
                <a:lnTo>
                  <a:pt x="1048003" y="282702"/>
                </a:lnTo>
                <a:lnTo>
                  <a:pt x="1064132" y="206630"/>
                </a:lnTo>
                <a:lnTo>
                  <a:pt x="1080262" y="140209"/>
                </a:lnTo>
                <a:lnTo>
                  <a:pt x="1096391" y="85345"/>
                </a:lnTo>
                <a:lnTo>
                  <a:pt x="1112519" y="43053"/>
                </a:lnTo>
                <a:lnTo>
                  <a:pt x="1128649" y="14606"/>
                </a:lnTo>
                <a:lnTo>
                  <a:pt x="1144778" y="255"/>
                </a:lnTo>
                <a:lnTo>
                  <a:pt x="1160779" y="0"/>
                </a:lnTo>
                <a:lnTo>
                  <a:pt x="1176909" y="13462"/>
                </a:lnTo>
                <a:lnTo>
                  <a:pt x="1193038" y="39878"/>
                </a:lnTo>
                <a:lnTo>
                  <a:pt x="1209166" y="77978"/>
                </a:lnTo>
                <a:lnTo>
                  <a:pt x="1225296" y="126365"/>
                </a:lnTo>
                <a:lnTo>
                  <a:pt x="1241425" y="183770"/>
                </a:lnTo>
                <a:lnTo>
                  <a:pt x="1257553" y="248539"/>
                </a:lnTo>
                <a:lnTo>
                  <a:pt x="1273682" y="319025"/>
                </a:lnTo>
                <a:lnTo>
                  <a:pt x="1289812" y="393574"/>
                </a:lnTo>
                <a:lnTo>
                  <a:pt x="1370456" y="776987"/>
                </a:lnTo>
                <a:lnTo>
                  <a:pt x="1386585" y="846963"/>
                </a:lnTo>
                <a:lnTo>
                  <a:pt x="1402715" y="912369"/>
                </a:lnTo>
                <a:lnTo>
                  <a:pt x="1418844" y="972694"/>
                </a:lnTo>
                <a:lnTo>
                  <a:pt x="1434972" y="1027303"/>
                </a:lnTo>
                <a:lnTo>
                  <a:pt x="1450975" y="1075944"/>
                </a:lnTo>
                <a:lnTo>
                  <a:pt x="1467103" y="1118870"/>
                </a:lnTo>
                <a:lnTo>
                  <a:pt x="1483232" y="1155955"/>
                </a:lnTo>
                <a:lnTo>
                  <a:pt x="1499362" y="1187705"/>
                </a:lnTo>
                <a:lnTo>
                  <a:pt x="1515491" y="1214501"/>
                </a:lnTo>
                <a:lnTo>
                  <a:pt x="1531619" y="1236981"/>
                </a:lnTo>
                <a:lnTo>
                  <a:pt x="1547749" y="1255650"/>
                </a:lnTo>
                <a:lnTo>
                  <a:pt x="1563878" y="1271144"/>
                </a:lnTo>
                <a:lnTo>
                  <a:pt x="1580006" y="1283844"/>
                </a:lnTo>
                <a:lnTo>
                  <a:pt x="1596135" y="1294257"/>
                </a:lnTo>
                <a:lnTo>
                  <a:pt x="1612265" y="1302639"/>
                </a:lnTo>
                <a:lnTo>
                  <a:pt x="1628394" y="1309244"/>
                </a:lnTo>
                <a:lnTo>
                  <a:pt x="1644522" y="1314196"/>
                </a:lnTo>
                <a:lnTo>
                  <a:pt x="1660651" y="1317752"/>
                </a:lnTo>
                <a:lnTo>
                  <a:pt x="1676781" y="1319657"/>
                </a:lnTo>
                <a:lnTo>
                  <a:pt x="1692909" y="1320038"/>
                </a:lnTo>
                <a:lnTo>
                  <a:pt x="1709038" y="1319023"/>
                </a:lnTo>
                <a:lnTo>
                  <a:pt x="1725168" y="1316609"/>
                </a:lnTo>
                <a:lnTo>
                  <a:pt x="1741169" y="1312926"/>
                </a:lnTo>
                <a:lnTo>
                  <a:pt x="1757299" y="1308355"/>
                </a:lnTo>
                <a:lnTo>
                  <a:pt x="1773428" y="1303020"/>
                </a:lnTo>
                <a:lnTo>
                  <a:pt x="1805685" y="1291844"/>
                </a:lnTo>
                <a:lnTo>
                  <a:pt x="1821815" y="1286764"/>
                </a:lnTo>
                <a:lnTo>
                  <a:pt x="1837944" y="1282574"/>
                </a:lnTo>
                <a:lnTo>
                  <a:pt x="1854072" y="1279652"/>
                </a:lnTo>
                <a:lnTo>
                  <a:pt x="1870201" y="1278256"/>
                </a:lnTo>
                <a:lnTo>
                  <a:pt x="1886331" y="1278637"/>
                </a:lnTo>
                <a:lnTo>
                  <a:pt x="1902459" y="1280923"/>
                </a:lnTo>
                <a:lnTo>
                  <a:pt x="1918588" y="1285240"/>
                </a:lnTo>
                <a:lnTo>
                  <a:pt x="1934718" y="1291718"/>
                </a:lnTo>
                <a:lnTo>
                  <a:pt x="1950847" y="1300226"/>
                </a:lnTo>
                <a:lnTo>
                  <a:pt x="1966975" y="1310894"/>
                </a:lnTo>
                <a:lnTo>
                  <a:pt x="1983104" y="1323468"/>
                </a:lnTo>
                <a:lnTo>
                  <a:pt x="1999234" y="1338073"/>
                </a:lnTo>
                <a:lnTo>
                  <a:pt x="2015363" y="1354456"/>
                </a:lnTo>
                <a:lnTo>
                  <a:pt x="2031365" y="1372489"/>
                </a:lnTo>
                <a:lnTo>
                  <a:pt x="2047494" y="1392048"/>
                </a:lnTo>
                <a:lnTo>
                  <a:pt x="2063622" y="1412749"/>
                </a:lnTo>
                <a:lnTo>
                  <a:pt x="2079751" y="1434465"/>
                </a:lnTo>
                <a:lnTo>
                  <a:pt x="2176525" y="1568324"/>
                </a:lnTo>
                <a:lnTo>
                  <a:pt x="2192654" y="1588263"/>
                </a:lnTo>
                <a:lnTo>
                  <a:pt x="2208784" y="1607058"/>
                </a:lnTo>
                <a:lnTo>
                  <a:pt x="2224913" y="1624331"/>
                </a:lnTo>
                <a:lnTo>
                  <a:pt x="2241041" y="1640078"/>
                </a:lnTo>
                <a:lnTo>
                  <a:pt x="2257171" y="1654430"/>
                </a:lnTo>
                <a:lnTo>
                  <a:pt x="2273300" y="1667257"/>
                </a:lnTo>
                <a:lnTo>
                  <a:pt x="2289428" y="1678687"/>
                </a:lnTo>
                <a:lnTo>
                  <a:pt x="2305431" y="1688846"/>
                </a:lnTo>
                <a:lnTo>
                  <a:pt x="2321559" y="1697863"/>
                </a:lnTo>
                <a:lnTo>
                  <a:pt x="2337688" y="1705992"/>
                </a:lnTo>
                <a:lnTo>
                  <a:pt x="2353818" y="1713103"/>
                </a:lnTo>
                <a:lnTo>
                  <a:pt x="2369947" y="1719581"/>
                </a:lnTo>
                <a:lnTo>
                  <a:pt x="2386075" y="1725295"/>
                </a:lnTo>
                <a:lnTo>
                  <a:pt x="2402204" y="1730502"/>
                </a:lnTo>
                <a:lnTo>
                  <a:pt x="2418334" y="1735201"/>
                </a:lnTo>
                <a:lnTo>
                  <a:pt x="2434463" y="1739265"/>
                </a:lnTo>
                <a:lnTo>
                  <a:pt x="2450591" y="1742949"/>
                </a:lnTo>
                <a:lnTo>
                  <a:pt x="2466721" y="1746124"/>
                </a:lnTo>
                <a:lnTo>
                  <a:pt x="2482850" y="1748918"/>
                </a:lnTo>
                <a:lnTo>
                  <a:pt x="2498978" y="1751331"/>
                </a:lnTo>
                <a:lnTo>
                  <a:pt x="2515107" y="1753236"/>
                </a:lnTo>
                <a:lnTo>
                  <a:pt x="2531237" y="1754887"/>
                </a:lnTo>
                <a:lnTo>
                  <a:pt x="2547366" y="1756157"/>
                </a:lnTo>
                <a:lnTo>
                  <a:pt x="2563494" y="1757173"/>
                </a:lnTo>
                <a:lnTo>
                  <a:pt x="2579624" y="1757934"/>
                </a:lnTo>
                <a:lnTo>
                  <a:pt x="2595625" y="1758569"/>
                </a:lnTo>
                <a:lnTo>
                  <a:pt x="2611754" y="1758950"/>
                </a:lnTo>
              </a:path>
            </a:pathLst>
          </a:custGeom>
          <a:noFill/>
          <a:ln w="18288" cap="flat" cmpd="sng">
            <a:solidFill>
              <a:srgbClr val="445694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2" name="Freeform 262"/>
          <p:cNvSpPr/>
          <p:nvPr/>
        </p:nvSpPr>
        <p:spPr>
          <a:xfrm>
            <a:off x="5360707" y="1869245"/>
            <a:ext cx="2731388" cy="903479"/>
          </a:xfrm>
          <a:custGeom>
            <a:avLst/>
            <a:gdLst/>
            <a:ahLst/>
            <a:cxnLst/>
            <a:rect l="0" t="0" r="0" b="0"/>
            <a:pathLst>
              <a:path w="2731388" h="903479">
                <a:moveTo>
                  <a:pt x="0" y="902209"/>
                </a:moveTo>
                <a:lnTo>
                  <a:pt x="11556" y="901700"/>
                </a:lnTo>
                <a:lnTo>
                  <a:pt x="23114" y="901066"/>
                </a:lnTo>
                <a:lnTo>
                  <a:pt x="34670" y="900430"/>
                </a:lnTo>
                <a:lnTo>
                  <a:pt x="46228" y="899668"/>
                </a:lnTo>
                <a:lnTo>
                  <a:pt x="57785" y="898779"/>
                </a:lnTo>
                <a:lnTo>
                  <a:pt x="69469" y="897763"/>
                </a:lnTo>
                <a:lnTo>
                  <a:pt x="81025" y="896748"/>
                </a:lnTo>
                <a:lnTo>
                  <a:pt x="92583" y="895604"/>
                </a:lnTo>
                <a:lnTo>
                  <a:pt x="104139" y="894335"/>
                </a:lnTo>
                <a:lnTo>
                  <a:pt x="115697" y="892811"/>
                </a:lnTo>
                <a:lnTo>
                  <a:pt x="127253" y="891160"/>
                </a:lnTo>
                <a:lnTo>
                  <a:pt x="138811" y="889509"/>
                </a:lnTo>
                <a:lnTo>
                  <a:pt x="150367" y="887477"/>
                </a:lnTo>
                <a:lnTo>
                  <a:pt x="162052" y="885317"/>
                </a:lnTo>
                <a:lnTo>
                  <a:pt x="173608" y="883031"/>
                </a:lnTo>
                <a:lnTo>
                  <a:pt x="185166" y="880492"/>
                </a:lnTo>
                <a:lnTo>
                  <a:pt x="196722" y="877571"/>
                </a:lnTo>
                <a:lnTo>
                  <a:pt x="208280" y="874523"/>
                </a:lnTo>
                <a:lnTo>
                  <a:pt x="219836" y="871221"/>
                </a:lnTo>
                <a:lnTo>
                  <a:pt x="231394" y="867537"/>
                </a:lnTo>
                <a:lnTo>
                  <a:pt x="243078" y="863600"/>
                </a:lnTo>
                <a:lnTo>
                  <a:pt x="254635" y="859282"/>
                </a:lnTo>
                <a:lnTo>
                  <a:pt x="266191" y="854711"/>
                </a:lnTo>
                <a:lnTo>
                  <a:pt x="277749" y="849630"/>
                </a:lnTo>
                <a:lnTo>
                  <a:pt x="289305" y="844297"/>
                </a:lnTo>
                <a:lnTo>
                  <a:pt x="300863" y="838454"/>
                </a:lnTo>
                <a:lnTo>
                  <a:pt x="312419" y="832231"/>
                </a:lnTo>
                <a:lnTo>
                  <a:pt x="323977" y="825500"/>
                </a:lnTo>
                <a:lnTo>
                  <a:pt x="335661" y="818388"/>
                </a:lnTo>
                <a:lnTo>
                  <a:pt x="347217" y="810768"/>
                </a:lnTo>
                <a:lnTo>
                  <a:pt x="358775" y="802641"/>
                </a:lnTo>
                <a:lnTo>
                  <a:pt x="370331" y="794004"/>
                </a:lnTo>
                <a:lnTo>
                  <a:pt x="381889" y="784861"/>
                </a:lnTo>
                <a:lnTo>
                  <a:pt x="393445" y="775209"/>
                </a:lnTo>
                <a:lnTo>
                  <a:pt x="405003" y="764922"/>
                </a:lnTo>
                <a:lnTo>
                  <a:pt x="416686" y="753999"/>
                </a:lnTo>
                <a:lnTo>
                  <a:pt x="428244" y="742569"/>
                </a:lnTo>
                <a:lnTo>
                  <a:pt x="439800" y="730631"/>
                </a:lnTo>
                <a:lnTo>
                  <a:pt x="451358" y="718059"/>
                </a:lnTo>
                <a:lnTo>
                  <a:pt x="462914" y="704850"/>
                </a:lnTo>
                <a:lnTo>
                  <a:pt x="474472" y="691007"/>
                </a:lnTo>
                <a:lnTo>
                  <a:pt x="486028" y="676656"/>
                </a:lnTo>
                <a:lnTo>
                  <a:pt x="497586" y="661671"/>
                </a:lnTo>
                <a:lnTo>
                  <a:pt x="509269" y="646177"/>
                </a:lnTo>
                <a:lnTo>
                  <a:pt x="520827" y="630048"/>
                </a:lnTo>
                <a:lnTo>
                  <a:pt x="532383" y="613537"/>
                </a:lnTo>
                <a:lnTo>
                  <a:pt x="555497" y="578612"/>
                </a:lnTo>
                <a:lnTo>
                  <a:pt x="578611" y="541910"/>
                </a:lnTo>
                <a:lnTo>
                  <a:pt x="601853" y="503682"/>
                </a:lnTo>
                <a:lnTo>
                  <a:pt x="636524" y="443738"/>
                </a:lnTo>
                <a:lnTo>
                  <a:pt x="763905" y="221742"/>
                </a:lnTo>
                <a:lnTo>
                  <a:pt x="787019" y="185167"/>
                </a:lnTo>
                <a:lnTo>
                  <a:pt x="798575" y="167641"/>
                </a:lnTo>
                <a:lnTo>
                  <a:pt x="810133" y="150877"/>
                </a:lnTo>
                <a:lnTo>
                  <a:pt x="821689" y="134874"/>
                </a:lnTo>
                <a:lnTo>
                  <a:pt x="833247" y="119507"/>
                </a:lnTo>
                <a:lnTo>
                  <a:pt x="844804" y="105029"/>
                </a:lnTo>
                <a:lnTo>
                  <a:pt x="856488" y="91441"/>
                </a:lnTo>
                <a:lnTo>
                  <a:pt x="868045" y="78613"/>
                </a:lnTo>
                <a:lnTo>
                  <a:pt x="879601" y="66675"/>
                </a:lnTo>
                <a:lnTo>
                  <a:pt x="891158" y="55754"/>
                </a:lnTo>
                <a:lnTo>
                  <a:pt x="902716" y="45848"/>
                </a:lnTo>
                <a:lnTo>
                  <a:pt x="914273" y="36830"/>
                </a:lnTo>
                <a:lnTo>
                  <a:pt x="925829" y="28829"/>
                </a:lnTo>
                <a:lnTo>
                  <a:pt x="937386" y="21844"/>
                </a:lnTo>
                <a:lnTo>
                  <a:pt x="949070" y="15875"/>
                </a:lnTo>
                <a:lnTo>
                  <a:pt x="960628" y="10796"/>
                </a:lnTo>
                <a:lnTo>
                  <a:pt x="972185" y="6731"/>
                </a:lnTo>
                <a:lnTo>
                  <a:pt x="983742" y="3684"/>
                </a:lnTo>
                <a:lnTo>
                  <a:pt x="995298" y="1524"/>
                </a:lnTo>
                <a:lnTo>
                  <a:pt x="1006855" y="381"/>
                </a:lnTo>
                <a:lnTo>
                  <a:pt x="1018413" y="0"/>
                </a:lnTo>
                <a:lnTo>
                  <a:pt x="1030097" y="509"/>
                </a:lnTo>
                <a:lnTo>
                  <a:pt x="1041654" y="1905"/>
                </a:lnTo>
                <a:lnTo>
                  <a:pt x="1053210" y="4065"/>
                </a:lnTo>
                <a:lnTo>
                  <a:pt x="1064767" y="6859"/>
                </a:lnTo>
                <a:lnTo>
                  <a:pt x="1076325" y="10415"/>
                </a:lnTo>
                <a:lnTo>
                  <a:pt x="1087882" y="14479"/>
                </a:lnTo>
                <a:lnTo>
                  <a:pt x="1099438" y="19178"/>
                </a:lnTo>
                <a:lnTo>
                  <a:pt x="1110995" y="24511"/>
                </a:lnTo>
                <a:lnTo>
                  <a:pt x="1122679" y="30099"/>
                </a:lnTo>
                <a:lnTo>
                  <a:pt x="1134236" y="36323"/>
                </a:lnTo>
                <a:lnTo>
                  <a:pt x="1145794" y="42799"/>
                </a:lnTo>
                <a:lnTo>
                  <a:pt x="1157351" y="49530"/>
                </a:lnTo>
                <a:lnTo>
                  <a:pt x="1180464" y="63754"/>
                </a:lnTo>
                <a:lnTo>
                  <a:pt x="1296288" y="136779"/>
                </a:lnTo>
                <a:lnTo>
                  <a:pt x="1307845" y="143384"/>
                </a:lnTo>
                <a:lnTo>
                  <a:pt x="1319403" y="149606"/>
                </a:lnTo>
                <a:lnTo>
                  <a:pt x="1330960" y="155575"/>
                </a:lnTo>
                <a:lnTo>
                  <a:pt x="1342517" y="161291"/>
                </a:lnTo>
                <a:lnTo>
                  <a:pt x="1354073" y="166624"/>
                </a:lnTo>
                <a:lnTo>
                  <a:pt x="1365630" y="171704"/>
                </a:lnTo>
                <a:lnTo>
                  <a:pt x="1377314" y="176404"/>
                </a:lnTo>
                <a:lnTo>
                  <a:pt x="1388872" y="180722"/>
                </a:lnTo>
                <a:lnTo>
                  <a:pt x="1400429" y="184786"/>
                </a:lnTo>
                <a:lnTo>
                  <a:pt x="1411985" y="188468"/>
                </a:lnTo>
                <a:lnTo>
                  <a:pt x="1423542" y="191898"/>
                </a:lnTo>
                <a:lnTo>
                  <a:pt x="1435100" y="194946"/>
                </a:lnTo>
                <a:lnTo>
                  <a:pt x="1446657" y="197740"/>
                </a:lnTo>
                <a:lnTo>
                  <a:pt x="1458213" y="200153"/>
                </a:lnTo>
                <a:lnTo>
                  <a:pt x="1469898" y="202311"/>
                </a:lnTo>
                <a:lnTo>
                  <a:pt x="1481454" y="204217"/>
                </a:lnTo>
                <a:lnTo>
                  <a:pt x="1493011" y="205867"/>
                </a:lnTo>
                <a:lnTo>
                  <a:pt x="1504569" y="207265"/>
                </a:lnTo>
                <a:lnTo>
                  <a:pt x="1516126" y="208407"/>
                </a:lnTo>
                <a:lnTo>
                  <a:pt x="1527682" y="209423"/>
                </a:lnTo>
                <a:lnTo>
                  <a:pt x="1539239" y="210312"/>
                </a:lnTo>
                <a:lnTo>
                  <a:pt x="1550923" y="211074"/>
                </a:lnTo>
                <a:lnTo>
                  <a:pt x="1562480" y="211710"/>
                </a:lnTo>
                <a:lnTo>
                  <a:pt x="1574038" y="212344"/>
                </a:lnTo>
                <a:lnTo>
                  <a:pt x="1597151" y="213487"/>
                </a:lnTo>
                <a:lnTo>
                  <a:pt x="1608708" y="214123"/>
                </a:lnTo>
                <a:lnTo>
                  <a:pt x="1620266" y="214757"/>
                </a:lnTo>
                <a:lnTo>
                  <a:pt x="1631823" y="215519"/>
                </a:lnTo>
                <a:lnTo>
                  <a:pt x="1643507" y="216536"/>
                </a:lnTo>
                <a:lnTo>
                  <a:pt x="1655063" y="217679"/>
                </a:lnTo>
                <a:lnTo>
                  <a:pt x="1666620" y="218948"/>
                </a:lnTo>
                <a:lnTo>
                  <a:pt x="1678178" y="220599"/>
                </a:lnTo>
                <a:lnTo>
                  <a:pt x="1689735" y="222504"/>
                </a:lnTo>
                <a:lnTo>
                  <a:pt x="1701292" y="224663"/>
                </a:lnTo>
                <a:lnTo>
                  <a:pt x="1712848" y="227204"/>
                </a:lnTo>
                <a:lnTo>
                  <a:pt x="1724532" y="230252"/>
                </a:lnTo>
                <a:lnTo>
                  <a:pt x="1736089" y="233554"/>
                </a:lnTo>
                <a:lnTo>
                  <a:pt x="1747647" y="237363"/>
                </a:lnTo>
                <a:lnTo>
                  <a:pt x="1759204" y="241681"/>
                </a:lnTo>
                <a:lnTo>
                  <a:pt x="1770760" y="246380"/>
                </a:lnTo>
                <a:lnTo>
                  <a:pt x="1782317" y="251715"/>
                </a:lnTo>
                <a:lnTo>
                  <a:pt x="1793875" y="257429"/>
                </a:lnTo>
                <a:lnTo>
                  <a:pt x="1805432" y="263779"/>
                </a:lnTo>
                <a:lnTo>
                  <a:pt x="1817116" y="270637"/>
                </a:lnTo>
                <a:lnTo>
                  <a:pt x="1828673" y="278004"/>
                </a:lnTo>
                <a:lnTo>
                  <a:pt x="1840229" y="286004"/>
                </a:lnTo>
                <a:lnTo>
                  <a:pt x="1851786" y="294513"/>
                </a:lnTo>
                <a:lnTo>
                  <a:pt x="1863344" y="303530"/>
                </a:lnTo>
                <a:lnTo>
                  <a:pt x="1874901" y="313182"/>
                </a:lnTo>
                <a:lnTo>
                  <a:pt x="1886457" y="323216"/>
                </a:lnTo>
                <a:lnTo>
                  <a:pt x="1898142" y="333884"/>
                </a:lnTo>
                <a:lnTo>
                  <a:pt x="1909698" y="345060"/>
                </a:lnTo>
                <a:lnTo>
                  <a:pt x="1921255" y="356617"/>
                </a:lnTo>
                <a:lnTo>
                  <a:pt x="1932813" y="368681"/>
                </a:lnTo>
                <a:lnTo>
                  <a:pt x="1944370" y="381128"/>
                </a:lnTo>
                <a:lnTo>
                  <a:pt x="1967483" y="407290"/>
                </a:lnTo>
                <a:lnTo>
                  <a:pt x="1990725" y="434722"/>
                </a:lnTo>
                <a:lnTo>
                  <a:pt x="2025395" y="477648"/>
                </a:lnTo>
                <a:lnTo>
                  <a:pt x="2164333" y="650875"/>
                </a:lnTo>
                <a:lnTo>
                  <a:pt x="2187448" y="677037"/>
                </a:lnTo>
                <a:lnTo>
                  <a:pt x="2210561" y="701929"/>
                </a:lnTo>
                <a:lnTo>
                  <a:pt x="2222119" y="713741"/>
                </a:lnTo>
                <a:lnTo>
                  <a:pt x="2233676" y="725298"/>
                </a:lnTo>
                <a:lnTo>
                  <a:pt x="2245232" y="736347"/>
                </a:lnTo>
                <a:lnTo>
                  <a:pt x="2256917" y="747015"/>
                </a:lnTo>
                <a:lnTo>
                  <a:pt x="2268473" y="757174"/>
                </a:lnTo>
                <a:lnTo>
                  <a:pt x="2280030" y="767080"/>
                </a:lnTo>
                <a:lnTo>
                  <a:pt x="2291588" y="776479"/>
                </a:lnTo>
                <a:lnTo>
                  <a:pt x="2303145" y="785368"/>
                </a:lnTo>
                <a:lnTo>
                  <a:pt x="2314701" y="793878"/>
                </a:lnTo>
                <a:lnTo>
                  <a:pt x="2326258" y="802005"/>
                </a:lnTo>
                <a:lnTo>
                  <a:pt x="2337942" y="809625"/>
                </a:lnTo>
                <a:lnTo>
                  <a:pt x="2349500" y="816992"/>
                </a:lnTo>
                <a:lnTo>
                  <a:pt x="2361057" y="823849"/>
                </a:lnTo>
                <a:lnTo>
                  <a:pt x="2372613" y="830199"/>
                </a:lnTo>
                <a:lnTo>
                  <a:pt x="2384170" y="836296"/>
                </a:lnTo>
                <a:lnTo>
                  <a:pt x="2395728" y="842011"/>
                </a:lnTo>
                <a:lnTo>
                  <a:pt x="2407285" y="847344"/>
                </a:lnTo>
                <a:lnTo>
                  <a:pt x="2418842" y="852298"/>
                </a:lnTo>
                <a:lnTo>
                  <a:pt x="2430526" y="856997"/>
                </a:lnTo>
                <a:lnTo>
                  <a:pt x="2442082" y="861315"/>
                </a:lnTo>
                <a:lnTo>
                  <a:pt x="2453639" y="865252"/>
                </a:lnTo>
                <a:lnTo>
                  <a:pt x="2465197" y="868935"/>
                </a:lnTo>
                <a:lnTo>
                  <a:pt x="2476754" y="872363"/>
                </a:lnTo>
                <a:lnTo>
                  <a:pt x="2488311" y="875538"/>
                </a:lnTo>
                <a:lnTo>
                  <a:pt x="2499868" y="878460"/>
                </a:lnTo>
                <a:lnTo>
                  <a:pt x="2511551" y="881254"/>
                </a:lnTo>
                <a:lnTo>
                  <a:pt x="2523108" y="883667"/>
                </a:lnTo>
                <a:lnTo>
                  <a:pt x="2534666" y="885953"/>
                </a:lnTo>
                <a:lnTo>
                  <a:pt x="2546223" y="887985"/>
                </a:lnTo>
                <a:lnTo>
                  <a:pt x="2557780" y="889890"/>
                </a:lnTo>
                <a:lnTo>
                  <a:pt x="2569337" y="891541"/>
                </a:lnTo>
                <a:lnTo>
                  <a:pt x="2580893" y="893065"/>
                </a:lnTo>
                <a:lnTo>
                  <a:pt x="2592450" y="894461"/>
                </a:lnTo>
                <a:lnTo>
                  <a:pt x="2604135" y="895731"/>
                </a:lnTo>
                <a:lnTo>
                  <a:pt x="2615692" y="896874"/>
                </a:lnTo>
                <a:lnTo>
                  <a:pt x="2627249" y="898017"/>
                </a:lnTo>
                <a:lnTo>
                  <a:pt x="2638806" y="898906"/>
                </a:lnTo>
                <a:lnTo>
                  <a:pt x="2650362" y="899668"/>
                </a:lnTo>
                <a:lnTo>
                  <a:pt x="2661919" y="900430"/>
                </a:lnTo>
                <a:lnTo>
                  <a:pt x="2673476" y="901192"/>
                </a:lnTo>
                <a:lnTo>
                  <a:pt x="2685161" y="901700"/>
                </a:lnTo>
                <a:lnTo>
                  <a:pt x="2696718" y="902209"/>
                </a:lnTo>
                <a:lnTo>
                  <a:pt x="2708274" y="902717"/>
                </a:lnTo>
                <a:lnTo>
                  <a:pt x="2719831" y="903098"/>
                </a:lnTo>
                <a:lnTo>
                  <a:pt x="2731388" y="903479"/>
                </a:lnTo>
              </a:path>
            </a:pathLst>
          </a:custGeom>
          <a:noFill/>
          <a:ln w="18288" cap="flat" cmpd="sng">
            <a:solidFill>
              <a:srgbClr val="A23A2E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3" name="Freeform 263"/>
          <p:cNvSpPr/>
          <p:nvPr/>
        </p:nvSpPr>
        <p:spPr>
          <a:xfrm>
            <a:off x="5076227" y="2011105"/>
            <a:ext cx="3042793" cy="762253"/>
          </a:xfrm>
          <a:custGeom>
            <a:avLst/>
            <a:gdLst/>
            <a:ahLst/>
            <a:cxnLst/>
            <a:rect l="0" t="0" r="0" b="0"/>
            <a:pathLst>
              <a:path w="3042793" h="762253">
                <a:moveTo>
                  <a:pt x="0" y="762253"/>
                </a:moveTo>
                <a:lnTo>
                  <a:pt x="11939" y="762000"/>
                </a:lnTo>
                <a:lnTo>
                  <a:pt x="23750" y="761745"/>
                </a:lnTo>
                <a:lnTo>
                  <a:pt x="35688" y="761492"/>
                </a:lnTo>
                <a:lnTo>
                  <a:pt x="47625" y="761238"/>
                </a:lnTo>
                <a:lnTo>
                  <a:pt x="59436" y="760857"/>
                </a:lnTo>
                <a:lnTo>
                  <a:pt x="71375" y="760602"/>
                </a:lnTo>
                <a:lnTo>
                  <a:pt x="83185" y="760221"/>
                </a:lnTo>
                <a:lnTo>
                  <a:pt x="95124" y="759840"/>
                </a:lnTo>
                <a:lnTo>
                  <a:pt x="106935" y="759332"/>
                </a:lnTo>
                <a:lnTo>
                  <a:pt x="118872" y="758825"/>
                </a:lnTo>
                <a:lnTo>
                  <a:pt x="130810" y="758317"/>
                </a:lnTo>
                <a:lnTo>
                  <a:pt x="142621" y="757808"/>
                </a:lnTo>
                <a:lnTo>
                  <a:pt x="154560" y="757174"/>
                </a:lnTo>
                <a:lnTo>
                  <a:pt x="166371" y="756538"/>
                </a:lnTo>
                <a:lnTo>
                  <a:pt x="178309" y="755903"/>
                </a:lnTo>
                <a:lnTo>
                  <a:pt x="190246" y="755142"/>
                </a:lnTo>
                <a:lnTo>
                  <a:pt x="202057" y="754380"/>
                </a:lnTo>
                <a:lnTo>
                  <a:pt x="213996" y="753490"/>
                </a:lnTo>
                <a:lnTo>
                  <a:pt x="225807" y="752601"/>
                </a:lnTo>
                <a:lnTo>
                  <a:pt x="237745" y="751586"/>
                </a:lnTo>
                <a:lnTo>
                  <a:pt x="249682" y="750569"/>
                </a:lnTo>
                <a:lnTo>
                  <a:pt x="261493" y="749426"/>
                </a:lnTo>
                <a:lnTo>
                  <a:pt x="273432" y="748283"/>
                </a:lnTo>
                <a:lnTo>
                  <a:pt x="285242" y="747013"/>
                </a:lnTo>
                <a:lnTo>
                  <a:pt x="297181" y="745617"/>
                </a:lnTo>
                <a:lnTo>
                  <a:pt x="308992" y="744093"/>
                </a:lnTo>
                <a:lnTo>
                  <a:pt x="320930" y="742569"/>
                </a:lnTo>
                <a:lnTo>
                  <a:pt x="332867" y="740918"/>
                </a:lnTo>
                <a:lnTo>
                  <a:pt x="344678" y="739139"/>
                </a:lnTo>
                <a:lnTo>
                  <a:pt x="356617" y="737362"/>
                </a:lnTo>
                <a:lnTo>
                  <a:pt x="368428" y="735330"/>
                </a:lnTo>
                <a:lnTo>
                  <a:pt x="380366" y="733170"/>
                </a:lnTo>
                <a:lnTo>
                  <a:pt x="392303" y="731012"/>
                </a:lnTo>
                <a:lnTo>
                  <a:pt x="404114" y="728599"/>
                </a:lnTo>
                <a:lnTo>
                  <a:pt x="416053" y="726058"/>
                </a:lnTo>
                <a:lnTo>
                  <a:pt x="427864" y="723392"/>
                </a:lnTo>
                <a:lnTo>
                  <a:pt x="439801" y="720597"/>
                </a:lnTo>
                <a:lnTo>
                  <a:pt x="451739" y="717550"/>
                </a:lnTo>
                <a:lnTo>
                  <a:pt x="463550" y="714375"/>
                </a:lnTo>
                <a:lnTo>
                  <a:pt x="475489" y="711072"/>
                </a:lnTo>
                <a:lnTo>
                  <a:pt x="487300" y="707517"/>
                </a:lnTo>
                <a:lnTo>
                  <a:pt x="499237" y="703833"/>
                </a:lnTo>
                <a:lnTo>
                  <a:pt x="511048" y="699896"/>
                </a:lnTo>
                <a:lnTo>
                  <a:pt x="522986" y="695832"/>
                </a:lnTo>
                <a:lnTo>
                  <a:pt x="534925" y="691514"/>
                </a:lnTo>
                <a:lnTo>
                  <a:pt x="546736" y="686943"/>
                </a:lnTo>
                <a:lnTo>
                  <a:pt x="558673" y="682117"/>
                </a:lnTo>
                <a:lnTo>
                  <a:pt x="570484" y="677037"/>
                </a:lnTo>
                <a:lnTo>
                  <a:pt x="582422" y="671702"/>
                </a:lnTo>
                <a:lnTo>
                  <a:pt x="594361" y="666114"/>
                </a:lnTo>
                <a:lnTo>
                  <a:pt x="606172" y="660272"/>
                </a:lnTo>
                <a:lnTo>
                  <a:pt x="618109" y="654176"/>
                </a:lnTo>
                <a:lnTo>
                  <a:pt x="629920" y="647826"/>
                </a:lnTo>
                <a:lnTo>
                  <a:pt x="641859" y="641095"/>
                </a:lnTo>
                <a:lnTo>
                  <a:pt x="653797" y="634111"/>
                </a:lnTo>
                <a:lnTo>
                  <a:pt x="665608" y="626871"/>
                </a:lnTo>
                <a:lnTo>
                  <a:pt x="677545" y="619251"/>
                </a:lnTo>
                <a:lnTo>
                  <a:pt x="689356" y="611251"/>
                </a:lnTo>
                <a:lnTo>
                  <a:pt x="701295" y="603122"/>
                </a:lnTo>
                <a:lnTo>
                  <a:pt x="713233" y="594487"/>
                </a:lnTo>
                <a:lnTo>
                  <a:pt x="725044" y="585596"/>
                </a:lnTo>
                <a:lnTo>
                  <a:pt x="736981" y="576326"/>
                </a:lnTo>
                <a:lnTo>
                  <a:pt x="748792" y="566801"/>
                </a:lnTo>
                <a:lnTo>
                  <a:pt x="760731" y="556894"/>
                </a:lnTo>
                <a:lnTo>
                  <a:pt x="772542" y="546734"/>
                </a:lnTo>
                <a:lnTo>
                  <a:pt x="784480" y="536067"/>
                </a:lnTo>
                <a:lnTo>
                  <a:pt x="808228" y="514095"/>
                </a:lnTo>
                <a:lnTo>
                  <a:pt x="831978" y="490727"/>
                </a:lnTo>
                <a:lnTo>
                  <a:pt x="855853" y="466217"/>
                </a:lnTo>
                <a:lnTo>
                  <a:pt x="879603" y="440689"/>
                </a:lnTo>
                <a:lnTo>
                  <a:pt x="903351" y="414146"/>
                </a:lnTo>
                <a:lnTo>
                  <a:pt x="939039" y="372999"/>
                </a:lnTo>
                <a:lnTo>
                  <a:pt x="1117347" y="165353"/>
                </a:lnTo>
                <a:lnTo>
                  <a:pt x="1141095" y="140969"/>
                </a:lnTo>
                <a:lnTo>
                  <a:pt x="1152907" y="129286"/>
                </a:lnTo>
                <a:lnTo>
                  <a:pt x="1164844" y="118109"/>
                </a:lnTo>
                <a:lnTo>
                  <a:pt x="1176656" y="107314"/>
                </a:lnTo>
                <a:lnTo>
                  <a:pt x="1188594" y="96901"/>
                </a:lnTo>
                <a:lnTo>
                  <a:pt x="1200532" y="87121"/>
                </a:lnTo>
                <a:lnTo>
                  <a:pt x="1212342" y="77724"/>
                </a:lnTo>
                <a:lnTo>
                  <a:pt x="1224281" y="68833"/>
                </a:lnTo>
                <a:lnTo>
                  <a:pt x="1236091" y="60578"/>
                </a:lnTo>
                <a:lnTo>
                  <a:pt x="1248029" y="52705"/>
                </a:lnTo>
                <a:lnTo>
                  <a:pt x="1259967" y="45465"/>
                </a:lnTo>
                <a:lnTo>
                  <a:pt x="1271779" y="38862"/>
                </a:lnTo>
                <a:lnTo>
                  <a:pt x="1283716" y="32638"/>
                </a:lnTo>
                <a:lnTo>
                  <a:pt x="1295528" y="27177"/>
                </a:lnTo>
                <a:lnTo>
                  <a:pt x="1307466" y="22097"/>
                </a:lnTo>
                <a:lnTo>
                  <a:pt x="1319404" y="17652"/>
                </a:lnTo>
                <a:lnTo>
                  <a:pt x="1331214" y="13715"/>
                </a:lnTo>
                <a:lnTo>
                  <a:pt x="1343153" y="10287"/>
                </a:lnTo>
                <a:lnTo>
                  <a:pt x="1354963" y="7493"/>
                </a:lnTo>
                <a:lnTo>
                  <a:pt x="1366901" y="5080"/>
                </a:lnTo>
                <a:lnTo>
                  <a:pt x="1378839" y="3175"/>
                </a:lnTo>
                <a:lnTo>
                  <a:pt x="1390651" y="1777"/>
                </a:lnTo>
                <a:lnTo>
                  <a:pt x="1402588" y="762"/>
                </a:lnTo>
                <a:lnTo>
                  <a:pt x="1414400" y="253"/>
                </a:lnTo>
                <a:lnTo>
                  <a:pt x="1426338" y="0"/>
                </a:lnTo>
                <a:lnTo>
                  <a:pt x="1438148" y="253"/>
                </a:lnTo>
                <a:lnTo>
                  <a:pt x="1450086" y="762"/>
                </a:lnTo>
                <a:lnTo>
                  <a:pt x="1462025" y="1651"/>
                </a:lnTo>
                <a:lnTo>
                  <a:pt x="1473835" y="2667"/>
                </a:lnTo>
                <a:lnTo>
                  <a:pt x="1485773" y="4063"/>
                </a:lnTo>
                <a:lnTo>
                  <a:pt x="1497585" y="5588"/>
                </a:lnTo>
                <a:lnTo>
                  <a:pt x="1509523" y="7365"/>
                </a:lnTo>
                <a:lnTo>
                  <a:pt x="1521460" y="9270"/>
                </a:lnTo>
                <a:lnTo>
                  <a:pt x="1533272" y="11302"/>
                </a:lnTo>
                <a:lnTo>
                  <a:pt x="1557020" y="15494"/>
                </a:lnTo>
                <a:lnTo>
                  <a:pt x="1592707" y="21844"/>
                </a:lnTo>
                <a:lnTo>
                  <a:pt x="1604645" y="24002"/>
                </a:lnTo>
                <a:lnTo>
                  <a:pt x="1616457" y="25907"/>
                </a:lnTo>
                <a:lnTo>
                  <a:pt x="1628394" y="27813"/>
                </a:lnTo>
                <a:lnTo>
                  <a:pt x="1640206" y="29463"/>
                </a:lnTo>
                <a:lnTo>
                  <a:pt x="1652144" y="31114"/>
                </a:lnTo>
                <a:lnTo>
                  <a:pt x="1664082" y="32512"/>
                </a:lnTo>
                <a:lnTo>
                  <a:pt x="1675892" y="33655"/>
                </a:lnTo>
                <a:lnTo>
                  <a:pt x="1687831" y="34797"/>
                </a:lnTo>
                <a:lnTo>
                  <a:pt x="1699641" y="35559"/>
                </a:lnTo>
                <a:lnTo>
                  <a:pt x="1711579" y="36321"/>
                </a:lnTo>
                <a:lnTo>
                  <a:pt x="1723517" y="36702"/>
                </a:lnTo>
                <a:lnTo>
                  <a:pt x="1735329" y="36957"/>
                </a:lnTo>
                <a:lnTo>
                  <a:pt x="1747266" y="37083"/>
                </a:lnTo>
                <a:lnTo>
                  <a:pt x="1759078" y="36957"/>
                </a:lnTo>
                <a:lnTo>
                  <a:pt x="1771016" y="36702"/>
                </a:lnTo>
                <a:lnTo>
                  <a:pt x="1782954" y="36194"/>
                </a:lnTo>
                <a:lnTo>
                  <a:pt x="1794764" y="35559"/>
                </a:lnTo>
                <a:lnTo>
                  <a:pt x="1806703" y="34797"/>
                </a:lnTo>
                <a:lnTo>
                  <a:pt x="1818513" y="34036"/>
                </a:lnTo>
                <a:lnTo>
                  <a:pt x="1830451" y="33019"/>
                </a:lnTo>
                <a:lnTo>
                  <a:pt x="1842263" y="32003"/>
                </a:lnTo>
                <a:lnTo>
                  <a:pt x="1889888" y="27813"/>
                </a:lnTo>
                <a:lnTo>
                  <a:pt x="1901698" y="26924"/>
                </a:lnTo>
                <a:lnTo>
                  <a:pt x="1913636" y="26034"/>
                </a:lnTo>
                <a:lnTo>
                  <a:pt x="1925575" y="25400"/>
                </a:lnTo>
                <a:lnTo>
                  <a:pt x="1937385" y="24892"/>
                </a:lnTo>
                <a:lnTo>
                  <a:pt x="1949323" y="24511"/>
                </a:lnTo>
                <a:lnTo>
                  <a:pt x="1961135" y="24511"/>
                </a:lnTo>
                <a:lnTo>
                  <a:pt x="1973073" y="24764"/>
                </a:lnTo>
                <a:lnTo>
                  <a:pt x="1985010" y="25272"/>
                </a:lnTo>
                <a:lnTo>
                  <a:pt x="1996822" y="26162"/>
                </a:lnTo>
                <a:lnTo>
                  <a:pt x="2008760" y="27432"/>
                </a:lnTo>
                <a:lnTo>
                  <a:pt x="2020570" y="28956"/>
                </a:lnTo>
                <a:lnTo>
                  <a:pt x="2032509" y="31114"/>
                </a:lnTo>
                <a:lnTo>
                  <a:pt x="2044447" y="33527"/>
                </a:lnTo>
                <a:lnTo>
                  <a:pt x="2056257" y="36576"/>
                </a:lnTo>
                <a:lnTo>
                  <a:pt x="2068195" y="40005"/>
                </a:lnTo>
                <a:lnTo>
                  <a:pt x="2080007" y="44069"/>
                </a:lnTo>
                <a:lnTo>
                  <a:pt x="2091944" y="48640"/>
                </a:lnTo>
                <a:lnTo>
                  <a:pt x="2103756" y="53594"/>
                </a:lnTo>
                <a:lnTo>
                  <a:pt x="2115694" y="59308"/>
                </a:lnTo>
                <a:lnTo>
                  <a:pt x="2127632" y="65405"/>
                </a:lnTo>
                <a:lnTo>
                  <a:pt x="2139442" y="72136"/>
                </a:lnTo>
                <a:lnTo>
                  <a:pt x="2151381" y="79501"/>
                </a:lnTo>
                <a:lnTo>
                  <a:pt x="2163191" y="87376"/>
                </a:lnTo>
                <a:lnTo>
                  <a:pt x="2175129" y="95757"/>
                </a:lnTo>
                <a:lnTo>
                  <a:pt x="2187067" y="104775"/>
                </a:lnTo>
                <a:lnTo>
                  <a:pt x="2198879" y="114300"/>
                </a:lnTo>
                <a:lnTo>
                  <a:pt x="2210816" y="124332"/>
                </a:lnTo>
                <a:lnTo>
                  <a:pt x="2222628" y="134874"/>
                </a:lnTo>
                <a:lnTo>
                  <a:pt x="2234566" y="145922"/>
                </a:lnTo>
                <a:lnTo>
                  <a:pt x="2246504" y="157480"/>
                </a:lnTo>
                <a:lnTo>
                  <a:pt x="2258314" y="169418"/>
                </a:lnTo>
                <a:lnTo>
                  <a:pt x="2270253" y="181863"/>
                </a:lnTo>
                <a:lnTo>
                  <a:pt x="2294001" y="207771"/>
                </a:lnTo>
                <a:lnTo>
                  <a:pt x="2317751" y="235076"/>
                </a:lnTo>
                <a:lnTo>
                  <a:pt x="2341500" y="263525"/>
                </a:lnTo>
                <a:lnTo>
                  <a:pt x="2389125" y="322326"/>
                </a:lnTo>
                <a:lnTo>
                  <a:pt x="2484120" y="440563"/>
                </a:lnTo>
                <a:lnTo>
                  <a:pt x="2507869" y="468630"/>
                </a:lnTo>
                <a:lnTo>
                  <a:pt x="2531745" y="495807"/>
                </a:lnTo>
                <a:lnTo>
                  <a:pt x="2555494" y="521715"/>
                </a:lnTo>
                <a:lnTo>
                  <a:pt x="2579244" y="546353"/>
                </a:lnTo>
                <a:lnTo>
                  <a:pt x="2591182" y="558164"/>
                </a:lnTo>
                <a:lnTo>
                  <a:pt x="2602992" y="569468"/>
                </a:lnTo>
                <a:lnTo>
                  <a:pt x="2614931" y="580517"/>
                </a:lnTo>
                <a:lnTo>
                  <a:pt x="2626741" y="591184"/>
                </a:lnTo>
                <a:lnTo>
                  <a:pt x="2638679" y="601471"/>
                </a:lnTo>
                <a:lnTo>
                  <a:pt x="2650617" y="611251"/>
                </a:lnTo>
                <a:lnTo>
                  <a:pt x="2662429" y="620776"/>
                </a:lnTo>
                <a:lnTo>
                  <a:pt x="2674366" y="629793"/>
                </a:lnTo>
                <a:lnTo>
                  <a:pt x="2686178" y="638428"/>
                </a:lnTo>
                <a:lnTo>
                  <a:pt x="2698116" y="646683"/>
                </a:lnTo>
                <a:lnTo>
                  <a:pt x="2709926" y="654557"/>
                </a:lnTo>
                <a:lnTo>
                  <a:pt x="2721864" y="662051"/>
                </a:lnTo>
                <a:lnTo>
                  <a:pt x="2733803" y="669163"/>
                </a:lnTo>
                <a:lnTo>
                  <a:pt x="2745613" y="675894"/>
                </a:lnTo>
                <a:lnTo>
                  <a:pt x="2757551" y="682244"/>
                </a:lnTo>
                <a:lnTo>
                  <a:pt x="2769362" y="688339"/>
                </a:lnTo>
                <a:lnTo>
                  <a:pt x="2781300" y="693927"/>
                </a:lnTo>
                <a:lnTo>
                  <a:pt x="2793238" y="699262"/>
                </a:lnTo>
                <a:lnTo>
                  <a:pt x="2805049" y="704342"/>
                </a:lnTo>
                <a:lnTo>
                  <a:pt x="2816987" y="709040"/>
                </a:lnTo>
                <a:lnTo>
                  <a:pt x="2828799" y="713486"/>
                </a:lnTo>
                <a:lnTo>
                  <a:pt x="2840737" y="717550"/>
                </a:lnTo>
                <a:lnTo>
                  <a:pt x="2852674" y="721487"/>
                </a:lnTo>
                <a:lnTo>
                  <a:pt x="2864486" y="725043"/>
                </a:lnTo>
                <a:lnTo>
                  <a:pt x="2876424" y="728344"/>
                </a:lnTo>
                <a:lnTo>
                  <a:pt x="2888235" y="731519"/>
                </a:lnTo>
                <a:lnTo>
                  <a:pt x="2900173" y="734313"/>
                </a:lnTo>
                <a:lnTo>
                  <a:pt x="2912111" y="736981"/>
                </a:lnTo>
                <a:lnTo>
                  <a:pt x="2923922" y="739520"/>
                </a:lnTo>
                <a:lnTo>
                  <a:pt x="2935860" y="741680"/>
                </a:lnTo>
                <a:lnTo>
                  <a:pt x="2947670" y="743838"/>
                </a:lnTo>
                <a:lnTo>
                  <a:pt x="2959609" y="745744"/>
                </a:lnTo>
                <a:lnTo>
                  <a:pt x="2971419" y="747521"/>
                </a:lnTo>
                <a:lnTo>
                  <a:pt x="2983357" y="749172"/>
                </a:lnTo>
                <a:lnTo>
                  <a:pt x="2995295" y="750569"/>
                </a:lnTo>
                <a:lnTo>
                  <a:pt x="3007106" y="751967"/>
                </a:lnTo>
                <a:lnTo>
                  <a:pt x="3019044" y="753237"/>
                </a:lnTo>
                <a:lnTo>
                  <a:pt x="3030855" y="754380"/>
                </a:lnTo>
                <a:lnTo>
                  <a:pt x="3042793" y="755395"/>
                </a:lnTo>
              </a:path>
            </a:pathLst>
          </a:custGeom>
          <a:noFill/>
          <a:ln w="18288" cap="flat" cmpd="sng">
            <a:solidFill>
              <a:srgbClr val="01665E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4" name="Freeform 264"/>
          <p:cNvSpPr/>
          <p:nvPr/>
        </p:nvSpPr>
        <p:spPr>
          <a:xfrm>
            <a:off x="5045874" y="2805743"/>
            <a:ext cx="3103627" cy="0"/>
          </a:xfrm>
          <a:custGeom>
            <a:avLst/>
            <a:gdLst/>
            <a:ahLst/>
            <a:cxnLst/>
            <a:rect l="0" t="0" r="0" b="0"/>
            <a:pathLst>
              <a:path w="3103627">
                <a:moveTo>
                  <a:pt x="0" y="0"/>
                </a:moveTo>
                <a:lnTo>
                  <a:pt x="3103627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5" name="Freeform 265"/>
          <p:cNvSpPr/>
          <p:nvPr/>
        </p:nvSpPr>
        <p:spPr>
          <a:xfrm>
            <a:off x="8149501" y="573719"/>
            <a:ext cx="0" cy="2232024"/>
          </a:xfrm>
          <a:custGeom>
            <a:avLst/>
            <a:gdLst/>
            <a:ahLst/>
            <a:cxnLst/>
            <a:rect l="0" t="0" r="0" b="0"/>
            <a:pathLst>
              <a:path h="2232024">
                <a:moveTo>
                  <a:pt x="0" y="2232024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6" name="Freeform 266"/>
          <p:cNvSpPr/>
          <p:nvPr/>
        </p:nvSpPr>
        <p:spPr>
          <a:xfrm>
            <a:off x="5045874" y="573719"/>
            <a:ext cx="3103627" cy="0"/>
          </a:xfrm>
          <a:custGeom>
            <a:avLst/>
            <a:gdLst/>
            <a:ahLst/>
            <a:cxnLst/>
            <a:rect l="0" t="0" r="0" b="0"/>
            <a:pathLst>
              <a:path w="3103627">
                <a:moveTo>
                  <a:pt x="0" y="0"/>
                </a:moveTo>
                <a:lnTo>
                  <a:pt x="3103627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7" name="Freeform 267"/>
          <p:cNvSpPr/>
          <p:nvPr/>
        </p:nvSpPr>
        <p:spPr>
          <a:xfrm>
            <a:off x="5045874" y="573719"/>
            <a:ext cx="0" cy="2232024"/>
          </a:xfrm>
          <a:custGeom>
            <a:avLst/>
            <a:gdLst/>
            <a:ahLst/>
            <a:cxnLst/>
            <a:rect l="0" t="0" r="0" b="0"/>
            <a:pathLst>
              <a:path h="2232024">
                <a:moveTo>
                  <a:pt x="0" y="2232024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8" name="Freeform 268"/>
          <p:cNvSpPr/>
          <p:nvPr/>
        </p:nvSpPr>
        <p:spPr>
          <a:xfrm>
            <a:off x="5045874" y="2805743"/>
            <a:ext cx="3103627" cy="0"/>
          </a:xfrm>
          <a:custGeom>
            <a:avLst/>
            <a:gdLst/>
            <a:ahLst/>
            <a:cxnLst/>
            <a:rect l="0" t="0" r="0" b="0"/>
            <a:pathLst>
              <a:path w="3103627">
                <a:moveTo>
                  <a:pt x="0" y="0"/>
                </a:moveTo>
                <a:lnTo>
                  <a:pt x="3103627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9" name="Freeform 269"/>
          <p:cNvSpPr/>
          <p:nvPr/>
        </p:nvSpPr>
        <p:spPr>
          <a:xfrm>
            <a:off x="5555144" y="280574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0" name="Freeform 270"/>
          <p:cNvSpPr/>
          <p:nvPr/>
        </p:nvSpPr>
        <p:spPr>
          <a:xfrm>
            <a:off x="6280314" y="280574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1" name="Freeform 271"/>
          <p:cNvSpPr/>
          <p:nvPr/>
        </p:nvSpPr>
        <p:spPr>
          <a:xfrm>
            <a:off x="7005357" y="280574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2" name="Freeform 272"/>
          <p:cNvSpPr/>
          <p:nvPr/>
        </p:nvSpPr>
        <p:spPr>
          <a:xfrm>
            <a:off x="7730528" y="280574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3" name="Freeform 273"/>
          <p:cNvSpPr/>
          <p:nvPr/>
        </p:nvSpPr>
        <p:spPr>
          <a:xfrm>
            <a:off x="5045874" y="573719"/>
            <a:ext cx="0" cy="2232024"/>
          </a:xfrm>
          <a:custGeom>
            <a:avLst/>
            <a:gdLst/>
            <a:ahLst/>
            <a:cxnLst/>
            <a:rect l="0" t="0" r="0" b="0"/>
            <a:pathLst>
              <a:path h="2232024">
                <a:moveTo>
                  <a:pt x="0" y="2232024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4" name="Freeform 274"/>
          <p:cNvSpPr/>
          <p:nvPr/>
        </p:nvSpPr>
        <p:spPr>
          <a:xfrm>
            <a:off x="4999519" y="2775263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5" name="Freeform 275"/>
          <p:cNvSpPr/>
          <p:nvPr/>
        </p:nvSpPr>
        <p:spPr>
          <a:xfrm>
            <a:off x="4999519" y="2102672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6" name="Freeform 276"/>
          <p:cNvSpPr/>
          <p:nvPr/>
        </p:nvSpPr>
        <p:spPr>
          <a:xfrm>
            <a:off x="4999519" y="1429952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7" name="Freeform 277"/>
          <p:cNvSpPr/>
          <p:nvPr/>
        </p:nvSpPr>
        <p:spPr>
          <a:xfrm>
            <a:off x="4999519" y="757234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8" name="Freeform 278"/>
          <p:cNvSpPr/>
          <p:nvPr/>
        </p:nvSpPr>
        <p:spPr>
          <a:xfrm>
            <a:off x="712381" y="3444807"/>
            <a:ext cx="3651377" cy="2737231"/>
          </a:xfrm>
          <a:custGeom>
            <a:avLst/>
            <a:gdLst/>
            <a:ahLst/>
            <a:cxnLst/>
            <a:rect l="0" t="0" r="0" b="0"/>
            <a:pathLst>
              <a:path w="3651377" h="2737231">
                <a:moveTo>
                  <a:pt x="1825625" y="0"/>
                </a:moveTo>
                <a:lnTo>
                  <a:pt x="3651377" y="0"/>
                </a:lnTo>
                <a:lnTo>
                  <a:pt x="3651377" y="2737231"/>
                </a:lnTo>
                <a:lnTo>
                  <a:pt x="0" y="2737231"/>
                </a:lnTo>
                <a:lnTo>
                  <a:pt x="0" y="0"/>
                </a:lnTo>
                <a:lnTo>
                  <a:pt x="1825625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9" name="Freeform 279"/>
          <p:cNvSpPr/>
          <p:nvPr/>
        </p:nvSpPr>
        <p:spPr>
          <a:xfrm>
            <a:off x="712381" y="3444807"/>
            <a:ext cx="3651377" cy="2737231"/>
          </a:xfrm>
          <a:custGeom>
            <a:avLst/>
            <a:gdLst/>
            <a:ahLst/>
            <a:cxnLst/>
            <a:rect l="0" t="0" r="0" b="0"/>
            <a:pathLst>
              <a:path w="3651377" h="2737231">
                <a:moveTo>
                  <a:pt x="1825625" y="0"/>
                </a:moveTo>
                <a:lnTo>
                  <a:pt x="3651377" y="0"/>
                </a:lnTo>
                <a:lnTo>
                  <a:pt x="3651377" y="2737231"/>
                </a:lnTo>
                <a:lnTo>
                  <a:pt x="0" y="2737231"/>
                </a:lnTo>
                <a:lnTo>
                  <a:pt x="0" y="0"/>
                </a:lnTo>
                <a:lnTo>
                  <a:pt x="1825625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0" name="Freeform 280"/>
          <p:cNvSpPr/>
          <p:nvPr/>
        </p:nvSpPr>
        <p:spPr>
          <a:xfrm>
            <a:off x="712381" y="3444807"/>
            <a:ext cx="3596513" cy="48895"/>
          </a:xfrm>
          <a:custGeom>
            <a:avLst/>
            <a:gdLst/>
            <a:ahLst/>
            <a:cxnLst/>
            <a:rect l="0" t="0" r="0" b="0"/>
            <a:pathLst>
              <a:path w="3596513" h="48895">
                <a:moveTo>
                  <a:pt x="1798192" y="0"/>
                </a:moveTo>
                <a:lnTo>
                  <a:pt x="3596513" y="0"/>
                </a:lnTo>
                <a:lnTo>
                  <a:pt x="3596513" y="48895"/>
                </a:lnTo>
                <a:lnTo>
                  <a:pt x="0" y="48895"/>
                </a:lnTo>
                <a:lnTo>
                  <a:pt x="0" y="0"/>
                </a:lnTo>
                <a:lnTo>
                  <a:pt x="1798192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1" name="Freeform 281"/>
          <p:cNvSpPr/>
          <p:nvPr/>
        </p:nvSpPr>
        <p:spPr>
          <a:xfrm>
            <a:off x="712381" y="3499799"/>
            <a:ext cx="48640" cy="2682239"/>
          </a:xfrm>
          <a:custGeom>
            <a:avLst/>
            <a:gdLst/>
            <a:ahLst/>
            <a:cxnLst/>
            <a:rect l="0" t="0" r="0" b="0"/>
            <a:pathLst>
              <a:path w="48640" h="2682239">
                <a:moveTo>
                  <a:pt x="24256" y="0"/>
                </a:moveTo>
                <a:lnTo>
                  <a:pt x="48640" y="0"/>
                </a:lnTo>
                <a:lnTo>
                  <a:pt x="48640" y="2682239"/>
                </a:lnTo>
                <a:lnTo>
                  <a:pt x="0" y="2682239"/>
                </a:lnTo>
                <a:lnTo>
                  <a:pt x="0" y="0"/>
                </a:lnTo>
                <a:lnTo>
                  <a:pt x="24256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2" name="Freeform 282"/>
          <p:cNvSpPr/>
          <p:nvPr/>
        </p:nvSpPr>
        <p:spPr>
          <a:xfrm>
            <a:off x="767245" y="6133271"/>
            <a:ext cx="3596513" cy="48767"/>
          </a:xfrm>
          <a:custGeom>
            <a:avLst/>
            <a:gdLst/>
            <a:ahLst/>
            <a:cxnLst/>
            <a:rect l="0" t="0" r="0" b="0"/>
            <a:pathLst>
              <a:path w="3596513" h="48767">
                <a:moveTo>
                  <a:pt x="1798193" y="0"/>
                </a:moveTo>
                <a:lnTo>
                  <a:pt x="3596513" y="0"/>
                </a:lnTo>
                <a:lnTo>
                  <a:pt x="3596513" y="48767"/>
                </a:lnTo>
                <a:lnTo>
                  <a:pt x="0" y="48767"/>
                </a:lnTo>
                <a:lnTo>
                  <a:pt x="0" y="0"/>
                </a:lnTo>
                <a:lnTo>
                  <a:pt x="1798193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3" name="Freeform 283"/>
          <p:cNvSpPr/>
          <p:nvPr/>
        </p:nvSpPr>
        <p:spPr>
          <a:xfrm>
            <a:off x="4315116" y="3444807"/>
            <a:ext cx="48642" cy="2682241"/>
          </a:xfrm>
          <a:custGeom>
            <a:avLst/>
            <a:gdLst/>
            <a:ahLst/>
            <a:cxnLst/>
            <a:rect l="0" t="0" r="0" b="0"/>
            <a:pathLst>
              <a:path w="48642" h="2682241">
                <a:moveTo>
                  <a:pt x="24257" y="0"/>
                </a:moveTo>
                <a:lnTo>
                  <a:pt x="48642" y="0"/>
                </a:lnTo>
                <a:lnTo>
                  <a:pt x="48642" y="2682241"/>
                </a:lnTo>
                <a:lnTo>
                  <a:pt x="0" y="2682241"/>
                </a:lnTo>
                <a:lnTo>
                  <a:pt x="0" y="0"/>
                </a:lnTo>
                <a:lnTo>
                  <a:pt x="24257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4" name="Freeform 284"/>
          <p:cNvSpPr/>
          <p:nvPr/>
        </p:nvSpPr>
        <p:spPr>
          <a:xfrm>
            <a:off x="1205394" y="3527103"/>
            <a:ext cx="3103627" cy="2201672"/>
          </a:xfrm>
          <a:custGeom>
            <a:avLst/>
            <a:gdLst/>
            <a:ahLst/>
            <a:cxnLst/>
            <a:rect l="0" t="0" r="0" b="0"/>
            <a:pathLst>
              <a:path w="3103627" h="2201672">
                <a:moveTo>
                  <a:pt x="1551813" y="0"/>
                </a:moveTo>
                <a:lnTo>
                  <a:pt x="3103627" y="0"/>
                </a:lnTo>
                <a:lnTo>
                  <a:pt x="3103627" y="2201672"/>
                </a:lnTo>
                <a:lnTo>
                  <a:pt x="0" y="2201672"/>
                </a:lnTo>
                <a:lnTo>
                  <a:pt x="0" y="0"/>
                </a:lnTo>
                <a:lnTo>
                  <a:pt x="1551813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5" name="Freeform 285"/>
          <p:cNvSpPr/>
          <p:nvPr/>
        </p:nvSpPr>
        <p:spPr>
          <a:xfrm>
            <a:off x="1577758" y="5670482"/>
            <a:ext cx="205233" cy="30861"/>
          </a:xfrm>
          <a:custGeom>
            <a:avLst/>
            <a:gdLst/>
            <a:ahLst/>
            <a:cxnLst/>
            <a:rect l="0" t="0" r="0" b="0"/>
            <a:pathLst>
              <a:path w="205233" h="30861">
                <a:moveTo>
                  <a:pt x="102617" y="0"/>
                </a:moveTo>
                <a:lnTo>
                  <a:pt x="205233" y="0"/>
                </a:lnTo>
                <a:lnTo>
                  <a:pt x="205233" y="30861"/>
                </a:lnTo>
                <a:lnTo>
                  <a:pt x="0" y="30861"/>
                </a:lnTo>
                <a:lnTo>
                  <a:pt x="0" y="0"/>
                </a:lnTo>
                <a:lnTo>
                  <a:pt x="102617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6" name="Freeform 286"/>
          <p:cNvSpPr/>
          <p:nvPr/>
        </p:nvSpPr>
        <p:spPr>
          <a:xfrm>
            <a:off x="1577758" y="5670482"/>
            <a:ext cx="205233" cy="30861"/>
          </a:xfrm>
          <a:custGeom>
            <a:avLst/>
            <a:gdLst/>
            <a:ahLst/>
            <a:cxnLst/>
            <a:rect l="0" t="0" r="0" b="0"/>
            <a:pathLst>
              <a:path w="205233" h="30861">
                <a:moveTo>
                  <a:pt x="102617" y="0"/>
                </a:moveTo>
                <a:lnTo>
                  <a:pt x="205233" y="0"/>
                </a:lnTo>
                <a:lnTo>
                  <a:pt x="205233" y="30861"/>
                </a:lnTo>
                <a:lnTo>
                  <a:pt x="0" y="30861"/>
                </a:lnTo>
                <a:lnTo>
                  <a:pt x="0" y="0"/>
                </a:lnTo>
                <a:lnTo>
                  <a:pt x="102617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7" name="Freeform 287"/>
          <p:cNvSpPr/>
          <p:nvPr/>
        </p:nvSpPr>
        <p:spPr>
          <a:xfrm>
            <a:off x="1782991" y="5685977"/>
            <a:ext cx="205231" cy="15366"/>
          </a:xfrm>
          <a:custGeom>
            <a:avLst/>
            <a:gdLst/>
            <a:ahLst/>
            <a:cxnLst/>
            <a:rect l="0" t="0" r="0" b="0"/>
            <a:pathLst>
              <a:path w="205231" h="15366">
                <a:moveTo>
                  <a:pt x="102615" y="0"/>
                </a:moveTo>
                <a:lnTo>
                  <a:pt x="205231" y="0"/>
                </a:lnTo>
                <a:lnTo>
                  <a:pt x="205231" y="15366"/>
                </a:lnTo>
                <a:lnTo>
                  <a:pt x="0" y="15366"/>
                </a:lnTo>
                <a:lnTo>
                  <a:pt x="0" y="0"/>
                </a:lnTo>
                <a:lnTo>
                  <a:pt x="102615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8" name="Freeform 288"/>
          <p:cNvSpPr/>
          <p:nvPr/>
        </p:nvSpPr>
        <p:spPr>
          <a:xfrm>
            <a:off x="1782991" y="5685977"/>
            <a:ext cx="205231" cy="15366"/>
          </a:xfrm>
          <a:custGeom>
            <a:avLst/>
            <a:gdLst/>
            <a:ahLst/>
            <a:cxnLst/>
            <a:rect l="0" t="0" r="0" b="0"/>
            <a:pathLst>
              <a:path w="205231" h="15366">
                <a:moveTo>
                  <a:pt x="102615" y="0"/>
                </a:moveTo>
                <a:lnTo>
                  <a:pt x="205231" y="0"/>
                </a:lnTo>
                <a:lnTo>
                  <a:pt x="205231" y="15366"/>
                </a:lnTo>
                <a:lnTo>
                  <a:pt x="0" y="15366"/>
                </a:lnTo>
                <a:lnTo>
                  <a:pt x="0" y="0"/>
                </a:lnTo>
                <a:lnTo>
                  <a:pt x="102615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9" name="Freeform 289"/>
          <p:cNvSpPr/>
          <p:nvPr/>
        </p:nvSpPr>
        <p:spPr>
          <a:xfrm>
            <a:off x="1988222" y="5577646"/>
            <a:ext cx="205233" cy="123697"/>
          </a:xfrm>
          <a:custGeom>
            <a:avLst/>
            <a:gdLst/>
            <a:ahLst/>
            <a:cxnLst/>
            <a:rect l="0" t="0" r="0" b="0"/>
            <a:pathLst>
              <a:path w="205233" h="123697">
                <a:moveTo>
                  <a:pt x="102617" y="0"/>
                </a:moveTo>
                <a:lnTo>
                  <a:pt x="205233" y="0"/>
                </a:lnTo>
                <a:lnTo>
                  <a:pt x="205233" y="123697"/>
                </a:lnTo>
                <a:lnTo>
                  <a:pt x="0" y="123697"/>
                </a:lnTo>
                <a:lnTo>
                  <a:pt x="0" y="0"/>
                </a:lnTo>
                <a:lnTo>
                  <a:pt x="102617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0" name="Freeform 290"/>
          <p:cNvSpPr/>
          <p:nvPr/>
        </p:nvSpPr>
        <p:spPr>
          <a:xfrm>
            <a:off x="1988222" y="5577646"/>
            <a:ext cx="205233" cy="123697"/>
          </a:xfrm>
          <a:custGeom>
            <a:avLst/>
            <a:gdLst/>
            <a:ahLst/>
            <a:cxnLst/>
            <a:rect l="0" t="0" r="0" b="0"/>
            <a:pathLst>
              <a:path w="205233" h="123697">
                <a:moveTo>
                  <a:pt x="102617" y="0"/>
                </a:moveTo>
                <a:lnTo>
                  <a:pt x="205233" y="0"/>
                </a:lnTo>
                <a:lnTo>
                  <a:pt x="205233" y="123697"/>
                </a:lnTo>
                <a:lnTo>
                  <a:pt x="0" y="123697"/>
                </a:lnTo>
                <a:lnTo>
                  <a:pt x="0" y="0"/>
                </a:lnTo>
                <a:lnTo>
                  <a:pt x="102617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1" name="Freeform 291"/>
          <p:cNvSpPr/>
          <p:nvPr/>
        </p:nvSpPr>
        <p:spPr>
          <a:xfrm>
            <a:off x="2193455" y="5422960"/>
            <a:ext cx="205105" cy="278383"/>
          </a:xfrm>
          <a:custGeom>
            <a:avLst/>
            <a:gdLst/>
            <a:ahLst/>
            <a:cxnLst/>
            <a:rect l="0" t="0" r="0" b="0"/>
            <a:pathLst>
              <a:path w="205105" h="278383">
                <a:moveTo>
                  <a:pt x="102489" y="0"/>
                </a:moveTo>
                <a:lnTo>
                  <a:pt x="205105" y="0"/>
                </a:lnTo>
                <a:lnTo>
                  <a:pt x="205105" y="278383"/>
                </a:lnTo>
                <a:lnTo>
                  <a:pt x="0" y="278383"/>
                </a:lnTo>
                <a:lnTo>
                  <a:pt x="0" y="0"/>
                </a:lnTo>
                <a:lnTo>
                  <a:pt x="102489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2" name="Freeform 292"/>
          <p:cNvSpPr/>
          <p:nvPr/>
        </p:nvSpPr>
        <p:spPr>
          <a:xfrm>
            <a:off x="2193455" y="5422960"/>
            <a:ext cx="205105" cy="278383"/>
          </a:xfrm>
          <a:custGeom>
            <a:avLst/>
            <a:gdLst/>
            <a:ahLst/>
            <a:cxnLst/>
            <a:rect l="0" t="0" r="0" b="0"/>
            <a:pathLst>
              <a:path w="205105" h="278383">
                <a:moveTo>
                  <a:pt x="102489" y="0"/>
                </a:moveTo>
                <a:lnTo>
                  <a:pt x="205105" y="0"/>
                </a:lnTo>
                <a:lnTo>
                  <a:pt x="205105" y="278383"/>
                </a:lnTo>
                <a:lnTo>
                  <a:pt x="0" y="278383"/>
                </a:lnTo>
                <a:lnTo>
                  <a:pt x="0" y="0"/>
                </a:lnTo>
                <a:lnTo>
                  <a:pt x="102489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3" name="Freeform 293"/>
          <p:cNvSpPr/>
          <p:nvPr/>
        </p:nvSpPr>
        <p:spPr>
          <a:xfrm>
            <a:off x="2398560" y="3922581"/>
            <a:ext cx="205231" cy="1778762"/>
          </a:xfrm>
          <a:custGeom>
            <a:avLst/>
            <a:gdLst/>
            <a:ahLst/>
            <a:cxnLst/>
            <a:rect l="0" t="0" r="0" b="0"/>
            <a:pathLst>
              <a:path w="205231" h="1778762">
                <a:moveTo>
                  <a:pt x="102616" y="0"/>
                </a:moveTo>
                <a:lnTo>
                  <a:pt x="205231" y="0"/>
                </a:lnTo>
                <a:lnTo>
                  <a:pt x="205231" y="1778762"/>
                </a:lnTo>
                <a:lnTo>
                  <a:pt x="0" y="1778762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4" name="Freeform 294"/>
          <p:cNvSpPr/>
          <p:nvPr/>
        </p:nvSpPr>
        <p:spPr>
          <a:xfrm>
            <a:off x="2398560" y="3922581"/>
            <a:ext cx="205231" cy="1778762"/>
          </a:xfrm>
          <a:custGeom>
            <a:avLst/>
            <a:gdLst/>
            <a:ahLst/>
            <a:cxnLst/>
            <a:rect l="0" t="0" r="0" b="0"/>
            <a:pathLst>
              <a:path w="205231" h="1778762">
                <a:moveTo>
                  <a:pt x="102616" y="0"/>
                </a:moveTo>
                <a:lnTo>
                  <a:pt x="205231" y="0"/>
                </a:lnTo>
                <a:lnTo>
                  <a:pt x="205231" y="1778762"/>
                </a:lnTo>
                <a:lnTo>
                  <a:pt x="0" y="1778762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5" name="Freeform 295"/>
          <p:cNvSpPr/>
          <p:nvPr/>
        </p:nvSpPr>
        <p:spPr>
          <a:xfrm>
            <a:off x="2603791" y="4123623"/>
            <a:ext cx="205232" cy="1577720"/>
          </a:xfrm>
          <a:custGeom>
            <a:avLst/>
            <a:gdLst/>
            <a:ahLst/>
            <a:cxnLst/>
            <a:rect l="0" t="0" r="0" b="0"/>
            <a:pathLst>
              <a:path w="205232" h="1577720">
                <a:moveTo>
                  <a:pt x="102616" y="0"/>
                </a:moveTo>
                <a:lnTo>
                  <a:pt x="205232" y="0"/>
                </a:lnTo>
                <a:lnTo>
                  <a:pt x="205232" y="1577720"/>
                </a:lnTo>
                <a:lnTo>
                  <a:pt x="0" y="1577720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6" name="Freeform 296"/>
          <p:cNvSpPr/>
          <p:nvPr/>
        </p:nvSpPr>
        <p:spPr>
          <a:xfrm>
            <a:off x="2603791" y="4123623"/>
            <a:ext cx="205232" cy="1577720"/>
          </a:xfrm>
          <a:custGeom>
            <a:avLst/>
            <a:gdLst/>
            <a:ahLst/>
            <a:cxnLst/>
            <a:rect l="0" t="0" r="0" b="0"/>
            <a:pathLst>
              <a:path w="205232" h="1577720">
                <a:moveTo>
                  <a:pt x="102616" y="0"/>
                </a:moveTo>
                <a:lnTo>
                  <a:pt x="205232" y="0"/>
                </a:lnTo>
                <a:lnTo>
                  <a:pt x="205232" y="1577720"/>
                </a:lnTo>
                <a:lnTo>
                  <a:pt x="0" y="1577720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7" name="Freeform 297"/>
          <p:cNvSpPr/>
          <p:nvPr/>
        </p:nvSpPr>
        <p:spPr>
          <a:xfrm>
            <a:off x="2809023" y="5206424"/>
            <a:ext cx="205233" cy="494919"/>
          </a:xfrm>
          <a:custGeom>
            <a:avLst/>
            <a:gdLst/>
            <a:ahLst/>
            <a:cxnLst/>
            <a:rect l="0" t="0" r="0" b="0"/>
            <a:pathLst>
              <a:path w="205233" h="494919">
                <a:moveTo>
                  <a:pt x="102616" y="0"/>
                </a:moveTo>
                <a:lnTo>
                  <a:pt x="205233" y="0"/>
                </a:lnTo>
                <a:lnTo>
                  <a:pt x="205233" y="494919"/>
                </a:lnTo>
                <a:lnTo>
                  <a:pt x="0" y="494919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8" name="Freeform 298"/>
          <p:cNvSpPr/>
          <p:nvPr/>
        </p:nvSpPr>
        <p:spPr>
          <a:xfrm>
            <a:off x="2809023" y="5206424"/>
            <a:ext cx="205233" cy="494919"/>
          </a:xfrm>
          <a:custGeom>
            <a:avLst/>
            <a:gdLst/>
            <a:ahLst/>
            <a:cxnLst/>
            <a:rect l="0" t="0" r="0" b="0"/>
            <a:pathLst>
              <a:path w="205233" h="494919">
                <a:moveTo>
                  <a:pt x="102616" y="0"/>
                </a:moveTo>
                <a:lnTo>
                  <a:pt x="205233" y="0"/>
                </a:lnTo>
                <a:lnTo>
                  <a:pt x="205233" y="494919"/>
                </a:lnTo>
                <a:lnTo>
                  <a:pt x="0" y="494919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9" name="Freeform 299"/>
          <p:cNvSpPr/>
          <p:nvPr/>
        </p:nvSpPr>
        <p:spPr>
          <a:xfrm>
            <a:off x="3014256" y="5237412"/>
            <a:ext cx="205232" cy="463931"/>
          </a:xfrm>
          <a:custGeom>
            <a:avLst/>
            <a:gdLst/>
            <a:ahLst/>
            <a:cxnLst/>
            <a:rect l="0" t="0" r="0" b="0"/>
            <a:pathLst>
              <a:path w="205232" h="463931">
                <a:moveTo>
                  <a:pt x="102616" y="0"/>
                </a:moveTo>
                <a:lnTo>
                  <a:pt x="205232" y="0"/>
                </a:lnTo>
                <a:lnTo>
                  <a:pt x="205232" y="463931"/>
                </a:lnTo>
                <a:lnTo>
                  <a:pt x="0" y="463931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0" name="Freeform 300"/>
          <p:cNvSpPr/>
          <p:nvPr/>
        </p:nvSpPr>
        <p:spPr>
          <a:xfrm>
            <a:off x="3014256" y="5237412"/>
            <a:ext cx="205232" cy="463931"/>
          </a:xfrm>
          <a:custGeom>
            <a:avLst/>
            <a:gdLst/>
            <a:ahLst/>
            <a:cxnLst/>
            <a:rect l="0" t="0" r="0" b="0"/>
            <a:pathLst>
              <a:path w="205232" h="463931">
                <a:moveTo>
                  <a:pt x="102616" y="0"/>
                </a:moveTo>
                <a:lnTo>
                  <a:pt x="205232" y="0"/>
                </a:lnTo>
                <a:lnTo>
                  <a:pt x="205232" y="463931"/>
                </a:lnTo>
                <a:lnTo>
                  <a:pt x="0" y="463931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1" name="Freeform 301"/>
          <p:cNvSpPr/>
          <p:nvPr/>
        </p:nvSpPr>
        <p:spPr>
          <a:xfrm>
            <a:off x="3219488" y="5314755"/>
            <a:ext cx="205104" cy="386588"/>
          </a:xfrm>
          <a:custGeom>
            <a:avLst/>
            <a:gdLst/>
            <a:ahLst/>
            <a:cxnLst/>
            <a:rect l="0" t="0" r="0" b="0"/>
            <a:pathLst>
              <a:path w="205104" h="386588">
                <a:moveTo>
                  <a:pt x="102488" y="0"/>
                </a:moveTo>
                <a:lnTo>
                  <a:pt x="205104" y="0"/>
                </a:lnTo>
                <a:lnTo>
                  <a:pt x="205104" y="386588"/>
                </a:lnTo>
                <a:lnTo>
                  <a:pt x="0" y="386588"/>
                </a:lnTo>
                <a:lnTo>
                  <a:pt x="0" y="0"/>
                </a:lnTo>
                <a:lnTo>
                  <a:pt x="102488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2" name="Freeform 302"/>
          <p:cNvSpPr/>
          <p:nvPr/>
        </p:nvSpPr>
        <p:spPr>
          <a:xfrm>
            <a:off x="3219488" y="5314755"/>
            <a:ext cx="205104" cy="386588"/>
          </a:xfrm>
          <a:custGeom>
            <a:avLst/>
            <a:gdLst/>
            <a:ahLst/>
            <a:cxnLst/>
            <a:rect l="0" t="0" r="0" b="0"/>
            <a:pathLst>
              <a:path w="205104" h="386588">
                <a:moveTo>
                  <a:pt x="102488" y="0"/>
                </a:moveTo>
                <a:lnTo>
                  <a:pt x="205104" y="0"/>
                </a:lnTo>
                <a:lnTo>
                  <a:pt x="205104" y="386588"/>
                </a:lnTo>
                <a:lnTo>
                  <a:pt x="0" y="386588"/>
                </a:lnTo>
                <a:lnTo>
                  <a:pt x="0" y="0"/>
                </a:lnTo>
                <a:lnTo>
                  <a:pt x="102488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3" name="Freeform 303"/>
          <p:cNvSpPr/>
          <p:nvPr/>
        </p:nvSpPr>
        <p:spPr>
          <a:xfrm>
            <a:off x="3424592" y="5484809"/>
            <a:ext cx="205233" cy="216534"/>
          </a:xfrm>
          <a:custGeom>
            <a:avLst/>
            <a:gdLst/>
            <a:ahLst/>
            <a:cxnLst/>
            <a:rect l="0" t="0" r="0" b="0"/>
            <a:pathLst>
              <a:path w="205233" h="216534">
                <a:moveTo>
                  <a:pt x="102616" y="0"/>
                </a:moveTo>
                <a:lnTo>
                  <a:pt x="205233" y="0"/>
                </a:lnTo>
                <a:lnTo>
                  <a:pt x="205233" y="216534"/>
                </a:lnTo>
                <a:lnTo>
                  <a:pt x="0" y="216534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4" name="Freeform 304"/>
          <p:cNvSpPr/>
          <p:nvPr/>
        </p:nvSpPr>
        <p:spPr>
          <a:xfrm>
            <a:off x="3424592" y="5484809"/>
            <a:ext cx="205233" cy="216534"/>
          </a:xfrm>
          <a:custGeom>
            <a:avLst/>
            <a:gdLst/>
            <a:ahLst/>
            <a:cxnLst/>
            <a:rect l="0" t="0" r="0" b="0"/>
            <a:pathLst>
              <a:path w="205233" h="216534">
                <a:moveTo>
                  <a:pt x="102616" y="0"/>
                </a:moveTo>
                <a:lnTo>
                  <a:pt x="205233" y="0"/>
                </a:lnTo>
                <a:lnTo>
                  <a:pt x="205233" y="216534"/>
                </a:lnTo>
                <a:lnTo>
                  <a:pt x="0" y="216534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5" name="Freeform 305"/>
          <p:cNvSpPr/>
          <p:nvPr/>
        </p:nvSpPr>
        <p:spPr>
          <a:xfrm>
            <a:off x="1577758" y="5701343"/>
            <a:ext cx="205233" cy="0"/>
          </a:xfrm>
          <a:custGeom>
            <a:avLst/>
            <a:gdLst/>
            <a:ahLst/>
            <a:cxnLst/>
            <a:rect l="0" t="0" r="0" b="0"/>
            <a:pathLst>
              <a:path w="205233">
                <a:moveTo>
                  <a:pt x="0" y="0"/>
                </a:moveTo>
                <a:lnTo>
                  <a:pt x="205233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6" name="Freeform 306"/>
          <p:cNvSpPr/>
          <p:nvPr/>
        </p:nvSpPr>
        <p:spPr>
          <a:xfrm>
            <a:off x="1782991" y="5701343"/>
            <a:ext cx="205231" cy="0"/>
          </a:xfrm>
          <a:custGeom>
            <a:avLst/>
            <a:gdLst/>
            <a:ahLst/>
            <a:cxnLst/>
            <a:rect l="0" t="0" r="0" b="0"/>
            <a:pathLst>
              <a:path w="205231">
                <a:moveTo>
                  <a:pt x="0" y="0"/>
                </a:moveTo>
                <a:lnTo>
                  <a:pt x="205231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7" name="Freeform 307"/>
          <p:cNvSpPr/>
          <p:nvPr/>
        </p:nvSpPr>
        <p:spPr>
          <a:xfrm>
            <a:off x="1988222" y="5701343"/>
            <a:ext cx="205233" cy="0"/>
          </a:xfrm>
          <a:custGeom>
            <a:avLst/>
            <a:gdLst/>
            <a:ahLst/>
            <a:cxnLst/>
            <a:rect l="0" t="0" r="0" b="0"/>
            <a:pathLst>
              <a:path w="205233">
                <a:moveTo>
                  <a:pt x="0" y="0"/>
                </a:moveTo>
                <a:lnTo>
                  <a:pt x="205233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8" name="Freeform 308"/>
          <p:cNvSpPr/>
          <p:nvPr/>
        </p:nvSpPr>
        <p:spPr>
          <a:xfrm>
            <a:off x="2193455" y="5500684"/>
            <a:ext cx="205105" cy="200659"/>
          </a:xfrm>
          <a:custGeom>
            <a:avLst/>
            <a:gdLst/>
            <a:ahLst/>
            <a:cxnLst/>
            <a:rect l="0" t="0" r="0" b="0"/>
            <a:pathLst>
              <a:path w="205105" h="200659">
                <a:moveTo>
                  <a:pt x="102489" y="0"/>
                </a:moveTo>
                <a:lnTo>
                  <a:pt x="205105" y="0"/>
                </a:lnTo>
                <a:lnTo>
                  <a:pt x="205105" y="200659"/>
                </a:lnTo>
                <a:lnTo>
                  <a:pt x="0" y="200659"/>
                </a:lnTo>
                <a:lnTo>
                  <a:pt x="0" y="0"/>
                </a:lnTo>
                <a:lnTo>
                  <a:pt x="102489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9" name="Freeform 309"/>
          <p:cNvSpPr/>
          <p:nvPr/>
        </p:nvSpPr>
        <p:spPr>
          <a:xfrm>
            <a:off x="2193455" y="5500684"/>
            <a:ext cx="205105" cy="200659"/>
          </a:xfrm>
          <a:custGeom>
            <a:avLst/>
            <a:gdLst/>
            <a:ahLst/>
            <a:cxnLst/>
            <a:rect l="0" t="0" r="0" b="0"/>
            <a:pathLst>
              <a:path w="205105" h="200659">
                <a:moveTo>
                  <a:pt x="102489" y="0"/>
                </a:moveTo>
                <a:lnTo>
                  <a:pt x="205105" y="0"/>
                </a:lnTo>
                <a:lnTo>
                  <a:pt x="205105" y="200659"/>
                </a:lnTo>
                <a:lnTo>
                  <a:pt x="0" y="200659"/>
                </a:lnTo>
                <a:lnTo>
                  <a:pt x="0" y="0"/>
                </a:lnTo>
                <a:lnTo>
                  <a:pt x="102489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0" name="Freeform 310"/>
          <p:cNvSpPr/>
          <p:nvPr/>
        </p:nvSpPr>
        <p:spPr>
          <a:xfrm>
            <a:off x="2398560" y="4698171"/>
            <a:ext cx="205231" cy="1003172"/>
          </a:xfrm>
          <a:custGeom>
            <a:avLst/>
            <a:gdLst/>
            <a:ahLst/>
            <a:cxnLst/>
            <a:rect l="0" t="0" r="0" b="0"/>
            <a:pathLst>
              <a:path w="205231" h="1003172">
                <a:moveTo>
                  <a:pt x="102616" y="0"/>
                </a:moveTo>
                <a:lnTo>
                  <a:pt x="205231" y="0"/>
                </a:lnTo>
                <a:lnTo>
                  <a:pt x="205231" y="1003172"/>
                </a:lnTo>
                <a:lnTo>
                  <a:pt x="0" y="1003172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1" name="Freeform 311"/>
          <p:cNvSpPr/>
          <p:nvPr/>
        </p:nvSpPr>
        <p:spPr>
          <a:xfrm>
            <a:off x="2398560" y="4698171"/>
            <a:ext cx="205231" cy="1003172"/>
          </a:xfrm>
          <a:custGeom>
            <a:avLst/>
            <a:gdLst/>
            <a:ahLst/>
            <a:cxnLst/>
            <a:rect l="0" t="0" r="0" b="0"/>
            <a:pathLst>
              <a:path w="205231" h="1003172">
                <a:moveTo>
                  <a:pt x="102616" y="0"/>
                </a:moveTo>
                <a:lnTo>
                  <a:pt x="205231" y="0"/>
                </a:lnTo>
                <a:lnTo>
                  <a:pt x="205231" y="1003172"/>
                </a:lnTo>
                <a:lnTo>
                  <a:pt x="0" y="1003172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2" name="Freeform 312"/>
          <p:cNvSpPr/>
          <p:nvPr/>
        </p:nvSpPr>
        <p:spPr>
          <a:xfrm>
            <a:off x="2603791" y="4347016"/>
            <a:ext cx="205232" cy="1354327"/>
          </a:xfrm>
          <a:custGeom>
            <a:avLst/>
            <a:gdLst/>
            <a:ahLst/>
            <a:cxnLst/>
            <a:rect l="0" t="0" r="0" b="0"/>
            <a:pathLst>
              <a:path w="205232" h="1354327">
                <a:moveTo>
                  <a:pt x="102616" y="0"/>
                </a:moveTo>
                <a:lnTo>
                  <a:pt x="205232" y="0"/>
                </a:lnTo>
                <a:lnTo>
                  <a:pt x="205232" y="1354327"/>
                </a:lnTo>
                <a:lnTo>
                  <a:pt x="0" y="1354327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3" name="Freeform 313"/>
          <p:cNvSpPr/>
          <p:nvPr/>
        </p:nvSpPr>
        <p:spPr>
          <a:xfrm>
            <a:off x="2603791" y="4347016"/>
            <a:ext cx="205232" cy="1354327"/>
          </a:xfrm>
          <a:custGeom>
            <a:avLst/>
            <a:gdLst/>
            <a:ahLst/>
            <a:cxnLst/>
            <a:rect l="0" t="0" r="0" b="0"/>
            <a:pathLst>
              <a:path w="205232" h="1354327">
                <a:moveTo>
                  <a:pt x="102616" y="0"/>
                </a:moveTo>
                <a:lnTo>
                  <a:pt x="205232" y="0"/>
                </a:lnTo>
                <a:lnTo>
                  <a:pt x="205232" y="1354327"/>
                </a:lnTo>
                <a:lnTo>
                  <a:pt x="0" y="1354327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4" name="Freeform 314"/>
          <p:cNvSpPr/>
          <p:nvPr/>
        </p:nvSpPr>
        <p:spPr>
          <a:xfrm>
            <a:off x="2809023" y="4948996"/>
            <a:ext cx="205233" cy="752347"/>
          </a:xfrm>
          <a:custGeom>
            <a:avLst/>
            <a:gdLst/>
            <a:ahLst/>
            <a:cxnLst/>
            <a:rect l="0" t="0" r="0" b="0"/>
            <a:pathLst>
              <a:path w="205233" h="752347">
                <a:moveTo>
                  <a:pt x="102616" y="0"/>
                </a:moveTo>
                <a:lnTo>
                  <a:pt x="205233" y="0"/>
                </a:lnTo>
                <a:lnTo>
                  <a:pt x="205233" y="752347"/>
                </a:lnTo>
                <a:lnTo>
                  <a:pt x="0" y="752347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5" name="Freeform 315"/>
          <p:cNvSpPr/>
          <p:nvPr/>
        </p:nvSpPr>
        <p:spPr>
          <a:xfrm>
            <a:off x="2809023" y="4948996"/>
            <a:ext cx="205233" cy="752347"/>
          </a:xfrm>
          <a:custGeom>
            <a:avLst/>
            <a:gdLst/>
            <a:ahLst/>
            <a:cxnLst/>
            <a:rect l="0" t="0" r="0" b="0"/>
            <a:pathLst>
              <a:path w="205233" h="752347">
                <a:moveTo>
                  <a:pt x="102616" y="0"/>
                </a:moveTo>
                <a:lnTo>
                  <a:pt x="205233" y="0"/>
                </a:lnTo>
                <a:lnTo>
                  <a:pt x="205233" y="752347"/>
                </a:lnTo>
                <a:lnTo>
                  <a:pt x="0" y="752347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6" name="Freeform 316"/>
          <p:cNvSpPr/>
          <p:nvPr/>
        </p:nvSpPr>
        <p:spPr>
          <a:xfrm>
            <a:off x="3014256" y="5249986"/>
            <a:ext cx="205232" cy="451357"/>
          </a:xfrm>
          <a:custGeom>
            <a:avLst/>
            <a:gdLst/>
            <a:ahLst/>
            <a:cxnLst/>
            <a:rect l="0" t="0" r="0" b="0"/>
            <a:pathLst>
              <a:path w="205232" h="451357">
                <a:moveTo>
                  <a:pt x="102616" y="0"/>
                </a:moveTo>
                <a:lnTo>
                  <a:pt x="205232" y="0"/>
                </a:lnTo>
                <a:lnTo>
                  <a:pt x="205232" y="451357"/>
                </a:lnTo>
                <a:lnTo>
                  <a:pt x="0" y="451357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7" name="Freeform 317"/>
          <p:cNvSpPr/>
          <p:nvPr/>
        </p:nvSpPr>
        <p:spPr>
          <a:xfrm>
            <a:off x="3014256" y="5249986"/>
            <a:ext cx="205232" cy="451357"/>
          </a:xfrm>
          <a:custGeom>
            <a:avLst/>
            <a:gdLst/>
            <a:ahLst/>
            <a:cxnLst/>
            <a:rect l="0" t="0" r="0" b="0"/>
            <a:pathLst>
              <a:path w="205232" h="451357">
                <a:moveTo>
                  <a:pt x="102616" y="0"/>
                </a:moveTo>
                <a:lnTo>
                  <a:pt x="205232" y="0"/>
                </a:lnTo>
                <a:lnTo>
                  <a:pt x="205232" y="451357"/>
                </a:lnTo>
                <a:lnTo>
                  <a:pt x="0" y="451357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8" name="Freeform 318"/>
          <p:cNvSpPr/>
          <p:nvPr/>
        </p:nvSpPr>
        <p:spPr>
          <a:xfrm>
            <a:off x="3219488" y="4748336"/>
            <a:ext cx="205104" cy="953007"/>
          </a:xfrm>
          <a:custGeom>
            <a:avLst/>
            <a:gdLst/>
            <a:ahLst/>
            <a:cxnLst/>
            <a:rect l="0" t="0" r="0" b="0"/>
            <a:pathLst>
              <a:path w="205104" h="953007">
                <a:moveTo>
                  <a:pt x="102488" y="0"/>
                </a:moveTo>
                <a:lnTo>
                  <a:pt x="205104" y="0"/>
                </a:lnTo>
                <a:lnTo>
                  <a:pt x="205104" y="953007"/>
                </a:lnTo>
                <a:lnTo>
                  <a:pt x="0" y="953007"/>
                </a:lnTo>
                <a:lnTo>
                  <a:pt x="0" y="0"/>
                </a:lnTo>
                <a:lnTo>
                  <a:pt x="102488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9" name="Freeform 319"/>
          <p:cNvSpPr/>
          <p:nvPr/>
        </p:nvSpPr>
        <p:spPr>
          <a:xfrm>
            <a:off x="3219488" y="4748336"/>
            <a:ext cx="205104" cy="953007"/>
          </a:xfrm>
          <a:custGeom>
            <a:avLst/>
            <a:gdLst/>
            <a:ahLst/>
            <a:cxnLst/>
            <a:rect l="0" t="0" r="0" b="0"/>
            <a:pathLst>
              <a:path w="205104" h="953007">
                <a:moveTo>
                  <a:pt x="102488" y="0"/>
                </a:moveTo>
                <a:lnTo>
                  <a:pt x="205104" y="0"/>
                </a:lnTo>
                <a:lnTo>
                  <a:pt x="205104" y="953007"/>
                </a:lnTo>
                <a:lnTo>
                  <a:pt x="0" y="953007"/>
                </a:lnTo>
                <a:lnTo>
                  <a:pt x="0" y="0"/>
                </a:lnTo>
                <a:lnTo>
                  <a:pt x="102488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0" name="Freeform 320"/>
          <p:cNvSpPr/>
          <p:nvPr/>
        </p:nvSpPr>
        <p:spPr>
          <a:xfrm>
            <a:off x="3424592" y="5049325"/>
            <a:ext cx="205233" cy="652018"/>
          </a:xfrm>
          <a:custGeom>
            <a:avLst/>
            <a:gdLst/>
            <a:ahLst/>
            <a:cxnLst/>
            <a:rect l="0" t="0" r="0" b="0"/>
            <a:pathLst>
              <a:path w="205233" h="652018">
                <a:moveTo>
                  <a:pt x="102616" y="0"/>
                </a:moveTo>
                <a:lnTo>
                  <a:pt x="205233" y="0"/>
                </a:lnTo>
                <a:lnTo>
                  <a:pt x="205233" y="652018"/>
                </a:lnTo>
                <a:lnTo>
                  <a:pt x="0" y="652018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1" name="Freeform 321"/>
          <p:cNvSpPr/>
          <p:nvPr/>
        </p:nvSpPr>
        <p:spPr>
          <a:xfrm>
            <a:off x="3424592" y="5049325"/>
            <a:ext cx="205233" cy="652018"/>
          </a:xfrm>
          <a:custGeom>
            <a:avLst/>
            <a:gdLst/>
            <a:ahLst/>
            <a:cxnLst/>
            <a:rect l="0" t="0" r="0" b="0"/>
            <a:pathLst>
              <a:path w="205233" h="652018">
                <a:moveTo>
                  <a:pt x="102616" y="0"/>
                </a:moveTo>
                <a:lnTo>
                  <a:pt x="205233" y="0"/>
                </a:lnTo>
                <a:lnTo>
                  <a:pt x="205233" y="652018"/>
                </a:lnTo>
                <a:lnTo>
                  <a:pt x="0" y="652018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2" name="Freeform 322"/>
          <p:cNvSpPr/>
          <p:nvPr/>
        </p:nvSpPr>
        <p:spPr>
          <a:xfrm>
            <a:off x="1577758" y="5701343"/>
            <a:ext cx="205233" cy="0"/>
          </a:xfrm>
          <a:custGeom>
            <a:avLst/>
            <a:gdLst/>
            <a:ahLst/>
            <a:cxnLst/>
            <a:rect l="0" t="0" r="0" b="0"/>
            <a:pathLst>
              <a:path w="205233">
                <a:moveTo>
                  <a:pt x="0" y="0"/>
                </a:moveTo>
                <a:lnTo>
                  <a:pt x="205233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3" name="Freeform 323"/>
          <p:cNvSpPr/>
          <p:nvPr/>
        </p:nvSpPr>
        <p:spPr>
          <a:xfrm>
            <a:off x="1782991" y="5701343"/>
            <a:ext cx="205231" cy="0"/>
          </a:xfrm>
          <a:custGeom>
            <a:avLst/>
            <a:gdLst/>
            <a:ahLst/>
            <a:cxnLst/>
            <a:rect l="0" t="0" r="0" b="0"/>
            <a:pathLst>
              <a:path w="205231">
                <a:moveTo>
                  <a:pt x="0" y="0"/>
                </a:moveTo>
                <a:lnTo>
                  <a:pt x="205231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4" name="Freeform 324"/>
          <p:cNvSpPr/>
          <p:nvPr/>
        </p:nvSpPr>
        <p:spPr>
          <a:xfrm>
            <a:off x="1988222" y="5556310"/>
            <a:ext cx="205233" cy="145033"/>
          </a:xfrm>
          <a:custGeom>
            <a:avLst/>
            <a:gdLst/>
            <a:ahLst/>
            <a:cxnLst/>
            <a:rect l="0" t="0" r="0" b="0"/>
            <a:pathLst>
              <a:path w="205233" h="145033">
                <a:moveTo>
                  <a:pt x="102617" y="0"/>
                </a:moveTo>
                <a:lnTo>
                  <a:pt x="205233" y="0"/>
                </a:lnTo>
                <a:lnTo>
                  <a:pt x="205233" y="145033"/>
                </a:lnTo>
                <a:lnTo>
                  <a:pt x="0" y="145033"/>
                </a:lnTo>
                <a:lnTo>
                  <a:pt x="0" y="0"/>
                </a:lnTo>
                <a:lnTo>
                  <a:pt x="102617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5" name="Freeform 325"/>
          <p:cNvSpPr/>
          <p:nvPr/>
        </p:nvSpPr>
        <p:spPr>
          <a:xfrm>
            <a:off x="1988222" y="5556310"/>
            <a:ext cx="205233" cy="145033"/>
          </a:xfrm>
          <a:custGeom>
            <a:avLst/>
            <a:gdLst/>
            <a:ahLst/>
            <a:cxnLst/>
            <a:rect l="0" t="0" r="0" b="0"/>
            <a:pathLst>
              <a:path w="205233" h="145033">
                <a:moveTo>
                  <a:pt x="102617" y="0"/>
                </a:moveTo>
                <a:lnTo>
                  <a:pt x="205233" y="0"/>
                </a:lnTo>
                <a:lnTo>
                  <a:pt x="205233" y="145033"/>
                </a:lnTo>
                <a:lnTo>
                  <a:pt x="0" y="145033"/>
                </a:lnTo>
                <a:lnTo>
                  <a:pt x="0" y="0"/>
                </a:lnTo>
                <a:lnTo>
                  <a:pt x="102617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6" name="Freeform 326"/>
          <p:cNvSpPr/>
          <p:nvPr/>
        </p:nvSpPr>
        <p:spPr>
          <a:xfrm>
            <a:off x="2193455" y="5701343"/>
            <a:ext cx="205105" cy="0"/>
          </a:xfrm>
          <a:custGeom>
            <a:avLst/>
            <a:gdLst/>
            <a:ahLst/>
            <a:cxnLst/>
            <a:rect l="0" t="0" r="0" b="0"/>
            <a:pathLst>
              <a:path w="205105">
                <a:moveTo>
                  <a:pt x="0" y="0"/>
                </a:moveTo>
                <a:lnTo>
                  <a:pt x="205105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7" name="Freeform 327"/>
          <p:cNvSpPr/>
          <p:nvPr/>
        </p:nvSpPr>
        <p:spPr>
          <a:xfrm>
            <a:off x="2398560" y="4831012"/>
            <a:ext cx="205231" cy="870331"/>
          </a:xfrm>
          <a:custGeom>
            <a:avLst/>
            <a:gdLst/>
            <a:ahLst/>
            <a:cxnLst/>
            <a:rect l="0" t="0" r="0" b="0"/>
            <a:pathLst>
              <a:path w="205231" h="870331">
                <a:moveTo>
                  <a:pt x="102616" y="0"/>
                </a:moveTo>
                <a:lnTo>
                  <a:pt x="205231" y="0"/>
                </a:lnTo>
                <a:lnTo>
                  <a:pt x="205231" y="870331"/>
                </a:lnTo>
                <a:lnTo>
                  <a:pt x="0" y="870331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8" name="Freeform 328"/>
          <p:cNvSpPr/>
          <p:nvPr/>
        </p:nvSpPr>
        <p:spPr>
          <a:xfrm>
            <a:off x="2398560" y="4831012"/>
            <a:ext cx="205231" cy="870331"/>
          </a:xfrm>
          <a:custGeom>
            <a:avLst/>
            <a:gdLst/>
            <a:ahLst/>
            <a:cxnLst/>
            <a:rect l="0" t="0" r="0" b="0"/>
            <a:pathLst>
              <a:path w="205231" h="870331">
                <a:moveTo>
                  <a:pt x="102616" y="0"/>
                </a:moveTo>
                <a:lnTo>
                  <a:pt x="205231" y="0"/>
                </a:lnTo>
                <a:lnTo>
                  <a:pt x="205231" y="870331"/>
                </a:lnTo>
                <a:lnTo>
                  <a:pt x="0" y="870331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29" name="Freeform 329"/>
          <p:cNvSpPr/>
          <p:nvPr/>
        </p:nvSpPr>
        <p:spPr>
          <a:xfrm>
            <a:off x="2603791" y="4395784"/>
            <a:ext cx="205232" cy="1305559"/>
          </a:xfrm>
          <a:custGeom>
            <a:avLst/>
            <a:gdLst/>
            <a:ahLst/>
            <a:cxnLst/>
            <a:rect l="0" t="0" r="0" b="0"/>
            <a:pathLst>
              <a:path w="205232" h="1305559">
                <a:moveTo>
                  <a:pt x="102616" y="0"/>
                </a:moveTo>
                <a:lnTo>
                  <a:pt x="205232" y="0"/>
                </a:lnTo>
                <a:lnTo>
                  <a:pt x="205232" y="1305559"/>
                </a:lnTo>
                <a:lnTo>
                  <a:pt x="0" y="1305559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30" name="Freeform 330"/>
          <p:cNvSpPr/>
          <p:nvPr/>
        </p:nvSpPr>
        <p:spPr>
          <a:xfrm>
            <a:off x="2603791" y="4395784"/>
            <a:ext cx="205232" cy="1305559"/>
          </a:xfrm>
          <a:custGeom>
            <a:avLst/>
            <a:gdLst/>
            <a:ahLst/>
            <a:cxnLst/>
            <a:rect l="0" t="0" r="0" b="0"/>
            <a:pathLst>
              <a:path w="205232" h="1305559">
                <a:moveTo>
                  <a:pt x="102616" y="0"/>
                </a:moveTo>
                <a:lnTo>
                  <a:pt x="205232" y="0"/>
                </a:lnTo>
                <a:lnTo>
                  <a:pt x="205232" y="1305559"/>
                </a:lnTo>
                <a:lnTo>
                  <a:pt x="0" y="1305559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31" name="Freeform 331"/>
          <p:cNvSpPr/>
          <p:nvPr/>
        </p:nvSpPr>
        <p:spPr>
          <a:xfrm>
            <a:off x="2809023" y="5121080"/>
            <a:ext cx="205233" cy="580263"/>
          </a:xfrm>
          <a:custGeom>
            <a:avLst/>
            <a:gdLst/>
            <a:ahLst/>
            <a:cxnLst/>
            <a:rect l="0" t="0" r="0" b="0"/>
            <a:pathLst>
              <a:path w="205233" h="580263">
                <a:moveTo>
                  <a:pt x="102616" y="0"/>
                </a:moveTo>
                <a:lnTo>
                  <a:pt x="205233" y="0"/>
                </a:lnTo>
                <a:lnTo>
                  <a:pt x="205233" y="580263"/>
                </a:lnTo>
                <a:lnTo>
                  <a:pt x="0" y="580263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32" name="Freeform 332"/>
          <p:cNvSpPr/>
          <p:nvPr/>
        </p:nvSpPr>
        <p:spPr>
          <a:xfrm>
            <a:off x="2809023" y="5121080"/>
            <a:ext cx="205233" cy="580263"/>
          </a:xfrm>
          <a:custGeom>
            <a:avLst/>
            <a:gdLst/>
            <a:ahLst/>
            <a:cxnLst/>
            <a:rect l="0" t="0" r="0" b="0"/>
            <a:pathLst>
              <a:path w="205233" h="580263">
                <a:moveTo>
                  <a:pt x="102616" y="0"/>
                </a:moveTo>
                <a:lnTo>
                  <a:pt x="205233" y="0"/>
                </a:lnTo>
                <a:lnTo>
                  <a:pt x="205233" y="580263"/>
                </a:lnTo>
                <a:lnTo>
                  <a:pt x="0" y="580263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33" name="Freeform 333"/>
          <p:cNvSpPr/>
          <p:nvPr/>
        </p:nvSpPr>
        <p:spPr>
          <a:xfrm>
            <a:off x="3014256" y="5266242"/>
            <a:ext cx="205232" cy="435101"/>
          </a:xfrm>
          <a:custGeom>
            <a:avLst/>
            <a:gdLst/>
            <a:ahLst/>
            <a:cxnLst/>
            <a:rect l="0" t="0" r="0" b="0"/>
            <a:pathLst>
              <a:path w="205232" h="435101">
                <a:moveTo>
                  <a:pt x="102616" y="0"/>
                </a:moveTo>
                <a:lnTo>
                  <a:pt x="205232" y="0"/>
                </a:lnTo>
                <a:lnTo>
                  <a:pt x="205232" y="435101"/>
                </a:lnTo>
                <a:lnTo>
                  <a:pt x="0" y="435101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34" name="Freeform 334"/>
          <p:cNvSpPr/>
          <p:nvPr/>
        </p:nvSpPr>
        <p:spPr>
          <a:xfrm>
            <a:off x="3014256" y="5266242"/>
            <a:ext cx="205232" cy="435101"/>
          </a:xfrm>
          <a:custGeom>
            <a:avLst/>
            <a:gdLst/>
            <a:ahLst/>
            <a:cxnLst/>
            <a:rect l="0" t="0" r="0" b="0"/>
            <a:pathLst>
              <a:path w="205232" h="435101">
                <a:moveTo>
                  <a:pt x="102616" y="0"/>
                </a:moveTo>
                <a:lnTo>
                  <a:pt x="205232" y="0"/>
                </a:lnTo>
                <a:lnTo>
                  <a:pt x="205232" y="435101"/>
                </a:lnTo>
                <a:lnTo>
                  <a:pt x="0" y="435101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35" name="Freeform 335"/>
          <p:cNvSpPr/>
          <p:nvPr/>
        </p:nvSpPr>
        <p:spPr>
          <a:xfrm>
            <a:off x="3219488" y="4831012"/>
            <a:ext cx="205104" cy="870331"/>
          </a:xfrm>
          <a:custGeom>
            <a:avLst/>
            <a:gdLst/>
            <a:ahLst/>
            <a:cxnLst/>
            <a:rect l="0" t="0" r="0" b="0"/>
            <a:pathLst>
              <a:path w="205104" h="870331">
                <a:moveTo>
                  <a:pt x="102488" y="0"/>
                </a:moveTo>
                <a:lnTo>
                  <a:pt x="205104" y="0"/>
                </a:lnTo>
                <a:lnTo>
                  <a:pt x="205104" y="870331"/>
                </a:lnTo>
                <a:lnTo>
                  <a:pt x="0" y="870331"/>
                </a:lnTo>
                <a:lnTo>
                  <a:pt x="0" y="0"/>
                </a:lnTo>
                <a:lnTo>
                  <a:pt x="102488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36" name="Freeform 336"/>
          <p:cNvSpPr/>
          <p:nvPr/>
        </p:nvSpPr>
        <p:spPr>
          <a:xfrm>
            <a:off x="3219488" y="4831012"/>
            <a:ext cx="205104" cy="870331"/>
          </a:xfrm>
          <a:custGeom>
            <a:avLst/>
            <a:gdLst/>
            <a:ahLst/>
            <a:cxnLst/>
            <a:rect l="0" t="0" r="0" b="0"/>
            <a:pathLst>
              <a:path w="205104" h="870331">
                <a:moveTo>
                  <a:pt x="102488" y="0"/>
                </a:moveTo>
                <a:lnTo>
                  <a:pt x="205104" y="0"/>
                </a:lnTo>
                <a:lnTo>
                  <a:pt x="205104" y="870331"/>
                </a:lnTo>
                <a:lnTo>
                  <a:pt x="0" y="870331"/>
                </a:lnTo>
                <a:lnTo>
                  <a:pt x="0" y="0"/>
                </a:lnTo>
                <a:lnTo>
                  <a:pt x="102488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37" name="Freeform 337"/>
          <p:cNvSpPr/>
          <p:nvPr/>
        </p:nvSpPr>
        <p:spPr>
          <a:xfrm>
            <a:off x="3424592" y="4540944"/>
            <a:ext cx="205233" cy="1160399"/>
          </a:xfrm>
          <a:custGeom>
            <a:avLst/>
            <a:gdLst/>
            <a:ahLst/>
            <a:cxnLst/>
            <a:rect l="0" t="0" r="0" b="0"/>
            <a:pathLst>
              <a:path w="205233" h="1160399">
                <a:moveTo>
                  <a:pt x="102616" y="0"/>
                </a:moveTo>
                <a:lnTo>
                  <a:pt x="205233" y="0"/>
                </a:lnTo>
                <a:lnTo>
                  <a:pt x="205233" y="1160399"/>
                </a:lnTo>
                <a:lnTo>
                  <a:pt x="0" y="1160399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38" name="Freeform 338"/>
          <p:cNvSpPr/>
          <p:nvPr/>
        </p:nvSpPr>
        <p:spPr>
          <a:xfrm>
            <a:off x="3424592" y="4540944"/>
            <a:ext cx="205233" cy="1160399"/>
          </a:xfrm>
          <a:custGeom>
            <a:avLst/>
            <a:gdLst/>
            <a:ahLst/>
            <a:cxnLst/>
            <a:rect l="0" t="0" r="0" b="0"/>
            <a:pathLst>
              <a:path w="205233" h="1160399">
                <a:moveTo>
                  <a:pt x="102616" y="0"/>
                </a:moveTo>
                <a:lnTo>
                  <a:pt x="205233" y="0"/>
                </a:lnTo>
                <a:lnTo>
                  <a:pt x="205233" y="1160399"/>
                </a:lnTo>
                <a:lnTo>
                  <a:pt x="0" y="1160399"/>
                </a:lnTo>
                <a:lnTo>
                  <a:pt x="0" y="0"/>
                </a:lnTo>
                <a:lnTo>
                  <a:pt x="102616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39" name="Freeform 339"/>
          <p:cNvSpPr/>
          <p:nvPr/>
        </p:nvSpPr>
        <p:spPr>
          <a:xfrm>
            <a:off x="1448218" y="3693601"/>
            <a:ext cx="2341118" cy="2007235"/>
          </a:xfrm>
          <a:custGeom>
            <a:avLst/>
            <a:gdLst/>
            <a:ahLst/>
            <a:cxnLst/>
            <a:rect l="0" t="0" r="0" b="0"/>
            <a:pathLst>
              <a:path w="2341118" h="2007235">
                <a:moveTo>
                  <a:pt x="0" y="2007235"/>
                </a:moveTo>
                <a:lnTo>
                  <a:pt x="15114" y="2006980"/>
                </a:lnTo>
                <a:lnTo>
                  <a:pt x="30100" y="2006472"/>
                </a:lnTo>
                <a:lnTo>
                  <a:pt x="45086" y="2005837"/>
                </a:lnTo>
                <a:lnTo>
                  <a:pt x="60071" y="2004822"/>
                </a:lnTo>
                <a:lnTo>
                  <a:pt x="75057" y="2003552"/>
                </a:lnTo>
                <a:lnTo>
                  <a:pt x="90043" y="2002028"/>
                </a:lnTo>
                <a:lnTo>
                  <a:pt x="105157" y="2000122"/>
                </a:lnTo>
                <a:lnTo>
                  <a:pt x="120143" y="1997836"/>
                </a:lnTo>
                <a:lnTo>
                  <a:pt x="135129" y="1995297"/>
                </a:lnTo>
                <a:lnTo>
                  <a:pt x="150115" y="1992503"/>
                </a:lnTo>
                <a:lnTo>
                  <a:pt x="180087" y="1986915"/>
                </a:lnTo>
                <a:lnTo>
                  <a:pt x="195199" y="1984247"/>
                </a:lnTo>
                <a:lnTo>
                  <a:pt x="210185" y="1981961"/>
                </a:lnTo>
                <a:lnTo>
                  <a:pt x="225171" y="1980056"/>
                </a:lnTo>
                <a:lnTo>
                  <a:pt x="240157" y="1978533"/>
                </a:lnTo>
                <a:lnTo>
                  <a:pt x="255143" y="1977643"/>
                </a:lnTo>
                <a:lnTo>
                  <a:pt x="270129" y="1977135"/>
                </a:lnTo>
                <a:lnTo>
                  <a:pt x="285243" y="1977009"/>
                </a:lnTo>
                <a:lnTo>
                  <a:pt x="300229" y="1977262"/>
                </a:lnTo>
                <a:lnTo>
                  <a:pt x="315215" y="1977643"/>
                </a:lnTo>
                <a:lnTo>
                  <a:pt x="330201" y="1978024"/>
                </a:lnTo>
                <a:lnTo>
                  <a:pt x="345187" y="1978533"/>
                </a:lnTo>
                <a:lnTo>
                  <a:pt x="360173" y="1978786"/>
                </a:lnTo>
                <a:lnTo>
                  <a:pt x="375285" y="1978786"/>
                </a:lnTo>
                <a:lnTo>
                  <a:pt x="390271" y="1978405"/>
                </a:lnTo>
                <a:lnTo>
                  <a:pt x="405257" y="1977643"/>
                </a:lnTo>
                <a:lnTo>
                  <a:pt x="420243" y="1976247"/>
                </a:lnTo>
                <a:lnTo>
                  <a:pt x="435229" y="1974215"/>
                </a:lnTo>
                <a:lnTo>
                  <a:pt x="450215" y="1971421"/>
                </a:lnTo>
                <a:lnTo>
                  <a:pt x="465329" y="1967737"/>
                </a:lnTo>
                <a:lnTo>
                  <a:pt x="480315" y="1963420"/>
                </a:lnTo>
                <a:lnTo>
                  <a:pt x="495301" y="1958340"/>
                </a:lnTo>
                <a:lnTo>
                  <a:pt x="510287" y="1952624"/>
                </a:lnTo>
                <a:lnTo>
                  <a:pt x="525273" y="1946274"/>
                </a:lnTo>
                <a:lnTo>
                  <a:pt x="540259" y="1939543"/>
                </a:lnTo>
                <a:lnTo>
                  <a:pt x="555371" y="1932431"/>
                </a:lnTo>
                <a:lnTo>
                  <a:pt x="570357" y="1924811"/>
                </a:lnTo>
                <a:lnTo>
                  <a:pt x="585343" y="1916429"/>
                </a:lnTo>
                <a:lnTo>
                  <a:pt x="600329" y="1907412"/>
                </a:lnTo>
                <a:lnTo>
                  <a:pt x="615315" y="1897379"/>
                </a:lnTo>
                <a:lnTo>
                  <a:pt x="630301" y="1886330"/>
                </a:lnTo>
                <a:lnTo>
                  <a:pt x="645288" y="1874266"/>
                </a:lnTo>
                <a:lnTo>
                  <a:pt x="660401" y="1861439"/>
                </a:lnTo>
                <a:lnTo>
                  <a:pt x="735330" y="1795272"/>
                </a:lnTo>
                <a:lnTo>
                  <a:pt x="780415" y="1758696"/>
                </a:lnTo>
                <a:lnTo>
                  <a:pt x="795401" y="1744598"/>
                </a:lnTo>
                <a:lnTo>
                  <a:pt x="810388" y="1727708"/>
                </a:lnTo>
                <a:lnTo>
                  <a:pt x="825374" y="1706498"/>
                </a:lnTo>
                <a:lnTo>
                  <a:pt x="840487" y="1679321"/>
                </a:lnTo>
                <a:lnTo>
                  <a:pt x="855473" y="1644268"/>
                </a:lnTo>
                <a:lnTo>
                  <a:pt x="870459" y="1599946"/>
                </a:lnTo>
                <a:lnTo>
                  <a:pt x="885445" y="1544701"/>
                </a:lnTo>
                <a:lnTo>
                  <a:pt x="900430" y="1477772"/>
                </a:lnTo>
                <a:lnTo>
                  <a:pt x="915417" y="1398778"/>
                </a:lnTo>
                <a:lnTo>
                  <a:pt x="930530" y="1307591"/>
                </a:lnTo>
                <a:lnTo>
                  <a:pt x="945515" y="1205356"/>
                </a:lnTo>
                <a:lnTo>
                  <a:pt x="960502" y="1093597"/>
                </a:lnTo>
                <a:lnTo>
                  <a:pt x="975488" y="974471"/>
                </a:lnTo>
                <a:lnTo>
                  <a:pt x="1035558" y="481838"/>
                </a:lnTo>
                <a:lnTo>
                  <a:pt x="1050545" y="370459"/>
                </a:lnTo>
                <a:lnTo>
                  <a:pt x="1065530" y="269748"/>
                </a:lnTo>
                <a:lnTo>
                  <a:pt x="1080517" y="182245"/>
                </a:lnTo>
                <a:lnTo>
                  <a:pt x="1095502" y="109981"/>
                </a:lnTo>
                <a:lnTo>
                  <a:pt x="1110615" y="54737"/>
                </a:lnTo>
                <a:lnTo>
                  <a:pt x="1125602" y="17906"/>
                </a:lnTo>
                <a:lnTo>
                  <a:pt x="1140588" y="0"/>
                </a:lnTo>
                <a:lnTo>
                  <a:pt x="1155573" y="1397"/>
                </a:lnTo>
                <a:lnTo>
                  <a:pt x="1170560" y="21716"/>
                </a:lnTo>
                <a:lnTo>
                  <a:pt x="1185545" y="59816"/>
                </a:lnTo>
                <a:lnTo>
                  <a:pt x="1200658" y="113918"/>
                </a:lnTo>
                <a:lnTo>
                  <a:pt x="1215645" y="181990"/>
                </a:lnTo>
                <a:lnTo>
                  <a:pt x="1230630" y="261238"/>
                </a:lnTo>
                <a:lnTo>
                  <a:pt x="1245617" y="348868"/>
                </a:lnTo>
                <a:lnTo>
                  <a:pt x="1260602" y="441833"/>
                </a:lnTo>
                <a:lnTo>
                  <a:pt x="1335660" y="915289"/>
                </a:lnTo>
                <a:lnTo>
                  <a:pt x="1350645" y="1002791"/>
                </a:lnTo>
                <a:lnTo>
                  <a:pt x="1365632" y="1086485"/>
                </a:lnTo>
                <a:lnTo>
                  <a:pt x="1380745" y="1165733"/>
                </a:lnTo>
                <a:lnTo>
                  <a:pt x="1395730" y="1239901"/>
                </a:lnTo>
                <a:lnTo>
                  <a:pt x="1410717" y="1308353"/>
                </a:lnTo>
                <a:lnTo>
                  <a:pt x="1425702" y="1370584"/>
                </a:lnTo>
                <a:lnTo>
                  <a:pt x="1440689" y="1425955"/>
                </a:lnTo>
                <a:lnTo>
                  <a:pt x="1455674" y="1474216"/>
                </a:lnTo>
                <a:lnTo>
                  <a:pt x="1470661" y="1515236"/>
                </a:lnTo>
                <a:lnTo>
                  <a:pt x="1485773" y="1549146"/>
                </a:lnTo>
                <a:lnTo>
                  <a:pt x="1500760" y="1575942"/>
                </a:lnTo>
                <a:lnTo>
                  <a:pt x="1515745" y="1596262"/>
                </a:lnTo>
                <a:lnTo>
                  <a:pt x="1530732" y="1610360"/>
                </a:lnTo>
                <a:lnTo>
                  <a:pt x="1545717" y="1618615"/>
                </a:lnTo>
                <a:lnTo>
                  <a:pt x="1560704" y="1621535"/>
                </a:lnTo>
                <a:lnTo>
                  <a:pt x="1575817" y="1619758"/>
                </a:lnTo>
                <a:lnTo>
                  <a:pt x="1590802" y="1613916"/>
                </a:lnTo>
                <a:lnTo>
                  <a:pt x="1605789" y="1604772"/>
                </a:lnTo>
                <a:lnTo>
                  <a:pt x="1620774" y="1593468"/>
                </a:lnTo>
                <a:lnTo>
                  <a:pt x="1650746" y="1568196"/>
                </a:lnTo>
                <a:lnTo>
                  <a:pt x="1665860" y="1556766"/>
                </a:lnTo>
                <a:lnTo>
                  <a:pt x="1680845" y="1547495"/>
                </a:lnTo>
                <a:lnTo>
                  <a:pt x="1695832" y="1540891"/>
                </a:lnTo>
                <a:lnTo>
                  <a:pt x="1710817" y="1537589"/>
                </a:lnTo>
                <a:lnTo>
                  <a:pt x="1725804" y="1537461"/>
                </a:lnTo>
                <a:lnTo>
                  <a:pt x="1740789" y="1540255"/>
                </a:lnTo>
                <a:lnTo>
                  <a:pt x="1755902" y="1545462"/>
                </a:lnTo>
                <a:lnTo>
                  <a:pt x="1770889" y="1552447"/>
                </a:lnTo>
                <a:lnTo>
                  <a:pt x="1785874" y="1560576"/>
                </a:lnTo>
                <a:lnTo>
                  <a:pt x="1830833" y="1586737"/>
                </a:lnTo>
                <a:lnTo>
                  <a:pt x="1845945" y="1594992"/>
                </a:lnTo>
                <a:lnTo>
                  <a:pt x="1860932" y="1602740"/>
                </a:lnTo>
                <a:lnTo>
                  <a:pt x="1875917" y="1609978"/>
                </a:lnTo>
                <a:lnTo>
                  <a:pt x="1905889" y="1624203"/>
                </a:lnTo>
                <a:lnTo>
                  <a:pt x="1920876" y="1631696"/>
                </a:lnTo>
                <a:lnTo>
                  <a:pt x="1935989" y="1639951"/>
                </a:lnTo>
                <a:lnTo>
                  <a:pt x="1950974" y="1649348"/>
                </a:lnTo>
                <a:lnTo>
                  <a:pt x="1965961" y="1660143"/>
                </a:lnTo>
                <a:lnTo>
                  <a:pt x="1980946" y="1672590"/>
                </a:lnTo>
                <a:lnTo>
                  <a:pt x="1995933" y="1686941"/>
                </a:lnTo>
                <a:lnTo>
                  <a:pt x="2010918" y="1703197"/>
                </a:lnTo>
                <a:lnTo>
                  <a:pt x="2026032" y="1721230"/>
                </a:lnTo>
                <a:lnTo>
                  <a:pt x="2041017" y="1740789"/>
                </a:lnTo>
                <a:lnTo>
                  <a:pt x="2056004" y="1761490"/>
                </a:lnTo>
                <a:lnTo>
                  <a:pt x="2085976" y="1805431"/>
                </a:lnTo>
                <a:lnTo>
                  <a:pt x="2131061" y="1871598"/>
                </a:lnTo>
                <a:lnTo>
                  <a:pt x="2146046" y="1892427"/>
                </a:lnTo>
                <a:lnTo>
                  <a:pt x="2161033" y="1911858"/>
                </a:lnTo>
                <a:lnTo>
                  <a:pt x="2176018" y="1929637"/>
                </a:lnTo>
                <a:lnTo>
                  <a:pt x="2191005" y="1945512"/>
                </a:lnTo>
                <a:lnTo>
                  <a:pt x="2206117" y="1959483"/>
                </a:lnTo>
                <a:lnTo>
                  <a:pt x="2221104" y="1971166"/>
                </a:lnTo>
                <a:lnTo>
                  <a:pt x="2236089" y="1980818"/>
                </a:lnTo>
                <a:lnTo>
                  <a:pt x="2251076" y="1988439"/>
                </a:lnTo>
                <a:lnTo>
                  <a:pt x="2266061" y="1994280"/>
                </a:lnTo>
                <a:lnTo>
                  <a:pt x="2281048" y="1998726"/>
                </a:lnTo>
                <a:lnTo>
                  <a:pt x="2296033" y="2001773"/>
                </a:lnTo>
                <a:lnTo>
                  <a:pt x="2311146" y="2004060"/>
                </a:lnTo>
                <a:lnTo>
                  <a:pt x="2326133" y="2005456"/>
                </a:lnTo>
                <a:lnTo>
                  <a:pt x="2341118" y="2006346"/>
                </a:lnTo>
              </a:path>
            </a:pathLst>
          </a:custGeom>
          <a:noFill/>
          <a:ln w="18288" cap="flat" cmpd="sng">
            <a:solidFill>
              <a:srgbClr val="445694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40" name="Freeform 340"/>
          <p:cNvSpPr/>
          <p:nvPr/>
        </p:nvSpPr>
        <p:spPr>
          <a:xfrm>
            <a:off x="1685708" y="4677342"/>
            <a:ext cx="2463165" cy="1022096"/>
          </a:xfrm>
          <a:custGeom>
            <a:avLst/>
            <a:gdLst/>
            <a:ahLst/>
            <a:cxnLst/>
            <a:rect l="0" t="0" r="0" b="0"/>
            <a:pathLst>
              <a:path w="2463165" h="1022096">
                <a:moveTo>
                  <a:pt x="0" y="1022096"/>
                </a:moveTo>
                <a:lnTo>
                  <a:pt x="10923" y="1021843"/>
                </a:lnTo>
                <a:lnTo>
                  <a:pt x="21845" y="1021588"/>
                </a:lnTo>
                <a:lnTo>
                  <a:pt x="32767" y="1021207"/>
                </a:lnTo>
                <a:lnTo>
                  <a:pt x="43561" y="1020700"/>
                </a:lnTo>
                <a:lnTo>
                  <a:pt x="54484" y="1020319"/>
                </a:lnTo>
                <a:lnTo>
                  <a:pt x="65406" y="1019683"/>
                </a:lnTo>
                <a:lnTo>
                  <a:pt x="76328" y="1019175"/>
                </a:lnTo>
                <a:lnTo>
                  <a:pt x="87250" y="1018413"/>
                </a:lnTo>
                <a:lnTo>
                  <a:pt x="98172" y="1017651"/>
                </a:lnTo>
                <a:lnTo>
                  <a:pt x="108967" y="1016762"/>
                </a:lnTo>
                <a:lnTo>
                  <a:pt x="119889" y="1015874"/>
                </a:lnTo>
                <a:lnTo>
                  <a:pt x="130811" y="1014857"/>
                </a:lnTo>
                <a:lnTo>
                  <a:pt x="141733" y="1013587"/>
                </a:lnTo>
                <a:lnTo>
                  <a:pt x="152655" y="1012318"/>
                </a:lnTo>
                <a:lnTo>
                  <a:pt x="163450" y="1010920"/>
                </a:lnTo>
                <a:lnTo>
                  <a:pt x="174372" y="1009396"/>
                </a:lnTo>
                <a:lnTo>
                  <a:pt x="185294" y="1007619"/>
                </a:lnTo>
                <a:lnTo>
                  <a:pt x="196215" y="1005713"/>
                </a:lnTo>
                <a:lnTo>
                  <a:pt x="207137" y="1003555"/>
                </a:lnTo>
                <a:lnTo>
                  <a:pt x="218059" y="1001269"/>
                </a:lnTo>
                <a:lnTo>
                  <a:pt x="228855" y="998856"/>
                </a:lnTo>
                <a:lnTo>
                  <a:pt x="239776" y="996062"/>
                </a:lnTo>
                <a:lnTo>
                  <a:pt x="250698" y="993013"/>
                </a:lnTo>
                <a:lnTo>
                  <a:pt x="261620" y="989838"/>
                </a:lnTo>
                <a:lnTo>
                  <a:pt x="272542" y="986282"/>
                </a:lnTo>
                <a:lnTo>
                  <a:pt x="283337" y="982473"/>
                </a:lnTo>
                <a:lnTo>
                  <a:pt x="294259" y="978408"/>
                </a:lnTo>
                <a:lnTo>
                  <a:pt x="305181" y="973837"/>
                </a:lnTo>
                <a:lnTo>
                  <a:pt x="316103" y="969011"/>
                </a:lnTo>
                <a:lnTo>
                  <a:pt x="327025" y="963931"/>
                </a:lnTo>
                <a:lnTo>
                  <a:pt x="337948" y="958343"/>
                </a:lnTo>
                <a:lnTo>
                  <a:pt x="348742" y="952246"/>
                </a:lnTo>
                <a:lnTo>
                  <a:pt x="359664" y="945896"/>
                </a:lnTo>
                <a:lnTo>
                  <a:pt x="370586" y="939038"/>
                </a:lnTo>
                <a:lnTo>
                  <a:pt x="381509" y="931673"/>
                </a:lnTo>
                <a:lnTo>
                  <a:pt x="392431" y="923799"/>
                </a:lnTo>
                <a:lnTo>
                  <a:pt x="403225" y="915417"/>
                </a:lnTo>
                <a:lnTo>
                  <a:pt x="414148" y="906400"/>
                </a:lnTo>
                <a:lnTo>
                  <a:pt x="425070" y="897001"/>
                </a:lnTo>
                <a:lnTo>
                  <a:pt x="435992" y="886842"/>
                </a:lnTo>
                <a:lnTo>
                  <a:pt x="446914" y="876174"/>
                </a:lnTo>
                <a:lnTo>
                  <a:pt x="457836" y="864870"/>
                </a:lnTo>
                <a:lnTo>
                  <a:pt x="468631" y="852932"/>
                </a:lnTo>
                <a:lnTo>
                  <a:pt x="479553" y="840360"/>
                </a:lnTo>
                <a:lnTo>
                  <a:pt x="490475" y="827025"/>
                </a:lnTo>
                <a:lnTo>
                  <a:pt x="501397" y="813181"/>
                </a:lnTo>
                <a:lnTo>
                  <a:pt x="512319" y="798450"/>
                </a:lnTo>
                <a:lnTo>
                  <a:pt x="523114" y="783082"/>
                </a:lnTo>
                <a:lnTo>
                  <a:pt x="534036" y="767081"/>
                </a:lnTo>
                <a:lnTo>
                  <a:pt x="544958" y="750317"/>
                </a:lnTo>
                <a:lnTo>
                  <a:pt x="555880" y="732790"/>
                </a:lnTo>
                <a:lnTo>
                  <a:pt x="566801" y="714630"/>
                </a:lnTo>
                <a:lnTo>
                  <a:pt x="577723" y="695833"/>
                </a:lnTo>
                <a:lnTo>
                  <a:pt x="588519" y="676275"/>
                </a:lnTo>
                <a:lnTo>
                  <a:pt x="599440" y="656082"/>
                </a:lnTo>
                <a:lnTo>
                  <a:pt x="621284" y="613792"/>
                </a:lnTo>
                <a:lnTo>
                  <a:pt x="643001" y="569342"/>
                </a:lnTo>
                <a:lnTo>
                  <a:pt x="664846" y="522987"/>
                </a:lnTo>
                <a:lnTo>
                  <a:pt x="697612" y="450724"/>
                </a:lnTo>
                <a:lnTo>
                  <a:pt x="784733" y="256921"/>
                </a:lnTo>
                <a:lnTo>
                  <a:pt x="806577" y="211837"/>
                </a:lnTo>
                <a:lnTo>
                  <a:pt x="817499" y="190374"/>
                </a:lnTo>
                <a:lnTo>
                  <a:pt x="828295" y="169800"/>
                </a:lnTo>
                <a:lnTo>
                  <a:pt x="839217" y="149987"/>
                </a:lnTo>
                <a:lnTo>
                  <a:pt x="850139" y="131192"/>
                </a:lnTo>
                <a:lnTo>
                  <a:pt x="861061" y="113412"/>
                </a:lnTo>
                <a:lnTo>
                  <a:pt x="871983" y="96775"/>
                </a:lnTo>
                <a:lnTo>
                  <a:pt x="882777" y="81281"/>
                </a:lnTo>
                <a:lnTo>
                  <a:pt x="893699" y="67056"/>
                </a:lnTo>
                <a:lnTo>
                  <a:pt x="904621" y="54102"/>
                </a:lnTo>
                <a:lnTo>
                  <a:pt x="915543" y="42545"/>
                </a:lnTo>
                <a:lnTo>
                  <a:pt x="926465" y="32258"/>
                </a:lnTo>
                <a:lnTo>
                  <a:pt x="937387" y="23495"/>
                </a:lnTo>
                <a:lnTo>
                  <a:pt x="948183" y="16002"/>
                </a:lnTo>
                <a:lnTo>
                  <a:pt x="959105" y="10033"/>
                </a:lnTo>
                <a:lnTo>
                  <a:pt x="970027" y="5462"/>
                </a:lnTo>
                <a:lnTo>
                  <a:pt x="980949" y="2287"/>
                </a:lnTo>
                <a:lnTo>
                  <a:pt x="991871" y="508"/>
                </a:lnTo>
                <a:lnTo>
                  <a:pt x="1002793" y="0"/>
                </a:lnTo>
                <a:lnTo>
                  <a:pt x="1013587" y="889"/>
                </a:lnTo>
                <a:lnTo>
                  <a:pt x="1024509" y="3049"/>
                </a:lnTo>
                <a:lnTo>
                  <a:pt x="1035431" y="6477"/>
                </a:lnTo>
                <a:lnTo>
                  <a:pt x="1046353" y="11050"/>
                </a:lnTo>
                <a:lnTo>
                  <a:pt x="1057275" y="16764"/>
                </a:lnTo>
                <a:lnTo>
                  <a:pt x="1068071" y="23369"/>
                </a:lnTo>
                <a:lnTo>
                  <a:pt x="1078993" y="31115"/>
                </a:lnTo>
                <a:lnTo>
                  <a:pt x="1089915" y="39625"/>
                </a:lnTo>
                <a:lnTo>
                  <a:pt x="1100837" y="48895"/>
                </a:lnTo>
                <a:lnTo>
                  <a:pt x="1111758" y="58929"/>
                </a:lnTo>
                <a:lnTo>
                  <a:pt x="1122680" y="69596"/>
                </a:lnTo>
                <a:lnTo>
                  <a:pt x="1133475" y="80773"/>
                </a:lnTo>
                <a:lnTo>
                  <a:pt x="1144398" y="92456"/>
                </a:lnTo>
                <a:lnTo>
                  <a:pt x="1166242" y="116713"/>
                </a:lnTo>
                <a:lnTo>
                  <a:pt x="1253364" y="215138"/>
                </a:lnTo>
                <a:lnTo>
                  <a:pt x="1264286" y="226442"/>
                </a:lnTo>
                <a:lnTo>
                  <a:pt x="1275208" y="237363"/>
                </a:lnTo>
                <a:lnTo>
                  <a:pt x="1286130" y="247777"/>
                </a:lnTo>
                <a:lnTo>
                  <a:pt x="1297052" y="257683"/>
                </a:lnTo>
                <a:lnTo>
                  <a:pt x="1307846" y="266955"/>
                </a:lnTo>
                <a:lnTo>
                  <a:pt x="1318768" y="275844"/>
                </a:lnTo>
                <a:lnTo>
                  <a:pt x="1329690" y="283973"/>
                </a:lnTo>
                <a:lnTo>
                  <a:pt x="1340612" y="291593"/>
                </a:lnTo>
                <a:lnTo>
                  <a:pt x="1351534" y="298577"/>
                </a:lnTo>
                <a:lnTo>
                  <a:pt x="1362456" y="305055"/>
                </a:lnTo>
                <a:lnTo>
                  <a:pt x="1373252" y="310769"/>
                </a:lnTo>
                <a:lnTo>
                  <a:pt x="1384174" y="315976"/>
                </a:lnTo>
                <a:lnTo>
                  <a:pt x="1395096" y="320549"/>
                </a:lnTo>
                <a:lnTo>
                  <a:pt x="1406018" y="324486"/>
                </a:lnTo>
                <a:lnTo>
                  <a:pt x="1416940" y="327914"/>
                </a:lnTo>
                <a:lnTo>
                  <a:pt x="1427734" y="330836"/>
                </a:lnTo>
                <a:lnTo>
                  <a:pt x="1438656" y="333121"/>
                </a:lnTo>
                <a:lnTo>
                  <a:pt x="1449578" y="335026"/>
                </a:lnTo>
                <a:lnTo>
                  <a:pt x="1460500" y="336550"/>
                </a:lnTo>
                <a:lnTo>
                  <a:pt x="1471423" y="337567"/>
                </a:lnTo>
                <a:lnTo>
                  <a:pt x="1482345" y="338329"/>
                </a:lnTo>
                <a:lnTo>
                  <a:pt x="1493140" y="338710"/>
                </a:lnTo>
                <a:lnTo>
                  <a:pt x="1504062" y="338963"/>
                </a:lnTo>
                <a:lnTo>
                  <a:pt x="1514983" y="338963"/>
                </a:lnTo>
                <a:lnTo>
                  <a:pt x="1525905" y="338837"/>
                </a:lnTo>
                <a:lnTo>
                  <a:pt x="1536827" y="338710"/>
                </a:lnTo>
                <a:lnTo>
                  <a:pt x="1547623" y="338456"/>
                </a:lnTo>
                <a:lnTo>
                  <a:pt x="1558545" y="338329"/>
                </a:lnTo>
                <a:lnTo>
                  <a:pt x="1569467" y="338329"/>
                </a:lnTo>
                <a:lnTo>
                  <a:pt x="1580389" y="338456"/>
                </a:lnTo>
                <a:lnTo>
                  <a:pt x="1591311" y="338837"/>
                </a:lnTo>
                <a:lnTo>
                  <a:pt x="1602233" y="339471"/>
                </a:lnTo>
                <a:lnTo>
                  <a:pt x="1613027" y="340614"/>
                </a:lnTo>
                <a:lnTo>
                  <a:pt x="1623949" y="342012"/>
                </a:lnTo>
                <a:lnTo>
                  <a:pt x="1634871" y="343917"/>
                </a:lnTo>
                <a:lnTo>
                  <a:pt x="1645793" y="346330"/>
                </a:lnTo>
                <a:lnTo>
                  <a:pt x="1656715" y="349377"/>
                </a:lnTo>
                <a:lnTo>
                  <a:pt x="1667511" y="352933"/>
                </a:lnTo>
                <a:lnTo>
                  <a:pt x="1678433" y="357251"/>
                </a:lnTo>
                <a:lnTo>
                  <a:pt x="1689355" y="362077"/>
                </a:lnTo>
                <a:lnTo>
                  <a:pt x="1700277" y="367665"/>
                </a:lnTo>
                <a:lnTo>
                  <a:pt x="1711199" y="374015"/>
                </a:lnTo>
                <a:lnTo>
                  <a:pt x="1722121" y="381127"/>
                </a:lnTo>
                <a:lnTo>
                  <a:pt x="1732915" y="388875"/>
                </a:lnTo>
                <a:lnTo>
                  <a:pt x="1743837" y="397511"/>
                </a:lnTo>
                <a:lnTo>
                  <a:pt x="1754759" y="406781"/>
                </a:lnTo>
                <a:lnTo>
                  <a:pt x="1765681" y="416814"/>
                </a:lnTo>
                <a:lnTo>
                  <a:pt x="1776603" y="427610"/>
                </a:lnTo>
                <a:lnTo>
                  <a:pt x="1787399" y="439039"/>
                </a:lnTo>
                <a:lnTo>
                  <a:pt x="1798321" y="451231"/>
                </a:lnTo>
                <a:lnTo>
                  <a:pt x="1809243" y="464058"/>
                </a:lnTo>
                <a:lnTo>
                  <a:pt x="1820165" y="477520"/>
                </a:lnTo>
                <a:lnTo>
                  <a:pt x="1831087" y="491490"/>
                </a:lnTo>
                <a:lnTo>
                  <a:pt x="1842008" y="505969"/>
                </a:lnTo>
                <a:lnTo>
                  <a:pt x="1863725" y="536449"/>
                </a:lnTo>
                <a:lnTo>
                  <a:pt x="1885570" y="568325"/>
                </a:lnTo>
                <a:lnTo>
                  <a:pt x="1929130" y="634746"/>
                </a:lnTo>
                <a:lnTo>
                  <a:pt x="1983614" y="717931"/>
                </a:lnTo>
                <a:lnTo>
                  <a:pt x="2005458" y="749808"/>
                </a:lnTo>
                <a:lnTo>
                  <a:pt x="2027302" y="780288"/>
                </a:lnTo>
                <a:lnTo>
                  <a:pt x="2038096" y="795020"/>
                </a:lnTo>
                <a:lnTo>
                  <a:pt x="2049018" y="809244"/>
                </a:lnTo>
                <a:lnTo>
                  <a:pt x="2059940" y="823087"/>
                </a:lnTo>
                <a:lnTo>
                  <a:pt x="2070862" y="836295"/>
                </a:lnTo>
                <a:lnTo>
                  <a:pt x="2081784" y="849123"/>
                </a:lnTo>
                <a:lnTo>
                  <a:pt x="2092580" y="861314"/>
                </a:lnTo>
                <a:lnTo>
                  <a:pt x="2103502" y="872999"/>
                </a:lnTo>
                <a:lnTo>
                  <a:pt x="2114424" y="884175"/>
                </a:lnTo>
                <a:lnTo>
                  <a:pt x="2125346" y="894843"/>
                </a:lnTo>
                <a:lnTo>
                  <a:pt x="2136268" y="904875"/>
                </a:lnTo>
                <a:lnTo>
                  <a:pt x="2147190" y="914400"/>
                </a:lnTo>
                <a:lnTo>
                  <a:pt x="2157984" y="923290"/>
                </a:lnTo>
                <a:lnTo>
                  <a:pt x="2168906" y="931800"/>
                </a:lnTo>
                <a:lnTo>
                  <a:pt x="2179828" y="939674"/>
                </a:lnTo>
                <a:lnTo>
                  <a:pt x="2190750" y="947039"/>
                </a:lnTo>
                <a:lnTo>
                  <a:pt x="2201673" y="954025"/>
                </a:lnTo>
                <a:lnTo>
                  <a:pt x="2212468" y="960375"/>
                </a:lnTo>
                <a:lnTo>
                  <a:pt x="2223390" y="966344"/>
                </a:lnTo>
                <a:lnTo>
                  <a:pt x="2234312" y="971931"/>
                </a:lnTo>
                <a:lnTo>
                  <a:pt x="2245233" y="977012"/>
                </a:lnTo>
                <a:lnTo>
                  <a:pt x="2256155" y="981711"/>
                </a:lnTo>
                <a:lnTo>
                  <a:pt x="2267077" y="986029"/>
                </a:lnTo>
                <a:lnTo>
                  <a:pt x="2277873" y="989965"/>
                </a:lnTo>
                <a:lnTo>
                  <a:pt x="2288794" y="993521"/>
                </a:lnTo>
                <a:lnTo>
                  <a:pt x="2299717" y="996824"/>
                </a:lnTo>
                <a:lnTo>
                  <a:pt x="2310638" y="999871"/>
                </a:lnTo>
                <a:lnTo>
                  <a:pt x="2321561" y="1002538"/>
                </a:lnTo>
                <a:lnTo>
                  <a:pt x="2332356" y="1004951"/>
                </a:lnTo>
                <a:lnTo>
                  <a:pt x="2343277" y="1007111"/>
                </a:lnTo>
                <a:lnTo>
                  <a:pt x="2354200" y="1009143"/>
                </a:lnTo>
                <a:lnTo>
                  <a:pt x="2365121" y="1010920"/>
                </a:lnTo>
                <a:lnTo>
                  <a:pt x="2376044" y="1012571"/>
                </a:lnTo>
                <a:lnTo>
                  <a:pt x="2386965" y="1013969"/>
                </a:lnTo>
                <a:lnTo>
                  <a:pt x="2397761" y="1015238"/>
                </a:lnTo>
                <a:lnTo>
                  <a:pt x="2408682" y="1016381"/>
                </a:lnTo>
                <a:lnTo>
                  <a:pt x="2419605" y="1017398"/>
                </a:lnTo>
                <a:lnTo>
                  <a:pt x="2430526" y="1018287"/>
                </a:lnTo>
                <a:lnTo>
                  <a:pt x="2441449" y="1019049"/>
                </a:lnTo>
                <a:lnTo>
                  <a:pt x="2452244" y="1019683"/>
                </a:lnTo>
                <a:lnTo>
                  <a:pt x="2463165" y="1020319"/>
                </a:lnTo>
              </a:path>
            </a:pathLst>
          </a:custGeom>
          <a:noFill/>
          <a:ln w="18288" cap="flat" cmpd="sng">
            <a:solidFill>
              <a:srgbClr val="A23A2E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41" name="Freeform 341"/>
          <p:cNvSpPr/>
          <p:nvPr/>
        </p:nvSpPr>
        <p:spPr>
          <a:xfrm>
            <a:off x="1363510" y="4913690"/>
            <a:ext cx="2915030" cy="785748"/>
          </a:xfrm>
          <a:custGeom>
            <a:avLst/>
            <a:gdLst/>
            <a:ahLst/>
            <a:cxnLst/>
            <a:rect l="0" t="0" r="0" b="0"/>
            <a:pathLst>
              <a:path w="2915030" h="785748">
                <a:moveTo>
                  <a:pt x="0" y="785748"/>
                </a:moveTo>
                <a:lnTo>
                  <a:pt x="11557" y="785621"/>
                </a:lnTo>
                <a:lnTo>
                  <a:pt x="23114" y="785367"/>
                </a:lnTo>
                <a:lnTo>
                  <a:pt x="34671" y="785114"/>
                </a:lnTo>
                <a:lnTo>
                  <a:pt x="46227" y="784859"/>
                </a:lnTo>
                <a:lnTo>
                  <a:pt x="57784" y="784606"/>
                </a:lnTo>
                <a:lnTo>
                  <a:pt x="69341" y="784225"/>
                </a:lnTo>
                <a:lnTo>
                  <a:pt x="80898" y="783971"/>
                </a:lnTo>
                <a:lnTo>
                  <a:pt x="92455" y="783589"/>
                </a:lnTo>
                <a:lnTo>
                  <a:pt x="104140" y="783208"/>
                </a:lnTo>
                <a:lnTo>
                  <a:pt x="115697" y="782827"/>
                </a:lnTo>
                <a:lnTo>
                  <a:pt x="127254" y="782320"/>
                </a:lnTo>
                <a:lnTo>
                  <a:pt x="138811" y="781812"/>
                </a:lnTo>
                <a:lnTo>
                  <a:pt x="150368" y="781303"/>
                </a:lnTo>
                <a:lnTo>
                  <a:pt x="161924" y="780669"/>
                </a:lnTo>
                <a:lnTo>
                  <a:pt x="173482" y="780160"/>
                </a:lnTo>
                <a:lnTo>
                  <a:pt x="185038" y="779526"/>
                </a:lnTo>
                <a:lnTo>
                  <a:pt x="196596" y="778764"/>
                </a:lnTo>
                <a:lnTo>
                  <a:pt x="208153" y="778002"/>
                </a:lnTo>
                <a:lnTo>
                  <a:pt x="219709" y="777239"/>
                </a:lnTo>
                <a:lnTo>
                  <a:pt x="231267" y="776477"/>
                </a:lnTo>
                <a:lnTo>
                  <a:pt x="242951" y="775589"/>
                </a:lnTo>
                <a:lnTo>
                  <a:pt x="254507" y="774572"/>
                </a:lnTo>
                <a:lnTo>
                  <a:pt x="266065" y="773557"/>
                </a:lnTo>
                <a:lnTo>
                  <a:pt x="277621" y="772540"/>
                </a:lnTo>
                <a:lnTo>
                  <a:pt x="289179" y="771397"/>
                </a:lnTo>
                <a:lnTo>
                  <a:pt x="300735" y="770127"/>
                </a:lnTo>
                <a:lnTo>
                  <a:pt x="312293" y="768858"/>
                </a:lnTo>
                <a:lnTo>
                  <a:pt x="323849" y="767588"/>
                </a:lnTo>
                <a:lnTo>
                  <a:pt x="335407" y="766190"/>
                </a:lnTo>
                <a:lnTo>
                  <a:pt x="346963" y="764666"/>
                </a:lnTo>
                <a:lnTo>
                  <a:pt x="358521" y="763015"/>
                </a:lnTo>
                <a:lnTo>
                  <a:pt x="370204" y="761364"/>
                </a:lnTo>
                <a:lnTo>
                  <a:pt x="381762" y="759587"/>
                </a:lnTo>
                <a:lnTo>
                  <a:pt x="393318" y="757808"/>
                </a:lnTo>
                <a:lnTo>
                  <a:pt x="404876" y="755777"/>
                </a:lnTo>
                <a:lnTo>
                  <a:pt x="416432" y="753745"/>
                </a:lnTo>
                <a:lnTo>
                  <a:pt x="427990" y="751585"/>
                </a:lnTo>
                <a:lnTo>
                  <a:pt x="439546" y="749172"/>
                </a:lnTo>
                <a:lnTo>
                  <a:pt x="451104" y="746759"/>
                </a:lnTo>
                <a:lnTo>
                  <a:pt x="462660" y="744220"/>
                </a:lnTo>
                <a:lnTo>
                  <a:pt x="474218" y="741552"/>
                </a:lnTo>
                <a:lnTo>
                  <a:pt x="485774" y="738632"/>
                </a:lnTo>
                <a:lnTo>
                  <a:pt x="497332" y="735710"/>
                </a:lnTo>
                <a:lnTo>
                  <a:pt x="509015" y="732535"/>
                </a:lnTo>
                <a:lnTo>
                  <a:pt x="520573" y="729233"/>
                </a:lnTo>
                <a:lnTo>
                  <a:pt x="532129" y="725677"/>
                </a:lnTo>
                <a:lnTo>
                  <a:pt x="543687" y="721995"/>
                </a:lnTo>
                <a:lnTo>
                  <a:pt x="555243" y="718058"/>
                </a:lnTo>
                <a:lnTo>
                  <a:pt x="566801" y="713866"/>
                </a:lnTo>
                <a:lnTo>
                  <a:pt x="578357" y="709548"/>
                </a:lnTo>
                <a:lnTo>
                  <a:pt x="589915" y="704977"/>
                </a:lnTo>
                <a:lnTo>
                  <a:pt x="601471" y="700151"/>
                </a:lnTo>
                <a:lnTo>
                  <a:pt x="613029" y="695071"/>
                </a:lnTo>
                <a:lnTo>
                  <a:pt x="624585" y="689737"/>
                </a:lnTo>
                <a:lnTo>
                  <a:pt x="636143" y="684148"/>
                </a:lnTo>
                <a:lnTo>
                  <a:pt x="647826" y="678307"/>
                </a:lnTo>
                <a:lnTo>
                  <a:pt x="659384" y="672083"/>
                </a:lnTo>
                <a:lnTo>
                  <a:pt x="670940" y="665607"/>
                </a:lnTo>
                <a:lnTo>
                  <a:pt x="682498" y="658748"/>
                </a:lnTo>
                <a:lnTo>
                  <a:pt x="694054" y="651509"/>
                </a:lnTo>
                <a:lnTo>
                  <a:pt x="705612" y="644016"/>
                </a:lnTo>
                <a:lnTo>
                  <a:pt x="717168" y="636142"/>
                </a:lnTo>
                <a:lnTo>
                  <a:pt x="728726" y="628014"/>
                </a:lnTo>
                <a:lnTo>
                  <a:pt x="740282" y="619378"/>
                </a:lnTo>
                <a:lnTo>
                  <a:pt x="751840" y="610362"/>
                </a:lnTo>
                <a:lnTo>
                  <a:pt x="763396" y="601090"/>
                </a:lnTo>
                <a:lnTo>
                  <a:pt x="774954" y="591312"/>
                </a:lnTo>
                <a:lnTo>
                  <a:pt x="786637" y="581152"/>
                </a:lnTo>
                <a:lnTo>
                  <a:pt x="798195" y="570610"/>
                </a:lnTo>
                <a:lnTo>
                  <a:pt x="809751" y="559815"/>
                </a:lnTo>
                <a:lnTo>
                  <a:pt x="821309" y="548513"/>
                </a:lnTo>
                <a:lnTo>
                  <a:pt x="832865" y="536828"/>
                </a:lnTo>
                <a:lnTo>
                  <a:pt x="844423" y="524764"/>
                </a:lnTo>
                <a:lnTo>
                  <a:pt x="867537" y="499490"/>
                </a:lnTo>
                <a:lnTo>
                  <a:pt x="890651" y="472821"/>
                </a:lnTo>
                <a:lnTo>
                  <a:pt x="913765" y="444881"/>
                </a:lnTo>
                <a:lnTo>
                  <a:pt x="937006" y="415925"/>
                </a:lnTo>
                <a:lnTo>
                  <a:pt x="971676" y="370713"/>
                </a:lnTo>
                <a:lnTo>
                  <a:pt x="1122044" y="172973"/>
                </a:lnTo>
                <a:lnTo>
                  <a:pt x="1145159" y="145796"/>
                </a:lnTo>
                <a:lnTo>
                  <a:pt x="1156716" y="132841"/>
                </a:lnTo>
                <a:lnTo>
                  <a:pt x="1168272" y="120396"/>
                </a:lnTo>
                <a:lnTo>
                  <a:pt x="1179829" y="108458"/>
                </a:lnTo>
                <a:lnTo>
                  <a:pt x="1191387" y="97027"/>
                </a:lnTo>
                <a:lnTo>
                  <a:pt x="1203071" y="86106"/>
                </a:lnTo>
                <a:lnTo>
                  <a:pt x="1214628" y="75819"/>
                </a:lnTo>
                <a:lnTo>
                  <a:pt x="1226185" y="66166"/>
                </a:lnTo>
                <a:lnTo>
                  <a:pt x="1237741" y="57150"/>
                </a:lnTo>
                <a:lnTo>
                  <a:pt x="1249298" y="48895"/>
                </a:lnTo>
                <a:lnTo>
                  <a:pt x="1260856" y="41147"/>
                </a:lnTo>
                <a:lnTo>
                  <a:pt x="1272413" y="34035"/>
                </a:lnTo>
                <a:lnTo>
                  <a:pt x="1283969" y="27685"/>
                </a:lnTo>
                <a:lnTo>
                  <a:pt x="1295526" y="22097"/>
                </a:lnTo>
                <a:lnTo>
                  <a:pt x="1307084" y="17017"/>
                </a:lnTo>
                <a:lnTo>
                  <a:pt x="1318641" y="12700"/>
                </a:lnTo>
                <a:lnTo>
                  <a:pt x="1330197" y="9016"/>
                </a:lnTo>
                <a:lnTo>
                  <a:pt x="1341881" y="6096"/>
                </a:lnTo>
                <a:lnTo>
                  <a:pt x="1353438" y="3683"/>
                </a:lnTo>
                <a:lnTo>
                  <a:pt x="1364996" y="1904"/>
                </a:lnTo>
                <a:lnTo>
                  <a:pt x="1376553" y="634"/>
                </a:lnTo>
                <a:lnTo>
                  <a:pt x="1388110" y="127"/>
                </a:lnTo>
                <a:lnTo>
                  <a:pt x="1399666" y="0"/>
                </a:lnTo>
                <a:lnTo>
                  <a:pt x="1411223" y="381"/>
                </a:lnTo>
                <a:lnTo>
                  <a:pt x="1422781" y="1396"/>
                </a:lnTo>
                <a:lnTo>
                  <a:pt x="1434338" y="2666"/>
                </a:lnTo>
                <a:lnTo>
                  <a:pt x="1445894" y="4445"/>
                </a:lnTo>
                <a:lnTo>
                  <a:pt x="1457451" y="6603"/>
                </a:lnTo>
                <a:lnTo>
                  <a:pt x="1469009" y="9016"/>
                </a:lnTo>
                <a:lnTo>
                  <a:pt x="1480693" y="11683"/>
                </a:lnTo>
                <a:lnTo>
                  <a:pt x="1492250" y="14732"/>
                </a:lnTo>
                <a:lnTo>
                  <a:pt x="1503806" y="17779"/>
                </a:lnTo>
                <a:lnTo>
                  <a:pt x="1515363" y="21208"/>
                </a:lnTo>
                <a:lnTo>
                  <a:pt x="1538478" y="28066"/>
                </a:lnTo>
                <a:lnTo>
                  <a:pt x="1584706" y="42164"/>
                </a:lnTo>
                <a:lnTo>
                  <a:pt x="1596263" y="45592"/>
                </a:lnTo>
                <a:lnTo>
                  <a:pt x="1607819" y="48767"/>
                </a:lnTo>
                <a:lnTo>
                  <a:pt x="1619503" y="51815"/>
                </a:lnTo>
                <a:lnTo>
                  <a:pt x="1631060" y="54737"/>
                </a:lnTo>
                <a:lnTo>
                  <a:pt x="1642618" y="57403"/>
                </a:lnTo>
                <a:lnTo>
                  <a:pt x="1654175" y="59944"/>
                </a:lnTo>
                <a:lnTo>
                  <a:pt x="1665731" y="62229"/>
                </a:lnTo>
                <a:lnTo>
                  <a:pt x="1677288" y="64134"/>
                </a:lnTo>
                <a:lnTo>
                  <a:pt x="1688846" y="65913"/>
                </a:lnTo>
                <a:lnTo>
                  <a:pt x="1700403" y="67437"/>
                </a:lnTo>
                <a:lnTo>
                  <a:pt x="1711960" y="68707"/>
                </a:lnTo>
                <a:lnTo>
                  <a:pt x="1723516" y="69722"/>
                </a:lnTo>
                <a:lnTo>
                  <a:pt x="1735073" y="70484"/>
                </a:lnTo>
                <a:lnTo>
                  <a:pt x="1746757" y="70992"/>
                </a:lnTo>
                <a:lnTo>
                  <a:pt x="1758315" y="71373"/>
                </a:lnTo>
                <a:lnTo>
                  <a:pt x="1769872" y="71501"/>
                </a:lnTo>
                <a:lnTo>
                  <a:pt x="1781428" y="71373"/>
                </a:lnTo>
                <a:lnTo>
                  <a:pt x="1792985" y="71246"/>
                </a:lnTo>
                <a:lnTo>
                  <a:pt x="1804543" y="70865"/>
                </a:lnTo>
                <a:lnTo>
                  <a:pt x="1816100" y="70484"/>
                </a:lnTo>
                <a:lnTo>
                  <a:pt x="1827656" y="69977"/>
                </a:lnTo>
                <a:lnTo>
                  <a:pt x="1850771" y="68833"/>
                </a:lnTo>
                <a:lnTo>
                  <a:pt x="1862328" y="68326"/>
                </a:lnTo>
                <a:lnTo>
                  <a:pt x="1873885" y="67945"/>
                </a:lnTo>
                <a:lnTo>
                  <a:pt x="1885569" y="67690"/>
                </a:lnTo>
                <a:lnTo>
                  <a:pt x="1897125" y="67437"/>
                </a:lnTo>
                <a:lnTo>
                  <a:pt x="1908682" y="67564"/>
                </a:lnTo>
                <a:lnTo>
                  <a:pt x="1920240" y="67817"/>
                </a:lnTo>
                <a:lnTo>
                  <a:pt x="1931797" y="68326"/>
                </a:lnTo>
                <a:lnTo>
                  <a:pt x="1943353" y="69088"/>
                </a:lnTo>
                <a:lnTo>
                  <a:pt x="1954910" y="70231"/>
                </a:lnTo>
                <a:lnTo>
                  <a:pt x="1966468" y="71882"/>
                </a:lnTo>
                <a:lnTo>
                  <a:pt x="1978025" y="73787"/>
                </a:lnTo>
                <a:lnTo>
                  <a:pt x="1989581" y="76200"/>
                </a:lnTo>
                <a:lnTo>
                  <a:pt x="2001138" y="78994"/>
                </a:lnTo>
                <a:lnTo>
                  <a:pt x="2012696" y="82296"/>
                </a:lnTo>
                <a:lnTo>
                  <a:pt x="2024379" y="86233"/>
                </a:lnTo>
                <a:lnTo>
                  <a:pt x="2035937" y="90551"/>
                </a:lnTo>
                <a:lnTo>
                  <a:pt x="2047494" y="95503"/>
                </a:lnTo>
                <a:lnTo>
                  <a:pt x="2059050" y="100964"/>
                </a:lnTo>
                <a:lnTo>
                  <a:pt x="2070607" y="107060"/>
                </a:lnTo>
                <a:lnTo>
                  <a:pt x="2082165" y="113791"/>
                </a:lnTo>
                <a:lnTo>
                  <a:pt x="2093722" y="121031"/>
                </a:lnTo>
                <a:lnTo>
                  <a:pt x="2105278" y="128904"/>
                </a:lnTo>
                <a:lnTo>
                  <a:pt x="2116835" y="137287"/>
                </a:lnTo>
                <a:lnTo>
                  <a:pt x="2128393" y="146303"/>
                </a:lnTo>
                <a:lnTo>
                  <a:pt x="2139950" y="155828"/>
                </a:lnTo>
                <a:lnTo>
                  <a:pt x="2151506" y="165989"/>
                </a:lnTo>
                <a:lnTo>
                  <a:pt x="2163191" y="176657"/>
                </a:lnTo>
                <a:lnTo>
                  <a:pt x="2174747" y="187833"/>
                </a:lnTo>
                <a:lnTo>
                  <a:pt x="2186304" y="199389"/>
                </a:lnTo>
                <a:lnTo>
                  <a:pt x="2197862" y="211582"/>
                </a:lnTo>
                <a:lnTo>
                  <a:pt x="2209419" y="224154"/>
                </a:lnTo>
                <a:lnTo>
                  <a:pt x="2232532" y="250571"/>
                </a:lnTo>
                <a:lnTo>
                  <a:pt x="2255647" y="278257"/>
                </a:lnTo>
                <a:lnTo>
                  <a:pt x="2278760" y="307085"/>
                </a:lnTo>
                <a:lnTo>
                  <a:pt x="2325116" y="366648"/>
                </a:lnTo>
                <a:lnTo>
                  <a:pt x="2406015" y="471170"/>
                </a:lnTo>
                <a:lnTo>
                  <a:pt x="2429128" y="499617"/>
                </a:lnTo>
                <a:lnTo>
                  <a:pt x="2452369" y="527050"/>
                </a:lnTo>
                <a:lnTo>
                  <a:pt x="2475484" y="553212"/>
                </a:lnTo>
                <a:lnTo>
                  <a:pt x="2498597" y="577977"/>
                </a:lnTo>
                <a:lnTo>
                  <a:pt x="2510154" y="589788"/>
                </a:lnTo>
                <a:lnTo>
                  <a:pt x="2521712" y="601217"/>
                </a:lnTo>
                <a:lnTo>
                  <a:pt x="2533269" y="612266"/>
                </a:lnTo>
                <a:lnTo>
                  <a:pt x="2544825" y="622808"/>
                </a:lnTo>
                <a:lnTo>
                  <a:pt x="2556382" y="633095"/>
                </a:lnTo>
                <a:lnTo>
                  <a:pt x="2567940" y="642873"/>
                </a:lnTo>
                <a:lnTo>
                  <a:pt x="2579623" y="652271"/>
                </a:lnTo>
                <a:lnTo>
                  <a:pt x="2591181" y="661162"/>
                </a:lnTo>
                <a:lnTo>
                  <a:pt x="2602737" y="669797"/>
                </a:lnTo>
                <a:lnTo>
                  <a:pt x="2614294" y="677926"/>
                </a:lnTo>
                <a:lnTo>
                  <a:pt x="2625851" y="685672"/>
                </a:lnTo>
                <a:lnTo>
                  <a:pt x="2637409" y="692912"/>
                </a:lnTo>
                <a:lnTo>
                  <a:pt x="2648966" y="699896"/>
                </a:lnTo>
                <a:lnTo>
                  <a:pt x="2660523" y="706373"/>
                </a:lnTo>
                <a:lnTo>
                  <a:pt x="2672080" y="712596"/>
                </a:lnTo>
                <a:lnTo>
                  <a:pt x="2683636" y="718439"/>
                </a:lnTo>
                <a:lnTo>
                  <a:pt x="2695193" y="723900"/>
                </a:lnTo>
                <a:lnTo>
                  <a:pt x="2706750" y="728979"/>
                </a:lnTo>
                <a:lnTo>
                  <a:pt x="2718435" y="733806"/>
                </a:lnTo>
                <a:lnTo>
                  <a:pt x="2729992" y="738251"/>
                </a:lnTo>
                <a:lnTo>
                  <a:pt x="2741549" y="742441"/>
                </a:lnTo>
                <a:lnTo>
                  <a:pt x="2753105" y="746252"/>
                </a:lnTo>
                <a:lnTo>
                  <a:pt x="2764662" y="749934"/>
                </a:lnTo>
                <a:lnTo>
                  <a:pt x="2776219" y="753237"/>
                </a:lnTo>
                <a:lnTo>
                  <a:pt x="2787776" y="756412"/>
                </a:lnTo>
                <a:lnTo>
                  <a:pt x="2799334" y="759206"/>
                </a:lnTo>
                <a:lnTo>
                  <a:pt x="2810891" y="761872"/>
                </a:lnTo>
                <a:lnTo>
                  <a:pt x="2822448" y="764285"/>
                </a:lnTo>
                <a:lnTo>
                  <a:pt x="2834005" y="766571"/>
                </a:lnTo>
                <a:lnTo>
                  <a:pt x="2845561" y="768603"/>
                </a:lnTo>
                <a:lnTo>
                  <a:pt x="2857246" y="770508"/>
                </a:lnTo>
                <a:lnTo>
                  <a:pt x="2868803" y="772159"/>
                </a:lnTo>
                <a:lnTo>
                  <a:pt x="2880360" y="773810"/>
                </a:lnTo>
                <a:lnTo>
                  <a:pt x="2891917" y="775208"/>
                </a:lnTo>
                <a:lnTo>
                  <a:pt x="2903474" y="776477"/>
                </a:lnTo>
                <a:lnTo>
                  <a:pt x="2915030" y="777621"/>
                </a:lnTo>
              </a:path>
            </a:pathLst>
          </a:custGeom>
          <a:noFill/>
          <a:ln w="18288" cap="flat" cmpd="sng">
            <a:solidFill>
              <a:srgbClr val="01665E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42" name="Freeform 342"/>
          <p:cNvSpPr/>
          <p:nvPr/>
        </p:nvSpPr>
        <p:spPr>
          <a:xfrm>
            <a:off x="1205394" y="5731823"/>
            <a:ext cx="3103627" cy="0"/>
          </a:xfrm>
          <a:custGeom>
            <a:avLst/>
            <a:gdLst/>
            <a:ahLst/>
            <a:cxnLst/>
            <a:rect l="0" t="0" r="0" b="0"/>
            <a:pathLst>
              <a:path w="3103627">
                <a:moveTo>
                  <a:pt x="0" y="0"/>
                </a:moveTo>
                <a:lnTo>
                  <a:pt x="3103627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43" name="Freeform 343"/>
          <p:cNvSpPr/>
          <p:nvPr/>
        </p:nvSpPr>
        <p:spPr>
          <a:xfrm>
            <a:off x="4309021" y="3524055"/>
            <a:ext cx="0" cy="2207768"/>
          </a:xfrm>
          <a:custGeom>
            <a:avLst/>
            <a:gdLst/>
            <a:ahLst/>
            <a:cxnLst/>
            <a:rect l="0" t="0" r="0" b="0"/>
            <a:pathLst>
              <a:path h="2207768">
                <a:moveTo>
                  <a:pt x="0" y="2207768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44" name="Freeform 344"/>
          <p:cNvSpPr/>
          <p:nvPr/>
        </p:nvSpPr>
        <p:spPr>
          <a:xfrm>
            <a:off x="1205394" y="3524055"/>
            <a:ext cx="3103627" cy="0"/>
          </a:xfrm>
          <a:custGeom>
            <a:avLst/>
            <a:gdLst/>
            <a:ahLst/>
            <a:cxnLst/>
            <a:rect l="0" t="0" r="0" b="0"/>
            <a:pathLst>
              <a:path w="3103627">
                <a:moveTo>
                  <a:pt x="0" y="0"/>
                </a:moveTo>
                <a:lnTo>
                  <a:pt x="3103627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45" name="Freeform 345"/>
          <p:cNvSpPr/>
          <p:nvPr/>
        </p:nvSpPr>
        <p:spPr>
          <a:xfrm>
            <a:off x="1205394" y="3524055"/>
            <a:ext cx="0" cy="2207768"/>
          </a:xfrm>
          <a:custGeom>
            <a:avLst/>
            <a:gdLst/>
            <a:ahLst/>
            <a:cxnLst/>
            <a:rect l="0" t="0" r="0" b="0"/>
            <a:pathLst>
              <a:path h="2207768">
                <a:moveTo>
                  <a:pt x="0" y="2207768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46" name="Freeform 346"/>
          <p:cNvSpPr/>
          <p:nvPr/>
        </p:nvSpPr>
        <p:spPr>
          <a:xfrm>
            <a:off x="1205394" y="5731823"/>
            <a:ext cx="3103627" cy="0"/>
          </a:xfrm>
          <a:custGeom>
            <a:avLst/>
            <a:gdLst/>
            <a:ahLst/>
            <a:cxnLst/>
            <a:rect l="0" t="0" r="0" b="0"/>
            <a:pathLst>
              <a:path w="3103627">
                <a:moveTo>
                  <a:pt x="0" y="0"/>
                </a:moveTo>
                <a:lnTo>
                  <a:pt x="3103627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47" name="Freeform 347"/>
          <p:cNvSpPr/>
          <p:nvPr/>
        </p:nvSpPr>
        <p:spPr>
          <a:xfrm>
            <a:off x="1235747" y="573182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48" name="Freeform 348"/>
          <p:cNvSpPr/>
          <p:nvPr/>
        </p:nvSpPr>
        <p:spPr>
          <a:xfrm>
            <a:off x="1919769" y="573182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49" name="Freeform 349"/>
          <p:cNvSpPr/>
          <p:nvPr/>
        </p:nvSpPr>
        <p:spPr>
          <a:xfrm>
            <a:off x="2603791" y="573182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50" name="Freeform 350"/>
          <p:cNvSpPr/>
          <p:nvPr/>
        </p:nvSpPr>
        <p:spPr>
          <a:xfrm>
            <a:off x="3287813" y="573182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51" name="Freeform 351"/>
          <p:cNvSpPr/>
          <p:nvPr/>
        </p:nvSpPr>
        <p:spPr>
          <a:xfrm>
            <a:off x="3971835" y="573182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52" name="Freeform 352"/>
          <p:cNvSpPr/>
          <p:nvPr/>
        </p:nvSpPr>
        <p:spPr>
          <a:xfrm>
            <a:off x="1205394" y="3524055"/>
            <a:ext cx="0" cy="2207768"/>
          </a:xfrm>
          <a:custGeom>
            <a:avLst/>
            <a:gdLst/>
            <a:ahLst/>
            <a:cxnLst/>
            <a:rect l="0" t="0" r="0" b="0"/>
            <a:pathLst>
              <a:path h="2207768">
                <a:moveTo>
                  <a:pt x="0" y="2207768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53" name="Freeform 353"/>
          <p:cNvSpPr/>
          <p:nvPr/>
        </p:nvSpPr>
        <p:spPr>
          <a:xfrm>
            <a:off x="1159039" y="5701343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54" name="Freeform 354"/>
          <p:cNvSpPr/>
          <p:nvPr/>
        </p:nvSpPr>
        <p:spPr>
          <a:xfrm>
            <a:off x="1159039" y="5164642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55" name="Freeform 355"/>
          <p:cNvSpPr/>
          <p:nvPr/>
        </p:nvSpPr>
        <p:spPr>
          <a:xfrm>
            <a:off x="1159039" y="4627940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56" name="Freeform 356"/>
          <p:cNvSpPr/>
          <p:nvPr/>
        </p:nvSpPr>
        <p:spPr>
          <a:xfrm>
            <a:off x="1159039" y="4091238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57" name="Freeform 357"/>
          <p:cNvSpPr/>
          <p:nvPr/>
        </p:nvSpPr>
        <p:spPr>
          <a:xfrm>
            <a:off x="1159039" y="3554536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58" name="Freeform 358"/>
          <p:cNvSpPr/>
          <p:nvPr/>
        </p:nvSpPr>
        <p:spPr>
          <a:xfrm>
            <a:off x="4552860" y="3444807"/>
            <a:ext cx="3651377" cy="2737231"/>
          </a:xfrm>
          <a:custGeom>
            <a:avLst/>
            <a:gdLst/>
            <a:ahLst/>
            <a:cxnLst/>
            <a:rect l="0" t="0" r="0" b="0"/>
            <a:pathLst>
              <a:path w="3651377" h="2737231">
                <a:moveTo>
                  <a:pt x="1825625" y="0"/>
                </a:moveTo>
                <a:lnTo>
                  <a:pt x="3651377" y="0"/>
                </a:lnTo>
                <a:lnTo>
                  <a:pt x="3651377" y="2737231"/>
                </a:lnTo>
                <a:lnTo>
                  <a:pt x="0" y="2737231"/>
                </a:lnTo>
                <a:lnTo>
                  <a:pt x="0" y="0"/>
                </a:lnTo>
                <a:lnTo>
                  <a:pt x="1825625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59" name="Freeform 359"/>
          <p:cNvSpPr/>
          <p:nvPr/>
        </p:nvSpPr>
        <p:spPr>
          <a:xfrm>
            <a:off x="4552860" y="3444807"/>
            <a:ext cx="3651377" cy="2737231"/>
          </a:xfrm>
          <a:custGeom>
            <a:avLst/>
            <a:gdLst/>
            <a:ahLst/>
            <a:cxnLst/>
            <a:rect l="0" t="0" r="0" b="0"/>
            <a:pathLst>
              <a:path w="3651377" h="2737231">
                <a:moveTo>
                  <a:pt x="1825625" y="0"/>
                </a:moveTo>
                <a:lnTo>
                  <a:pt x="3651377" y="0"/>
                </a:lnTo>
                <a:lnTo>
                  <a:pt x="3651377" y="2737231"/>
                </a:lnTo>
                <a:lnTo>
                  <a:pt x="0" y="2737231"/>
                </a:lnTo>
                <a:lnTo>
                  <a:pt x="0" y="0"/>
                </a:lnTo>
                <a:lnTo>
                  <a:pt x="1825625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60" name="Freeform 360"/>
          <p:cNvSpPr/>
          <p:nvPr/>
        </p:nvSpPr>
        <p:spPr>
          <a:xfrm>
            <a:off x="4552860" y="3444807"/>
            <a:ext cx="3596513" cy="48895"/>
          </a:xfrm>
          <a:custGeom>
            <a:avLst/>
            <a:gdLst/>
            <a:ahLst/>
            <a:cxnLst/>
            <a:rect l="0" t="0" r="0" b="0"/>
            <a:pathLst>
              <a:path w="3596513" h="48895">
                <a:moveTo>
                  <a:pt x="1798192" y="0"/>
                </a:moveTo>
                <a:lnTo>
                  <a:pt x="3596513" y="0"/>
                </a:lnTo>
                <a:lnTo>
                  <a:pt x="3596513" y="48895"/>
                </a:lnTo>
                <a:lnTo>
                  <a:pt x="0" y="48895"/>
                </a:lnTo>
                <a:lnTo>
                  <a:pt x="0" y="0"/>
                </a:lnTo>
                <a:lnTo>
                  <a:pt x="1798192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61" name="Freeform 361"/>
          <p:cNvSpPr/>
          <p:nvPr/>
        </p:nvSpPr>
        <p:spPr>
          <a:xfrm>
            <a:off x="4552860" y="3499799"/>
            <a:ext cx="48640" cy="2682239"/>
          </a:xfrm>
          <a:custGeom>
            <a:avLst/>
            <a:gdLst/>
            <a:ahLst/>
            <a:cxnLst/>
            <a:rect l="0" t="0" r="0" b="0"/>
            <a:pathLst>
              <a:path w="48640" h="2682239">
                <a:moveTo>
                  <a:pt x="24256" y="0"/>
                </a:moveTo>
                <a:lnTo>
                  <a:pt x="48640" y="0"/>
                </a:lnTo>
                <a:lnTo>
                  <a:pt x="48640" y="2682239"/>
                </a:lnTo>
                <a:lnTo>
                  <a:pt x="0" y="2682239"/>
                </a:lnTo>
                <a:lnTo>
                  <a:pt x="0" y="0"/>
                </a:lnTo>
                <a:lnTo>
                  <a:pt x="24256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62" name="Freeform 362"/>
          <p:cNvSpPr/>
          <p:nvPr/>
        </p:nvSpPr>
        <p:spPr>
          <a:xfrm>
            <a:off x="4607724" y="6133271"/>
            <a:ext cx="3596513" cy="48767"/>
          </a:xfrm>
          <a:custGeom>
            <a:avLst/>
            <a:gdLst/>
            <a:ahLst/>
            <a:cxnLst/>
            <a:rect l="0" t="0" r="0" b="0"/>
            <a:pathLst>
              <a:path w="3596513" h="48767">
                <a:moveTo>
                  <a:pt x="1798193" y="0"/>
                </a:moveTo>
                <a:lnTo>
                  <a:pt x="3596513" y="0"/>
                </a:lnTo>
                <a:lnTo>
                  <a:pt x="3596513" y="48767"/>
                </a:lnTo>
                <a:lnTo>
                  <a:pt x="0" y="48767"/>
                </a:lnTo>
                <a:lnTo>
                  <a:pt x="0" y="0"/>
                </a:lnTo>
                <a:lnTo>
                  <a:pt x="1798193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63" name="Freeform 363"/>
          <p:cNvSpPr/>
          <p:nvPr/>
        </p:nvSpPr>
        <p:spPr>
          <a:xfrm>
            <a:off x="8155596" y="3444807"/>
            <a:ext cx="48642" cy="2682241"/>
          </a:xfrm>
          <a:custGeom>
            <a:avLst/>
            <a:gdLst/>
            <a:ahLst/>
            <a:cxnLst/>
            <a:rect l="0" t="0" r="0" b="0"/>
            <a:pathLst>
              <a:path w="48642" h="2682241">
                <a:moveTo>
                  <a:pt x="24257" y="0"/>
                </a:moveTo>
                <a:lnTo>
                  <a:pt x="48642" y="0"/>
                </a:lnTo>
                <a:lnTo>
                  <a:pt x="48642" y="2682241"/>
                </a:lnTo>
                <a:lnTo>
                  <a:pt x="0" y="2682241"/>
                </a:lnTo>
                <a:lnTo>
                  <a:pt x="0" y="0"/>
                </a:lnTo>
                <a:lnTo>
                  <a:pt x="24257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64" name="Freeform 364"/>
          <p:cNvSpPr/>
          <p:nvPr/>
        </p:nvSpPr>
        <p:spPr>
          <a:xfrm>
            <a:off x="5045874" y="3502719"/>
            <a:ext cx="3103627" cy="2226056"/>
          </a:xfrm>
          <a:custGeom>
            <a:avLst/>
            <a:gdLst/>
            <a:ahLst/>
            <a:cxnLst/>
            <a:rect l="0" t="0" r="0" b="0"/>
            <a:pathLst>
              <a:path w="3103627" h="2226056">
                <a:moveTo>
                  <a:pt x="1551813" y="0"/>
                </a:moveTo>
                <a:lnTo>
                  <a:pt x="3103627" y="0"/>
                </a:lnTo>
                <a:lnTo>
                  <a:pt x="3103627" y="2226056"/>
                </a:lnTo>
                <a:lnTo>
                  <a:pt x="0" y="2226056"/>
                </a:lnTo>
                <a:lnTo>
                  <a:pt x="0" y="0"/>
                </a:lnTo>
                <a:lnTo>
                  <a:pt x="1551813" y="0"/>
                </a:lnTo>
              </a:path>
            </a:pathLst>
          </a:custGeom>
          <a:solidFill>
            <a:srgbClr val="FFFFFF">
              <a:alpha val="100000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65" name="Freeform 365"/>
          <p:cNvSpPr/>
          <p:nvPr/>
        </p:nvSpPr>
        <p:spPr>
          <a:xfrm>
            <a:off x="5434494" y="5681531"/>
            <a:ext cx="214758" cy="19812"/>
          </a:xfrm>
          <a:custGeom>
            <a:avLst/>
            <a:gdLst/>
            <a:ahLst/>
            <a:cxnLst/>
            <a:rect l="0" t="0" r="0" b="0"/>
            <a:pathLst>
              <a:path w="214758" h="19812">
                <a:moveTo>
                  <a:pt x="107442" y="0"/>
                </a:moveTo>
                <a:lnTo>
                  <a:pt x="214758" y="0"/>
                </a:lnTo>
                <a:lnTo>
                  <a:pt x="214758" y="19812"/>
                </a:lnTo>
                <a:lnTo>
                  <a:pt x="0" y="19812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66" name="Freeform 366"/>
          <p:cNvSpPr/>
          <p:nvPr/>
        </p:nvSpPr>
        <p:spPr>
          <a:xfrm>
            <a:off x="5434494" y="5681531"/>
            <a:ext cx="214758" cy="19812"/>
          </a:xfrm>
          <a:custGeom>
            <a:avLst/>
            <a:gdLst/>
            <a:ahLst/>
            <a:cxnLst/>
            <a:rect l="0" t="0" r="0" b="0"/>
            <a:pathLst>
              <a:path w="214758" h="19812">
                <a:moveTo>
                  <a:pt x="107442" y="0"/>
                </a:moveTo>
                <a:lnTo>
                  <a:pt x="214758" y="0"/>
                </a:lnTo>
                <a:lnTo>
                  <a:pt x="214758" y="19812"/>
                </a:lnTo>
                <a:lnTo>
                  <a:pt x="0" y="19812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67" name="Freeform 367"/>
          <p:cNvSpPr/>
          <p:nvPr/>
        </p:nvSpPr>
        <p:spPr>
          <a:xfrm>
            <a:off x="5649251" y="5641654"/>
            <a:ext cx="214756" cy="59689"/>
          </a:xfrm>
          <a:custGeom>
            <a:avLst/>
            <a:gdLst/>
            <a:ahLst/>
            <a:cxnLst/>
            <a:rect l="0" t="0" r="0" b="0"/>
            <a:pathLst>
              <a:path w="214756" h="59689">
                <a:moveTo>
                  <a:pt x="107442" y="0"/>
                </a:moveTo>
                <a:lnTo>
                  <a:pt x="214756" y="0"/>
                </a:lnTo>
                <a:lnTo>
                  <a:pt x="214756" y="59689"/>
                </a:lnTo>
                <a:lnTo>
                  <a:pt x="0" y="59689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68" name="Freeform 368"/>
          <p:cNvSpPr/>
          <p:nvPr/>
        </p:nvSpPr>
        <p:spPr>
          <a:xfrm>
            <a:off x="5649251" y="5641654"/>
            <a:ext cx="214756" cy="59689"/>
          </a:xfrm>
          <a:custGeom>
            <a:avLst/>
            <a:gdLst/>
            <a:ahLst/>
            <a:cxnLst/>
            <a:rect l="0" t="0" r="0" b="0"/>
            <a:pathLst>
              <a:path w="214756" h="59689">
                <a:moveTo>
                  <a:pt x="107442" y="0"/>
                </a:moveTo>
                <a:lnTo>
                  <a:pt x="214756" y="0"/>
                </a:lnTo>
                <a:lnTo>
                  <a:pt x="214756" y="59689"/>
                </a:lnTo>
                <a:lnTo>
                  <a:pt x="0" y="59689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69" name="Freeform 369"/>
          <p:cNvSpPr/>
          <p:nvPr/>
        </p:nvSpPr>
        <p:spPr>
          <a:xfrm>
            <a:off x="5864008" y="5422452"/>
            <a:ext cx="214758" cy="278891"/>
          </a:xfrm>
          <a:custGeom>
            <a:avLst/>
            <a:gdLst/>
            <a:ahLst/>
            <a:cxnLst/>
            <a:rect l="0" t="0" r="0" b="0"/>
            <a:pathLst>
              <a:path w="214758" h="278891">
                <a:moveTo>
                  <a:pt x="107442" y="0"/>
                </a:moveTo>
                <a:lnTo>
                  <a:pt x="214758" y="0"/>
                </a:lnTo>
                <a:lnTo>
                  <a:pt x="214758" y="278891"/>
                </a:lnTo>
                <a:lnTo>
                  <a:pt x="0" y="278891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0" name="Freeform 370"/>
          <p:cNvSpPr/>
          <p:nvPr/>
        </p:nvSpPr>
        <p:spPr>
          <a:xfrm>
            <a:off x="5864008" y="5422452"/>
            <a:ext cx="214758" cy="278891"/>
          </a:xfrm>
          <a:custGeom>
            <a:avLst/>
            <a:gdLst/>
            <a:ahLst/>
            <a:cxnLst/>
            <a:rect l="0" t="0" r="0" b="0"/>
            <a:pathLst>
              <a:path w="214758" h="278891">
                <a:moveTo>
                  <a:pt x="107442" y="0"/>
                </a:moveTo>
                <a:lnTo>
                  <a:pt x="214758" y="0"/>
                </a:lnTo>
                <a:lnTo>
                  <a:pt x="214758" y="278891"/>
                </a:lnTo>
                <a:lnTo>
                  <a:pt x="0" y="278891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1" name="Freeform 371"/>
          <p:cNvSpPr/>
          <p:nvPr/>
        </p:nvSpPr>
        <p:spPr>
          <a:xfrm>
            <a:off x="6078765" y="4765227"/>
            <a:ext cx="214756" cy="936116"/>
          </a:xfrm>
          <a:custGeom>
            <a:avLst/>
            <a:gdLst/>
            <a:ahLst/>
            <a:cxnLst/>
            <a:rect l="0" t="0" r="0" b="0"/>
            <a:pathLst>
              <a:path w="214756" h="936116">
                <a:moveTo>
                  <a:pt x="107442" y="0"/>
                </a:moveTo>
                <a:lnTo>
                  <a:pt x="214756" y="0"/>
                </a:lnTo>
                <a:lnTo>
                  <a:pt x="214756" y="936116"/>
                </a:lnTo>
                <a:lnTo>
                  <a:pt x="0" y="936116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2" name="Freeform 372"/>
          <p:cNvSpPr/>
          <p:nvPr/>
        </p:nvSpPr>
        <p:spPr>
          <a:xfrm>
            <a:off x="6078765" y="4765227"/>
            <a:ext cx="214756" cy="936116"/>
          </a:xfrm>
          <a:custGeom>
            <a:avLst/>
            <a:gdLst/>
            <a:ahLst/>
            <a:cxnLst/>
            <a:rect l="0" t="0" r="0" b="0"/>
            <a:pathLst>
              <a:path w="214756" h="936116">
                <a:moveTo>
                  <a:pt x="107442" y="0"/>
                </a:moveTo>
                <a:lnTo>
                  <a:pt x="214756" y="0"/>
                </a:lnTo>
                <a:lnTo>
                  <a:pt x="214756" y="936116"/>
                </a:lnTo>
                <a:lnTo>
                  <a:pt x="0" y="936116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3" name="Freeform 373"/>
          <p:cNvSpPr/>
          <p:nvPr/>
        </p:nvSpPr>
        <p:spPr>
          <a:xfrm>
            <a:off x="6293522" y="3530151"/>
            <a:ext cx="214758" cy="2171192"/>
          </a:xfrm>
          <a:custGeom>
            <a:avLst/>
            <a:gdLst/>
            <a:ahLst/>
            <a:cxnLst/>
            <a:rect l="0" t="0" r="0" b="0"/>
            <a:pathLst>
              <a:path w="214758" h="2171192">
                <a:moveTo>
                  <a:pt x="107443" y="0"/>
                </a:moveTo>
                <a:lnTo>
                  <a:pt x="214758" y="0"/>
                </a:lnTo>
                <a:lnTo>
                  <a:pt x="214758" y="2171192"/>
                </a:lnTo>
                <a:lnTo>
                  <a:pt x="0" y="2171192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4" name="Freeform 374"/>
          <p:cNvSpPr/>
          <p:nvPr/>
        </p:nvSpPr>
        <p:spPr>
          <a:xfrm>
            <a:off x="6293522" y="3530151"/>
            <a:ext cx="214758" cy="2171192"/>
          </a:xfrm>
          <a:custGeom>
            <a:avLst/>
            <a:gdLst/>
            <a:ahLst/>
            <a:cxnLst/>
            <a:rect l="0" t="0" r="0" b="0"/>
            <a:pathLst>
              <a:path w="214758" h="2171192">
                <a:moveTo>
                  <a:pt x="107443" y="0"/>
                </a:moveTo>
                <a:lnTo>
                  <a:pt x="214758" y="0"/>
                </a:lnTo>
                <a:lnTo>
                  <a:pt x="214758" y="2171192"/>
                </a:lnTo>
                <a:lnTo>
                  <a:pt x="0" y="2171192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5" name="Freeform 375"/>
          <p:cNvSpPr/>
          <p:nvPr/>
        </p:nvSpPr>
        <p:spPr>
          <a:xfrm>
            <a:off x="6508279" y="3928551"/>
            <a:ext cx="214757" cy="1772792"/>
          </a:xfrm>
          <a:custGeom>
            <a:avLst/>
            <a:gdLst/>
            <a:ahLst/>
            <a:cxnLst/>
            <a:rect l="0" t="0" r="0" b="0"/>
            <a:pathLst>
              <a:path w="214757" h="1772792">
                <a:moveTo>
                  <a:pt x="107441" y="0"/>
                </a:moveTo>
                <a:lnTo>
                  <a:pt x="214757" y="0"/>
                </a:lnTo>
                <a:lnTo>
                  <a:pt x="214757" y="1772792"/>
                </a:lnTo>
                <a:lnTo>
                  <a:pt x="0" y="1772792"/>
                </a:lnTo>
                <a:lnTo>
                  <a:pt x="0" y="0"/>
                </a:lnTo>
                <a:lnTo>
                  <a:pt x="107441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6" name="Freeform 376"/>
          <p:cNvSpPr/>
          <p:nvPr/>
        </p:nvSpPr>
        <p:spPr>
          <a:xfrm>
            <a:off x="6508279" y="3928551"/>
            <a:ext cx="214757" cy="1772792"/>
          </a:xfrm>
          <a:custGeom>
            <a:avLst/>
            <a:gdLst/>
            <a:ahLst/>
            <a:cxnLst/>
            <a:rect l="0" t="0" r="0" b="0"/>
            <a:pathLst>
              <a:path w="214757" h="1772792">
                <a:moveTo>
                  <a:pt x="107441" y="0"/>
                </a:moveTo>
                <a:lnTo>
                  <a:pt x="214757" y="0"/>
                </a:lnTo>
                <a:lnTo>
                  <a:pt x="214757" y="1772792"/>
                </a:lnTo>
                <a:lnTo>
                  <a:pt x="0" y="1772792"/>
                </a:lnTo>
                <a:lnTo>
                  <a:pt x="0" y="0"/>
                </a:lnTo>
                <a:lnTo>
                  <a:pt x="107441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7" name="Freeform 377"/>
          <p:cNvSpPr/>
          <p:nvPr/>
        </p:nvSpPr>
        <p:spPr>
          <a:xfrm>
            <a:off x="6723036" y="5024179"/>
            <a:ext cx="214756" cy="677164"/>
          </a:xfrm>
          <a:custGeom>
            <a:avLst/>
            <a:gdLst/>
            <a:ahLst/>
            <a:cxnLst/>
            <a:rect l="0" t="0" r="0" b="0"/>
            <a:pathLst>
              <a:path w="214756" h="677164">
                <a:moveTo>
                  <a:pt x="107441" y="0"/>
                </a:moveTo>
                <a:lnTo>
                  <a:pt x="214756" y="0"/>
                </a:lnTo>
                <a:lnTo>
                  <a:pt x="214756" y="677164"/>
                </a:lnTo>
                <a:lnTo>
                  <a:pt x="0" y="677164"/>
                </a:lnTo>
                <a:lnTo>
                  <a:pt x="0" y="0"/>
                </a:lnTo>
                <a:lnTo>
                  <a:pt x="107441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8" name="Freeform 378"/>
          <p:cNvSpPr/>
          <p:nvPr/>
        </p:nvSpPr>
        <p:spPr>
          <a:xfrm>
            <a:off x="6723036" y="5024179"/>
            <a:ext cx="214756" cy="677164"/>
          </a:xfrm>
          <a:custGeom>
            <a:avLst/>
            <a:gdLst/>
            <a:ahLst/>
            <a:cxnLst/>
            <a:rect l="0" t="0" r="0" b="0"/>
            <a:pathLst>
              <a:path w="214756" h="677164">
                <a:moveTo>
                  <a:pt x="107441" y="0"/>
                </a:moveTo>
                <a:lnTo>
                  <a:pt x="214756" y="0"/>
                </a:lnTo>
                <a:lnTo>
                  <a:pt x="214756" y="677164"/>
                </a:lnTo>
                <a:lnTo>
                  <a:pt x="0" y="677164"/>
                </a:lnTo>
                <a:lnTo>
                  <a:pt x="0" y="0"/>
                </a:lnTo>
                <a:lnTo>
                  <a:pt x="107441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9" name="Freeform 379"/>
          <p:cNvSpPr/>
          <p:nvPr/>
        </p:nvSpPr>
        <p:spPr>
          <a:xfrm>
            <a:off x="6937793" y="5143686"/>
            <a:ext cx="214757" cy="557657"/>
          </a:xfrm>
          <a:custGeom>
            <a:avLst/>
            <a:gdLst/>
            <a:ahLst/>
            <a:cxnLst/>
            <a:rect l="0" t="0" r="0" b="0"/>
            <a:pathLst>
              <a:path w="214757" h="557657">
                <a:moveTo>
                  <a:pt x="107443" y="0"/>
                </a:moveTo>
                <a:lnTo>
                  <a:pt x="214757" y="0"/>
                </a:lnTo>
                <a:lnTo>
                  <a:pt x="214757" y="557657"/>
                </a:lnTo>
                <a:lnTo>
                  <a:pt x="0" y="557657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80" name="Freeform 380"/>
          <p:cNvSpPr/>
          <p:nvPr/>
        </p:nvSpPr>
        <p:spPr>
          <a:xfrm>
            <a:off x="6937793" y="5143686"/>
            <a:ext cx="214757" cy="557657"/>
          </a:xfrm>
          <a:custGeom>
            <a:avLst/>
            <a:gdLst/>
            <a:ahLst/>
            <a:cxnLst/>
            <a:rect l="0" t="0" r="0" b="0"/>
            <a:pathLst>
              <a:path w="214757" h="557657">
                <a:moveTo>
                  <a:pt x="107443" y="0"/>
                </a:moveTo>
                <a:lnTo>
                  <a:pt x="214757" y="0"/>
                </a:lnTo>
                <a:lnTo>
                  <a:pt x="214757" y="557657"/>
                </a:lnTo>
                <a:lnTo>
                  <a:pt x="0" y="557657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81" name="Freeform 381"/>
          <p:cNvSpPr/>
          <p:nvPr/>
        </p:nvSpPr>
        <p:spPr>
          <a:xfrm>
            <a:off x="7152550" y="5402640"/>
            <a:ext cx="214758" cy="298703"/>
          </a:xfrm>
          <a:custGeom>
            <a:avLst/>
            <a:gdLst/>
            <a:ahLst/>
            <a:cxnLst/>
            <a:rect l="0" t="0" r="0" b="0"/>
            <a:pathLst>
              <a:path w="214758" h="298703">
                <a:moveTo>
                  <a:pt x="107443" y="0"/>
                </a:moveTo>
                <a:lnTo>
                  <a:pt x="214758" y="0"/>
                </a:lnTo>
                <a:lnTo>
                  <a:pt x="214758" y="298703"/>
                </a:lnTo>
                <a:lnTo>
                  <a:pt x="0" y="298703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82" name="Freeform 382"/>
          <p:cNvSpPr/>
          <p:nvPr/>
        </p:nvSpPr>
        <p:spPr>
          <a:xfrm>
            <a:off x="7152550" y="5402640"/>
            <a:ext cx="214758" cy="298703"/>
          </a:xfrm>
          <a:custGeom>
            <a:avLst/>
            <a:gdLst/>
            <a:ahLst/>
            <a:cxnLst/>
            <a:rect l="0" t="0" r="0" b="0"/>
            <a:pathLst>
              <a:path w="214758" h="298703">
                <a:moveTo>
                  <a:pt x="107443" y="0"/>
                </a:moveTo>
                <a:lnTo>
                  <a:pt x="214758" y="0"/>
                </a:lnTo>
                <a:lnTo>
                  <a:pt x="214758" y="298703"/>
                </a:lnTo>
                <a:lnTo>
                  <a:pt x="0" y="298703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83" name="Freeform 383"/>
          <p:cNvSpPr/>
          <p:nvPr/>
        </p:nvSpPr>
        <p:spPr>
          <a:xfrm>
            <a:off x="7367307" y="5561898"/>
            <a:ext cx="214757" cy="139445"/>
          </a:xfrm>
          <a:custGeom>
            <a:avLst/>
            <a:gdLst/>
            <a:ahLst/>
            <a:cxnLst/>
            <a:rect l="0" t="0" r="0" b="0"/>
            <a:pathLst>
              <a:path w="214757" h="139445">
                <a:moveTo>
                  <a:pt x="107442" y="0"/>
                </a:moveTo>
                <a:lnTo>
                  <a:pt x="214757" y="0"/>
                </a:lnTo>
                <a:lnTo>
                  <a:pt x="214757" y="139445"/>
                </a:lnTo>
                <a:lnTo>
                  <a:pt x="0" y="139445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84" name="Freeform 384"/>
          <p:cNvSpPr/>
          <p:nvPr/>
        </p:nvSpPr>
        <p:spPr>
          <a:xfrm>
            <a:off x="7367307" y="5561898"/>
            <a:ext cx="214757" cy="139445"/>
          </a:xfrm>
          <a:custGeom>
            <a:avLst/>
            <a:gdLst/>
            <a:ahLst/>
            <a:cxnLst/>
            <a:rect l="0" t="0" r="0" b="0"/>
            <a:pathLst>
              <a:path w="214757" h="139445">
                <a:moveTo>
                  <a:pt x="107442" y="0"/>
                </a:moveTo>
                <a:lnTo>
                  <a:pt x="214757" y="0"/>
                </a:lnTo>
                <a:lnTo>
                  <a:pt x="214757" y="139445"/>
                </a:lnTo>
                <a:lnTo>
                  <a:pt x="0" y="139445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noFill/>
          <a:ln w="6095" cap="flat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85" name="Freeform 385"/>
          <p:cNvSpPr/>
          <p:nvPr/>
        </p:nvSpPr>
        <p:spPr>
          <a:xfrm>
            <a:off x="5434494" y="5701343"/>
            <a:ext cx="214758" cy="0"/>
          </a:xfrm>
          <a:custGeom>
            <a:avLst/>
            <a:gdLst/>
            <a:ahLst/>
            <a:cxnLst/>
            <a:rect l="0" t="0" r="0" b="0"/>
            <a:pathLst>
              <a:path w="214758">
                <a:moveTo>
                  <a:pt x="0" y="0"/>
                </a:moveTo>
                <a:lnTo>
                  <a:pt x="214758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86" name="Freeform 386"/>
          <p:cNvSpPr/>
          <p:nvPr/>
        </p:nvSpPr>
        <p:spPr>
          <a:xfrm>
            <a:off x="5649251" y="5701343"/>
            <a:ext cx="214756" cy="0"/>
          </a:xfrm>
          <a:custGeom>
            <a:avLst/>
            <a:gdLst/>
            <a:ahLst/>
            <a:cxnLst/>
            <a:rect l="0" t="0" r="0" b="0"/>
            <a:pathLst>
              <a:path w="214756">
                <a:moveTo>
                  <a:pt x="0" y="0"/>
                </a:moveTo>
                <a:lnTo>
                  <a:pt x="214756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87" name="Freeform 387"/>
          <p:cNvSpPr/>
          <p:nvPr/>
        </p:nvSpPr>
        <p:spPr>
          <a:xfrm>
            <a:off x="5864008" y="5572185"/>
            <a:ext cx="214758" cy="129158"/>
          </a:xfrm>
          <a:custGeom>
            <a:avLst/>
            <a:gdLst/>
            <a:ahLst/>
            <a:cxnLst/>
            <a:rect l="0" t="0" r="0" b="0"/>
            <a:pathLst>
              <a:path w="214758" h="129158">
                <a:moveTo>
                  <a:pt x="107442" y="0"/>
                </a:moveTo>
                <a:lnTo>
                  <a:pt x="214758" y="0"/>
                </a:lnTo>
                <a:lnTo>
                  <a:pt x="214758" y="129158"/>
                </a:lnTo>
                <a:lnTo>
                  <a:pt x="0" y="129158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88" name="Freeform 388"/>
          <p:cNvSpPr/>
          <p:nvPr/>
        </p:nvSpPr>
        <p:spPr>
          <a:xfrm>
            <a:off x="5864008" y="5572185"/>
            <a:ext cx="214758" cy="129158"/>
          </a:xfrm>
          <a:custGeom>
            <a:avLst/>
            <a:gdLst/>
            <a:ahLst/>
            <a:cxnLst/>
            <a:rect l="0" t="0" r="0" b="0"/>
            <a:pathLst>
              <a:path w="214758" h="129158">
                <a:moveTo>
                  <a:pt x="107442" y="0"/>
                </a:moveTo>
                <a:lnTo>
                  <a:pt x="214758" y="0"/>
                </a:lnTo>
                <a:lnTo>
                  <a:pt x="214758" y="129158"/>
                </a:lnTo>
                <a:lnTo>
                  <a:pt x="0" y="129158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89" name="Freeform 389"/>
          <p:cNvSpPr/>
          <p:nvPr/>
        </p:nvSpPr>
        <p:spPr>
          <a:xfrm>
            <a:off x="6078765" y="5443025"/>
            <a:ext cx="214756" cy="258318"/>
          </a:xfrm>
          <a:custGeom>
            <a:avLst/>
            <a:gdLst/>
            <a:ahLst/>
            <a:cxnLst/>
            <a:rect l="0" t="0" r="0" b="0"/>
            <a:pathLst>
              <a:path w="214756" h="258318">
                <a:moveTo>
                  <a:pt x="107442" y="0"/>
                </a:moveTo>
                <a:lnTo>
                  <a:pt x="214756" y="0"/>
                </a:lnTo>
                <a:lnTo>
                  <a:pt x="214756" y="258318"/>
                </a:lnTo>
                <a:lnTo>
                  <a:pt x="0" y="258318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90" name="Freeform 390"/>
          <p:cNvSpPr/>
          <p:nvPr/>
        </p:nvSpPr>
        <p:spPr>
          <a:xfrm>
            <a:off x="6078765" y="5443025"/>
            <a:ext cx="214756" cy="258318"/>
          </a:xfrm>
          <a:custGeom>
            <a:avLst/>
            <a:gdLst/>
            <a:ahLst/>
            <a:cxnLst/>
            <a:rect l="0" t="0" r="0" b="0"/>
            <a:pathLst>
              <a:path w="214756" h="258318">
                <a:moveTo>
                  <a:pt x="107442" y="0"/>
                </a:moveTo>
                <a:lnTo>
                  <a:pt x="214756" y="0"/>
                </a:lnTo>
                <a:lnTo>
                  <a:pt x="214756" y="258318"/>
                </a:lnTo>
                <a:lnTo>
                  <a:pt x="0" y="258318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91" name="Freeform 391"/>
          <p:cNvSpPr/>
          <p:nvPr/>
        </p:nvSpPr>
        <p:spPr>
          <a:xfrm>
            <a:off x="6293522" y="4086412"/>
            <a:ext cx="214758" cy="1614931"/>
          </a:xfrm>
          <a:custGeom>
            <a:avLst/>
            <a:gdLst/>
            <a:ahLst/>
            <a:cxnLst/>
            <a:rect l="0" t="0" r="0" b="0"/>
            <a:pathLst>
              <a:path w="214758" h="1614931">
                <a:moveTo>
                  <a:pt x="107443" y="0"/>
                </a:moveTo>
                <a:lnTo>
                  <a:pt x="214758" y="0"/>
                </a:lnTo>
                <a:lnTo>
                  <a:pt x="214758" y="1614931"/>
                </a:lnTo>
                <a:lnTo>
                  <a:pt x="0" y="1614931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92" name="Freeform 392"/>
          <p:cNvSpPr/>
          <p:nvPr/>
        </p:nvSpPr>
        <p:spPr>
          <a:xfrm>
            <a:off x="6293522" y="4086412"/>
            <a:ext cx="214758" cy="1614931"/>
          </a:xfrm>
          <a:custGeom>
            <a:avLst/>
            <a:gdLst/>
            <a:ahLst/>
            <a:cxnLst/>
            <a:rect l="0" t="0" r="0" b="0"/>
            <a:pathLst>
              <a:path w="214758" h="1614931">
                <a:moveTo>
                  <a:pt x="107443" y="0"/>
                </a:moveTo>
                <a:lnTo>
                  <a:pt x="214758" y="0"/>
                </a:lnTo>
                <a:lnTo>
                  <a:pt x="214758" y="1614931"/>
                </a:lnTo>
                <a:lnTo>
                  <a:pt x="0" y="1614931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93" name="Freeform 393"/>
          <p:cNvSpPr/>
          <p:nvPr/>
        </p:nvSpPr>
        <p:spPr>
          <a:xfrm>
            <a:off x="6508279" y="3892610"/>
            <a:ext cx="214757" cy="1808733"/>
          </a:xfrm>
          <a:custGeom>
            <a:avLst/>
            <a:gdLst/>
            <a:ahLst/>
            <a:cxnLst/>
            <a:rect l="0" t="0" r="0" b="0"/>
            <a:pathLst>
              <a:path w="214757" h="1808733">
                <a:moveTo>
                  <a:pt x="107441" y="0"/>
                </a:moveTo>
                <a:lnTo>
                  <a:pt x="214757" y="0"/>
                </a:lnTo>
                <a:lnTo>
                  <a:pt x="214757" y="1808733"/>
                </a:lnTo>
                <a:lnTo>
                  <a:pt x="0" y="1808733"/>
                </a:lnTo>
                <a:lnTo>
                  <a:pt x="0" y="0"/>
                </a:lnTo>
                <a:lnTo>
                  <a:pt x="107441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94" name="Freeform 394"/>
          <p:cNvSpPr/>
          <p:nvPr/>
        </p:nvSpPr>
        <p:spPr>
          <a:xfrm>
            <a:off x="6508279" y="3892610"/>
            <a:ext cx="214757" cy="1808733"/>
          </a:xfrm>
          <a:custGeom>
            <a:avLst/>
            <a:gdLst/>
            <a:ahLst/>
            <a:cxnLst/>
            <a:rect l="0" t="0" r="0" b="0"/>
            <a:pathLst>
              <a:path w="214757" h="1808733">
                <a:moveTo>
                  <a:pt x="107441" y="0"/>
                </a:moveTo>
                <a:lnTo>
                  <a:pt x="214757" y="0"/>
                </a:lnTo>
                <a:lnTo>
                  <a:pt x="214757" y="1808733"/>
                </a:lnTo>
                <a:lnTo>
                  <a:pt x="0" y="1808733"/>
                </a:lnTo>
                <a:lnTo>
                  <a:pt x="0" y="0"/>
                </a:lnTo>
                <a:lnTo>
                  <a:pt x="107441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95" name="Freeform 395"/>
          <p:cNvSpPr/>
          <p:nvPr/>
        </p:nvSpPr>
        <p:spPr>
          <a:xfrm>
            <a:off x="6723036" y="4926136"/>
            <a:ext cx="214756" cy="775207"/>
          </a:xfrm>
          <a:custGeom>
            <a:avLst/>
            <a:gdLst/>
            <a:ahLst/>
            <a:cxnLst/>
            <a:rect l="0" t="0" r="0" b="0"/>
            <a:pathLst>
              <a:path w="214756" h="775207">
                <a:moveTo>
                  <a:pt x="107441" y="0"/>
                </a:moveTo>
                <a:lnTo>
                  <a:pt x="214756" y="0"/>
                </a:lnTo>
                <a:lnTo>
                  <a:pt x="214756" y="775207"/>
                </a:lnTo>
                <a:lnTo>
                  <a:pt x="0" y="775207"/>
                </a:lnTo>
                <a:lnTo>
                  <a:pt x="0" y="0"/>
                </a:lnTo>
                <a:lnTo>
                  <a:pt x="107441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96" name="Freeform 396"/>
          <p:cNvSpPr/>
          <p:nvPr/>
        </p:nvSpPr>
        <p:spPr>
          <a:xfrm>
            <a:off x="6723036" y="4926136"/>
            <a:ext cx="214756" cy="775207"/>
          </a:xfrm>
          <a:custGeom>
            <a:avLst/>
            <a:gdLst/>
            <a:ahLst/>
            <a:cxnLst/>
            <a:rect l="0" t="0" r="0" b="0"/>
            <a:pathLst>
              <a:path w="214756" h="775207">
                <a:moveTo>
                  <a:pt x="107441" y="0"/>
                </a:moveTo>
                <a:lnTo>
                  <a:pt x="214756" y="0"/>
                </a:lnTo>
                <a:lnTo>
                  <a:pt x="214756" y="775207"/>
                </a:lnTo>
                <a:lnTo>
                  <a:pt x="0" y="775207"/>
                </a:lnTo>
                <a:lnTo>
                  <a:pt x="0" y="0"/>
                </a:lnTo>
                <a:lnTo>
                  <a:pt x="107441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97" name="Freeform 397"/>
          <p:cNvSpPr/>
          <p:nvPr/>
        </p:nvSpPr>
        <p:spPr>
          <a:xfrm>
            <a:off x="6937793" y="4796977"/>
            <a:ext cx="214757" cy="904366"/>
          </a:xfrm>
          <a:custGeom>
            <a:avLst/>
            <a:gdLst/>
            <a:ahLst/>
            <a:cxnLst/>
            <a:rect l="0" t="0" r="0" b="0"/>
            <a:pathLst>
              <a:path w="214757" h="904366">
                <a:moveTo>
                  <a:pt x="107443" y="0"/>
                </a:moveTo>
                <a:lnTo>
                  <a:pt x="214757" y="0"/>
                </a:lnTo>
                <a:lnTo>
                  <a:pt x="214757" y="904366"/>
                </a:lnTo>
                <a:lnTo>
                  <a:pt x="0" y="904366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98" name="Freeform 398"/>
          <p:cNvSpPr/>
          <p:nvPr/>
        </p:nvSpPr>
        <p:spPr>
          <a:xfrm>
            <a:off x="6937793" y="4796977"/>
            <a:ext cx="214757" cy="904366"/>
          </a:xfrm>
          <a:custGeom>
            <a:avLst/>
            <a:gdLst/>
            <a:ahLst/>
            <a:cxnLst/>
            <a:rect l="0" t="0" r="0" b="0"/>
            <a:pathLst>
              <a:path w="214757" h="904366">
                <a:moveTo>
                  <a:pt x="107443" y="0"/>
                </a:moveTo>
                <a:lnTo>
                  <a:pt x="214757" y="0"/>
                </a:lnTo>
                <a:lnTo>
                  <a:pt x="214757" y="904366"/>
                </a:lnTo>
                <a:lnTo>
                  <a:pt x="0" y="904366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99" name="Freeform 399"/>
          <p:cNvSpPr/>
          <p:nvPr/>
        </p:nvSpPr>
        <p:spPr>
          <a:xfrm>
            <a:off x="7152550" y="4538659"/>
            <a:ext cx="214758" cy="1162684"/>
          </a:xfrm>
          <a:custGeom>
            <a:avLst/>
            <a:gdLst/>
            <a:ahLst/>
            <a:cxnLst/>
            <a:rect l="0" t="0" r="0" b="0"/>
            <a:pathLst>
              <a:path w="214758" h="1162684">
                <a:moveTo>
                  <a:pt x="107443" y="0"/>
                </a:moveTo>
                <a:lnTo>
                  <a:pt x="214758" y="0"/>
                </a:lnTo>
                <a:lnTo>
                  <a:pt x="214758" y="1162684"/>
                </a:lnTo>
                <a:lnTo>
                  <a:pt x="0" y="1162684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00" name="Freeform 400"/>
          <p:cNvSpPr/>
          <p:nvPr/>
        </p:nvSpPr>
        <p:spPr>
          <a:xfrm>
            <a:off x="7152550" y="4538659"/>
            <a:ext cx="214758" cy="1162684"/>
          </a:xfrm>
          <a:custGeom>
            <a:avLst/>
            <a:gdLst/>
            <a:ahLst/>
            <a:cxnLst/>
            <a:rect l="0" t="0" r="0" b="0"/>
            <a:pathLst>
              <a:path w="214758" h="1162684">
                <a:moveTo>
                  <a:pt x="107443" y="0"/>
                </a:moveTo>
                <a:lnTo>
                  <a:pt x="214758" y="0"/>
                </a:lnTo>
                <a:lnTo>
                  <a:pt x="214758" y="1162684"/>
                </a:lnTo>
                <a:lnTo>
                  <a:pt x="0" y="1162684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01" name="Freeform 401"/>
          <p:cNvSpPr/>
          <p:nvPr/>
        </p:nvSpPr>
        <p:spPr>
          <a:xfrm>
            <a:off x="7367307" y="5443025"/>
            <a:ext cx="214757" cy="258318"/>
          </a:xfrm>
          <a:custGeom>
            <a:avLst/>
            <a:gdLst/>
            <a:ahLst/>
            <a:cxnLst/>
            <a:rect l="0" t="0" r="0" b="0"/>
            <a:pathLst>
              <a:path w="214757" h="258318">
                <a:moveTo>
                  <a:pt x="107442" y="0"/>
                </a:moveTo>
                <a:lnTo>
                  <a:pt x="214757" y="0"/>
                </a:lnTo>
                <a:lnTo>
                  <a:pt x="214757" y="258318"/>
                </a:lnTo>
                <a:lnTo>
                  <a:pt x="0" y="258318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02" name="Freeform 402"/>
          <p:cNvSpPr/>
          <p:nvPr/>
        </p:nvSpPr>
        <p:spPr>
          <a:xfrm>
            <a:off x="7367307" y="5443025"/>
            <a:ext cx="214757" cy="258318"/>
          </a:xfrm>
          <a:custGeom>
            <a:avLst/>
            <a:gdLst/>
            <a:ahLst/>
            <a:cxnLst/>
            <a:rect l="0" t="0" r="0" b="0"/>
            <a:pathLst>
              <a:path w="214757" h="258318">
                <a:moveTo>
                  <a:pt x="107442" y="0"/>
                </a:moveTo>
                <a:lnTo>
                  <a:pt x="214757" y="0"/>
                </a:lnTo>
                <a:lnTo>
                  <a:pt x="214757" y="258318"/>
                </a:lnTo>
                <a:lnTo>
                  <a:pt x="0" y="258318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noFill/>
          <a:ln w="6095" cap="flat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03" name="Freeform 403"/>
          <p:cNvSpPr/>
          <p:nvPr/>
        </p:nvSpPr>
        <p:spPr>
          <a:xfrm>
            <a:off x="5434494" y="5701343"/>
            <a:ext cx="214758" cy="0"/>
          </a:xfrm>
          <a:custGeom>
            <a:avLst/>
            <a:gdLst/>
            <a:ahLst/>
            <a:cxnLst/>
            <a:rect l="0" t="0" r="0" b="0"/>
            <a:pathLst>
              <a:path w="214758">
                <a:moveTo>
                  <a:pt x="0" y="0"/>
                </a:moveTo>
                <a:lnTo>
                  <a:pt x="214758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04" name="Freeform 404"/>
          <p:cNvSpPr/>
          <p:nvPr/>
        </p:nvSpPr>
        <p:spPr>
          <a:xfrm>
            <a:off x="5649251" y="5514527"/>
            <a:ext cx="214756" cy="186816"/>
          </a:xfrm>
          <a:custGeom>
            <a:avLst/>
            <a:gdLst/>
            <a:ahLst/>
            <a:cxnLst/>
            <a:rect l="0" t="0" r="0" b="0"/>
            <a:pathLst>
              <a:path w="214756" h="186816">
                <a:moveTo>
                  <a:pt x="107442" y="0"/>
                </a:moveTo>
                <a:lnTo>
                  <a:pt x="214756" y="0"/>
                </a:lnTo>
                <a:lnTo>
                  <a:pt x="214756" y="186816"/>
                </a:lnTo>
                <a:lnTo>
                  <a:pt x="0" y="186816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05" name="Freeform 405"/>
          <p:cNvSpPr/>
          <p:nvPr/>
        </p:nvSpPr>
        <p:spPr>
          <a:xfrm>
            <a:off x="5649251" y="5514527"/>
            <a:ext cx="214756" cy="186816"/>
          </a:xfrm>
          <a:custGeom>
            <a:avLst/>
            <a:gdLst/>
            <a:ahLst/>
            <a:cxnLst/>
            <a:rect l="0" t="0" r="0" b="0"/>
            <a:pathLst>
              <a:path w="214756" h="186816">
                <a:moveTo>
                  <a:pt x="107442" y="0"/>
                </a:moveTo>
                <a:lnTo>
                  <a:pt x="214756" y="0"/>
                </a:lnTo>
                <a:lnTo>
                  <a:pt x="214756" y="186816"/>
                </a:lnTo>
                <a:lnTo>
                  <a:pt x="0" y="186816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06" name="Freeform 406"/>
          <p:cNvSpPr/>
          <p:nvPr/>
        </p:nvSpPr>
        <p:spPr>
          <a:xfrm>
            <a:off x="5864008" y="5701343"/>
            <a:ext cx="214758" cy="0"/>
          </a:xfrm>
          <a:custGeom>
            <a:avLst/>
            <a:gdLst/>
            <a:ahLst/>
            <a:cxnLst/>
            <a:rect l="0" t="0" r="0" b="0"/>
            <a:pathLst>
              <a:path w="214758">
                <a:moveTo>
                  <a:pt x="0" y="0"/>
                </a:moveTo>
                <a:lnTo>
                  <a:pt x="214758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07" name="Freeform 407"/>
          <p:cNvSpPr/>
          <p:nvPr/>
        </p:nvSpPr>
        <p:spPr>
          <a:xfrm>
            <a:off x="6078765" y="5514527"/>
            <a:ext cx="214756" cy="186816"/>
          </a:xfrm>
          <a:custGeom>
            <a:avLst/>
            <a:gdLst/>
            <a:ahLst/>
            <a:cxnLst/>
            <a:rect l="0" t="0" r="0" b="0"/>
            <a:pathLst>
              <a:path w="214756" h="186816">
                <a:moveTo>
                  <a:pt x="107442" y="0"/>
                </a:moveTo>
                <a:lnTo>
                  <a:pt x="214756" y="0"/>
                </a:lnTo>
                <a:lnTo>
                  <a:pt x="214756" y="186816"/>
                </a:lnTo>
                <a:lnTo>
                  <a:pt x="0" y="186816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08" name="Freeform 408"/>
          <p:cNvSpPr/>
          <p:nvPr/>
        </p:nvSpPr>
        <p:spPr>
          <a:xfrm>
            <a:off x="6078765" y="5514527"/>
            <a:ext cx="214756" cy="186816"/>
          </a:xfrm>
          <a:custGeom>
            <a:avLst/>
            <a:gdLst/>
            <a:ahLst/>
            <a:cxnLst/>
            <a:rect l="0" t="0" r="0" b="0"/>
            <a:pathLst>
              <a:path w="214756" h="186816">
                <a:moveTo>
                  <a:pt x="107442" y="0"/>
                </a:moveTo>
                <a:lnTo>
                  <a:pt x="214756" y="0"/>
                </a:lnTo>
                <a:lnTo>
                  <a:pt x="214756" y="186816"/>
                </a:lnTo>
                <a:lnTo>
                  <a:pt x="0" y="186816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09" name="Freeform 409"/>
          <p:cNvSpPr/>
          <p:nvPr/>
        </p:nvSpPr>
        <p:spPr>
          <a:xfrm>
            <a:off x="6293522" y="4393752"/>
            <a:ext cx="214758" cy="1307591"/>
          </a:xfrm>
          <a:custGeom>
            <a:avLst/>
            <a:gdLst/>
            <a:ahLst/>
            <a:cxnLst/>
            <a:rect l="0" t="0" r="0" b="0"/>
            <a:pathLst>
              <a:path w="214758" h="1307591">
                <a:moveTo>
                  <a:pt x="107443" y="0"/>
                </a:moveTo>
                <a:lnTo>
                  <a:pt x="214758" y="0"/>
                </a:lnTo>
                <a:lnTo>
                  <a:pt x="214758" y="1307591"/>
                </a:lnTo>
                <a:lnTo>
                  <a:pt x="0" y="1307591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10" name="Freeform 410"/>
          <p:cNvSpPr/>
          <p:nvPr/>
        </p:nvSpPr>
        <p:spPr>
          <a:xfrm>
            <a:off x="6293522" y="4393752"/>
            <a:ext cx="214758" cy="1307591"/>
          </a:xfrm>
          <a:custGeom>
            <a:avLst/>
            <a:gdLst/>
            <a:ahLst/>
            <a:cxnLst/>
            <a:rect l="0" t="0" r="0" b="0"/>
            <a:pathLst>
              <a:path w="214758" h="1307591">
                <a:moveTo>
                  <a:pt x="107443" y="0"/>
                </a:moveTo>
                <a:lnTo>
                  <a:pt x="214758" y="0"/>
                </a:lnTo>
                <a:lnTo>
                  <a:pt x="214758" y="1307591"/>
                </a:lnTo>
                <a:lnTo>
                  <a:pt x="0" y="1307591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11" name="Freeform 411"/>
          <p:cNvSpPr/>
          <p:nvPr/>
        </p:nvSpPr>
        <p:spPr>
          <a:xfrm>
            <a:off x="6508279" y="4020117"/>
            <a:ext cx="214757" cy="1681226"/>
          </a:xfrm>
          <a:custGeom>
            <a:avLst/>
            <a:gdLst/>
            <a:ahLst/>
            <a:cxnLst/>
            <a:rect l="0" t="0" r="0" b="0"/>
            <a:pathLst>
              <a:path w="214757" h="1681226">
                <a:moveTo>
                  <a:pt x="107441" y="0"/>
                </a:moveTo>
                <a:lnTo>
                  <a:pt x="214757" y="0"/>
                </a:lnTo>
                <a:lnTo>
                  <a:pt x="214757" y="1681226"/>
                </a:lnTo>
                <a:lnTo>
                  <a:pt x="0" y="1681226"/>
                </a:lnTo>
                <a:lnTo>
                  <a:pt x="0" y="0"/>
                </a:lnTo>
                <a:lnTo>
                  <a:pt x="107441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12" name="Freeform 412"/>
          <p:cNvSpPr/>
          <p:nvPr/>
        </p:nvSpPr>
        <p:spPr>
          <a:xfrm>
            <a:off x="6508279" y="4020117"/>
            <a:ext cx="214757" cy="1681226"/>
          </a:xfrm>
          <a:custGeom>
            <a:avLst/>
            <a:gdLst/>
            <a:ahLst/>
            <a:cxnLst/>
            <a:rect l="0" t="0" r="0" b="0"/>
            <a:pathLst>
              <a:path w="214757" h="1681226">
                <a:moveTo>
                  <a:pt x="107441" y="0"/>
                </a:moveTo>
                <a:lnTo>
                  <a:pt x="214757" y="0"/>
                </a:lnTo>
                <a:lnTo>
                  <a:pt x="214757" y="1681226"/>
                </a:lnTo>
                <a:lnTo>
                  <a:pt x="0" y="1681226"/>
                </a:lnTo>
                <a:lnTo>
                  <a:pt x="0" y="0"/>
                </a:lnTo>
                <a:lnTo>
                  <a:pt x="107441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13" name="Freeform 413"/>
          <p:cNvSpPr/>
          <p:nvPr/>
        </p:nvSpPr>
        <p:spPr>
          <a:xfrm>
            <a:off x="6723036" y="4954075"/>
            <a:ext cx="214756" cy="747268"/>
          </a:xfrm>
          <a:custGeom>
            <a:avLst/>
            <a:gdLst/>
            <a:ahLst/>
            <a:cxnLst/>
            <a:rect l="0" t="0" r="0" b="0"/>
            <a:pathLst>
              <a:path w="214756" h="747268">
                <a:moveTo>
                  <a:pt x="107441" y="0"/>
                </a:moveTo>
                <a:lnTo>
                  <a:pt x="214756" y="0"/>
                </a:lnTo>
                <a:lnTo>
                  <a:pt x="214756" y="747268"/>
                </a:lnTo>
                <a:lnTo>
                  <a:pt x="0" y="747268"/>
                </a:lnTo>
                <a:lnTo>
                  <a:pt x="0" y="0"/>
                </a:lnTo>
                <a:lnTo>
                  <a:pt x="107441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14" name="Freeform 414"/>
          <p:cNvSpPr/>
          <p:nvPr/>
        </p:nvSpPr>
        <p:spPr>
          <a:xfrm>
            <a:off x="6723036" y="4954075"/>
            <a:ext cx="214756" cy="747268"/>
          </a:xfrm>
          <a:custGeom>
            <a:avLst/>
            <a:gdLst/>
            <a:ahLst/>
            <a:cxnLst/>
            <a:rect l="0" t="0" r="0" b="0"/>
            <a:pathLst>
              <a:path w="214756" h="747268">
                <a:moveTo>
                  <a:pt x="107441" y="0"/>
                </a:moveTo>
                <a:lnTo>
                  <a:pt x="214756" y="0"/>
                </a:lnTo>
                <a:lnTo>
                  <a:pt x="214756" y="747268"/>
                </a:lnTo>
                <a:lnTo>
                  <a:pt x="0" y="747268"/>
                </a:lnTo>
                <a:lnTo>
                  <a:pt x="0" y="0"/>
                </a:lnTo>
                <a:lnTo>
                  <a:pt x="107441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15" name="Freeform 415"/>
          <p:cNvSpPr/>
          <p:nvPr/>
        </p:nvSpPr>
        <p:spPr>
          <a:xfrm>
            <a:off x="6937793" y="5140892"/>
            <a:ext cx="214757" cy="560451"/>
          </a:xfrm>
          <a:custGeom>
            <a:avLst/>
            <a:gdLst/>
            <a:ahLst/>
            <a:cxnLst/>
            <a:rect l="0" t="0" r="0" b="0"/>
            <a:pathLst>
              <a:path w="214757" h="560451">
                <a:moveTo>
                  <a:pt x="107443" y="0"/>
                </a:moveTo>
                <a:lnTo>
                  <a:pt x="214757" y="0"/>
                </a:lnTo>
                <a:lnTo>
                  <a:pt x="214757" y="560451"/>
                </a:lnTo>
                <a:lnTo>
                  <a:pt x="0" y="560451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16" name="Freeform 416"/>
          <p:cNvSpPr/>
          <p:nvPr/>
        </p:nvSpPr>
        <p:spPr>
          <a:xfrm>
            <a:off x="6937793" y="5140892"/>
            <a:ext cx="214757" cy="560451"/>
          </a:xfrm>
          <a:custGeom>
            <a:avLst/>
            <a:gdLst/>
            <a:ahLst/>
            <a:cxnLst/>
            <a:rect l="0" t="0" r="0" b="0"/>
            <a:pathLst>
              <a:path w="214757" h="560451">
                <a:moveTo>
                  <a:pt x="107443" y="0"/>
                </a:moveTo>
                <a:lnTo>
                  <a:pt x="214757" y="0"/>
                </a:lnTo>
                <a:lnTo>
                  <a:pt x="214757" y="560451"/>
                </a:lnTo>
                <a:lnTo>
                  <a:pt x="0" y="560451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17" name="Freeform 417"/>
          <p:cNvSpPr/>
          <p:nvPr/>
        </p:nvSpPr>
        <p:spPr>
          <a:xfrm>
            <a:off x="7152550" y="4020117"/>
            <a:ext cx="214758" cy="1681226"/>
          </a:xfrm>
          <a:custGeom>
            <a:avLst/>
            <a:gdLst/>
            <a:ahLst/>
            <a:cxnLst/>
            <a:rect l="0" t="0" r="0" b="0"/>
            <a:pathLst>
              <a:path w="214758" h="1681226">
                <a:moveTo>
                  <a:pt x="107443" y="0"/>
                </a:moveTo>
                <a:lnTo>
                  <a:pt x="214758" y="0"/>
                </a:lnTo>
                <a:lnTo>
                  <a:pt x="214758" y="1681226"/>
                </a:lnTo>
                <a:lnTo>
                  <a:pt x="0" y="1681226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18" name="Freeform 418"/>
          <p:cNvSpPr/>
          <p:nvPr/>
        </p:nvSpPr>
        <p:spPr>
          <a:xfrm>
            <a:off x="7152550" y="4020117"/>
            <a:ext cx="214758" cy="1681226"/>
          </a:xfrm>
          <a:custGeom>
            <a:avLst/>
            <a:gdLst/>
            <a:ahLst/>
            <a:cxnLst/>
            <a:rect l="0" t="0" r="0" b="0"/>
            <a:pathLst>
              <a:path w="214758" h="1681226">
                <a:moveTo>
                  <a:pt x="107443" y="0"/>
                </a:moveTo>
                <a:lnTo>
                  <a:pt x="214758" y="0"/>
                </a:lnTo>
                <a:lnTo>
                  <a:pt x="214758" y="1681226"/>
                </a:lnTo>
                <a:lnTo>
                  <a:pt x="0" y="1681226"/>
                </a:lnTo>
                <a:lnTo>
                  <a:pt x="0" y="0"/>
                </a:lnTo>
                <a:lnTo>
                  <a:pt x="107443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19" name="Freeform 419"/>
          <p:cNvSpPr/>
          <p:nvPr/>
        </p:nvSpPr>
        <p:spPr>
          <a:xfrm>
            <a:off x="7367307" y="5140892"/>
            <a:ext cx="214757" cy="560451"/>
          </a:xfrm>
          <a:custGeom>
            <a:avLst/>
            <a:gdLst/>
            <a:ahLst/>
            <a:cxnLst/>
            <a:rect l="0" t="0" r="0" b="0"/>
            <a:pathLst>
              <a:path w="214757" h="560451">
                <a:moveTo>
                  <a:pt x="107442" y="0"/>
                </a:moveTo>
                <a:lnTo>
                  <a:pt x="214757" y="0"/>
                </a:lnTo>
                <a:lnTo>
                  <a:pt x="214757" y="560451"/>
                </a:lnTo>
                <a:lnTo>
                  <a:pt x="0" y="560451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20" name="Freeform 420"/>
          <p:cNvSpPr/>
          <p:nvPr/>
        </p:nvSpPr>
        <p:spPr>
          <a:xfrm>
            <a:off x="7367307" y="5140892"/>
            <a:ext cx="214757" cy="560451"/>
          </a:xfrm>
          <a:custGeom>
            <a:avLst/>
            <a:gdLst/>
            <a:ahLst/>
            <a:cxnLst/>
            <a:rect l="0" t="0" r="0" b="0"/>
            <a:pathLst>
              <a:path w="214757" h="560451">
                <a:moveTo>
                  <a:pt x="107442" y="0"/>
                </a:moveTo>
                <a:lnTo>
                  <a:pt x="214757" y="0"/>
                </a:lnTo>
                <a:lnTo>
                  <a:pt x="214757" y="560451"/>
                </a:lnTo>
                <a:lnTo>
                  <a:pt x="0" y="560451"/>
                </a:lnTo>
                <a:lnTo>
                  <a:pt x="0" y="0"/>
                </a:lnTo>
                <a:lnTo>
                  <a:pt x="107442" y="0"/>
                </a:lnTo>
              </a:path>
            </a:pathLst>
          </a:custGeom>
          <a:noFill/>
          <a:ln w="6095" cap="flat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21" name="Freeform 421"/>
          <p:cNvSpPr/>
          <p:nvPr/>
        </p:nvSpPr>
        <p:spPr>
          <a:xfrm>
            <a:off x="5229643" y="3568251"/>
            <a:ext cx="2538094" cy="2132458"/>
          </a:xfrm>
          <a:custGeom>
            <a:avLst/>
            <a:gdLst/>
            <a:ahLst/>
            <a:cxnLst/>
            <a:rect l="0" t="0" r="0" b="0"/>
            <a:pathLst>
              <a:path w="2538094" h="2132458">
                <a:moveTo>
                  <a:pt x="0" y="2132458"/>
                </a:moveTo>
                <a:lnTo>
                  <a:pt x="16001" y="2132203"/>
                </a:lnTo>
                <a:lnTo>
                  <a:pt x="32130" y="2131696"/>
                </a:lnTo>
                <a:lnTo>
                  <a:pt x="48133" y="2130934"/>
                </a:lnTo>
                <a:lnTo>
                  <a:pt x="64261" y="2130172"/>
                </a:lnTo>
                <a:lnTo>
                  <a:pt x="80264" y="2129028"/>
                </a:lnTo>
                <a:lnTo>
                  <a:pt x="96393" y="2127631"/>
                </a:lnTo>
                <a:lnTo>
                  <a:pt x="112394" y="2125980"/>
                </a:lnTo>
                <a:lnTo>
                  <a:pt x="128523" y="2124076"/>
                </a:lnTo>
                <a:lnTo>
                  <a:pt x="144525" y="2122043"/>
                </a:lnTo>
                <a:lnTo>
                  <a:pt x="208788" y="2113535"/>
                </a:lnTo>
                <a:lnTo>
                  <a:pt x="224917" y="2111629"/>
                </a:lnTo>
                <a:lnTo>
                  <a:pt x="240919" y="2109724"/>
                </a:lnTo>
                <a:lnTo>
                  <a:pt x="289178" y="2104517"/>
                </a:lnTo>
                <a:lnTo>
                  <a:pt x="305180" y="2102612"/>
                </a:lnTo>
                <a:lnTo>
                  <a:pt x="321309" y="2100453"/>
                </a:lnTo>
                <a:lnTo>
                  <a:pt x="337311" y="2098041"/>
                </a:lnTo>
                <a:lnTo>
                  <a:pt x="353441" y="2095501"/>
                </a:lnTo>
                <a:lnTo>
                  <a:pt x="385572" y="2090166"/>
                </a:lnTo>
                <a:lnTo>
                  <a:pt x="401574" y="2087753"/>
                </a:lnTo>
                <a:lnTo>
                  <a:pt x="417703" y="2085595"/>
                </a:lnTo>
                <a:lnTo>
                  <a:pt x="433705" y="2083816"/>
                </a:lnTo>
                <a:lnTo>
                  <a:pt x="449833" y="2082420"/>
                </a:lnTo>
                <a:lnTo>
                  <a:pt x="465836" y="2081403"/>
                </a:lnTo>
                <a:lnTo>
                  <a:pt x="481964" y="2080260"/>
                </a:lnTo>
                <a:lnTo>
                  <a:pt x="497967" y="2078991"/>
                </a:lnTo>
                <a:lnTo>
                  <a:pt x="514095" y="2077212"/>
                </a:lnTo>
                <a:lnTo>
                  <a:pt x="530097" y="2074291"/>
                </a:lnTo>
                <a:lnTo>
                  <a:pt x="546227" y="2069847"/>
                </a:lnTo>
                <a:lnTo>
                  <a:pt x="562228" y="2063623"/>
                </a:lnTo>
                <a:lnTo>
                  <a:pt x="578230" y="2054987"/>
                </a:lnTo>
                <a:lnTo>
                  <a:pt x="594359" y="2043685"/>
                </a:lnTo>
                <a:lnTo>
                  <a:pt x="610361" y="2029587"/>
                </a:lnTo>
                <a:lnTo>
                  <a:pt x="626491" y="2012697"/>
                </a:lnTo>
                <a:lnTo>
                  <a:pt x="642492" y="1993139"/>
                </a:lnTo>
                <a:lnTo>
                  <a:pt x="658622" y="1971041"/>
                </a:lnTo>
                <a:lnTo>
                  <a:pt x="674624" y="1947037"/>
                </a:lnTo>
                <a:lnTo>
                  <a:pt x="690753" y="1921384"/>
                </a:lnTo>
                <a:lnTo>
                  <a:pt x="706755" y="1894586"/>
                </a:lnTo>
                <a:lnTo>
                  <a:pt x="738886" y="1838579"/>
                </a:lnTo>
                <a:lnTo>
                  <a:pt x="755014" y="1809116"/>
                </a:lnTo>
                <a:lnTo>
                  <a:pt x="771017" y="1778381"/>
                </a:lnTo>
                <a:lnTo>
                  <a:pt x="787145" y="1745616"/>
                </a:lnTo>
                <a:lnTo>
                  <a:pt x="803147" y="1709802"/>
                </a:lnTo>
                <a:lnTo>
                  <a:pt x="819277" y="1670178"/>
                </a:lnTo>
                <a:lnTo>
                  <a:pt x="835278" y="1625728"/>
                </a:lnTo>
                <a:lnTo>
                  <a:pt x="851408" y="1575562"/>
                </a:lnTo>
                <a:lnTo>
                  <a:pt x="867409" y="1518921"/>
                </a:lnTo>
                <a:lnTo>
                  <a:pt x="883539" y="1455421"/>
                </a:lnTo>
                <a:lnTo>
                  <a:pt x="899541" y="1384809"/>
                </a:lnTo>
                <a:lnTo>
                  <a:pt x="915669" y="1307466"/>
                </a:lnTo>
                <a:lnTo>
                  <a:pt x="931672" y="1223646"/>
                </a:lnTo>
                <a:lnTo>
                  <a:pt x="947800" y="1134237"/>
                </a:lnTo>
                <a:lnTo>
                  <a:pt x="963802" y="1040258"/>
                </a:lnTo>
                <a:lnTo>
                  <a:pt x="1060196" y="462662"/>
                </a:lnTo>
                <a:lnTo>
                  <a:pt x="1076324" y="378206"/>
                </a:lnTo>
                <a:lnTo>
                  <a:pt x="1092327" y="300483"/>
                </a:lnTo>
                <a:lnTo>
                  <a:pt x="1108456" y="230378"/>
                </a:lnTo>
                <a:lnTo>
                  <a:pt x="1124458" y="168529"/>
                </a:lnTo>
                <a:lnTo>
                  <a:pt x="1140587" y="115571"/>
                </a:lnTo>
                <a:lnTo>
                  <a:pt x="1156589" y="72010"/>
                </a:lnTo>
                <a:lnTo>
                  <a:pt x="1172590" y="38227"/>
                </a:lnTo>
                <a:lnTo>
                  <a:pt x="1188719" y="14733"/>
                </a:lnTo>
                <a:lnTo>
                  <a:pt x="1204721" y="1778"/>
                </a:lnTo>
                <a:lnTo>
                  <a:pt x="1220850" y="0"/>
                </a:lnTo>
                <a:lnTo>
                  <a:pt x="1236852" y="9399"/>
                </a:lnTo>
                <a:lnTo>
                  <a:pt x="1252981" y="29973"/>
                </a:lnTo>
                <a:lnTo>
                  <a:pt x="1268984" y="61850"/>
                </a:lnTo>
                <a:lnTo>
                  <a:pt x="1285112" y="104267"/>
                </a:lnTo>
                <a:lnTo>
                  <a:pt x="1301115" y="156591"/>
                </a:lnTo>
                <a:lnTo>
                  <a:pt x="1317243" y="217551"/>
                </a:lnTo>
                <a:lnTo>
                  <a:pt x="1333246" y="286004"/>
                </a:lnTo>
                <a:lnTo>
                  <a:pt x="1349374" y="360173"/>
                </a:lnTo>
                <a:lnTo>
                  <a:pt x="1381506" y="518923"/>
                </a:lnTo>
                <a:lnTo>
                  <a:pt x="1413637" y="679831"/>
                </a:lnTo>
                <a:lnTo>
                  <a:pt x="1429639" y="757302"/>
                </a:lnTo>
                <a:lnTo>
                  <a:pt x="1445768" y="831216"/>
                </a:lnTo>
                <a:lnTo>
                  <a:pt x="1461769" y="900685"/>
                </a:lnTo>
                <a:lnTo>
                  <a:pt x="1477899" y="965201"/>
                </a:lnTo>
                <a:lnTo>
                  <a:pt x="1493900" y="1024636"/>
                </a:lnTo>
                <a:lnTo>
                  <a:pt x="1510030" y="1078866"/>
                </a:lnTo>
                <a:lnTo>
                  <a:pt x="1526031" y="1128396"/>
                </a:lnTo>
                <a:lnTo>
                  <a:pt x="1542161" y="1173480"/>
                </a:lnTo>
                <a:lnTo>
                  <a:pt x="1558162" y="1215010"/>
                </a:lnTo>
                <a:lnTo>
                  <a:pt x="1574292" y="1253364"/>
                </a:lnTo>
                <a:lnTo>
                  <a:pt x="1590293" y="1289304"/>
                </a:lnTo>
                <a:lnTo>
                  <a:pt x="1606422" y="1323341"/>
                </a:lnTo>
                <a:lnTo>
                  <a:pt x="1622424" y="1355979"/>
                </a:lnTo>
                <a:lnTo>
                  <a:pt x="1638553" y="1387348"/>
                </a:lnTo>
                <a:lnTo>
                  <a:pt x="1654556" y="1417574"/>
                </a:lnTo>
                <a:lnTo>
                  <a:pt x="1670684" y="1446785"/>
                </a:lnTo>
                <a:lnTo>
                  <a:pt x="1686687" y="1474597"/>
                </a:lnTo>
                <a:lnTo>
                  <a:pt x="1702815" y="1501141"/>
                </a:lnTo>
                <a:lnTo>
                  <a:pt x="1718818" y="1526033"/>
                </a:lnTo>
                <a:lnTo>
                  <a:pt x="1734819" y="1549147"/>
                </a:lnTo>
                <a:lnTo>
                  <a:pt x="1750949" y="1570610"/>
                </a:lnTo>
                <a:lnTo>
                  <a:pt x="1766950" y="1590422"/>
                </a:lnTo>
                <a:lnTo>
                  <a:pt x="1783080" y="1608836"/>
                </a:lnTo>
                <a:lnTo>
                  <a:pt x="1799081" y="1625981"/>
                </a:lnTo>
                <a:lnTo>
                  <a:pt x="1815211" y="1642237"/>
                </a:lnTo>
                <a:lnTo>
                  <a:pt x="1831212" y="1657731"/>
                </a:lnTo>
                <a:lnTo>
                  <a:pt x="1847342" y="1672717"/>
                </a:lnTo>
                <a:lnTo>
                  <a:pt x="1863343" y="1687196"/>
                </a:lnTo>
                <a:lnTo>
                  <a:pt x="1879472" y="1701166"/>
                </a:lnTo>
                <a:lnTo>
                  <a:pt x="1895474" y="1714373"/>
                </a:lnTo>
                <a:lnTo>
                  <a:pt x="1911603" y="1726692"/>
                </a:lnTo>
                <a:lnTo>
                  <a:pt x="1927606" y="1737996"/>
                </a:lnTo>
                <a:lnTo>
                  <a:pt x="1943734" y="1748410"/>
                </a:lnTo>
                <a:lnTo>
                  <a:pt x="1959737" y="1757680"/>
                </a:lnTo>
                <a:lnTo>
                  <a:pt x="1975865" y="1766443"/>
                </a:lnTo>
                <a:lnTo>
                  <a:pt x="2007996" y="1783461"/>
                </a:lnTo>
                <a:lnTo>
                  <a:pt x="2023999" y="1792605"/>
                </a:lnTo>
                <a:lnTo>
                  <a:pt x="2040127" y="1802892"/>
                </a:lnTo>
                <a:lnTo>
                  <a:pt x="2056130" y="1814577"/>
                </a:lnTo>
                <a:lnTo>
                  <a:pt x="2072259" y="1827785"/>
                </a:lnTo>
                <a:lnTo>
                  <a:pt x="2088261" y="1842262"/>
                </a:lnTo>
                <a:lnTo>
                  <a:pt x="2104390" y="1858010"/>
                </a:lnTo>
                <a:lnTo>
                  <a:pt x="2120392" y="1874647"/>
                </a:lnTo>
                <a:lnTo>
                  <a:pt x="2184653" y="1942847"/>
                </a:lnTo>
                <a:lnTo>
                  <a:pt x="2200783" y="1958976"/>
                </a:lnTo>
                <a:lnTo>
                  <a:pt x="2216784" y="1974597"/>
                </a:lnTo>
                <a:lnTo>
                  <a:pt x="2232914" y="1989583"/>
                </a:lnTo>
                <a:lnTo>
                  <a:pt x="2248915" y="2004060"/>
                </a:lnTo>
                <a:lnTo>
                  <a:pt x="2265044" y="2018158"/>
                </a:lnTo>
                <a:lnTo>
                  <a:pt x="2281046" y="2031620"/>
                </a:lnTo>
                <a:lnTo>
                  <a:pt x="2297049" y="2044573"/>
                </a:lnTo>
                <a:lnTo>
                  <a:pt x="2313177" y="2057020"/>
                </a:lnTo>
                <a:lnTo>
                  <a:pt x="2329180" y="2068577"/>
                </a:lnTo>
                <a:lnTo>
                  <a:pt x="2345309" y="2079372"/>
                </a:lnTo>
                <a:lnTo>
                  <a:pt x="2361311" y="2089151"/>
                </a:lnTo>
                <a:lnTo>
                  <a:pt x="2377440" y="2097914"/>
                </a:lnTo>
                <a:lnTo>
                  <a:pt x="2393442" y="2105406"/>
                </a:lnTo>
                <a:lnTo>
                  <a:pt x="2409571" y="2111884"/>
                </a:lnTo>
                <a:lnTo>
                  <a:pt x="2425572" y="2117217"/>
                </a:lnTo>
                <a:lnTo>
                  <a:pt x="2441702" y="2121409"/>
                </a:lnTo>
                <a:lnTo>
                  <a:pt x="2457703" y="2124710"/>
                </a:lnTo>
                <a:lnTo>
                  <a:pt x="2473833" y="2127251"/>
                </a:lnTo>
                <a:lnTo>
                  <a:pt x="2489834" y="2129155"/>
                </a:lnTo>
                <a:lnTo>
                  <a:pt x="2505964" y="2130553"/>
                </a:lnTo>
                <a:lnTo>
                  <a:pt x="2521965" y="2131441"/>
                </a:lnTo>
                <a:lnTo>
                  <a:pt x="2538094" y="2132077"/>
                </a:lnTo>
              </a:path>
            </a:pathLst>
          </a:custGeom>
          <a:noFill/>
          <a:ln w="18288" cap="flat" cmpd="sng">
            <a:solidFill>
              <a:srgbClr val="445694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22" name="Freeform 422"/>
          <p:cNvSpPr/>
          <p:nvPr/>
        </p:nvSpPr>
        <p:spPr>
          <a:xfrm>
            <a:off x="5519076" y="4158421"/>
            <a:ext cx="2435098" cy="1541271"/>
          </a:xfrm>
          <a:custGeom>
            <a:avLst/>
            <a:gdLst/>
            <a:ahLst/>
            <a:cxnLst/>
            <a:rect l="0" t="0" r="0" b="0"/>
            <a:pathLst>
              <a:path w="2435098" h="1541271">
                <a:moveTo>
                  <a:pt x="0" y="1541271"/>
                </a:moveTo>
                <a:lnTo>
                  <a:pt x="12064" y="1540890"/>
                </a:lnTo>
                <a:lnTo>
                  <a:pt x="24130" y="1540509"/>
                </a:lnTo>
                <a:lnTo>
                  <a:pt x="36195" y="1540002"/>
                </a:lnTo>
                <a:lnTo>
                  <a:pt x="48259" y="1539494"/>
                </a:lnTo>
                <a:lnTo>
                  <a:pt x="60325" y="1538732"/>
                </a:lnTo>
                <a:lnTo>
                  <a:pt x="72389" y="1538096"/>
                </a:lnTo>
                <a:lnTo>
                  <a:pt x="84455" y="1537208"/>
                </a:lnTo>
                <a:lnTo>
                  <a:pt x="96520" y="1536191"/>
                </a:lnTo>
                <a:lnTo>
                  <a:pt x="108584" y="1535048"/>
                </a:lnTo>
                <a:lnTo>
                  <a:pt x="120522" y="1533778"/>
                </a:lnTo>
                <a:lnTo>
                  <a:pt x="132587" y="1532382"/>
                </a:lnTo>
                <a:lnTo>
                  <a:pt x="144653" y="1530858"/>
                </a:lnTo>
                <a:lnTo>
                  <a:pt x="156717" y="1529079"/>
                </a:lnTo>
                <a:lnTo>
                  <a:pt x="168783" y="1527047"/>
                </a:lnTo>
                <a:lnTo>
                  <a:pt x="180847" y="1524889"/>
                </a:lnTo>
                <a:lnTo>
                  <a:pt x="192912" y="1522476"/>
                </a:lnTo>
                <a:lnTo>
                  <a:pt x="204978" y="1519808"/>
                </a:lnTo>
                <a:lnTo>
                  <a:pt x="217042" y="1516760"/>
                </a:lnTo>
                <a:lnTo>
                  <a:pt x="229108" y="1513585"/>
                </a:lnTo>
                <a:lnTo>
                  <a:pt x="241172" y="1510029"/>
                </a:lnTo>
                <a:lnTo>
                  <a:pt x="253237" y="1506220"/>
                </a:lnTo>
                <a:lnTo>
                  <a:pt x="265303" y="1502028"/>
                </a:lnTo>
                <a:lnTo>
                  <a:pt x="277241" y="1497583"/>
                </a:lnTo>
                <a:lnTo>
                  <a:pt x="289306" y="1492631"/>
                </a:lnTo>
                <a:lnTo>
                  <a:pt x="301370" y="1487423"/>
                </a:lnTo>
                <a:lnTo>
                  <a:pt x="313436" y="1481708"/>
                </a:lnTo>
                <a:lnTo>
                  <a:pt x="325500" y="1475613"/>
                </a:lnTo>
                <a:lnTo>
                  <a:pt x="337566" y="1469135"/>
                </a:lnTo>
                <a:lnTo>
                  <a:pt x="349631" y="1462151"/>
                </a:lnTo>
                <a:lnTo>
                  <a:pt x="361695" y="1454531"/>
                </a:lnTo>
                <a:lnTo>
                  <a:pt x="373761" y="1446529"/>
                </a:lnTo>
                <a:lnTo>
                  <a:pt x="385825" y="1437894"/>
                </a:lnTo>
                <a:lnTo>
                  <a:pt x="397891" y="1428622"/>
                </a:lnTo>
                <a:lnTo>
                  <a:pt x="409956" y="1418716"/>
                </a:lnTo>
                <a:lnTo>
                  <a:pt x="421894" y="1408048"/>
                </a:lnTo>
                <a:lnTo>
                  <a:pt x="433959" y="1396619"/>
                </a:lnTo>
                <a:lnTo>
                  <a:pt x="446023" y="1384300"/>
                </a:lnTo>
                <a:lnTo>
                  <a:pt x="458089" y="1371219"/>
                </a:lnTo>
                <a:lnTo>
                  <a:pt x="470153" y="1357121"/>
                </a:lnTo>
                <a:lnTo>
                  <a:pt x="482219" y="1341882"/>
                </a:lnTo>
                <a:lnTo>
                  <a:pt x="494284" y="1325626"/>
                </a:lnTo>
                <a:lnTo>
                  <a:pt x="506348" y="1308227"/>
                </a:lnTo>
                <a:lnTo>
                  <a:pt x="518414" y="1289431"/>
                </a:lnTo>
                <a:lnTo>
                  <a:pt x="530478" y="1269365"/>
                </a:lnTo>
                <a:lnTo>
                  <a:pt x="542544" y="1247902"/>
                </a:lnTo>
                <a:lnTo>
                  <a:pt x="554609" y="1224915"/>
                </a:lnTo>
                <a:lnTo>
                  <a:pt x="566547" y="1200403"/>
                </a:lnTo>
                <a:lnTo>
                  <a:pt x="578611" y="1174369"/>
                </a:lnTo>
                <a:lnTo>
                  <a:pt x="590676" y="1146556"/>
                </a:lnTo>
                <a:lnTo>
                  <a:pt x="602742" y="1117091"/>
                </a:lnTo>
                <a:lnTo>
                  <a:pt x="614806" y="1085977"/>
                </a:lnTo>
                <a:lnTo>
                  <a:pt x="626872" y="1053083"/>
                </a:lnTo>
                <a:lnTo>
                  <a:pt x="638936" y="1018540"/>
                </a:lnTo>
                <a:lnTo>
                  <a:pt x="651001" y="982345"/>
                </a:lnTo>
                <a:lnTo>
                  <a:pt x="663066" y="944498"/>
                </a:lnTo>
                <a:lnTo>
                  <a:pt x="675132" y="905256"/>
                </a:lnTo>
                <a:lnTo>
                  <a:pt x="687197" y="864489"/>
                </a:lnTo>
                <a:lnTo>
                  <a:pt x="711200" y="779145"/>
                </a:lnTo>
                <a:lnTo>
                  <a:pt x="735329" y="689990"/>
                </a:lnTo>
                <a:lnTo>
                  <a:pt x="831850" y="330708"/>
                </a:lnTo>
                <a:lnTo>
                  <a:pt x="843914" y="289940"/>
                </a:lnTo>
                <a:lnTo>
                  <a:pt x="855853" y="250952"/>
                </a:lnTo>
                <a:lnTo>
                  <a:pt x="867917" y="214121"/>
                </a:lnTo>
                <a:lnTo>
                  <a:pt x="879982" y="179577"/>
                </a:lnTo>
                <a:lnTo>
                  <a:pt x="892048" y="147701"/>
                </a:lnTo>
                <a:lnTo>
                  <a:pt x="904113" y="118617"/>
                </a:lnTo>
                <a:lnTo>
                  <a:pt x="916178" y="92329"/>
                </a:lnTo>
                <a:lnTo>
                  <a:pt x="928242" y="69215"/>
                </a:lnTo>
                <a:lnTo>
                  <a:pt x="940307" y="49403"/>
                </a:lnTo>
                <a:lnTo>
                  <a:pt x="952373" y="32766"/>
                </a:lnTo>
                <a:lnTo>
                  <a:pt x="964438" y="19557"/>
                </a:lnTo>
                <a:lnTo>
                  <a:pt x="976503" y="9652"/>
                </a:lnTo>
                <a:lnTo>
                  <a:pt x="988567" y="3175"/>
                </a:lnTo>
                <a:lnTo>
                  <a:pt x="1000506" y="0"/>
                </a:lnTo>
                <a:lnTo>
                  <a:pt x="1012570" y="0"/>
                </a:lnTo>
                <a:lnTo>
                  <a:pt x="1024635" y="3302"/>
                </a:lnTo>
                <a:lnTo>
                  <a:pt x="1036701" y="9525"/>
                </a:lnTo>
                <a:lnTo>
                  <a:pt x="1048766" y="18668"/>
                </a:lnTo>
                <a:lnTo>
                  <a:pt x="1060831" y="30606"/>
                </a:lnTo>
                <a:lnTo>
                  <a:pt x="1072895" y="44957"/>
                </a:lnTo>
                <a:lnTo>
                  <a:pt x="1084960" y="61594"/>
                </a:lnTo>
                <a:lnTo>
                  <a:pt x="1097026" y="80391"/>
                </a:lnTo>
                <a:lnTo>
                  <a:pt x="1109091" y="101091"/>
                </a:lnTo>
                <a:lnTo>
                  <a:pt x="1121156" y="123316"/>
                </a:lnTo>
                <a:lnTo>
                  <a:pt x="1133220" y="147065"/>
                </a:lnTo>
                <a:lnTo>
                  <a:pt x="1145159" y="171831"/>
                </a:lnTo>
                <a:lnTo>
                  <a:pt x="1169288" y="224154"/>
                </a:lnTo>
                <a:lnTo>
                  <a:pt x="1253744" y="411479"/>
                </a:lnTo>
                <a:lnTo>
                  <a:pt x="1265809" y="436245"/>
                </a:lnTo>
                <a:lnTo>
                  <a:pt x="1277873" y="460247"/>
                </a:lnTo>
                <a:lnTo>
                  <a:pt x="1289811" y="483108"/>
                </a:lnTo>
                <a:lnTo>
                  <a:pt x="1301876" y="504825"/>
                </a:lnTo>
                <a:lnTo>
                  <a:pt x="1313941" y="525398"/>
                </a:lnTo>
                <a:lnTo>
                  <a:pt x="1326007" y="544576"/>
                </a:lnTo>
                <a:lnTo>
                  <a:pt x="1338072" y="562483"/>
                </a:lnTo>
                <a:lnTo>
                  <a:pt x="1350136" y="578992"/>
                </a:lnTo>
                <a:lnTo>
                  <a:pt x="1362201" y="594233"/>
                </a:lnTo>
                <a:lnTo>
                  <a:pt x="1374266" y="607948"/>
                </a:lnTo>
                <a:lnTo>
                  <a:pt x="1386332" y="620267"/>
                </a:lnTo>
                <a:lnTo>
                  <a:pt x="1398397" y="631316"/>
                </a:lnTo>
                <a:lnTo>
                  <a:pt x="1410461" y="640969"/>
                </a:lnTo>
                <a:lnTo>
                  <a:pt x="1422526" y="649477"/>
                </a:lnTo>
                <a:lnTo>
                  <a:pt x="1434464" y="656590"/>
                </a:lnTo>
                <a:lnTo>
                  <a:pt x="1446529" y="662558"/>
                </a:lnTo>
                <a:lnTo>
                  <a:pt x="1458594" y="667511"/>
                </a:lnTo>
                <a:lnTo>
                  <a:pt x="1470660" y="671448"/>
                </a:lnTo>
                <a:lnTo>
                  <a:pt x="1482725" y="674496"/>
                </a:lnTo>
                <a:lnTo>
                  <a:pt x="1494789" y="676656"/>
                </a:lnTo>
                <a:lnTo>
                  <a:pt x="1506854" y="678179"/>
                </a:lnTo>
                <a:lnTo>
                  <a:pt x="1518919" y="679069"/>
                </a:lnTo>
                <a:lnTo>
                  <a:pt x="1530985" y="679450"/>
                </a:lnTo>
                <a:lnTo>
                  <a:pt x="1543050" y="679450"/>
                </a:lnTo>
                <a:lnTo>
                  <a:pt x="1555114" y="679196"/>
                </a:lnTo>
                <a:lnTo>
                  <a:pt x="1567179" y="678815"/>
                </a:lnTo>
                <a:lnTo>
                  <a:pt x="1579117" y="678433"/>
                </a:lnTo>
                <a:lnTo>
                  <a:pt x="1591182" y="678179"/>
                </a:lnTo>
                <a:lnTo>
                  <a:pt x="1603248" y="678052"/>
                </a:lnTo>
                <a:lnTo>
                  <a:pt x="1615313" y="678307"/>
                </a:lnTo>
                <a:lnTo>
                  <a:pt x="1627378" y="678941"/>
                </a:lnTo>
                <a:lnTo>
                  <a:pt x="1639442" y="680211"/>
                </a:lnTo>
                <a:lnTo>
                  <a:pt x="1651507" y="682116"/>
                </a:lnTo>
                <a:lnTo>
                  <a:pt x="1663573" y="684783"/>
                </a:lnTo>
                <a:lnTo>
                  <a:pt x="1675638" y="688213"/>
                </a:lnTo>
                <a:lnTo>
                  <a:pt x="1687703" y="692658"/>
                </a:lnTo>
                <a:lnTo>
                  <a:pt x="1699767" y="698119"/>
                </a:lnTo>
                <a:lnTo>
                  <a:pt x="1711832" y="704722"/>
                </a:lnTo>
                <a:lnTo>
                  <a:pt x="1723770" y="712470"/>
                </a:lnTo>
                <a:lnTo>
                  <a:pt x="1735835" y="721486"/>
                </a:lnTo>
                <a:lnTo>
                  <a:pt x="1747901" y="731646"/>
                </a:lnTo>
                <a:lnTo>
                  <a:pt x="1759966" y="743203"/>
                </a:lnTo>
                <a:lnTo>
                  <a:pt x="1772031" y="756031"/>
                </a:lnTo>
                <a:lnTo>
                  <a:pt x="1784095" y="770254"/>
                </a:lnTo>
                <a:lnTo>
                  <a:pt x="1796160" y="785748"/>
                </a:lnTo>
                <a:lnTo>
                  <a:pt x="1808226" y="802513"/>
                </a:lnTo>
                <a:lnTo>
                  <a:pt x="1820291" y="820546"/>
                </a:lnTo>
                <a:lnTo>
                  <a:pt x="1832356" y="839723"/>
                </a:lnTo>
                <a:lnTo>
                  <a:pt x="1844420" y="860171"/>
                </a:lnTo>
                <a:lnTo>
                  <a:pt x="1856485" y="881507"/>
                </a:lnTo>
                <a:lnTo>
                  <a:pt x="1868423" y="903858"/>
                </a:lnTo>
                <a:lnTo>
                  <a:pt x="1880488" y="927100"/>
                </a:lnTo>
                <a:lnTo>
                  <a:pt x="1904619" y="975740"/>
                </a:lnTo>
                <a:lnTo>
                  <a:pt x="1940813" y="1052067"/>
                </a:lnTo>
                <a:lnTo>
                  <a:pt x="2001138" y="1179829"/>
                </a:lnTo>
                <a:lnTo>
                  <a:pt x="2025141" y="1228090"/>
                </a:lnTo>
                <a:lnTo>
                  <a:pt x="2037207" y="1251203"/>
                </a:lnTo>
                <a:lnTo>
                  <a:pt x="2049272" y="1273556"/>
                </a:lnTo>
                <a:lnTo>
                  <a:pt x="2061336" y="1295019"/>
                </a:lnTo>
                <a:lnTo>
                  <a:pt x="2073401" y="1315465"/>
                </a:lnTo>
                <a:lnTo>
                  <a:pt x="2085466" y="1335023"/>
                </a:lnTo>
                <a:lnTo>
                  <a:pt x="2097532" y="1353439"/>
                </a:lnTo>
                <a:lnTo>
                  <a:pt x="2109597" y="1370965"/>
                </a:lnTo>
                <a:lnTo>
                  <a:pt x="2121661" y="1387347"/>
                </a:lnTo>
                <a:lnTo>
                  <a:pt x="2133726" y="1402588"/>
                </a:lnTo>
                <a:lnTo>
                  <a:pt x="2145791" y="1416811"/>
                </a:lnTo>
                <a:lnTo>
                  <a:pt x="2157729" y="1430020"/>
                </a:lnTo>
                <a:lnTo>
                  <a:pt x="2169794" y="1442211"/>
                </a:lnTo>
                <a:lnTo>
                  <a:pt x="2181860" y="1453515"/>
                </a:lnTo>
                <a:lnTo>
                  <a:pt x="2193925" y="1463675"/>
                </a:lnTo>
                <a:lnTo>
                  <a:pt x="2205989" y="1472946"/>
                </a:lnTo>
                <a:lnTo>
                  <a:pt x="2218054" y="1481454"/>
                </a:lnTo>
                <a:lnTo>
                  <a:pt x="2230119" y="1489075"/>
                </a:lnTo>
                <a:lnTo>
                  <a:pt x="2242185" y="1495933"/>
                </a:lnTo>
                <a:lnTo>
                  <a:pt x="2254250" y="1502028"/>
                </a:lnTo>
                <a:lnTo>
                  <a:pt x="2266314" y="1507490"/>
                </a:lnTo>
                <a:lnTo>
                  <a:pt x="2278379" y="1512442"/>
                </a:lnTo>
                <a:lnTo>
                  <a:pt x="2290444" y="1516633"/>
                </a:lnTo>
                <a:lnTo>
                  <a:pt x="2302382" y="1520444"/>
                </a:lnTo>
                <a:lnTo>
                  <a:pt x="2314448" y="1523746"/>
                </a:lnTo>
                <a:lnTo>
                  <a:pt x="2326512" y="1526666"/>
                </a:lnTo>
                <a:lnTo>
                  <a:pt x="2338578" y="1529079"/>
                </a:lnTo>
                <a:lnTo>
                  <a:pt x="2350643" y="1531239"/>
                </a:lnTo>
                <a:lnTo>
                  <a:pt x="2362707" y="1533144"/>
                </a:lnTo>
                <a:lnTo>
                  <a:pt x="2374773" y="1534795"/>
                </a:lnTo>
                <a:lnTo>
                  <a:pt x="2386837" y="1536065"/>
                </a:lnTo>
                <a:lnTo>
                  <a:pt x="2398903" y="1537334"/>
                </a:lnTo>
                <a:lnTo>
                  <a:pt x="2410968" y="1538223"/>
                </a:lnTo>
                <a:lnTo>
                  <a:pt x="2423032" y="1539113"/>
                </a:lnTo>
                <a:lnTo>
                  <a:pt x="2435098" y="1539747"/>
                </a:lnTo>
              </a:path>
            </a:pathLst>
          </a:custGeom>
          <a:noFill/>
          <a:ln w="18288" cap="flat" cmpd="sng">
            <a:solidFill>
              <a:srgbClr val="A23A2E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23" name="Freeform 423"/>
          <p:cNvSpPr/>
          <p:nvPr/>
        </p:nvSpPr>
        <p:spPr>
          <a:xfrm>
            <a:off x="5076227" y="4608000"/>
            <a:ext cx="3035428" cy="1090423"/>
          </a:xfrm>
          <a:custGeom>
            <a:avLst/>
            <a:gdLst/>
            <a:ahLst/>
            <a:cxnLst/>
            <a:rect l="0" t="0" r="0" b="0"/>
            <a:pathLst>
              <a:path w="3035428" h="1090423">
                <a:moveTo>
                  <a:pt x="0" y="1090423"/>
                </a:moveTo>
                <a:lnTo>
                  <a:pt x="12954" y="1090168"/>
                </a:lnTo>
                <a:lnTo>
                  <a:pt x="25909" y="1089915"/>
                </a:lnTo>
                <a:lnTo>
                  <a:pt x="38989" y="1089534"/>
                </a:lnTo>
                <a:lnTo>
                  <a:pt x="51943" y="1089153"/>
                </a:lnTo>
                <a:lnTo>
                  <a:pt x="64897" y="1088772"/>
                </a:lnTo>
                <a:lnTo>
                  <a:pt x="77852" y="1088263"/>
                </a:lnTo>
                <a:lnTo>
                  <a:pt x="90806" y="1087755"/>
                </a:lnTo>
                <a:lnTo>
                  <a:pt x="103760" y="1087121"/>
                </a:lnTo>
                <a:lnTo>
                  <a:pt x="116714" y="1086486"/>
                </a:lnTo>
                <a:lnTo>
                  <a:pt x="129795" y="1085850"/>
                </a:lnTo>
                <a:lnTo>
                  <a:pt x="142749" y="1085088"/>
                </a:lnTo>
                <a:lnTo>
                  <a:pt x="155703" y="1084327"/>
                </a:lnTo>
                <a:lnTo>
                  <a:pt x="168657" y="1083437"/>
                </a:lnTo>
                <a:lnTo>
                  <a:pt x="181610" y="1082548"/>
                </a:lnTo>
                <a:lnTo>
                  <a:pt x="194564" y="1081532"/>
                </a:lnTo>
                <a:lnTo>
                  <a:pt x="207518" y="1080390"/>
                </a:lnTo>
                <a:lnTo>
                  <a:pt x="220600" y="1079373"/>
                </a:lnTo>
                <a:lnTo>
                  <a:pt x="233553" y="1078104"/>
                </a:lnTo>
                <a:lnTo>
                  <a:pt x="246507" y="1076834"/>
                </a:lnTo>
                <a:lnTo>
                  <a:pt x="259461" y="1075563"/>
                </a:lnTo>
                <a:lnTo>
                  <a:pt x="272415" y="1074167"/>
                </a:lnTo>
                <a:lnTo>
                  <a:pt x="285370" y="1072642"/>
                </a:lnTo>
                <a:lnTo>
                  <a:pt x="298323" y="1071118"/>
                </a:lnTo>
                <a:lnTo>
                  <a:pt x="311278" y="1069467"/>
                </a:lnTo>
                <a:lnTo>
                  <a:pt x="324359" y="1067817"/>
                </a:lnTo>
                <a:lnTo>
                  <a:pt x="337312" y="1066166"/>
                </a:lnTo>
                <a:lnTo>
                  <a:pt x="350267" y="1064261"/>
                </a:lnTo>
                <a:lnTo>
                  <a:pt x="363220" y="1062355"/>
                </a:lnTo>
                <a:lnTo>
                  <a:pt x="376175" y="1060450"/>
                </a:lnTo>
                <a:lnTo>
                  <a:pt x="389128" y="1058418"/>
                </a:lnTo>
                <a:lnTo>
                  <a:pt x="402083" y="1056386"/>
                </a:lnTo>
                <a:lnTo>
                  <a:pt x="428117" y="1052068"/>
                </a:lnTo>
                <a:lnTo>
                  <a:pt x="454025" y="1047497"/>
                </a:lnTo>
                <a:lnTo>
                  <a:pt x="479934" y="1042671"/>
                </a:lnTo>
                <a:lnTo>
                  <a:pt x="505969" y="1037463"/>
                </a:lnTo>
                <a:lnTo>
                  <a:pt x="531876" y="1032129"/>
                </a:lnTo>
                <a:lnTo>
                  <a:pt x="544831" y="1029336"/>
                </a:lnTo>
                <a:lnTo>
                  <a:pt x="557784" y="1026415"/>
                </a:lnTo>
                <a:lnTo>
                  <a:pt x="570739" y="1023367"/>
                </a:lnTo>
                <a:lnTo>
                  <a:pt x="583692" y="1020192"/>
                </a:lnTo>
                <a:lnTo>
                  <a:pt x="596773" y="1017017"/>
                </a:lnTo>
                <a:lnTo>
                  <a:pt x="609728" y="1013587"/>
                </a:lnTo>
                <a:lnTo>
                  <a:pt x="622681" y="1010159"/>
                </a:lnTo>
                <a:lnTo>
                  <a:pt x="635636" y="1006475"/>
                </a:lnTo>
                <a:lnTo>
                  <a:pt x="648589" y="1002538"/>
                </a:lnTo>
                <a:lnTo>
                  <a:pt x="661544" y="998474"/>
                </a:lnTo>
                <a:lnTo>
                  <a:pt x="674497" y="994156"/>
                </a:lnTo>
                <a:lnTo>
                  <a:pt x="687451" y="989585"/>
                </a:lnTo>
                <a:lnTo>
                  <a:pt x="700533" y="984759"/>
                </a:lnTo>
                <a:lnTo>
                  <a:pt x="713486" y="979679"/>
                </a:lnTo>
                <a:lnTo>
                  <a:pt x="726441" y="974217"/>
                </a:lnTo>
                <a:lnTo>
                  <a:pt x="739395" y="968503"/>
                </a:lnTo>
                <a:lnTo>
                  <a:pt x="752348" y="962279"/>
                </a:lnTo>
                <a:lnTo>
                  <a:pt x="765303" y="955803"/>
                </a:lnTo>
                <a:lnTo>
                  <a:pt x="778256" y="948691"/>
                </a:lnTo>
                <a:lnTo>
                  <a:pt x="791337" y="941324"/>
                </a:lnTo>
                <a:lnTo>
                  <a:pt x="804292" y="933323"/>
                </a:lnTo>
                <a:lnTo>
                  <a:pt x="817245" y="924815"/>
                </a:lnTo>
                <a:lnTo>
                  <a:pt x="830200" y="915798"/>
                </a:lnTo>
                <a:lnTo>
                  <a:pt x="843153" y="906146"/>
                </a:lnTo>
                <a:lnTo>
                  <a:pt x="856108" y="895859"/>
                </a:lnTo>
                <a:lnTo>
                  <a:pt x="869061" y="885063"/>
                </a:lnTo>
                <a:lnTo>
                  <a:pt x="882142" y="873506"/>
                </a:lnTo>
                <a:lnTo>
                  <a:pt x="895097" y="861315"/>
                </a:lnTo>
                <a:lnTo>
                  <a:pt x="908050" y="848487"/>
                </a:lnTo>
                <a:lnTo>
                  <a:pt x="921005" y="834898"/>
                </a:lnTo>
                <a:lnTo>
                  <a:pt x="933959" y="820548"/>
                </a:lnTo>
                <a:lnTo>
                  <a:pt x="946912" y="805561"/>
                </a:lnTo>
                <a:lnTo>
                  <a:pt x="959867" y="789813"/>
                </a:lnTo>
                <a:lnTo>
                  <a:pt x="972947" y="773430"/>
                </a:lnTo>
                <a:lnTo>
                  <a:pt x="985901" y="756286"/>
                </a:lnTo>
                <a:lnTo>
                  <a:pt x="998856" y="738379"/>
                </a:lnTo>
                <a:lnTo>
                  <a:pt x="1011809" y="719836"/>
                </a:lnTo>
                <a:lnTo>
                  <a:pt x="1024764" y="700532"/>
                </a:lnTo>
                <a:lnTo>
                  <a:pt x="1037717" y="680721"/>
                </a:lnTo>
                <a:lnTo>
                  <a:pt x="1063625" y="639192"/>
                </a:lnTo>
                <a:lnTo>
                  <a:pt x="1089661" y="595630"/>
                </a:lnTo>
                <a:lnTo>
                  <a:pt x="1115569" y="550292"/>
                </a:lnTo>
                <a:lnTo>
                  <a:pt x="1167511" y="456185"/>
                </a:lnTo>
                <a:lnTo>
                  <a:pt x="1245235" y="315087"/>
                </a:lnTo>
                <a:lnTo>
                  <a:pt x="1271270" y="270511"/>
                </a:lnTo>
                <a:lnTo>
                  <a:pt x="1297179" y="228092"/>
                </a:lnTo>
                <a:lnTo>
                  <a:pt x="1310132" y="207899"/>
                </a:lnTo>
                <a:lnTo>
                  <a:pt x="1323086" y="188342"/>
                </a:lnTo>
                <a:lnTo>
                  <a:pt x="1336041" y="169673"/>
                </a:lnTo>
                <a:lnTo>
                  <a:pt x="1349122" y="151766"/>
                </a:lnTo>
                <a:lnTo>
                  <a:pt x="1362076" y="134874"/>
                </a:lnTo>
                <a:lnTo>
                  <a:pt x="1375029" y="118873"/>
                </a:lnTo>
                <a:lnTo>
                  <a:pt x="1387984" y="103760"/>
                </a:lnTo>
                <a:lnTo>
                  <a:pt x="1400938" y="89790"/>
                </a:lnTo>
                <a:lnTo>
                  <a:pt x="1413891" y="76836"/>
                </a:lnTo>
                <a:lnTo>
                  <a:pt x="1426845" y="64771"/>
                </a:lnTo>
                <a:lnTo>
                  <a:pt x="1439926" y="53975"/>
                </a:lnTo>
                <a:lnTo>
                  <a:pt x="1452881" y="44069"/>
                </a:lnTo>
                <a:lnTo>
                  <a:pt x="1465835" y="35306"/>
                </a:lnTo>
                <a:lnTo>
                  <a:pt x="1478788" y="27560"/>
                </a:lnTo>
                <a:lnTo>
                  <a:pt x="1491742" y="20829"/>
                </a:lnTo>
                <a:lnTo>
                  <a:pt x="1504697" y="15113"/>
                </a:lnTo>
                <a:lnTo>
                  <a:pt x="1517651" y="10415"/>
                </a:lnTo>
                <a:lnTo>
                  <a:pt x="1530604" y="6604"/>
                </a:lnTo>
                <a:lnTo>
                  <a:pt x="1543685" y="3684"/>
                </a:lnTo>
                <a:lnTo>
                  <a:pt x="1556639" y="1652"/>
                </a:lnTo>
                <a:lnTo>
                  <a:pt x="1569594" y="381"/>
                </a:lnTo>
                <a:lnTo>
                  <a:pt x="1582548" y="0"/>
                </a:lnTo>
                <a:lnTo>
                  <a:pt x="1595501" y="128"/>
                </a:lnTo>
                <a:lnTo>
                  <a:pt x="1608456" y="1017"/>
                </a:lnTo>
                <a:lnTo>
                  <a:pt x="1621410" y="2413"/>
                </a:lnTo>
                <a:lnTo>
                  <a:pt x="1634491" y="4446"/>
                </a:lnTo>
                <a:lnTo>
                  <a:pt x="1647444" y="6859"/>
                </a:lnTo>
                <a:lnTo>
                  <a:pt x="1660398" y="9653"/>
                </a:lnTo>
                <a:lnTo>
                  <a:pt x="1673353" y="12828"/>
                </a:lnTo>
                <a:lnTo>
                  <a:pt x="1686307" y="16256"/>
                </a:lnTo>
                <a:lnTo>
                  <a:pt x="1699260" y="19812"/>
                </a:lnTo>
                <a:lnTo>
                  <a:pt x="1725295" y="27432"/>
                </a:lnTo>
                <a:lnTo>
                  <a:pt x="1777111" y="43180"/>
                </a:lnTo>
                <a:lnTo>
                  <a:pt x="1790066" y="46863"/>
                </a:lnTo>
                <a:lnTo>
                  <a:pt x="1803019" y="50547"/>
                </a:lnTo>
                <a:lnTo>
                  <a:pt x="1816101" y="53975"/>
                </a:lnTo>
                <a:lnTo>
                  <a:pt x="1829054" y="57278"/>
                </a:lnTo>
                <a:lnTo>
                  <a:pt x="1842009" y="60453"/>
                </a:lnTo>
                <a:lnTo>
                  <a:pt x="1854963" y="63500"/>
                </a:lnTo>
                <a:lnTo>
                  <a:pt x="1867916" y="66294"/>
                </a:lnTo>
                <a:lnTo>
                  <a:pt x="1880870" y="68961"/>
                </a:lnTo>
                <a:lnTo>
                  <a:pt x="1893825" y="71502"/>
                </a:lnTo>
                <a:lnTo>
                  <a:pt x="1906779" y="73915"/>
                </a:lnTo>
                <a:lnTo>
                  <a:pt x="1932813" y="78486"/>
                </a:lnTo>
                <a:lnTo>
                  <a:pt x="1958722" y="82931"/>
                </a:lnTo>
                <a:lnTo>
                  <a:pt x="1971676" y="85217"/>
                </a:lnTo>
                <a:lnTo>
                  <a:pt x="1984629" y="87757"/>
                </a:lnTo>
                <a:lnTo>
                  <a:pt x="1997584" y="90298"/>
                </a:lnTo>
                <a:lnTo>
                  <a:pt x="2010664" y="93092"/>
                </a:lnTo>
                <a:lnTo>
                  <a:pt x="2023619" y="96140"/>
                </a:lnTo>
                <a:lnTo>
                  <a:pt x="2036573" y="99568"/>
                </a:lnTo>
                <a:lnTo>
                  <a:pt x="2049526" y="103379"/>
                </a:lnTo>
                <a:lnTo>
                  <a:pt x="2062481" y="107569"/>
                </a:lnTo>
                <a:lnTo>
                  <a:pt x="2075435" y="112268"/>
                </a:lnTo>
                <a:lnTo>
                  <a:pt x="2088388" y="117603"/>
                </a:lnTo>
                <a:lnTo>
                  <a:pt x="2101469" y="123444"/>
                </a:lnTo>
                <a:lnTo>
                  <a:pt x="2114423" y="129922"/>
                </a:lnTo>
                <a:lnTo>
                  <a:pt x="2127378" y="137034"/>
                </a:lnTo>
                <a:lnTo>
                  <a:pt x="2140332" y="144907"/>
                </a:lnTo>
                <a:lnTo>
                  <a:pt x="2153285" y="153543"/>
                </a:lnTo>
                <a:lnTo>
                  <a:pt x="2166239" y="163068"/>
                </a:lnTo>
                <a:lnTo>
                  <a:pt x="2179194" y="173229"/>
                </a:lnTo>
                <a:lnTo>
                  <a:pt x="2192275" y="184278"/>
                </a:lnTo>
                <a:lnTo>
                  <a:pt x="2205229" y="196216"/>
                </a:lnTo>
                <a:lnTo>
                  <a:pt x="2218182" y="208916"/>
                </a:lnTo>
                <a:lnTo>
                  <a:pt x="2231136" y="222504"/>
                </a:lnTo>
                <a:lnTo>
                  <a:pt x="2244091" y="236855"/>
                </a:lnTo>
                <a:lnTo>
                  <a:pt x="2257044" y="252096"/>
                </a:lnTo>
                <a:lnTo>
                  <a:pt x="2269998" y="268224"/>
                </a:lnTo>
                <a:lnTo>
                  <a:pt x="2282953" y="284988"/>
                </a:lnTo>
                <a:lnTo>
                  <a:pt x="2296034" y="302515"/>
                </a:lnTo>
                <a:lnTo>
                  <a:pt x="2308988" y="320803"/>
                </a:lnTo>
                <a:lnTo>
                  <a:pt x="2321941" y="339725"/>
                </a:lnTo>
                <a:lnTo>
                  <a:pt x="2347850" y="379477"/>
                </a:lnTo>
                <a:lnTo>
                  <a:pt x="2373757" y="421132"/>
                </a:lnTo>
                <a:lnTo>
                  <a:pt x="2412747" y="486537"/>
                </a:lnTo>
                <a:lnTo>
                  <a:pt x="2542413" y="706882"/>
                </a:lnTo>
                <a:lnTo>
                  <a:pt x="2568448" y="747777"/>
                </a:lnTo>
                <a:lnTo>
                  <a:pt x="2594357" y="786511"/>
                </a:lnTo>
                <a:lnTo>
                  <a:pt x="2607310" y="805054"/>
                </a:lnTo>
                <a:lnTo>
                  <a:pt x="2620264" y="822961"/>
                </a:lnTo>
                <a:lnTo>
                  <a:pt x="2633219" y="840232"/>
                </a:lnTo>
                <a:lnTo>
                  <a:pt x="2646173" y="856869"/>
                </a:lnTo>
                <a:lnTo>
                  <a:pt x="2659126" y="872744"/>
                </a:lnTo>
                <a:lnTo>
                  <a:pt x="2672207" y="887985"/>
                </a:lnTo>
                <a:lnTo>
                  <a:pt x="2685161" y="902590"/>
                </a:lnTo>
                <a:lnTo>
                  <a:pt x="2698116" y="916560"/>
                </a:lnTo>
                <a:lnTo>
                  <a:pt x="2711069" y="929641"/>
                </a:lnTo>
                <a:lnTo>
                  <a:pt x="2724023" y="942213"/>
                </a:lnTo>
                <a:lnTo>
                  <a:pt x="2736978" y="954024"/>
                </a:lnTo>
                <a:lnTo>
                  <a:pt x="2749931" y="965200"/>
                </a:lnTo>
                <a:lnTo>
                  <a:pt x="2763012" y="975615"/>
                </a:lnTo>
                <a:lnTo>
                  <a:pt x="2775967" y="985521"/>
                </a:lnTo>
                <a:lnTo>
                  <a:pt x="2788920" y="994665"/>
                </a:lnTo>
                <a:lnTo>
                  <a:pt x="2801874" y="1003300"/>
                </a:lnTo>
                <a:lnTo>
                  <a:pt x="2814829" y="1011302"/>
                </a:lnTo>
                <a:lnTo>
                  <a:pt x="2827782" y="1018794"/>
                </a:lnTo>
                <a:lnTo>
                  <a:pt x="2840737" y="1025653"/>
                </a:lnTo>
                <a:lnTo>
                  <a:pt x="2853818" y="1032003"/>
                </a:lnTo>
                <a:lnTo>
                  <a:pt x="2866772" y="1037972"/>
                </a:lnTo>
                <a:lnTo>
                  <a:pt x="2879725" y="1043432"/>
                </a:lnTo>
                <a:lnTo>
                  <a:pt x="2892680" y="1048386"/>
                </a:lnTo>
                <a:lnTo>
                  <a:pt x="2905634" y="1052957"/>
                </a:lnTo>
                <a:lnTo>
                  <a:pt x="2918587" y="1057148"/>
                </a:lnTo>
                <a:lnTo>
                  <a:pt x="2931542" y="1060959"/>
                </a:lnTo>
                <a:lnTo>
                  <a:pt x="2944623" y="1064387"/>
                </a:lnTo>
                <a:lnTo>
                  <a:pt x="2957576" y="1067562"/>
                </a:lnTo>
                <a:lnTo>
                  <a:pt x="2970530" y="1070356"/>
                </a:lnTo>
                <a:lnTo>
                  <a:pt x="2983485" y="1073023"/>
                </a:lnTo>
                <a:lnTo>
                  <a:pt x="2996438" y="1075310"/>
                </a:lnTo>
                <a:lnTo>
                  <a:pt x="3009393" y="1077342"/>
                </a:lnTo>
                <a:lnTo>
                  <a:pt x="3022347" y="1079247"/>
                </a:lnTo>
                <a:lnTo>
                  <a:pt x="3035428" y="1080898"/>
                </a:lnTo>
              </a:path>
            </a:pathLst>
          </a:custGeom>
          <a:noFill/>
          <a:ln w="18288" cap="flat" cmpd="sng">
            <a:solidFill>
              <a:srgbClr val="01665E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24" name="Freeform 424"/>
          <p:cNvSpPr/>
          <p:nvPr/>
        </p:nvSpPr>
        <p:spPr>
          <a:xfrm>
            <a:off x="5045874" y="5731823"/>
            <a:ext cx="3103627" cy="0"/>
          </a:xfrm>
          <a:custGeom>
            <a:avLst/>
            <a:gdLst/>
            <a:ahLst/>
            <a:cxnLst/>
            <a:rect l="0" t="0" r="0" b="0"/>
            <a:pathLst>
              <a:path w="3103627">
                <a:moveTo>
                  <a:pt x="0" y="0"/>
                </a:moveTo>
                <a:lnTo>
                  <a:pt x="3103627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25" name="Freeform 425"/>
          <p:cNvSpPr/>
          <p:nvPr/>
        </p:nvSpPr>
        <p:spPr>
          <a:xfrm>
            <a:off x="8149501" y="3499799"/>
            <a:ext cx="0" cy="2232024"/>
          </a:xfrm>
          <a:custGeom>
            <a:avLst/>
            <a:gdLst/>
            <a:ahLst/>
            <a:cxnLst/>
            <a:rect l="0" t="0" r="0" b="0"/>
            <a:pathLst>
              <a:path h="2232024">
                <a:moveTo>
                  <a:pt x="0" y="2232024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26" name="Freeform 426"/>
          <p:cNvSpPr/>
          <p:nvPr/>
        </p:nvSpPr>
        <p:spPr>
          <a:xfrm>
            <a:off x="5045874" y="3499799"/>
            <a:ext cx="3103627" cy="0"/>
          </a:xfrm>
          <a:custGeom>
            <a:avLst/>
            <a:gdLst/>
            <a:ahLst/>
            <a:cxnLst/>
            <a:rect l="0" t="0" r="0" b="0"/>
            <a:pathLst>
              <a:path w="3103627">
                <a:moveTo>
                  <a:pt x="0" y="0"/>
                </a:moveTo>
                <a:lnTo>
                  <a:pt x="3103627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27" name="Freeform 427"/>
          <p:cNvSpPr/>
          <p:nvPr/>
        </p:nvSpPr>
        <p:spPr>
          <a:xfrm>
            <a:off x="5045874" y="3499799"/>
            <a:ext cx="0" cy="2232024"/>
          </a:xfrm>
          <a:custGeom>
            <a:avLst/>
            <a:gdLst/>
            <a:ahLst/>
            <a:cxnLst/>
            <a:rect l="0" t="0" r="0" b="0"/>
            <a:pathLst>
              <a:path h="2232024">
                <a:moveTo>
                  <a:pt x="0" y="2232024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28" name="Freeform 428"/>
          <p:cNvSpPr/>
          <p:nvPr/>
        </p:nvSpPr>
        <p:spPr>
          <a:xfrm>
            <a:off x="5045874" y="5731823"/>
            <a:ext cx="3103627" cy="0"/>
          </a:xfrm>
          <a:custGeom>
            <a:avLst/>
            <a:gdLst/>
            <a:ahLst/>
            <a:cxnLst/>
            <a:rect l="0" t="0" r="0" b="0"/>
            <a:pathLst>
              <a:path w="3103627">
                <a:moveTo>
                  <a:pt x="0" y="0"/>
                </a:moveTo>
                <a:lnTo>
                  <a:pt x="3103627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29" name="Freeform 429"/>
          <p:cNvSpPr/>
          <p:nvPr/>
        </p:nvSpPr>
        <p:spPr>
          <a:xfrm>
            <a:off x="5434494" y="573182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30" name="Freeform 430"/>
          <p:cNvSpPr/>
          <p:nvPr/>
        </p:nvSpPr>
        <p:spPr>
          <a:xfrm>
            <a:off x="5971450" y="573182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31" name="Freeform 431"/>
          <p:cNvSpPr/>
          <p:nvPr/>
        </p:nvSpPr>
        <p:spPr>
          <a:xfrm>
            <a:off x="6508279" y="573182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32" name="Freeform 432"/>
          <p:cNvSpPr/>
          <p:nvPr/>
        </p:nvSpPr>
        <p:spPr>
          <a:xfrm>
            <a:off x="7045235" y="573182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33" name="Freeform 433"/>
          <p:cNvSpPr/>
          <p:nvPr/>
        </p:nvSpPr>
        <p:spPr>
          <a:xfrm>
            <a:off x="7582064" y="573182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34" name="Freeform 434"/>
          <p:cNvSpPr/>
          <p:nvPr/>
        </p:nvSpPr>
        <p:spPr>
          <a:xfrm>
            <a:off x="8119020" y="5731823"/>
            <a:ext cx="0" cy="46356"/>
          </a:xfrm>
          <a:custGeom>
            <a:avLst/>
            <a:gdLst/>
            <a:ahLst/>
            <a:cxnLst/>
            <a:rect l="0" t="0" r="0" b="0"/>
            <a:pathLst>
              <a:path h="46356">
                <a:moveTo>
                  <a:pt x="0" y="0"/>
                </a:moveTo>
                <a:lnTo>
                  <a:pt x="0" y="46356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35" name="Freeform 435"/>
          <p:cNvSpPr/>
          <p:nvPr/>
        </p:nvSpPr>
        <p:spPr>
          <a:xfrm>
            <a:off x="5045874" y="3499799"/>
            <a:ext cx="0" cy="2232024"/>
          </a:xfrm>
          <a:custGeom>
            <a:avLst/>
            <a:gdLst/>
            <a:ahLst/>
            <a:cxnLst/>
            <a:rect l="0" t="0" r="0" b="0"/>
            <a:pathLst>
              <a:path h="2232024">
                <a:moveTo>
                  <a:pt x="0" y="2232024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36" name="Freeform 436"/>
          <p:cNvSpPr/>
          <p:nvPr/>
        </p:nvSpPr>
        <p:spPr>
          <a:xfrm>
            <a:off x="4999519" y="5701343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37" name="Freeform 437"/>
          <p:cNvSpPr/>
          <p:nvPr/>
        </p:nvSpPr>
        <p:spPr>
          <a:xfrm>
            <a:off x="4999519" y="5010210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38" name="Freeform 438"/>
          <p:cNvSpPr/>
          <p:nvPr/>
        </p:nvSpPr>
        <p:spPr>
          <a:xfrm>
            <a:off x="4999519" y="4318948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39" name="Freeform 439"/>
          <p:cNvSpPr/>
          <p:nvPr/>
        </p:nvSpPr>
        <p:spPr>
          <a:xfrm>
            <a:off x="4999519" y="3627814"/>
            <a:ext cx="46355" cy="0"/>
          </a:xfrm>
          <a:custGeom>
            <a:avLst/>
            <a:gdLst/>
            <a:ahLst/>
            <a:cxnLst/>
            <a:rect l="0" t="0" r="0" b="0"/>
            <a:pathLst>
              <a:path w="46355">
                <a:moveTo>
                  <a:pt x="46355" y="0"/>
                </a:moveTo>
                <a:lnTo>
                  <a:pt x="0" y="0"/>
                </a:lnTo>
              </a:path>
            </a:pathLst>
          </a:custGeom>
          <a:noFill/>
          <a:ln w="6095" cap="flat" cmpd="sng">
            <a:solidFill>
              <a:srgbClr val="86898B">
                <a:alpha val="100000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40" name="Rectangle 440"/>
          <p:cNvSpPr/>
          <p:nvPr/>
        </p:nvSpPr>
        <p:spPr>
          <a:xfrm>
            <a:off x="1151293" y="2866665"/>
            <a:ext cx="3153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>
              <a:tabLst>
                <a:tab pos="603504" algn="l"/>
                <a:tab pos="1219200" algn="l"/>
                <a:tab pos="1822704" algn="l"/>
                <a:tab pos="2426208" algn="l"/>
                <a:tab pos="3023616" algn="l"/>
              </a:tabLst>
            </a:pPr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-5.0	-2.5	0.0	2.5	5.0	7.5</a:t>
            </a:r>
          </a:p>
        </p:txBody>
      </p:sp>
      <p:sp>
        <p:nvSpPr>
          <p:cNvPr id="442" name="Rectangle 442"/>
          <p:cNvSpPr/>
          <p:nvPr/>
        </p:nvSpPr>
        <p:spPr>
          <a:xfrm>
            <a:off x="2559469" y="3033080"/>
            <a:ext cx="798295" cy="14760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959" spc="-11" dirty="0" smtClean="0">
                <a:solidFill>
                  <a:srgbClr val="000000"/>
                </a:solidFill>
                <a:latin typeface="AlbanyAMT,Regular"/>
              </a:rPr>
              <a:t>PMRS VIP 0.7</a:t>
            </a:r>
            <a:endParaRPr lang="en-US" sz="959" b="0" i="0" spc="-18" baseline="0" dirty="0">
              <a:solidFill>
                <a:srgbClr val="000000"/>
              </a:solidFill>
              <a:latin typeface="AlbanyAMT,Regular"/>
            </a:endParaRPr>
          </a:p>
        </p:txBody>
      </p:sp>
      <p:sp>
        <p:nvSpPr>
          <p:cNvPr id="443" name="Rectangle 443"/>
          <p:cNvSpPr/>
          <p:nvPr/>
        </p:nvSpPr>
        <p:spPr>
          <a:xfrm>
            <a:off x="1078140" y="2702073"/>
            <a:ext cx="51088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0</a:t>
            </a:r>
          </a:p>
        </p:txBody>
      </p:sp>
      <p:sp>
        <p:nvSpPr>
          <p:cNvPr id="444" name="Rectangle 444"/>
          <p:cNvSpPr/>
          <p:nvPr/>
        </p:nvSpPr>
        <p:spPr>
          <a:xfrm>
            <a:off x="1023276" y="2104665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10</a:t>
            </a:r>
          </a:p>
        </p:txBody>
      </p:sp>
      <p:sp>
        <p:nvSpPr>
          <p:cNvPr id="445" name="Rectangle 445"/>
          <p:cNvSpPr/>
          <p:nvPr/>
        </p:nvSpPr>
        <p:spPr>
          <a:xfrm>
            <a:off x="1023276" y="1507257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20</a:t>
            </a:r>
          </a:p>
        </p:txBody>
      </p:sp>
      <p:sp>
        <p:nvSpPr>
          <p:cNvPr id="446" name="Rectangle 446"/>
          <p:cNvSpPr/>
          <p:nvPr/>
        </p:nvSpPr>
        <p:spPr>
          <a:xfrm>
            <a:off x="1023276" y="909849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30</a:t>
            </a:r>
          </a:p>
        </p:txBody>
      </p:sp>
      <p:sp>
        <p:nvSpPr>
          <p:cNvPr id="447" name="Rectangle 447"/>
          <p:cNvSpPr/>
          <p:nvPr/>
        </p:nvSpPr>
        <p:spPr>
          <a:xfrm rot="-5400000">
            <a:off x="629172" y="1610733"/>
            <a:ext cx="408278" cy="163104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959" b="0" i="0" spc="0" baseline="0" dirty="0">
                <a:solidFill>
                  <a:srgbClr val="000000"/>
                </a:solidFill>
                <a:latin typeface="AlbanyAMT,Regular"/>
              </a:rPr>
              <a:t>Perce</a:t>
            </a:r>
            <a:r>
              <a:rPr lang="en-US" sz="959" b="0" i="0" spc="-29" baseline="0" dirty="0">
                <a:solidFill>
                  <a:srgbClr val="000000"/>
                </a:solidFill>
                <a:latin typeface="AlbanyAMT,Regular"/>
              </a:rPr>
              <a:t>nt</a:t>
            </a:r>
          </a:p>
        </p:txBody>
      </p:sp>
      <p:sp>
        <p:nvSpPr>
          <p:cNvPr id="448" name="Rectangle 448"/>
          <p:cNvSpPr/>
          <p:nvPr/>
        </p:nvSpPr>
        <p:spPr>
          <a:xfrm>
            <a:off x="5473356" y="2866665"/>
            <a:ext cx="2318800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>
              <a:tabLst>
                <a:tab pos="737615" algn="l"/>
                <a:tab pos="1463039" algn="l"/>
                <a:tab pos="2188464" algn="l"/>
              </a:tabLst>
            </a:pPr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-2.5	0.0	2.5	5.0</a:t>
            </a:r>
          </a:p>
        </p:txBody>
      </p:sp>
      <p:sp>
        <p:nvSpPr>
          <p:cNvPr id="449" name="Rectangle 449"/>
          <p:cNvSpPr/>
          <p:nvPr/>
        </p:nvSpPr>
        <p:spPr>
          <a:xfrm>
            <a:off x="6357276" y="3033080"/>
            <a:ext cx="773353" cy="14760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959" spc="-11" dirty="0" smtClean="0">
                <a:solidFill>
                  <a:srgbClr val="000000"/>
                </a:solidFill>
                <a:latin typeface="AlbanyAMT,Regular"/>
              </a:rPr>
              <a:t>PMRS VIP 1.0</a:t>
            </a:r>
            <a:endParaRPr lang="en-US" sz="959" b="0" i="0" spc="0" baseline="0" dirty="0">
              <a:solidFill>
                <a:srgbClr val="000000"/>
              </a:solidFill>
              <a:latin typeface="AlbanyAMT,Regular"/>
            </a:endParaRPr>
          </a:p>
        </p:txBody>
      </p:sp>
      <p:sp>
        <p:nvSpPr>
          <p:cNvPr id="450" name="Rectangle 450"/>
          <p:cNvSpPr/>
          <p:nvPr/>
        </p:nvSpPr>
        <p:spPr>
          <a:xfrm>
            <a:off x="4918620" y="2702073"/>
            <a:ext cx="51088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0</a:t>
            </a:r>
          </a:p>
        </p:txBody>
      </p:sp>
      <p:sp>
        <p:nvSpPr>
          <p:cNvPr id="451" name="Rectangle 451"/>
          <p:cNvSpPr/>
          <p:nvPr/>
        </p:nvSpPr>
        <p:spPr>
          <a:xfrm>
            <a:off x="4863756" y="2031513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10</a:t>
            </a:r>
          </a:p>
        </p:txBody>
      </p:sp>
      <p:sp>
        <p:nvSpPr>
          <p:cNvPr id="452" name="Rectangle 452"/>
          <p:cNvSpPr/>
          <p:nvPr/>
        </p:nvSpPr>
        <p:spPr>
          <a:xfrm>
            <a:off x="4863756" y="1354857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20</a:t>
            </a:r>
          </a:p>
        </p:txBody>
      </p:sp>
      <p:sp>
        <p:nvSpPr>
          <p:cNvPr id="453" name="Rectangle 453"/>
          <p:cNvSpPr/>
          <p:nvPr/>
        </p:nvSpPr>
        <p:spPr>
          <a:xfrm>
            <a:off x="4863756" y="684297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30</a:t>
            </a:r>
          </a:p>
        </p:txBody>
      </p:sp>
      <p:sp>
        <p:nvSpPr>
          <p:cNvPr id="454" name="Rectangle 454"/>
          <p:cNvSpPr/>
          <p:nvPr/>
        </p:nvSpPr>
        <p:spPr>
          <a:xfrm rot="-5400000">
            <a:off x="4469652" y="1610733"/>
            <a:ext cx="408278" cy="163104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959" b="0" i="0" spc="0" baseline="0" dirty="0">
                <a:solidFill>
                  <a:srgbClr val="000000"/>
                </a:solidFill>
                <a:latin typeface="AlbanyAMT,Regular"/>
              </a:rPr>
              <a:t>Perce</a:t>
            </a:r>
            <a:r>
              <a:rPr lang="en-US" sz="959" b="0" i="0" spc="-29" baseline="0" dirty="0">
                <a:solidFill>
                  <a:srgbClr val="000000"/>
                </a:solidFill>
                <a:latin typeface="AlbanyAMT,Regular"/>
              </a:rPr>
              <a:t>nt</a:t>
            </a:r>
          </a:p>
        </p:txBody>
      </p:sp>
      <p:sp>
        <p:nvSpPr>
          <p:cNvPr id="455" name="Rectangle 455"/>
          <p:cNvSpPr/>
          <p:nvPr/>
        </p:nvSpPr>
        <p:spPr>
          <a:xfrm>
            <a:off x="1193964" y="5792745"/>
            <a:ext cx="2800384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>
              <a:tabLst>
                <a:tab pos="682752" algn="l"/>
                <a:tab pos="1383792" algn="l"/>
                <a:tab pos="2066544" algn="l"/>
                <a:tab pos="2749295" algn="l"/>
                <a:tab pos="2749295" algn="l"/>
              </a:tabLst>
            </a:pPr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-4	-2	0	2	4	</a:t>
            </a:r>
          </a:p>
        </p:txBody>
      </p:sp>
      <p:sp>
        <p:nvSpPr>
          <p:cNvPr id="456" name="Rectangle 456"/>
          <p:cNvSpPr/>
          <p:nvPr/>
        </p:nvSpPr>
        <p:spPr>
          <a:xfrm>
            <a:off x="2413164" y="5959160"/>
            <a:ext cx="773353" cy="14760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959" spc="-11" dirty="0" smtClean="0">
                <a:solidFill>
                  <a:srgbClr val="000000"/>
                </a:solidFill>
                <a:latin typeface="AlbanyAMT,Regular"/>
              </a:rPr>
              <a:t>PMRS VIP 1.2</a:t>
            </a:r>
            <a:endParaRPr lang="en-US" sz="959" b="0" i="0" spc="0" baseline="0" dirty="0">
              <a:solidFill>
                <a:srgbClr val="000000"/>
              </a:solidFill>
              <a:latin typeface="AlbanyAMT,Regular"/>
            </a:endParaRPr>
          </a:p>
        </p:txBody>
      </p:sp>
      <p:sp>
        <p:nvSpPr>
          <p:cNvPr id="457" name="Rectangle 457"/>
          <p:cNvSpPr/>
          <p:nvPr/>
        </p:nvSpPr>
        <p:spPr>
          <a:xfrm>
            <a:off x="1078140" y="5628153"/>
            <a:ext cx="51088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0</a:t>
            </a:r>
          </a:p>
        </p:txBody>
      </p:sp>
      <p:sp>
        <p:nvSpPr>
          <p:cNvPr id="458" name="Rectangle 458"/>
          <p:cNvSpPr/>
          <p:nvPr/>
        </p:nvSpPr>
        <p:spPr>
          <a:xfrm>
            <a:off x="1023276" y="5091705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10</a:t>
            </a:r>
          </a:p>
        </p:txBody>
      </p:sp>
      <p:sp>
        <p:nvSpPr>
          <p:cNvPr id="459" name="Rectangle 459"/>
          <p:cNvSpPr/>
          <p:nvPr/>
        </p:nvSpPr>
        <p:spPr>
          <a:xfrm>
            <a:off x="1023276" y="4555257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20</a:t>
            </a:r>
          </a:p>
        </p:txBody>
      </p:sp>
      <p:sp>
        <p:nvSpPr>
          <p:cNvPr id="460" name="Rectangle 460"/>
          <p:cNvSpPr/>
          <p:nvPr/>
        </p:nvSpPr>
        <p:spPr>
          <a:xfrm>
            <a:off x="1023276" y="4018809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30</a:t>
            </a:r>
          </a:p>
        </p:txBody>
      </p:sp>
      <p:sp>
        <p:nvSpPr>
          <p:cNvPr id="461" name="Rectangle 461"/>
          <p:cNvSpPr/>
          <p:nvPr/>
        </p:nvSpPr>
        <p:spPr>
          <a:xfrm>
            <a:off x="1023276" y="3482361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40</a:t>
            </a:r>
          </a:p>
        </p:txBody>
      </p:sp>
      <p:sp>
        <p:nvSpPr>
          <p:cNvPr id="462" name="Rectangle 462"/>
          <p:cNvSpPr/>
          <p:nvPr/>
        </p:nvSpPr>
        <p:spPr>
          <a:xfrm rot="-5400000">
            <a:off x="629172" y="4549005"/>
            <a:ext cx="408278" cy="163104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959" b="0" i="0" spc="0" baseline="0" dirty="0">
                <a:solidFill>
                  <a:srgbClr val="000000"/>
                </a:solidFill>
                <a:latin typeface="AlbanyAMT,Regular"/>
              </a:rPr>
              <a:t>Perce</a:t>
            </a:r>
            <a:r>
              <a:rPr lang="en-US" sz="959" b="0" i="0" spc="-29" baseline="0" dirty="0">
                <a:solidFill>
                  <a:srgbClr val="000000"/>
                </a:solidFill>
                <a:latin typeface="AlbanyAMT,Regular"/>
              </a:rPr>
              <a:t>nt</a:t>
            </a:r>
          </a:p>
        </p:txBody>
      </p:sp>
      <p:sp>
        <p:nvSpPr>
          <p:cNvPr id="463" name="Rectangle 463"/>
          <p:cNvSpPr/>
          <p:nvPr/>
        </p:nvSpPr>
        <p:spPr>
          <a:xfrm>
            <a:off x="5394108" y="5792745"/>
            <a:ext cx="2751616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>
              <a:tabLst>
                <a:tab pos="536448" algn="l"/>
                <a:tab pos="1085087" algn="l"/>
                <a:tab pos="1621536" algn="l"/>
                <a:tab pos="2157984" algn="l"/>
                <a:tab pos="2700528" algn="l"/>
                <a:tab pos="2700528" algn="l"/>
              </a:tabLst>
            </a:pPr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-2	-1	0	1	2	3	</a:t>
            </a:r>
          </a:p>
        </p:txBody>
      </p:sp>
      <p:sp>
        <p:nvSpPr>
          <p:cNvPr id="464" name="Rectangle 464"/>
          <p:cNvSpPr/>
          <p:nvPr/>
        </p:nvSpPr>
        <p:spPr>
          <a:xfrm>
            <a:off x="6253644" y="5959160"/>
            <a:ext cx="790281" cy="14760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959" b="0" i="0" spc="0" baseline="0" dirty="0" smtClean="0">
                <a:solidFill>
                  <a:srgbClr val="000000"/>
                </a:solidFill>
                <a:latin typeface="AlbanyAMT,Regular"/>
              </a:rPr>
              <a:t>PMRS VIP 1.4</a:t>
            </a:r>
            <a:endParaRPr lang="en-US" sz="959" b="0" i="0" spc="0" baseline="0" dirty="0">
              <a:solidFill>
                <a:srgbClr val="000000"/>
              </a:solidFill>
              <a:latin typeface="AlbanyAMT,Regular"/>
            </a:endParaRPr>
          </a:p>
        </p:txBody>
      </p:sp>
      <p:sp>
        <p:nvSpPr>
          <p:cNvPr id="465" name="Rectangle 465"/>
          <p:cNvSpPr/>
          <p:nvPr/>
        </p:nvSpPr>
        <p:spPr>
          <a:xfrm>
            <a:off x="4918620" y="5628153"/>
            <a:ext cx="51088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0</a:t>
            </a:r>
          </a:p>
        </p:txBody>
      </p:sp>
      <p:sp>
        <p:nvSpPr>
          <p:cNvPr id="466" name="Rectangle 466"/>
          <p:cNvSpPr/>
          <p:nvPr/>
        </p:nvSpPr>
        <p:spPr>
          <a:xfrm>
            <a:off x="4863756" y="4939305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10</a:t>
            </a:r>
          </a:p>
        </p:txBody>
      </p:sp>
      <p:sp>
        <p:nvSpPr>
          <p:cNvPr id="467" name="Rectangle 467"/>
          <p:cNvSpPr/>
          <p:nvPr/>
        </p:nvSpPr>
        <p:spPr>
          <a:xfrm>
            <a:off x="4863756" y="4244361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20</a:t>
            </a:r>
          </a:p>
        </p:txBody>
      </p:sp>
      <p:sp>
        <p:nvSpPr>
          <p:cNvPr id="468" name="Rectangle 468"/>
          <p:cNvSpPr/>
          <p:nvPr/>
        </p:nvSpPr>
        <p:spPr>
          <a:xfrm>
            <a:off x="4863756" y="3555513"/>
            <a:ext cx="105952" cy="1290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9" b="0" i="0" spc="0" baseline="0" dirty="0">
                <a:solidFill>
                  <a:srgbClr val="000000"/>
                </a:solidFill>
                <a:latin typeface="AlbanyAMT,Regular"/>
              </a:rPr>
              <a:t>30</a:t>
            </a:r>
          </a:p>
        </p:txBody>
      </p:sp>
      <p:sp>
        <p:nvSpPr>
          <p:cNvPr id="469" name="Rectangle 469"/>
          <p:cNvSpPr/>
          <p:nvPr/>
        </p:nvSpPr>
        <p:spPr>
          <a:xfrm rot="-5400000">
            <a:off x="4469652" y="4536813"/>
            <a:ext cx="408278" cy="163104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959" b="0" i="0" spc="0" baseline="0" dirty="0">
                <a:solidFill>
                  <a:srgbClr val="000000"/>
                </a:solidFill>
                <a:latin typeface="AlbanyAMT,Regular"/>
              </a:rPr>
              <a:t>Perce</a:t>
            </a:r>
            <a:r>
              <a:rPr lang="en-US" sz="959" b="0" i="0" spc="-29" baseline="0" dirty="0">
                <a:solidFill>
                  <a:srgbClr val="000000"/>
                </a:solidFill>
                <a:latin typeface="AlbanyAMT,Regular"/>
              </a:rPr>
              <a:t>nt</a:t>
            </a:r>
          </a:p>
        </p:txBody>
      </p:sp>
      <p:sp>
        <p:nvSpPr>
          <p:cNvPr id="471" name="Freeform 177"/>
          <p:cNvSpPr/>
          <p:nvPr/>
        </p:nvSpPr>
        <p:spPr>
          <a:xfrm>
            <a:off x="5673471" y="6709794"/>
            <a:ext cx="85470" cy="85344"/>
          </a:xfrm>
          <a:custGeom>
            <a:avLst/>
            <a:gdLst/>
            <a:ahLst/>
            <a:cxnLst/>
            <a:rect l="0" t="0" r="0" b="0"/>
            <a:pathLst>
              <a:path w="85470" h="85344">
                <a:moveTo>
                  <a:pt x="42672" y="0"/>
                </a:moveTo>
                <a:lnTo>
                  <a:pt x="85470" y="0"/>
                </a:lnTo>
                <a:lnTo>
                  <a:pt x="85470" y="85344"/>
                </a:lnTo>
                <a:lnTo>
                  <a:pt x="0" y="85344"/>
                </a:lnTo>
                <a:lnTo>
                  <a:pt x="0" y="0"/>
                </a:lnTo>
                <a:lnTo>
                  <a:pt x="42672" y="0"/>
                </a:lnTo>
              </a:path>
            </a:pathLst>
          </a:custGeom>
          <a:solidFill>
            <a:srgbClr val="66A5A0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72" name="Freeform 178"/>
          <p:cNvSpPr/>
          <p:nvPr/>
        </p:nvSpPr>
        <p:spPr>
          <a:xfrm>
            <a:off x="5670289" y="6709794"/>
            <a:ext cx="85470" cy="85344"/>
          </a:xfrm>
          <a:custGeom>
            <a:avLst/>
            <a:gdLst/>
            <a:ahLst/>
            <a:cxnLst/>
            <a:rect l="0" t="0" r="0" b="0"/>
            <a:pathLst>
              <a:path w="85470" h="85344">
                <a:moveTo>
                  <a:pt x="42672" y="0"/>
                </a:moveTo>
                <a:lnTo>
                  <a:pt x="85470" y="0"/>
                </a:lnTo>
                <a:lnTo>
                  <a:pt x="85470" y="85344"/>
                </a:lnTo>
                <a:lnTo>
                  <a:pt x="0" y="85344"/>
                </a:lnTo>
                <a:lnTo>
                  <a:pt x="0" y="0"/>
                </a:lnTo>
                <a:lnTo>
                  <a:pt x="42672" y="0"/>
                </a:lnTo>
              </a:path>
            </a:pathLst>
          </a:custGeom>
          <a:noFill/>
          <a:ln w="6095" cap="sq" cmpd="sng">
            <a:solidFill>
              <a:srgbClr val="01665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73" name="Freeform 179"/>
          <p:cNvSpPr/>
          <p:nvPr/>
        </p:nvSpPr>
        <p:spPr>
          <a:xfrm>
            <a:off x="4406832" y="6709794"/>
            <a:ext cx="85344" cy="85344"/>
          </a:xfrm>
          <a:custGeom>
            <a:avLst/>
            <a:gdLst/>
            <a:ahLst/>
            <a:cxnLst/>
            <a:rect l="0" t="0" r="0" b="0"/>
            <a:pathLst>
              <a:path w="85344" h="85344">
                <a:moveTo>
                  <a:pt x="42672" y="0"/>
                </a:moveTo>
                <a:lnTo>
                  <a:pt x="85344" y="0"/>
                </a:lnTo>
                <a:lnTo>
                  <a:pt x="85344" y="85344"/>
                </a:lnTo>
                <a:lnTo>
                  <a:pt x="0" y="85344"/>
                </a:lnTo>
                <a:lnTo>
                  <a:pt x="0" y="0"/>
                </a:lnTo>
                <a:lnTo>
                  <a:pt x="42672" y="0"/>
                </a:lnTo>
              </a:path>
            </a:pathLst>
          </a:custGeom>
          <a:solidFill>
            <a:srgbClr val="D05B5B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74" name="Freeform 180"/>
          <p:cNvSpPr/>
          <p:nvPr/>
        </p:nvSpPr>
        <p:spPr>
          <a:xfrm>
            <a:off x="4406832" y="6709794"/>
            <a:ext cx="85344" cy="85344"/>
          </a:xfrm>
          <a:custGeom>
            <a:avLst/>
            <a:gdLst/>
            <a:ahLst/>
            <a:cxnLst/>
            <a:rect l="0" t="0" r="0" b="0"/>
            <a:pathLst>
              <a:path w="85344" h="85344">
                <a:moveTo>
                  <a:pt x="42672" y="0"/>
                </a:moveTo>
                <a:lnTo>
                  <a:pt x="85344" y="0"/>
                </a:lnTo>
                <a:lnTo>
                  <a:pt x="85344" y="85344"/>
                </a:lnTo>
                <a:lnTo>
                  <a:pt x="0" y="85344"/>
                </a:lnTo>
                <a:lnTo>
                  <a:pt x="0" y="0"/>
                </a:lnTo>
                <a:lnTo>
                  <a:pt x="42672" y="0"/>
                </a:lnTo>
              </a:path>
            </a:pathLst>
          </a:custGeom>
          <a:noFill/>
          <a:ln w="6095" cap="sq" cmpd="sng">
            <a:solidFill>
              <a:srgbClr val="A23A2E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75" name="Freeform 181"/>
          <p:cNvSpPr/>
          <p:nvPr/>
        </p:nvSpPr>
        <p:spPr>
          <a:xfrm>
            <a:off x="3364416" y="6709794"/>
            <a:ext cx="85344" cy="85344"/>
          </a:xfrm>
          <a:custGeom>
            <a:avLst/>
            <a:gdLst/>
            <a:ahLst/>
            <a:cxnLst/>
            <a:rect l="0" t="0" r="0" b="0"/>
            <a:pathLst>
              <a:path w="85344" h="85344">
                <a:moveTo>
                  <a:pt x="42672" y="0"/>
                </a:moveTo>
                <a:lnTo>
                  <a:pt x="85344" y="0"/>
                </a:lnTo>
                <a:lnTo>
                  <a:pt x="85344" y="85344"/>
                </a:lnTo>
                <a:lnTo>
                  <a:pt x="0" y="85344"/>
                </a:lnTo>
                <a:lnTo>
                  <a:pt x="0" y="0"/>
                </a:lnTo>
                <a:lnTo>
                  <a:pt x="42672" y="0"/>
                </a:lnTo>
              </a:path>
            </a:pathLst>
          </a:custGeom>
          <a:solidFill>
            <a:srgbClr val="6F7EB3">
              <a:alpha val="49799"/>
            </a:srgbClr>
          </a:solidFill>
          <a:ln w="609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76" name="Freeform 182"/>
          <p:cNvSpPr/>
          <p:nvPr/>
        </p:nvSpPr>
        <p:spPr>
          <a:xfrm>
            <a:off x="3364416" y="6709794"/>
            <a:ext cx="85344" cy="85344"/>
          </a:xfrm>
          <a:custGeom>
            <a:avLst/>
            <a:gdLst/>
            <a:ahLst/>
            <a:cxnLst/>
            <a:rect l="0" t="0" r="0" b="0"/>
            <a:pathLst>
              <a:path w="85344" h="85344">
                <a:moveTo>
                  <a:pt x="42672" y="0"/>
                </a:moveTo>
                <a:lnTo>
                  <a:pt x="85344" y="0"/>
                </a:lnTo>
                <a:lnTo>
                  <a:pt x="85344" y="85344"/>
                </a:lnTo>
                <a:lnTo>
                  <a:pt x="0" y="85344"/>
                </a:lnTo>
                <a:lnTo>
                  <a:pt x="0" y="0"/>
                </a:lnTo>
                <a:lnTo>
                  <a:pt x="42672" y="0"/>
                </a:lnTo>
              </a:path>
            </a:pathLst>
          </a:custGeom>
          <a:noFill/>
          <a:ln w="6095" cap="sq" cmpd="sng">
            <a:solidFill>
              <a:srgbClr val="445694">
                <a:alpha val="49799"/>
              </a:srgbClr>
            </a:solidFill>
            <a:miter lim="127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77" name="Rectangle 194"/>
          <p:cNvSpPr/>
          <p:nvPr/>
        </p:nvSpPr>
        <p:spPr>
          <a:xfrm>
            <a:off x="3567332" y="6667750"/>
            <a:ext cx="3465261" cy="14760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marL="0">
              <a:tabLst>
                <a:tab pos="1042415" algn="l"/>
                <a:tab pos="1908047" algn="l"/>
              </a:tabLst>
            </a:pPr>
            <a:r>
              <a:rPr lang="en-US" sz="959" spc="-65" dirty="0" smtClean="0">
                <a:solidFill>
                  <a:srgbClr val="000000"/>
                </a:solidFill>
                <a:latin typeface="AlbanyAMT,Regular"/>
              </a:rPr>
              <a:t>Below 25 kg/m</a:t>
            </a:r>
            <a:r>
              <a:rPr lang="en-US" sz="959" spc="-65" baseline="30000" dirty="0" smtClean="0">
                <a:solidFill>
                  <a:srgbClr val="000000"/>
                </a:solidFill>
                <a:latin typeface="AlbanyAMT,Regular"/>
              </a:rPr>
              <a:t>2</a:t>
            </a:r>
            <a:r>
              <a:rPr lang="en-US" sz="959" b="0" i="0" spc="0" baseline="0" dirty="0">
                <a:solidFill>
                  <a:srgbClr val="000000"/>
                </a:solidFill>
                <a:latin typeface="AlbanyAMT,Regular"/>
              </a:rPr>
              <a:t>	</a:t>
            </a:r>
            <a:r>
              <a:rPr lang="en-US" sz="959" dirty="0" smtClean="0">
                <a:solidFill>
                  <a:srgbClr val="000000"/>
                </a:solidFill>
                <a:latin typeface="AlbanyAMT,Regular"/>
              </a:rPr>
              <a:t>25 to 30</a:t>
            </a:r>
            <a:r>
              <a:rPr lang="en-US" sz="959" spc="-65" dirty="0" smtClean="0">
                <a:solidFill>
                  <a:srgbClr val="000000"/>
                </a:solidFill>
                <a:latin typeface="AlbanyAMT,Regular"/>
              </a:rPr>
              <a:t> kg/m</a:t>
            </a:r>
            <a:r>
              <a:rPr lang="en-US" sz="959" spc="-65" baseline="30000" dirty="0" smtClean="0">
                <a:solidFill>
                  <a:srgbClr val="000000"/>
                </a:solidFill>
                <a:latin typeface="AlbanyAMT,Regular"/>
              </a:rPr>
              <a:t>2</a:t>
            </a:r>
            <a:r>
              <a:rPr lang="en-US" sz="959" dirty="0" smtClean="0">
                <a:solidFill>
                  <a:srgbClr val="000000"/>
                </a:solidFill>
                <a:latin typeface="AlbanyAMT,Regular"/>
              </a:rPr>
              <a:t>              30</a:t>
            </a:r>
            <a:r>
              <a:rPr lang="en-US" sz="959" spc="-65" dirty="0" smtClean="0">
                <a:solidFill>
                  <a:srgbClr val="000000"/>
                </a:solidFill>
                <a:latin typeface="AlbanyAMT,Regular"/>
              </a:rPr>
              <a:t> kg/m</a:t>
            </a:r>
            <a:r>
              <a:rPr lang="en-US" sz="959" spc="-65" baseline="30000" dirty="0" smtClean="0">
                <a:solidFill>
                  <a:srgbClr val="000000"/>
                </a:solidFill>
                <a:latin typeface="AlbanyAMT,Regular"/>
              </a:rPr>
              <a:t>2 </a:t>
            </a:r>
            <a:r>
              <a:rPr lang="en-US" sz="959" spc="-65" dirty="0" smtClean="0">
                <a:solidFill>
                  <a:srgbClr val="000000"/>
                </a:solidFill>
                <a:latin typeface="AlbanyAMT,Regular"/>
              </a:rPr>
              <a:t>and above</a:t>
            </a:r>
            <a:r>
              <a:rPr lang="en-US" sz="959" spc="-65" baseline="30000" dirty="0" smtClean="0">
                <a:solidFill>
                  <a:srgbClr val="000000"/>
                </a:solidFill>
                <a:latin typeface="AlbanyAMT,Regular"/>
              </a:rPr>
              <a:t>               </a:t>
            </a:r>
            <a:r>
              <a:rPr lang="en-US" sz="959" dirty="0" smtClean="0">
                <a:solidFill>
                  <a:srgbClr val="000000"/>
                </a:solidFill>
                <a:latin typeface="AlbanyAMT,Regular"/>
              </a:rPr>
              <a:t>         </a:t>
            </a:r>
            <a:endParaRPr lang="en-US" sz="959" b="0" i="0" spc="0" baseline="0" dirty="0">
              <a:solidFill>
                <a:srgbClr val="000000"/>
              </a:solidFill>
              <a:latin typeface="AlbanyAMT,Regular"/>
            </a:endParaRPr>
          </a:p>
        </p:txBody>
      </p:sp>
      <p:sp>
        <p:nvSpPr>
          <p:cNvPr id="478" name="Rectangle 195"/>
          <p:cNvSpPr/>
          <p:nvPr/>
        </p:nvSpPr>
        <p:spPr>
          <a:xfrm>
            <a:off x="4108576" y="6399729"/>
            <a:ext cx="1929763" cy="16927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marL="0"/>
            <a:r>
              <a:rPr lang="en-US" sz="1100" b="0" i="0" spc="0" baseline="0" dirty="0" smtClean="0">
                <a:solidFill>
                  <a:srgbClr val="000000"/>
                </a:solidFill>
                <a:latin typeface="AlbanyAMT,Regular"/>
              </a:rPr>
              <a:t>Materna</a:t>
            </a:r>
            <a:r>
              <a:rPr lang="en-US" sz="1100" b="0" i="0" spc="-48" baseline="0" dirty="0" smtClean="0">
                <a:solidFill>
                  <a:srgbClr val="000000"/>
                </a:solidFill>
                <a:latin typeface="AlbanyAMT,Regular"/>
              </a:rPr>
              <a:t>l</a:t>
            </a:r>
            <a:r>
              <a:rPr lang="en-US" sz="1100" dirty="0">
                <a:solidFill>
                  <a:srgbClr val="000000"/>
                </a:solidFill>
                <a:latin typeface="AlbanyAMT,Regular"/>
              </a:rPr>
              <a:t> </a:t>
            </a:r>
            <a:r>
              <a:rPr lang="en-US" sz="1100" dirty="0" smtClean="0">
                <a:solidFill>
                  <a:srgbClr val="000000"/>
                </a:solidFill>
                <a:latin typeface="AlbanyAMT,Regular"/>
              </a:rPr>
              <a:t>pre-pregnancy BMI</a:t>
            </a:r>
            <a:endParaRPr lang="en-US" sz="1100" b="0" i="0" spc="0" baseline="0" dirty="0">
              <a:solidFill>
                <a:srgbClr val="000000"/>
              </a:solidFill>
              <a:latin typeface="AlbanyAMT,Regular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18650" y="182821"/>
            <a:ext cx="12554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/>
              <a:t>Figure 1. </a:t>
            </a:r>
            <a:r>
              <a:rPr lang="en-US" sz="1000" b="1" dirty="0" smtClean="0"/>
              <a:t>Panel B.</a:t>
            </a:r>
            <a:endParaRPr lang="en-US" sz="10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/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48</Words>
  <Application>Microsoft Office PowerPoint</Application>
  <PresentationFormat>Custom</PresentationFormat>
  <Paragraphs>4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AlbanyAMT,Regular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rchenko, Polina</dc:creator>
  <cp:lastModifiedBy>Girchenko, Polina</cp:lastModifiedBy>
  <cp:revision>7</cp:revision>
  <dcterms:modified xsi:type="dcterms:W3CDTF">2023-12-13T12:55:56Z</dcterms:modified>
</cp:coreProperties>
</file>